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  <p:sldId id="267" r:id="rId6"/>
    <p:sldId id="272" r:id="rId7"/>
    <p:sldId id="269" r:id="rId8"/>
    <p:sldId id="270" r:id="rId9"/>
    <p:sldId id="265" r:id="rId10"/>
    <p:sldId id="257" r:id="rId11"/>
    <p:sldId id="273" r:id="rId12"/>
    <p:sldId id="258" r:id="rId13"/>
    <p:sldId id="259" r:id="rId14"/>
    <p:sldId id="260" r:id="rId15"/>
    <p:sldId id="261" r:id="rId16"/>
    <p:sldId id="263" r:id="rId17"/>
    <p:sldId id="271" r:id="rId1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haffey, Jessica" initials="CJ" lastIdx="2" clrIdx="0">
    <p:extLst>
      <p:ext uri="{19B8F6BF-5375-455C-9EA6-DF929625EA0E}">
        <p15:presenceInfo xmlns:p15="http://schemas.microsoft.com/office/powerpoint/2012/main" userId="S::J.R.Chaffey@exeter.ac.uk::dfaac082-a21f-4bd8-8583-e2115658a55f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826C407-A27E-49D6-A5F0-3C0403B96868}" v="278" dt="2021-05-20T14:04:12.383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88" d="100"/>
          <a:sy n="88" d="100"/>
        </p:scale>
        <p:origin x="451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slide" Target="slides/slide14.xml"/><Relationship Id="rId26" Type="http://schemas.microsoft.com/office/2015/10/relationships/revisionInfo" Target="revisionInfo.xml"/><Relationship Id="rId3" Type="http://schemas.openxmlformats.org/officeDocument/2006/relationships/customXml" Target="../customXml/item3.xml"/><Relationship Id="rId21" Type="http://schemas.openxmlformats.org/officeDocument/2006/relationships/viewProps" Target="viewProps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slide" Target="slides/slide13.xml"/><Relationship Id="rId25" Type="http://schemas.microsoft.com/office/2016/11/relationships/changesInfo" Target="changesInfos/changesInfo1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0" Type="http://schemas.openxmlformats.org/officeDocument/2006/relationships/presProps" Target="presProp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23" Type="http://schemas.openxmlformats.org/officeDocument/2006/relationships/tableStyles" Target="tableStyles.xml"/><Relationship Id="rId10" Type="http://schemas.openxmlformats.org/officeDocument/2006/relationships/slide" Target="slides/slide6.xml"/><Relationship Id="rId19" Type="http://schemas.openxmlformats.org/officeDocument/2006/relationships/commentAuthors" Target="commentAuthor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organ, Noel" userId="S::n.g.morgan@exeter.ac.uk::313cb4c6-7f54-4075-b55e-1af55349c6ed" providerId="AD" clId="Web-{FE287935-35AF-4A59-8660-5593BC5CF064}"/>
    <pc:docChg chg="modSld">
      <pc:chgData name="Morgan, Noel" userId="S::n.g.morgan@exeter.ac.uk::313cb4c6-7f54-4075-b55e-1af55349c6ed" providerId="AD" clId="Web-{FE287935-35AF-4A59-8660-5593BC5CF064}" dt="2021-05-17T12:04:19.402" v="9"/>
      <pc:docMkLst>
        <pc:docMk/>
      </pc:docMkLst>
      <pc:sldChg chg="delSp modSp">
        <pc:chgData name="Morgan, Noel" userId="S::n.g.morgan@exeter.ac.uk::313cb4c6-7f54-4075-b55e-1af55349c6ed" providerId="AD" clId="Web-{FE287935-35AF-4A59-8660-5593BC5CF064}" dt="2021-05-17T12:04:19.402" v="9"/>
        <pc:sldMkLst>
          <pc:docMk/>
          <pc:sldMk cId="3649101259" sldId="257"/>
        </pc:sldMkLst>
        <pc:spChg chg="del">
          <ac:chgData name="Morgan, Noel" userId="S::n.g.morgan@exeter.ac.uk::313cb4c6-7f54-4075-b55e-1af55349c6ed" providerId="AD" clId="Web-{FE287935-35AF-4A59-8660-5593BC5CF064}" dt="2021-05-17T12:04:15.730" v="8"/>
          <ac:spMkLst>
            <pc:docMk/>
            <pc:sldMk cId="3649101259" sldId="257"/>
            <ac:spMk id="38" creationId="{A89C6280-4C30-4815-B960-18916C919557}"/>
          </ac:spMkLst>
        </pc:spChg>
        <pc:spChg chg="mod">
          <ac:chgData name="Morgan, Noel" userId="S::n.g.morgan@exeter.ac.uk::313cb4c6-7f54-4075-b55e-1af55349c6ed" providerId="AD" clId="Web-{FE287935-35AF-4A59-8660-5593BC5CF064}" dt="2021-05-17T12:04:02.823" v="6" actId="20577"/>
          <ac:spMkLst>
            <pc:docMk/>
            <pc:sldMk cId="3649101259" sldId="257"/>
            <ac:spMk id="41" creationId="{B71A6BEA-BC7D-45A0-A8E5-5D58CA62411E}"/>
          </ac:spMkLst>
        </pc:spChg>
        <pc:cxnChg chg="del">
          <ac:chgData name="Morgan, Noel" userId="S::n.g.morgan@exeter.ac.uk::313cb4c6-7f54-4075-b55e-1af55349c6ed" providerId="AD" clId="Web-{FE287935-35AF-4A59-8660-5593BC5CF064}" dt="2021-05-17T12:04:19.402" v="9"/>
          <ac:cxnSpMkLst>
            <pc:docMk/>
            <pc:sldMk cId="3649101259" sldId="257"/>
            <ac:cxnSpMk id="39" creationId="{E07CA82D-6174-4960-B6F8-1C350D781955}"/>
          </ac:cxnSpMkLst>
        </pc:cxnChg>
        <pc:cxnChg chg="del">
          <ac:chgData name="Morgan, Noel" userId="S::n.g.morgan@exeter.ac.uk::313cb4c6-7f54-4075-b55e-1af55349c6ed" providerId="AD" clId="Web-{FE287935-35AF-4A59-8660-5593BC5CF064}" dt="2021-05-17T12:04:10.917" v="7"/>
          <ac:cxnSpMkLst>
            <pc:docMk/>
            <pc:sldMk cId="3649101259" sldId="257"/>
            <ac:cxnSpMk id="40" creationId="{79481DB6-1F25-4BD7-9CE2-1A756107EE31}"/>
          </ac:cxnSpMkLst>
        </pc:cxnChg>
      </pc:sldChg>
    </pc:docChg>
  </pc:docChgLst>
  <pc:docChgLst>
    <pc:chgData name="Chaffey, Jessica" userId="dfaac082-a21f-4bd8-8583-e2115658a55f" providerId="ADAL" clId="{3821B51F-EF30-4C63-BE82-1707C230E536}"/>
    <pc:docChg chg="undo redo custSel addSld delSld modSld sldOrd">
      <pc:chgData name="Chaffey, Jessica" userId="dfaac082-a21f-4bd8-8583-e2115658a55f" providerId="ADAL" clId="{3821B51F-EF30-4C63-BE82-1707C230E536}" dt="2021-05-17T11:13:14.402" v="826" actId="478"/>
      <pc:docMkLst>
        <pc:docMk/>
      </pc:docMkLst>
      <pc:sldChg chg="modSp">
        <pc:chgData name="Chaffey, Jessica" userId="dfaac082-a21f-4bd8-8583-e2115658a55f" providerId="ADAL" clId="{3821B51F-EF30-4C63-BE82-1707C230E536}" dt="2021-05-17T10:56:00.041" v="436" actId="20577"/>
        <pc:sldMkLst>
          <pc:docMk/>
          <pc:sldMk cId="2985740509" sldId="256"/>
        </pc:sldMkLst>
        <pc:spChg chg="mod">
          <ac:chgData name="Chaffey, Jessica" userId="dfaac082-a21f-4bd8-8583-e2115658a55f" providerId="ADAL" clId="{3821B51F-EF30-4C63-BE82-1707C230E536}" dt="2021-05-17T10:56:00.041" v="436" actId="20577"/>
          <ac:spMkLst>
            <pc:docMk/>
            <pc:sldMk cId="2985740509" sldId="256"/>
            <ac:spMk id="2" creationId="{EEE6CB7C-0BA8-4F61-AC8D-6D45E1A364C6}"/>
          </ac:spMkLst>
        </pc:spChg>
      </pc:sldChg>
      <pc:sldChg chg="addSp delSp modSp">
        <pc:chgData name="Chaffey, Jessica" userId="dfaac082-a21f-4bd8-8583-e2115658a55f" providerId="ADAL" clId="{3821B51F-EF30-4C63-BE82-1707C230E536}" dt="2021-05-17T10:28:59.019" v="367" actId="6549"/>
        <pc:sldMkLst>
          <pc:docMk/>
          <pc:sldMk cId="3649101259" sldId="257"/>
        </pc:sldMkLst>
        <pc:spChg chg="mod">
          <ac:chgData name="Chaffey, Jessica" userId="dfaac082-a21f-4bd8-8583-e2115658a55f" providerId="ADAL" clId="{3821B51F-EF30-4C63-BE82-1707C230E536}" dt="2021-05-17T10:28:59.019" v="367" actId="6549"/>
          <ac:spMkLst>
            <pc:docMk/>
            <pc:sldMk cId="3649101259" sldId="257"/>
            <ac:spMk id="20" creationId="{8E41C580-05D7-43BD-A843-91971202CC2A}"/>
          </ac:spMkLst>
        </pc:spChg>
        <pc:spChg chg="mod">
          <ac:chgData name="Chaffey, Jessica" userId="dfaac082-a21f-4bd8-8583-e2115658a55f" providerId="ADAL" clId="{3821B51F-EF30-4C63-BE82-1707C230E536}" dt="2021-05-17T10:28:45.997" v="366" actId="20577"/>
          <ac:spMkLst>
            <pc:docMk/>
            <pc:sldMk cId="3649101259" sldId="257"/>
            <ac:spMk id="67" creationId="{8A8871F9-1B0F-43A2-91D9-1244198C91FF}"/>
          </ac:spMkLst>
        </pc:spChg>
        <pc:spChg chg="add del mod">
          <ac:chgData name="Chaffey, Jessica" userId="dfaac082-a21f-4bd8-8583-e2115658a55f" providerId="ADAL" clId="{3821B51F-EF30-4C63-BE82-1707C230E536}" dt="2021-05-17T10:10:35.146" v="124" actId="478"/>
          <ac:spMkLst>
            <pc:docMk/>
            <pc:sldMk cId="3649101259" sldId="257"/>
            <ac:spMk id="68" creationId="{09D1A4E7-DA5F-492C-A48F-FAE521950D1A}"/>
          </ac:spMkLst>
        </pc:spChg>
      </pc:sldChg>
      <pc:sldChg chg="modSp">
        <pc:chgData name="Chaffey, Jessica" userId="dfaac082-a21f-4bd8-8583-e2115658a55f" providerId="ADAL" clId="{3821B51F-EF30-4C63-BE82-1707C230E536}" dt="2021-05-17T10:29:32.822" v="369" actId="14100"/>
        <pc:sldMkLst>
          <pc:docMk/>
          <pc:sldMk cId="522916658" sldId="258"/>
        </pc:sldMkLst>
        <pc:spChg chg="mod">
          <ac:chgData name="Chaffey, Jessica" userId="dfaac082-a21f-4bd8-8583-e2115658a55f" providerId="ADAL" clId="{3821B51F-EF30-4C63-BE82-1707C230E536}" dt="2021-05-17T10:29:32.822" v="369" actId="14100"/>
          <ac:spMkLst>
            <pc:docMk/>
            <pc:sldMk cId="522916658" sldId="258"/>
            <ac:spMk id="49" creationId="{D8759829-68E9-4C25-8CAC-992DC2C290C4}"/>
          </ac:spMkLst>
        </pc:spChg>
      </pc:sldChg>
      <pc:sldChg chg="modSp">
        <pc:chgData name="Chaffey, Jessica" userId="dfaac082-a21f-4bd8-8583-e2115658a55f" providerId="ADAL" clId="{3821B51F-EF30-4C63-BE82-1707C230E536}" dt="2021-05-17T10:29:58.501" v="370" actId="20577"/>
        <pc:sldMkLst>
          <pc:docMk/>
          <pc:sldMk cId="3147858600" sldId="259"/>
        </pc:sldMkLst>
        <pc:spChg chg="mod">
          <ac:chgData name="Chaffey, Jessica" userId="dfaac082-a21f-4bd8-8583-e2115658a55f" providerId="ADAL" clId="{3821B51F-EF30-4C63-BE82-1707C230E536}" dt="2021-05-17T10:29:58.501" v="370" actId="20577"/>
          <ac:spMkLst>
            <pc:docMk/>
            <pc:sldMk cId="3147858600" sldId="259"/>
            <ac:spMk id="2" creationId="{80359C45-03E2-4476-A724-3DD986F5F5BB}"/>
          </ac:spMkLst>
        </pc:spChg>
        <pc:spChg chg="mod">
          <ac:chgData name="Chaffey, Jessica" userId="dfaac082-a21f-4bd8-8583-e2115658a55f" providerId="ADAL" clId="{3821B51F-EF30-4C63-BE82-1707C230E536}" dt="2021-05-17T10:10:45.829" v="125" actId="1076"/>
          <ac:spMkLst>
            <pc:docMk/>
            <pc:sldMk cId="3147858600" sldId="259"/>
            <ac:spMk id="21" creationId="{1D2B0153-28B3-4676-BF4E-29E8CB2B84CB}"/>
          </ac:spMkLst>
        </pc:spChg>
      </pc:sldChg>
      <pc:sldChg chg="modSp">
        <pc:chgData name="Chaffey, Jessica" userId="dfaac082-a21f-4bd8-8583-e2115658a55f" providerId="ADAL" clId="{3821B51F-EF30-4C63-BE82-1707C230E536}" dt="2021-05-17T10:30:01.054" v="371" actId="20577"/>
        <pc:sldMkLst>
          <pc:docMk/>
          <pc:sldMk cId="557411176" sldId="260"/>
        </pc:sldMkLst>
        <pc:spChg chg="mod">
          <ac:chgData name="Chaffey, Jessica" userId="dfaac082-a21f-4bd8-8583-e2115658a55f" providerId="ADAL" clId="{3821B51F-EF30-4C63-BE82-1707C230E536}" dt="2021-05-17T10:30:01.054" v="371" actId="20577"/>
          <ac:spMkLst>
            <pc:docMk/>
            <pc:sldMk cId="557411176" sldId="260"/>
            <ac:spMk id="28" creationId="{C5E76836-1554-4437-9C22-FBF283D1909A}"/>
          </ac:spMkLst>
        </pc:spChg>
      </pc:sldChg>
      <pc:sldChg chg="addSp modSp">
        <pc:chgData name="Chaffey, Jessica" userId="dfaac082-a21f-4bd8-8583-e2115658a55f" providerId="ADAL" clId="{3821B51F-EF30-4C63-BE82-1707C230E536}" dt="2021-05-17T10:30:06.252" v="372" actId="20577"/>
        <pc:sldMkLst>
          <pc:docMk/>
          <pc:sldMk cId="380026549" sldId="261"/>
        </pc:sldMkLst>
        <pc:spChg chg="mod">
          <ac:chgData name="Chaffey, Jessica" userId="dfaac082-a21f-4bd8-8583-e2115658a55f" providerId="ADAL" clId="{3821B51F-EF30-4C63-BE82-1707C230E536}" dt="2021-05-17T10:30:06.252" v="372" actId="20577"/>
          <ac:spMkLst>
            <pc:docMk/>
            <pc:sldMk cId="380026549" sldId="261"/>
            <ac:spMk id="3" creationId="{26B347BB-F65A-40E1-8D44-25B2A0FE4554}"/>
          </ac:spMkLst>
        </pc:spChg>
        <pc:spChg chg="add mod">
          <ac:chgData name="Chaffey, Jessica" userId="dfaac082-a21f-4bd8-8583-e2115658a55f" providerId="ADAL" clId="{3821B51F-EF30-4C63-BE82-1707C230E536}" dt="2021-05-17T10:12:32.880" v="145" actId="1076"/>
          <ac:spMkLst>
            <pc:docMk/>
            <pc:sldMk cId="380026549" sldId="261"/>
            <ac:spMk id="4" creationId="{C7174C41-84CE-4B8E-8FC1-803B73BB670D}"/>
          </ac:spMkLst>
        </pc:spChg>
        <pc:spChg chg="add mod">
          <ac:chgData name="Chaffey, Jessica" userId="dfaac082-a21f-4bd8-8583-e2115658a55f" providerId="ADAL" clId="{3821B51F-EF30-4C63-BE82-1707C230E536}" dt="2021-05-17T10:12:43.690" v="147" actId="1076"/>
          <ac:spMkLst>
            <pc:docMk/>
            <pc:sldMk cId="380026549" sldId="261"/>
            <ac:spMk id="7" creationId="{449B6169-7498-4C9B-96F8-326A60A75ED9}"/>
          </ac:spMkLst>
        </pc:spChg>
        <pc:picChg chg="mod">
          <ac:chgData name="Chaffey, Jessica" userId="dfaac082-a21f-4bd8-8583-e2115658a55f" providerId="ADAL" clId="{3821B51F-EF30-4C63-BE82-1707C230E536}" dt="2021-05-17T10:12:32.880" v="145" actId="1076"/>
          <ac:picMkLst>
            <pc:docMk/>
            <pc:sldMk cId="380026549" sldId="261"/>
            <ac:picMk id="5" creationId="{E10DD320-6C6A-4C31-BE2E-32B12C245C03}"/>
          </ac:picMkLst>
        </pc:picChg>
        <pc:picChg chg="add mod">
          <ac:chgData name="Chaffey, Jessica" userId="dfaac082-a21f-4bd8-8583-e2115658a55f" providerId="ADAL" clId="{3821B51F-EF30-4C63-BE82-1707C230E536}" dt="2021-05-17T10:12:43.690" v="147" actId="1076"/>
          <ac:picMkLst>
            <pc:docMk/>
            <pc:sldMk cId="380026549" sldId="261"/>
            <ac:picMk id="6" creationId="{F0CD575D-E64B-440A-B624-B16F0BF59340}"/>
          </ac:picMkLst>
        </pc:picChg>
      </pc:sldChg>
      <pc:sldChg chg="addSp delSp modSp del">
        <pc:chgData name="Chaffey, Jessica" userId="dfaac082-a21f-4bd8-8583-e2115658a55f" providerId="ADAL" clId="{3821B51F-EF30-4C63-BE82-1707C230E536}" dt="2021-05-17T10:12:51.519" v="150" actId="2696"/>
        <pc:sldMkLst>
          <pc:docMk/>
          <pc:sldMk cId="3009793800" sldId="262"/>
        </pc:sldMkLst>
        <pc:spChg chg="add del mod">
          <ac:chgData name="Chaffey, Jessica" userId="dfaac082-a21f-4bd8-8583-e2115658a55f" providerId="ADAL" clId="{3821B51F-EF30-4C63-BE82-1707C230E536}" dt="2021-05-17T10:12:49.409" v="149" actId="478"/>
          <ac:spMkLst>
            <pc:docMk/>
            <pc:sldMk cId="3009793800" sldId="262"/>
            <ac:spMk id="5" creationId="{0DB401F0-5E7C-4C41-917B-89CF7439DB53}"/>
          </ac:spMkLst>
        </pc:spChg>
        <pc:picChg chg="del">
          <ac:chgData name="Chaffey, Jessica" userId="dfaac082-a21f-4bd8-8583-e2115658a55f" providerId="ADAL" clId="{3821B51F-EF30-4C63-BE82-1707C230E536}" dt="2021-05-17T10:12:47.778" v="148" actId="478"/>
          <ac:picMkLst>
            <pc:docMk/>
            <pc:sldMk cId="3009793800" sldId="262"/>
            <ac:picMk id="4" creationId="{41EF509B-0EC5-42E1-A286-DCA51B676FA7}"/>
          </ac:picMkLst>
        </pc:picChg>
      </pc:sldChg>
      <pc:sldChg chg="addSp delSp modSp">
        <pc:chgData name="Chaffey, Jessica" userId="dfaac082-a21f-4bd8-8583-e2115658a55f" providerId="ADAL" clId="{3821B51F-EF30-4C63-BE82-1707C230E536}" dt="2021-05-17T10:30:10.132" v="373" actId="20577"/>
        <pc:sldMkLst>
          <pc:docMk/>
          <pc:sldMk cId="76243372" sldId="263"/>
        </pc:sldMkLst>
        <pc:spChg chg="mod">
          <ac:chgData name="Chaffey, Jessica" userId="dfaac082-a21f-4bd8-8583-e2115658a55f" providerId="ADAL" clId="{3821B51F-EF30-4C63-BE82-1707C230E536}" dt="2021-05-17T10:30:10.132" v="373" actId="20577"/>
          <ac:spMkLst>
            <pc:docMk/>
            <pc:sldMk cId="76243372" sldId="263"/>
            <ac:spMk id="3" creationId="{4922D3A7-6C01-4E29-A660-CD5C4322C673}"/>
          </ac:spMkLst>
        </pc:spChg>
        <pc:spChg chg="add del mod">
          <ac:chgData name="Chaffey, Jessica" userId="dfaac082-a21f-4bd8-8583-e2115658a55f" providerId="ADAL" clId="{3821B51F-EF30-4C63-BE82-1707C230E536}" dt="2021-05-17T10:12:00.157" v="140" actId="478"/>
          <ac:spMkLst>
            <pc:docMk/>
            <pc:sldMk cId="76243372" sldId="263"/>
            <ac:spMk id="5" creationId="{8978B847-E6A7-4635-9FC3-7CF17BC624FB}"/>
          </ac:spMkLst>
        </pc:spChg>
        <pc:spChg chg="add mod">
          <ac:chgData name="Chaffey, Jessica" userId="dfaac082-a21f-4bd8-8583-e2115658a55f" providerId="ADAL" clId="{3821B51F-EF30-4C63-BE82-1707C230E536}" dt="2021-05-17T10:12:59.822" v="151" actId="1076"/>
          <ac:spMkLst>
            <pc:docMk/>
            <pc:sldMk cId="76243372" sldId="263"/>
            <ac:spMk id="6" creationId="{157514D0-1F0F-47F8-B66D-14C8051BABBF}"/>
          </ac:spMkLst>
        </pc:spChg>
        <pc:spChg chg="add mod">
          <ac:chgData name="Chaffey, Jessica" userId="dfaac082-a21f-4bd8-8583-e2115658a55f" providerId="ADAL" clId="{3821B51F-EF30-4C63-BE82-1707C230E536}" dt="2021-05-17T10:13:03.662" v="153" actId="1076"/>
          <ac:spMkLst>
            <pc:docMk/>
            <pc:sldMk cId="76243372" sldId="263"/>
            <ac:spMk id="8" creationId="{8EECFCDF-B4C0-4E95-8DE5-7A9266B618CC}"/>
          </ac:spMkLst>
        </pc:spChg>
        <pc:picChg chg="mod">
          <ac:chgData name="Chaffey, Jessica" userId="dfaac082-a21f-4bd8-8583-e2115658a55f" providerId="ADAL" clId="{3821B51F-EF30-4C63-BE82-1707C230E536}" dt="2021-05-17T10:12:59.822" v="151" actId="1076"/>
          <ac:picMkLst>
            <pc:docMk/>
            <pc:sldMk cId="76243372" sldId="263"/>
            <ac:picMk id="4" creationId="{BB7FAC9B-8021-403C-8449-50CC4880F6EA}"/>
          </ac:picMkLst>
        </pc:picChg>
        <pc:picChg chg="add mod">
          <ac:chgData name="Chaffey, Jessica" userId="dfaac082-a21f-4bd8-8583-e2115658a55f" providerId="ADAL" clId="{3821B51F-EF30-4C63-BE82-1707C230E536}" dt="2021-05-17T10:13:03.662" v="153" actId="1076"/>
          <ac:picMkLst>
            <pc:docMk/>
            <pc:sldMk cId="76243372" sldId="263"/>
            <ac:picMk id="7" creationId="{22B06C6E-9A10-48D7-8320-6AFAA102D579}"/>
          </ac:picMkLst>
        </pc:picChg>
      </pc:sldChg>
      <pc:sldChg chg="addSp modSp del">
        <pc:chgData name="Chaffey, Jessica" userId="dfaac082-a21f-4bd8-8583-e2115658a55f" providerId="ADAL" clId="{3821B51F-EF30-4C63-BE82-1707C230E536}" dt="2021-05-17T10:13:06.216" v="154" actId="2696"/>
        <pc:sldMkLst>
          <pc:docMk/>
          <pc:sldMk cId="1781453486" sldId="264"/>
        </pc:sldMkLst>
        <pc:spChg chg="add mod">
          <ac:chgData name="Chaffey, Jessica" userId="dfaac082-a21f-4bd8-8583-e2115658a55f" providerId="ADAL" clId="{3821B51F-EF30-4C63-BE82-1707C230E536}" dt="2021-05-17T10:12:17.409" v="144" actId="14100"/>
          <ac:spMkLst>
            <pc:docMk/>
            <pc:sldMk cId="1781453486" sldId="264"/>
            <ac:spMk id="5" creationId="{BA43CA3F-3F34-4C45-9CE1-64BA873348AD}"/>
          </ac:spMkLst>
        </pc:spChg>
      </pc:sldChg>
      <pc:sldChg chg="addSp delSp modSp">
        <pc:chgData name="Chaffey, Jessica" userId="dfaac082-a21f-4bd8-8583-e2115658a55f" providerId="ADAL" clId="{3821B51F-EF30-4C63-BE82-1707C230E536}" dt="2021-05-17T10:28:15.231" v="362" actId="14100"/>
        <pc:sldMkLst>
          <pc:docMk/>
          <pc:sldMk cId="3052797791" sldId="265"/>
        </pc:sldMkLst>
        <pc:spChg chg="mod">
          <ac:chgData name="Chaffey, Jessica" userId="dfaac082-a21f-4bd8-8583-e2115658a55f" providerId="ADAL" clId="{3821B51F-EF30-4C63-BE82-1707C230E536}" dt="2021-05-17T10:23:34.157" v="254" actId="1076"/>
          <ac:spMkLst>
            <pc:docMk/>
            <pc:sldMk cId="3052797791" sldId="265"/>
            <ac:spMk id="5" creationId="{B7ACB047-A4BC-4D54-984A-2718C7DA9C13}"/>
          </ac:spMkLst>
        </pc:spChg>
        <pc:spChg chg="mod">
          <ac:chgData name="Chaffey, Jessica" userId="dfaac082-a21f-4bd8-8583-e2115658a55f" providerId="ADAL" clId="{3821B51F-EF30-4C63-BE82-1707C230E536}" dt="2021-05-17T10:23:35.677" v="255" actId="1076"/>
          <ac:spMkLst>
            <pc:docMk/>
            <pc:sldMk cId="3052797791" sldId="265"/>
            <ac:spMk id="6" creationId="{805C71D6-1E0C-475A-9259-507526B1BD0D}"/>
          </ac:spMkLst>
        </pc:spChg>
        <pc:spChg chg="mod">
          <ac:chgData name="Chaffey, Jessica" userId="dfaac082-a21f-4bd8-8583-e2115658a55f" providerId="ADAL" clId="{3821B51F-EF30-4C63-BE82-1707C230E536}" dt="2021-05-17T10:23:39.599" v="257" actId="1037"/>
          <ac:spMkLst>
            <pc:docMk/>
            <pc:sldMk cId="3052797791" sldId="265"/>
            <ac:spMk id="7" creationId="{E3BE7DA6-1839-4A9B-8A22-047A7FDB2616}"/>
          </ac:spMkLst>
        </pc:spChg>
        <pc:spChg chg="mod">
          <ac:chgData name="Chaffey, Jessica" userId="dfaac082-a21f-4bd8-8583-e2115658a55f" providerId="ADAL" clId="{3821B51F-EF30-4C63-BE82-1707C230E536}" dt="2021-05-17T10:23:41.291" v="260" actId="1037"/>
          <ac:spMkLst>
            <pc:docMk/>
            <pc:sldMk cId="3052797791" sldId="265"/>
            <ac:spMk id="8" creationId="{0D7755B9-BEE5-4EA7-A95F-28C95E70814B}"/>
          </ac:spMkLst>
        </pc:spChg>
        <pc:spChg chg="mod">
          <ac:chgData name="Chaffey, Jessica" userId="dfaac082-a21f-4bd8-8583-e2115658a55f" providerId="ADAL" clId="{3821B51F-EF30-4C63-BE82-1707C230E536}" dt="2021-05-17T10:23:46.552" v="265" actId="1037"/>
          <ac:spMkLst>
            <pc:docMk/>
            <pc:sldMk cId="3052797791" sldId="265"/>
            <ac:spMk id="9" creationId="{6F808192-A594-4225-B3F7-2278220FA4CF}"/>
          </ac:spMkLst>
        </pc:spChg>
        <pc:spChg chg="mod">
          <ac:chgData name="Chaffey, Jessica" userId="dfaac082-a21f-4bd8-8583-e2115658a55f" providerId="ADAL" clId="{3821B51F-EF30-4C63-BE82-1707C230E536}" dt="2021-05-17T10:23:48.632" v="267" actId="1037"/>
          <ac:spMkLst>
            <pc:docMk/>
            <pc:sldMk cId="3052797791" sldId="265"/>
            <ac:spMk id="10" creationId="{D6A6F22A-E5F4-492E-844D-837953560A1D}"/>
          </ac:spMkLst>
        </pc:spChg>
        <pc:spChg chg="mod">
          <ac:chgData name="Chaffey, Jessica" userId="dfaac082-a21f-4bd8-8583-e2115658a55f" providerId="ADAL" clId="{3821B51F-EF30-4C63-BE82-1707C230E536}" dt="2021-05-17T10:23:50.071" v="269" actId="1037"/>
          <ac:spMkLst>
            <pc:docMk/>
            <pc:sldMk cId="3052797791" sldId="265"/>
            <ac:spMk id="11" creationId="{06E830B1-8E49-418F-864E-AD3807C58010}"/>
          </ac:spMkLst>
        </pc:spChg>
        <pc:spChg chg="mod">
          <ac:chgData name="Chaffey, Jessica" userId="dfaac082-a21f-4bd8-8583-e2115658a55f" providerId="ADAL" clId="{3821B51F-EF30-4C63-BE82-1707C230E536}" dt="2021-05-17T10:23:22.744" v="252" actId="1076"/>
          <ac:spMkLst>
            <pc:docMk/>
            <pc:sldMk cId="3052797791" sldId="265"/>
            <ac:spMk id="12" creationId="{D3C0A5E4-8C15-40C3-AF77-5918DDADCF1F}"/>
          </ac:spMkLst>
        </pc:spChg>
        <pc:spChg chg="mod">
          <ac:chgData name="Chaffey, Jessica" userId="dfaac082-a21f-4bd8-8583-e2115658a55f" providerId="ADAL" clId="{3821B51F-EF30-4C63-BE82-1707C230E536}" dt="2021-05-17T10:23:22.744" v="252" actId="1076"/>
          <ac:spMkLst>
            <pc:docMk/>
            <pc:sldMk cId="3052797791" sldId="265"/>
            <ac:spMk id="13" creationId="{C1C3C590-99F2-4297-AD7C-D3C9875E3391}"/>
          </ac:spMkLst>
        </pc:spChg>
        <pc:spChg chg="mod">
          <ac:chgData name="Chaffey, Jessica" userId="dfaac082-a21f-4bd8-8583-e2115658a55f" providerId="ADAL" clId="{3821B51F-EF30-4C63-BE82-1707C230E536}" dt="2021-05-17T10:23:22.744" v="252" actId="1076"/>
          <ac:spMkLst>
            <pc:docMk/>
            <pc:sldMk cId="3052797791" sldId="265"/>
            <ac:spMk id="14" creationId="{BA7EF933-BF5F-4B05-9C55-D310F79FD0EE}"/>
          </ac:spMkLst>
        </pc:spChg>
        <pc:spChg chg="mod">
          <ac:chgData name="Chaffey, Jessica" userId="dfaac082-a21f-4bd8-8583-e2115658a55f" providerId="ADAL" clId="{3821B51F-EF30-4C63-BE82-1707C230E536}" dt="2021-05-17T10:28:15.231" v="362" actId="14100"/>
          <ac:spMkLst>
            <pc:docMk/>
            <pc:sldMk cId="3052797791" sldId="265"/>
            <ac:spMk id="15" creationId="{EFEDDA83-CC30-4A83-A92C-EB8A7C5A1C4E}"/>
          </ac:spMkLst>
        </pc:spChg>
        <pc:spChg chg="add mod">
          <ac:chgData name="Chaffey, Jessica" userId="dfaac082-a21f-4bd8-8583-e2115658a55f" providerId="ADAL" clId="{3821B51F-EF30-4C63-BE82-1707C230E536}" dt="2021-05-17T10:23:22.744" v="252" actId="1076"/>
          <ac:spMkLst>
            <pc:docMk/>
            <pc:sldMk cId="3052797791" sldId="265"/>
            <ac:spMk id="16" creationId="{9D0572F1-282D-4D18-8957-6F7B4C5D84AF}"/>
          </ac:spMkLst>
        </pc:spChg>
        <pc:spChg chg="add del mod">
          <ac:chgData name="Chaffey, Jessica" userId="dfaac082-a21f-4bd8-8583-e2115658a55f" providerId="ADAL" clId="{3821B51F-EF30-4C63-BE82-1707C230E536}" dt="2021-05-17T10:23:09.347" v="248" actId="478"/>
          <ac:spMkLst>
            <pc:docMk/>
            <pc:sldMk cId="3052797791" sldId="265"/>
            <ac:spMk id="18" creationId="{1A47C94E-99F8-44C0-B344-D91240E67185}"/>
          </ac:spMkLst>
        </pc:spChg>
        <pc:spChg chg="add del mod">
          <ac:chgData name="Chaffey, Jessica" userId="dfaac082-a21f-4bd8-8583-e2115658a55f" providerId="ADAL" clId="{3821B51F-EF30-4C63-BE82-1707C230E536}" dt="2021-05-17T10:23:09.347" v="248" actId="478"/>
          <ac:spMkLst>
            <pc:docMk/>
            <pc:sldMk cId="3052797791" sldId="265"/>
            <ac:spMk id="19" creationId="{D2AD48DB-C269-4E98-B4C1-584056198B46}"/>
          </ac:spMkLst>
        </pc:spChg>
        <pc:spChg chg="add del mod">
          <ac:chgData name="Chaffey, Jessica" userId="dfaac082-a21f-4bd8-8583-e2115658a55f" providerId="ADAL" clId="{3821B51F-EF30-4C63-BE82-1707C230E536}" dt="2021-05-17T10:23:09.347" v="248" actId="478"/>
          <ac:spMkLst>
            <pc:docMk/>
            <pc:sldMk cId="3052797791" sldId="265"/>
            <ac:spMk id="20" creationId="{11290E43-7DF5-46AD-9726-94DE322B605F}"/>
          </ac:spMkLst>
        </pc:spChg>
        <pc:spChg chg="add del mod">
          <ac:chgData name="Chaffey, Jessica" userId="dfaac082-a21f-4bd8-8583-e2115658a55f" providerId="ADAL" clId="{3821B51F-EF30-4C63-BE82-1707C230E536}" dt="2021-05-17T10:23:09.347" v="248" actId="478"/>
          <ac:spMkLst>
            <pc:docMk/>
            <pc:sldMk cId="3052797791" sldId="265"/>
            <ac:spMk id="21" creationId="{1D9BBEF3-F391-45E1-AE17-80C52A3A3BC8}"/>
          </ac:spMkLst>
        </pc:spChg>
        <pc:spChg chg="add del mod">
          <ac:chgData name="Chaffey, Jessica" userId="dfaac082-a21f-4bd8-8583-e2115658a55f" providerId="ADAL" clId="{3821B51F-EF30-4C63-BE82-1707C230E536}" dt="2021-05-17T10:23:09.347" v="248" actId="478"/>
          <ac:spMkLst>
            <pc:docMk/>
            <pc:sldMk cId="3052797791" sldId="265"/>
            <ac:spMk id="22" creationId="{A7C5C642-2FE6-4EC2-8864-12E587488678}"/>
          </ac:spMkLst>
        </pc:spChg>
        <pc:spChg chg="add del mod">
          <ac:chgData name="Chaffey, Jessica" userId="dfaac082-a21f-4bd8-8583-e2115658a55f" providerId="ADAL" clId="{3821B51F-EF30-4C63-BE82-1707C230E536}" dt="2021-05-17T10:23:09.347" v="248" actId="478"/>
          <ac:spMkLst>
            <pc:docMk/>
            <pc:sldMk cId="3052797791" sldId="265"/>
            <ac:spMk id="23" creationId="{45A1DA0F-1F14-46A2-929A-4C45EFB30FF9}"/>
          </ac:spMkLst>
        </pc:spChg>
        <pc:spChg chg="add del mod">
          <ac:chgData name="Chaffey, Jessica" userId="dfaac082-a21f-4bd8-8583-e2115658a55f" providerId="ADAL" clId="{3821B51F-EF30-4C63-BE82-1707C230E536}" dt="2021-05-17T10:23:09.347" v="248" actId="478"/>
          <ac:spMkLst>
            <pc:docMk/>
            <pc:sldMk cId="3052797791" sldId="265"/>
            <ac:spMk id="24" creationId="{EABBDD60-695C-4483-883D-4EB85C17D0C6}"/>
          </ac:spMkLst>
        </pc:spChg>
        <pc:spChg chg="add del mod">
          <ac:chgData name="Chaffey, Jessica" userId="dfaac082-a21f-4bd8-8583-e2115658a55f" providerId="ADAL" clId="{3821B51F-EF30-4C63-BE82-1707C230E536}" dt="2021-05-17T10:23:14.425" v="251" actId="478"/>
          <ac:spMkLst>
            <pc:docMk/>
            <pc:sldMk cId="3052797791" sldId="265"/>
            <ac:spMk id="25" creationId="{45602860-DCDD-4DB9-B5DC-34E4D4692107}"/>
          </ac:spMkLst>
        </pc:spChg>
        <pc:spChg chg="add del mod">
          <ac:chgData name="Chaffey, Jessica" userId="dfaac082-a21f-4bd8-8583-e2115658a55f" providerId="ADAL" clId="{3821B51F-EF30-4C63-BE82-1707C230E536}" dt="2021-05-17T10:23:14.425" v="251" actId="478"/>
          <ac:spMkLst>
            <pc:docMk/>
            <pc:sldMk cId="3052797791" sldId="265"/>
            <ac:spMk id="26" creationId="{90DAA7DE-AA7E-4256-A645-091E43611B81}"/>
          </ac:spMkLst>
        </pc:spChg>
        <pc:spChg chg="add del mod">
          <ac:chgData name="Chaffey, Jessica" userId="dfaac082-a21f-4bd8-8583-e2115658a55f" providerId="ADAL" clId="{3821B51F-EF30-4C63-BE82-1707C230E536}" dt="2021-05-17T10:23:12.833" v="250" actId="478"/>
          <ac:spMkLst>
            <pc:docMk/>
            <pc:sldMk cId="3052797791" sldId="265"/>
            <ac:spMk id="27" creationId="{AF430D66-0697-44A8-AED3-2AFB92E0C4F8}"/>
          </ac:spMkLst>
        </pc:spChg>
        <pc:spChg chg="add del mod">
          <ac:chgData name="Chaffey, Jessica" userId="dfaac082-a21f-4bd8-8583-e2115658a55f" providerId="ADAL" clId="{3821B51F-EF30-4C63-BE82-1707C230E536}" dt="2021-05-17T10:23:09.347" v="248" actId="478"/>
          <ac:spMkLst>
            <pc:docMk/>
            <pc:sldMk cId="3052797791" sldId="265"/>
            <ac:spMk id="28" creationId="{BB7424FC-26C8-4CC3-ADC1-E9C980008989}"/>
          </ac:spMkLst>
        </pc:spChg>
        <pc:picChg chg="mod">
          <ac:chgData name="Chaffey, Jessica" userId="dfaac082-a21f-4bd8-8583-e2115658a55f" providerId="ADAL" clId="{3821B51F-EF30-4C63-BE82-1707C230E536}" dt="2021-05-17T10:23:22.744" v="252" actId="1076"/>
          <ac:picMkLst>
            <pc:docMk/>
            <pc:sldMk cId="3052797791" sldId="265"/>
            <ac:picMk id="4" creationId="{B6BA2107-0AC7-4581-93F9-DB78224EBA51}"/>
          </ac:picMkLst>
        </pc:picChg>
        <pc:picChg chg="add del mod">
          <ac:chgData name="Chaffey, Jessica" userId="dfaac082-a21f-4bd8-8583-e2115658a55f" providerId="ADAL" clId="{3821B51F-EF30-4C63-BE82-1707C230E536}" dt="2021-05-17T10:23:09.347" v="248" actId="478"/>
          <ac:picMkLst>
            <pc:docMk/>
            <pc:sldMk cId="3052797791" sldId="265"/>
            <ac:picMk id="17" creationId="{3987FFDB-29BB-40E6-9AFE-0AE2BEE03F55}"/>
          </ac:picMkLst>
        </pc:picChg>
      </pc:sldChg>
      <pc:sldChg chg="addSp delSp modSp">
        <pc:chgData name="Chaffey, Jessica" userId="dfaac082-a21f-4bd8-8583-e2115658a55f" providerId="ADAL" clId="{3821B51F-EF30-4C63-BE82-1707C230E536}" dt="2021-05-17T10:27:39.967" v="321" actId="20577"/>
        <pc:sldMkLst>
          <pc:docMk/>
          <pc:sldMk cId="2282323561" sldId="267"/>
        </pc:sldMkLst>
        <pc:spChg chg="mod">
          <ac:chgData name="Chaffey, Jessica" userId="dfaac082-a21f-4bd8-8583-e2115658a55f" providerId="ADAL" clId="{3821B51F-EF30-4C63-BE82-1707C230E536}" dt="2021-05-17T10:27:39.967" v="321" actId="20577"/>
          <ac:spMkLst>
            <pc:docMk/>
            <pc:sldMk cId="2282323561" sldId="267"/>
            <ac:spMk id="4" creationId="{00000000-0000-0000-0000-000000000000}"/>
          </ac:spMkLst>
        </pc:spChg>
        <pc:spChg chg="mod">
          <ac:chgData name="Chaffey, Jessica" userId="dfaac082-a21f-4bd8-8583-e2115658a55f" providerId="ADAL" clId="{3821B51F-EF30-4C63-BE82-1707C230E536}" dt="2021-05-17T10:27:18.037" v="290" actId="14100"/>
          <ac:spMkLst>
            <pc:docMk/>
            <pc:sldMk cId="2282323561" sldId="267"/>
            <ac:spMk id="5" creationId="{975F7F80-18FD-4E74-A827-6ED5DB4615B2}"/>
          </ac:spMkLst>
        </pc:spChg>
        <pc:spChg chg="add mod">
          <ac:chgData name="Chaffey, Jessica" userId="dfaac082-a21f-4bd8-8583-e2115658a55f" providerId="ADAL" clId="{3821B51F-EF30-4C63-BE82-1707C230E536}" dt="2021-05-17T10:19:11.727" v="173" actId="1076"/>
          <ac:spMkLst>
            <pc:docMk/>
            <pc:sldMk cId="2282323561" sldId="267"/>
            <ac:spMk id="6" creationId="{2C00DF54-A0EE-49DF-8D5F-043425D2F462}"/>
          </ac:spMkLst>
        </pc:spChg>
        <pc:spChg chg="add mod">
          <ac:chgData name="Chaffey, Jessica" userId="dfaac082-a21f-4bd8-8583-e2115658a55f" providerId="ADAL" clId="{3821B51F-EF30-4C63-BE82-1707C230E536}" dt="2021-05-17T10:19:11.727" v="173" actId="1076"/>
          <ac:spMkLst>
            <pc:docMk/>
            <pc:sldMk cId="2282323561" sldId="267"/>
            <ac:spMk id="11" creationId="{FAA75E1E-8E60-4B58-9C6C-F59CFEB8092F}"/>
          </ac:spMkLst>
        </pc:spChg>
        <pc:spChg chg="add mod">
          <ac:chgData name="Chaffey, Jessica" userId="dfaac082-a21f-4bd8-8583-e2115658a55f" providerId="ADAL" clId="{3821B51F-EF30-4C63-BE82-1707C230E536}" dt="2021-05-17T10:19:11.727" v="173" actId="1076"/>
          <ac:spMkLst>
            <pc:docMk/>
            <pc:sldMk cId="2282323561" sldId="267"/>
            <ac:spMk id="12" creationId="{C652FF0E-5C37-4E61-9DFA-4678A9CBE36B}"/>
          </ac:spMkLst>
        </pc:spChg>
        <pc:spChg chg="add mod">
          <ac:chgData name="Chaffey, Jessica" userId="dfaac082-a21f-4bd8-8583-e2115658a55f" providerId="ADAL" clId="{3821B51F-EF30-4C63-BE82-1707C230E536}" dt="2021-05-17T10:19:11.727" v="173" actId="1076"/>
          <ac:spMkLst>
            <pc:docMk/>
            <pc:sldMk cId="2282323561" sldId="267"/>
            <ac:spMk id="13" creationId="{E9F46D42-4628-42A8-8BD4-B9988262DCA9}"/>
          </ac:spMkLst>
        </pc:spChg>
        <pc:spChg chg="add mod">
          <ac:chgData name="Chaffey, Jessica" userId="dfaac082-a21f-4bd8-8583-e2115658a55f" providerId="ADAL" clId="{3821B51F-EF30-4C63-BE82-1707C230E536}" dt="2021-05-17T10:19:11.727" v="173" actId="1076"/>
          <ac:spMkLst>
            <pc:docMk/>
            <pc:sldMk cId="2282323561" sldId="267"/>
            <ac:spMk id="14" creationId="{1F2C9789-2E57-44C2-BAEB-A49BD6DC2A4A}"/>
          </ac:spMkLst>
        </pc:spChg>
        <pc:spChg chg="add del mod">
          <ac:chgData name="Chaffey, Jessica" userId="dfaac082-a21f-4bd8-8583-e2115658a55f" providerId="ADAL" clId="{3821B51F-EF30-4C63-BE82-1707C230E536}" dt="2021-05-17T10:14:01.261" v="157" actId="478"/>
          <ac:spMkLst>
            <pc:docMk/>
            <pc:sldMk cId="2282323561" sldId="267"/>
            <ac:spMk id="15" creationId="{3FAB3345-7F15-4043-88E9-98709A315982}"/>
          </ac:spMkLst>
        </pc:spChg>
        <pc:spChg chg="add del mod">
          <ac:chgData name="Chaffey, Jessica" userId="dfaac082-a21f-4bd8-8583-e2115658a55f" providerId="ADAL" clId="{3821B51F-EF30-4C63-BE82-1707C230E536}" dt="2021-05-17T10:14:02.628" v="158" actId="478"/>
          <ac:spMkLst>
            <pc:docMk/>
            <pc:sldMk cId="2282323561" sldId="267"/>
            <ac:spMk id="16" creationId="{62B147DE-51F2-49D1-8924-2D6B33B76231}"/>
          </ac:spMkLst>
        </pc:spChg>
        <pc:spChg chg="add del mod">
          <ac:chgData name="Chaffey, Jessica" userId="dfaac082-a21f-4bd8-8583-e2115658a55f" providerId="ADAL" clId="{3821B51F-EF30-4C63-BE82-1707C230E536}" dt="2021-05-17T10:14:40.662" v="160" actId="478"/>
          <ac:spMkLst>
            <pc:docMk/>
            <pc:sldMk cId="2282323561" sldId="267"/>
            <ac:spMk id="17" creationId="{5B8D0001-8710-4AAB-9D6E-625E7980CC5B}"/>
          </ac:spMkLst>
        </pc:spChg>
        <pc:spChg chg="add mod">
          <ac:chgData name="Chaffey, Jessica" userId="dfaac082-a21f-4bd8-8583-e2115658a55f" providerId="ADAL" clId="{3821B51F-EF30-4C63-BE82-1707C230E536}" dt="2021-05-17T10:19:11.727" v="173" actId="1076"/>
          <ac:spMkLst>
            <pc:docMk/>
            <pc:sldMk cId="2282323561" sldId="267"/>
            <ac:spMk id="18" creationId="{777D00D8-5E75-4614-BC67-3838BA5DCFE0}"/>
          </ac:spMkLst>
        </pc:spChg>
        <pc:spChg chg="add mod">
          <ac:chgData name="Chaffey, Jessica" userId="dfaac082-a21f-4bd8-8583-e2115658a55f" providerId="ADAL" clId="{3821B51F-EF30-4C63-BE82-1707C230E536}" dt="2021-05-17T10:19:11.727" v="173" actId="1076"/>
          <ac:spMkLst>
            <pc:docMk/>
            <pc:sldMk cId="2282323561" sldId="267"/>
            <ac:spMk id="19" creationId="{7AA119D1-6876-482B-B098-A4F4659E5C03}"/>
          </ac:spMkLst>
        </pc:spChg>
        <pc:picChg chg="mod">
          <ac:chgData name="Chaffey, Jessica" userId="dfaac082-a21f-4bd8-8583-e2115658a55f" providerId="ADAL" clId="{3821B51F-EF30-4C63-BE82-1707C230E536}" dt="2021-05-17T10:19:11.727" v="173" actId="1076"/>
          <ac:picMkLst>
            <pc:docMk/>
            <pc:sldMk cId="2282323561" sldId="267"/>
            <ac:picMk id="2" creationId="{00000000-0000-0000-0000-000000000000}"/>
          </ac:picMkLst>
        </pc:picChg>
        <pc:picChg chg="mod">
          <ac:chgData name="Chaffey, Jessica" userId="dfaac082-a21f-4bd8-8583-e2115658a55f" providerId="ADAL" clId="{3821B51F-EF30-4C63-BE82-1707C230E536}" dt="2021-05-17T10:19:11.727" v="173" actId="1076"/>
          <ac:picMkLst>
            <pc:docMk/>
            <pc:sldMk cId="2282323561" sldId="267"/>
            <ac:picMk id="3" creationId="{00000000-0000-0000-0000-000000000000}"/>
          </ac:picMkLst>
        </pc:picChg>
        <pc:picChg chg="mod">
          <ac:chgData name="Chaffey, Jessica" userId="dfaac082-a21f-4bd8-8583-e2115658a55f" providerId="ADAL" clId="{3821B51F-EF30-4C63-BE82-1707C230E536}" dt="2021-05-17T10:19:11.727" v="173" actId="1076"/>
          <ac:picMkLst>
            <pc:docMk/>
            <pc:sldMk cId="2282323561" sldId="267"/>
            <ac:picMk id="1026" creationId="{00000000-0000-0000-0000-000000000000}"/>
          </ac:picMkLst>
        </pc:picChg>
        <pc:picChg chg="mod">
          <ac:chgData name="Chaffey, Jessica" userId="dfaac082-a21f-4bd8-8583-e2115658a55f" providerId="ADAL" clId="{3821B51F-EF30-4C63-BE82-1707C230E536}" dt="2021-05-17T10:19:11.727" v="173" actId="1076"/>
          <ac:picMkLst>
            <pc:docMk/>
            <pc:sldMk cId="2282323561" sldId="267"/>
            <ac:picMk id="1027" creationId="{00000000-0000-0000-0000-000000000000}"/>
          </ac:picMkLst>
        </pc:picChg>
        <pc:picChg chg="mod">
          <ac:chgData name="Chaffey, Jessica" userId="dfaac082-a21f-4bd8-8583-e2115658a55f" providerId="ADAL" clId="{3821B51F-EF30-4C63-BE82-1707C230E536}" dt="2021-05-17T10:19:11.727" v="173" actId="1076"/>
          <ac:picMkLst>
            <pc:docMk/>
            <pc:sldMk cId="2282323561" sldId="267"/>
            <ac:picMk id="1029" creationId="{00000000-0000-0000-0000-000000000000}"/>
          </ac:picMkLst>
        </pc:picChg>
        <pc:picChg chg="mod">
          <ac:chgData name="Chaffey, Jessica" userId="dfaac082-a21f-4bd8-8583-e2115658a55f" providerId="ADAL" clId="{3821B51F-EF30-4C63-BE82-1707C230E536}" dt="2021-05-17T10:19:11.727" v="173" actId="1076"/>
          <ac:picMkLst>
            <pc:docMk/>
            <pc:sldMk cId="2282323561" sldId="267"/>
            <ac:picMk id="1030" creationId="{00000000-0000-0000-0000-000000000000}"/>
          </ac:picMkLst>
        </pc:picChg>
      </pc:sldChg>
      <pc:sldChg chg="addSp modSp">
        <pc:chgData name="Chaffey, Jessica" userId="dfaac082-a21f-4bd8-8583-e2115658a55f" providerId="ADAL" clId="{3821B51F-EF30-4C63-BE82-1707C230E536}" dt="2021-05-17T10:27:32.562" v="314" actId="1036"/>
        <pc:sldMkLst>
          <pc:docMk/>
          <pc:sldMk cId="171246689" sldId="268"/>
        </pc:sldMkLst>
        <pc:spChg chg="mod">
          <ac:chgData name="Chaffey, Jessica" userId="dfaac082-a21f-4bd8-8583-e2115658a55f" providerId="ADAL" clId="{3821B51F-EF30-4C63-BE82-1707C230E536}" dt="2021-05-17T10:27:32.562" v="314" actId="1036"/>
          <ac:spMkLst>
            <pc:docMk/>
            <pc:sldMk cId="171246689" sldId="268"/>
            <ac:spMk id="4" creationId="{00000000-0000-0000-0000-000000000000}"/>
          </ac:spMkLst>
        </pc:spChg>
        <pc:spChg chg="mod">
          <ac:chgData name="Chaffey, Jessica" userId="dfaac082-a21f-4bd8-8583-e2115658a55f" providerId="ADAL" clId="{3821B51F-EF30-4C63-BE82-1707C230E536}" dt="2021-05-17T10:27:25.063" v="292" actId="14100"/>
          <ac:spMkLst>
            <pc:docMk/>
            <pc:sldMk cId="171246689" sldId="268"/>
            <ac:spMk id="9" creationId="{7CC24D83-2869-4A0F-B805-7800429C219C}"/>
          </ac:spMkLst>
        </pc:spChg>
        <pc:spChg chg="add mod">
          <ac:chgData name="Chaffey, Jessica" userId="dfaac082-a21f-4bd8-8583-e2115658a55f" providerId="ADAL" clId="{3821B51F-EF30-4C63-BE82-1707C230E536}" dt="2021-05-17T10:27:32.562" v="314" actId="1036"/>
          <ac:spMkLst>
            <pc:docMk/>
            <pc:sldMk cId="171246689" sldId="268"/>
            <ac:spMk id="10" creationId="{7DB753AB-F135-433D-8923-726E24822BD0}"/>
          </ac:spMkLst>
        </pc:spChg>
        <pc:spChg chg="add mod">
          <ac:chgData name="Chaffey, Jessica" userId="dfaac082-a21f-4bd8-8583-e2115658a55f" providerId="ADAL" clId="{3821B51F-EF30-4C63-BE82-1707C230E536}" dt="2021-05-17T10:27:32.562" v="314" actId="1036"/>
          <ac:spMkLst>
            <pc:docMk/>
            <pc:sldMk cId="171246689" sldId="268"/>
            <ac:spMk id="11" creationId="{0453B38A-F356-4FF8-892D-B9339D5E27BD}"/>
          </ac:spMkLst>
        </pc:spChg>
        <pc:spChg chg="add mod">
          <ac:chgData name="Chaffey, Jessica" userId="dfaac082-a21f-4bd8-8583-e2115658a55f" providerId="ADAL" clId="{3821B51F-EF30-4C63-BE82-1707C230E536}" dt="2021-05-17T10:27:32.562" v="314" actId="1036"/>
          <ac:spMkLst>
            <pc:docMk/>
            <pc:sldMk cId="171246689" sldId="268"/>
            <ac:spMk id="12" creationId="{C4C65B61-382F-465F-B735-47110CE5BD73}"/>
          </ac:spMkLst>
        </pc:spChg>
        <pc:spChg chg="add mod">
          <ac:chgData name="Chaffey, Jessica" userId="dfaac082-a21f-4bd8-8583-e2115658a55f" providerId="ADAL" clId="{3821B51F-EF30-4C63-BE82-1707C230E536}" dt="2021-05-17T10:27:32.562" v="314" actId="1036"/>
          <ac:spMkLst>
            <pc:docMk/>
            <pc:sldMk cId="171246689" sldId="268"/>
            <ac:spMk id="13" creationId="{6443383D-C4E3-4D26-BB09-6EB78C16A549}"/>
          </ac:spMkLst>
        </pc:spChg>
        <pc:spChg chg="add mod">
          <ac:chgData name="Chaffey, Jessica" userId="dfaac082-a21f-4bd8-8583-e2115658a55f" providerId="ADAL" clId="{3821B51F-EF30-4C63-BE82-1707C230E536}" dt="2021-05-17T10:27:32.562" v="314" actId="1036"/>
          <ac:spMkLst>
            <pc:docMk/>
            <pc:sldMk cId="171246689" sldId="268"/>
            <ac:spMk id="14" creationId="{12AAC83A-783E-4BF9-A8EE-E42D24262739}"/>
          </ac:spMkLst>
        </pc:spChg>
        <pc:spChg chg="add mod">
          <ac:chgData name="Chaffey, Jessica" userId="dfaac082-a21f-4bd8-8583-e2115658a55f" providerId="ADAL" clId="{3821B51F-EF30-4C63-BE82-1707C230E536}" dt="2021-05-17T10:27:32.562" v="314" actId="1036"/>
          <ac:spMkLst>
            <pc:docMk/>
            <pc:sldMk cId="171246689" sldId="268"/>
            <ac:spMk id="15" creationId="{12FB68A2-0F05-49DE-A3C6-80B23F3CDEC7}"/>
          </ac:spMkLst>
        </pc:spChg>
        <pc:picChg chg="mod">
          <ac:chgData name="Chaffey, Jessica" userId="dfaac082-a21f-4bd8-8583-e2115658a55f" providerId="ADAL" clId="{3821B51F-EF30-4C63-BE82-1707C230E536}" dt="2021-05-17T10:27:32.562" v="314" actId="1036"/>
          <ac:picMkLst>
            <pc:docMk/>
            <pc:sldMk cId="171246689" sldId="268"/>
            <ac:picMk id="2050" creationId="{00000000-0000-0000-0000-000000000000}"/>
          </ac:picMkLst>
        </pc:picChg>
        <pc:picChg chg="mod">
          <ac:chgData name="Chaffey, Jessica" userId="dfaac082-a21f-4bd8-8583-e2115658a55f" providerId="ADAL" clId="{3821B51F-EF30-4C63-BE82-1707C230E536}" dt="2021-05-17T10:27:32.562" v="314" actId="1036"/>
          <ac:picMkLst>
            <pc:docMk/>
            <pc:sldMk cId="171246689" sldId="268"/>
            <ac:picMk id="2051" creationId="{00000000-0000-0000-0000-000000000000}"/>
          </ac:picMkLst>
        </pc:picChg>
        <pc:picChg chg="mod">
          <ac:chgData name="Chaffey, Jessica" userId="dfaac082-a21f-4bd8-8583-e2115658a55f" providerId="ADAL" clId="{3821B51F-EF30-4C63-BE82-1707C230E536}" dt="2021-05-17T10:27:32.562" v="314" actId="1036"/>
          <ac:picMkLst>
            <pc:docMk/>
            <pc:sldMk cId="171246689" sldId="268"/>
            <ac:picMk id="2052" creationId="{00000000-0000-0000-0000-000000000000}"/>
          </ac:picMkLst>
        </pc:picChg>
        <pc:picChg chg="mod">
          <ac:chgData name="Chaffey, Jessica" userId="dfaac082-a21f-4bd8-8583-e2115658a55f" providerId="ADAL" clId="{3821B51F-EF30-4C63-BE82-1707C230E536}" dt="2021-05-17T10:27:32.562" v="314" actId="1036"/>
          <ac:picMkLst>
            <pc:docMk/>
            <pc:sldMk cId="171246689" sldId="268"/>
            <ac:picMk id="2053" creationId="{00000000-0000-0000-0000-000000000000}"/>
          </ac:picMkLst>
        </pc:picChg>
        <pc:picChg chg="mod">
          <ac:chgData name="Chaffey, Jessica" userId="dfaac082-a21f-4bd8-8583-e2115658a55f" providerId="ADAL" clId="{3821B51F-EF30-4C63-BE82-1707C230E536}" dt="2021-05-17T10:27:32.562" v="314" actId="1036"/>
          <ac:picMkLst>
            <pc:docMk/>
            <pc:sldMk cId="171246689" sldId="268"/>
            <ac:picMk id="2054" creationId="{00000000-0000-0000-0000-000000000000}"/>
          </ac:picMkLst>
        </pc:picChg>
        <pc:picChg chg="mod">
          <ac:chgData name="Chaffey, Jessica" userId="dfaac082-a21f-4bd8-8583-e2115658a55f" providerId="ADAL" clId="{3821B51F-EF30-4C63-BE82-1707C230E536}" dt="2021-05-17T10:27:32.562" v="314" actId="1036"/>
          <ac:picMkLst>
            <pc:docMk/>
            <pc:sldMk cId="171246689" sldId="268"/>
            <ac:picMk id="2055" creationId="{00000000-0000-0000-0000-000000000000}"/>
          </ac:picMkLst>
        </pc:picChg>
      </pc:sldChg>
      <pc:sldChg chg="addSp modSp">
        <pc:chgData name="Chaffey, Jessica" userId="dfaac082-a21f-4bd8-8583-e2115658a55f" providerId="ADAL" clId="{3821B51F-EF30-4C63-BE82-1707C230E536}" dt="2021-05-17T10:28:00.466" v="342" actId="1036"/>
        <pc:sldMkLst>
          <pc:docMk/>
          <pc:sldMk cId="490872864" sldId="269"/>
        </pc:sldMkLst>
        <pc:spChg chg="mod">
          <ac:chgData name="Chaffey, Jessica" userId="dfaac082-a21f-4bd8-8583-e2115658a55f" providerId="ADAL" clId="{3821B51F-EF30-4C63-BE82-1707C230E536}" dt="2021-05-17T10:28:00.466" v="342" actId="1036"/>
          <ac:spMkLst>
            <pc:docMk/>
            <pc:sldMk cId="490872864" sldId="269"/>
            <ac:spMk id="4" creationId="{00000000-0000-0000-0000-000000000000}"/>
          </ac:spMkLst>
        </pc:spChg>
        <pc:spChg chg="mod">
          <ac:chgData name="Chaffey, Jessica" userId="dfaac082-a21f-4bd8-8583-e2115658a55f" providerId="ADAL" clId="{3821B51F-EF30-4C63-BE82-1707C230E536}" dt="2021-05-17T10:27:52.884" v="325" actId="14100"/>
          <ac:spMkLst>
            <pc:docMk/>
            <pc:sldMk cId="490872864" sldId="269"/>
            <ac:spMk id="8" creationId="{5BF8C513-761B-4EE0-AF7D-1ACC7C293818}"/>
          </ac:spMkLst>
        </pc:spChg>
        <pc:spChg chg="add mod">
          <ac:chgData name="Chaffey, Jessica" userId="dfaac082-a21f-4bd8-8583-e2115658a55f" providerId="ADAL" clId="{3821B51F-EF30-4C63-BE82-1707C230E536}" dt="2021-05-17T10:28:00.466" v="342" actId="1036"/>
          <ac:spMkLst>
            <pc:docMk/>
            <pc:sldMk cId="490872864" sldId="269"/>
            <ac:spMk id="9" creationId="{4CE2E6D0-9CD4-4B6F-8BC7-AAEA95DC297E}"/>
          </ac:spMkLst>
        </pc:spChg>
        <pc:spChg chg="add mod">
          <ac:chgData name="Chaffey, Jessica" userId="dfaac082-a21f-4bd8-8583-e2115658a55f" providerId="ADAL" clId="{3821B51F-EF30-4C63-BE82-1707C230E536}" dt="2021-05-17T10:28:00.466" v="342" actId="1036"/>
          <ac:spMkLst>
            <pc:docMk/>
            <pc:sldMk cId="490872864" sldId="269"/>
            <ac:spMk id="10" creationId="{CF8FFB76-62F0-4244-9480-75D838BA5885}"/>
          </ac:spMkLst>
        </pc:spChg>
        <pc:spChg chg="add mod">
          <ac:chgData name="Chaffey, Jessica" userId="dfaac082-a21f-4bd8-8583-e2115658a55f" providerId="ADAL" clId="{3821B51F-EF30-4C63-BE82-1707C230E536}" dt="2021-05-17T10:28:00.466" v="342" actId="1036"/>
          <ac:spMkLst>
            <pc:docMk/>
            <pc:sldMk cId="490872864" sldId="269"/>
            <ac:spMk id="11" creationId="{F01569BC-E2A0-4E54-8FAB-C4FB54E570C0}"/>
          </ac:spMkLst>
        </pc:spChg>
        <pc:spChg chg="add mod">
          <ac:chgData name="Chaffey, Jessica" userId="dfaac082-a21f-4bd8-8583-e2115658a55f" providerId="ADAL" clId="{3821B51F-EF30-4C63-BE82-1707C230E536}" dt="2021-05-17T10:28:00.466" v="342" actId="1036"/>
          <ac:spMkLst>
            <pc:docMk/>
            <pc:sldMk cId="490872864" sldId="269"/>
            <ac:spMk id="12" creationId="{B383F875-D981-4155-83B9-0E38A852BEA1}"/>
          </ac:spMkLst>
        </pc:spChg>
        <pc:spChg chg="add mod">
          <ac:chgData name="Chaffey, Jessica" userId="dfaac082-a21f-4bd8-8583-e2115658a55f" providerId="ADAL" clId="{3821B51F-EF30-4C63-BE82-1707C230E536}" dt="2021-05-17T10:28:00.466" v="342" actId="1036"/>
          <ac:spMkLst>
            <pc:docMk/>
            <pc:sldMk cId="490872864" sldId="269"/>
            <ac:spMk id="13" creationId="{160A8E74-9677-457F-8C41-873C5AD6CA4E}"/>
          </ac:spMkLst>
        </pc:spChg>
        <pc:picChg chg="mod">
          <ac:chgData name="Chaffey, Jessica" userId="dfaac082-a21f-4bd8-8583-e2115658a55f" providerId="ADAL" clId="{3821B51F-EF30-4C63-BE82-1707C230E536}" dt="2021-05-17T10:28:00.466" v="342" actId="1036"/>
          <ac:picMkLst>
            <pc:docMk/>
            <pc:sldMk cId="490872864" sldId="269"/>
            <ac:picMk id="2" creationId="{00000000-0000-0000-0000-000000000000}"/>
          </ac:picMkLst>
        </pc:picChg>
        <pc:picChg chg="mod">
          <ac:chgData name="Chaffey, Jessica" userId="dfaac082-a21f-4bd8-8583-e2115658a55f" providerId="ADAL" clId="{3821B51F-EF30-4C63-BE82-1707C230E536}" dt="2021-05-17T10:28:00.466" v="342" actId="1036"/>
          <ac:picMkLst>
            <pc:docMk/>
            <pc:sldMk cId="490872864" sldId="269"/>
            <ac:picMk id="3" creationId="{00000000-0000-0000-0000-000000000000}"/>
          </ac:picMkLst>
        </pc:picChg>
        <pc:picChg chg="mod">
          <ac:chgData name="Chaffey, Jessica" userId="dfaac082-a21f-4bd8-8583-e2115658a55f" providerId="ADAL" clId="{3821B51F-EF30-4C63-BE82-1707C230E536}" dt="2021-05-17T10:28:00.466" v="342" actId="1036"/>
          <ac:picMkLst>
            <pc:docMk/>
            <pc:sldMk cId="490872864" sldId="269"/>
            <ac:picMk id="5" creationId="{00000000-0000-0000-0000-000000000000}"/>
          </ac:picMkLst>
        </pc:picChg>
        <pc:picChg chg="mod">
          <ac:chgData name="Chaffey, Jessica" userId="dfaac082-a21f-4bd8-8583-e2115658a55f" providerId="ADAL" clId="{3821B51F-EF30-4C63-BE82-1707C230E536}" dt="2021-05-17T10:28:00.466" v="342" actId="1036"/>
          <ac:picMkLst>
            <pc:docMk/>
            <pc:sldMk cId="490872864" sldId="269"/>
            <ac:picMk id="1026" creationId="{00000000-0000-0000-0000-000000000000}"/>
          </ac:picMkLst>
        </pc:picChg>
        <pc:picChg chg="mod">
          <ac:chgData name="Chaffey, Jessica" userId="dfaac082-a21f-4bd8-8583-e2115658a55f" providerId="ADAL" clId="{3821B51F-EF30-4C63-BE82-1707C230E536}" dt="2021-05-17T10:28:00.466" v="342" actId="1036"/>
          <ac:picMkLst>
            <pc:docMk/>
            <pc:sldMk cId="490872864" sldId="269"/>
            <ac:picMk id="1027" creationId="{00000000-0000-0000-0000-000000000000}"/>
          </ac:picMkLst>
        </pc:picChg>
      </pc:sldChg>
      <pc:sldChg chg="addSp delSp modSp">
        <pc:chgData name="Chaffey, Jessica" userId="dfaac082-a21f-4bd8-8583-e2115658a55f" providerId="ADAL" clId="{3821B51F-EF30-4C63-BE82-1707C230E536}" dt="2021-05-17T10:28:06.160" v="360" actId="1036"/>
        <pc:sldMkLst>
          <pc:docMk/>
          <pc:sldMk cId="2694848396" sldId="270"/>
        </pc:sldMkLst>
        <pc:spChg chg="mod">
          <ac:chgData name="Chaffey, Jessica" userId="dfaac082-a21f-4bd8-8583-e2115658a55f" providerId="ADAL" clId="{3821B51F-EF30-4C63-BE82-1707C230E536}" dt="2021-05-17T10:28:06.160" v="360" actId="1036"/>
          <ac:spMkLst>
            <pc:docMk/>
            <pc:sldMk cId="2694848396" sldId="270"/>
            <ac:spMk id="4" creationId="{00000000-0000-0000-0000-000000000000}"/>
          </ac:spMkLst>
        </pc:spChg>
        <pc:spChg chg="mod">
          <ac:chgData name="Chaffey, Jessica" userId="dfaac082-a21f-4bd8-8583-e2115658a55f" providerId="ADAL" clId="{3821B51F-EF30-4C63-BE82-1707C230E536}" dt="2021-05-17T10:27:49.917" v="324" actId="14100"/>
          <ac:spMkLst>
            <pc:docMk/>
            <pc:sldMk cId="2694848396" sldId="270"/>
            <ac:spMk id="8" creationId="{08444670-3348-49EE-A102-7094F6737757}"/>
          </ac:spMkLst>
        </pc:spChg>
        <pc:spChg chg="add mod">
          <ac:chgData name="Chaffey, Jessica" userId="dfaac082-a21f-4bd8-8583-e2115658a55f" providerId="ADAL" clId="{3821B51F-EF30-4C63-BE82-1707C230E536}" dt="2021-05-17T10:28:06.160" v="360" actId="1036"/>
          <ac:spMkLst>
            <pc:docMk/>
            <pc:sldMk cId="2694848396" sldId="270"/>
            <ac:spMk id="9" creationId="{BCAEA6CE-47E4-4497-964D-2E28745DFB59}"/>
          </ac:spMkLst>
        </pc:spChg>
        <pc:spChg chg="add mod">
          <ac:chgData name="Chaffey, Jessica" userId="dfaac082-a21f-4bd8-8583-e2115658a55f" providerId="ADAL" clId="{3821B51F-EF30-4C63-BE82-1707C230E536}" dt="2021-05-17T10:28:06.160" v="360" actId="1036"/>
          <ac:spMkLst>
            <pc:docMk/>
            <pc:sldMk cId="2694848396" sldId="270"/>
            <ac:spMk id="10" creationId="{50D48E97-DB1F-4116-A870-93F50AB4123C}"/>
          </ac:spMkLst>
        </pc:spChg>
        <pc:spChg chg="add mod">
          <ac:chgData name="Chaffey, Jessica" userId="dfaac082-a21f-4bd8-8583-e2115658a55f" providerId="ADAL" clId="{3821B51F-EF30-4C63-BE82-1707C230E536}" dt="2021-05-17T10:28:06.160" v="360" actId="1036"/>
          <ac:spMkLst>
            <pc:docMk/>
            <pc:sldMk cId="2694848396" sldId="270"/>
            <ac:spMk id="11" creationId="{3A42C3A2-A89C-4820-B116-108C701FFA02}"/>
          </ac:spMkLst>
        </pc:spChg>
        <pc:spChg chg="add mod">
          <ac:chgData name="Chaffey, Jessica" userId="dfaac082-a21f-4bd8-8583-e2115658a55f" providerId="ADAL" clId="{3821B51F-EF30-4C63-BE82-1707C230E536}" dt="2021-05-17T10:28:06.160" v="360" actId="1036"/>
          <ac:spMkLst>
            <pc:docMk/>
            <pc:sldMk cId="2694848396" sldId="270"/>
            <ac:spMk id="12" creationId="{0C2D99A1-619A-485D-852A-E21D96D19B3A}"/>
          </ac:spMkLst>
        </pc:spChg>
        <pc:spChg chg="add mod">
          <ac:chgData name="Chaffey, Jessica" userId="dfaac082-a21f-4bd8-8583-e2115658a55f" providerId="ADAL" clId="{3821B51F-EF30-4C63-BE82-1707C230E536}" dt="2021-05-17T10:28:06.160" v="360" actId="1036"/>
          <ac:spMkLst>
            <pc:docMk/>
            <pc:sldMk cId="2694848396" sldId="270"/>
            <ac:spMk id="14" creationId="{33CC0F24-7D94-4320-9F49-027D9DE6DF96}"/>
          </ac:spMkLst>
        </pc:spChg>
        <pc:picChg chg="add del mod">
          <ac:chgData name="Chaffey, Jessica" userId="dfaac082-a21f-4bd8-8583-e2115658a55f" providerId="ADAL" clId="{3821B51F-EF30-4C63-BE82-1707C230E536}" dt="2021-05-17T10:07:03.869" v="101" actId="478"/>
          <ac:picMkLst>
            <pc:docMk/>
            <pc:sldMk cId="2694848396" sldId="270"/>
            <ac:picMk id="13" creationId="{84F3E8A9-B582-4993-8185-6FC5A16C6728}"/>
          </ac:picMkLst>
        </pc:picChg>
        <pc:picChg chg="mod">
          <ac:chgData name="Chaffey, Jessica" userId="dfaac082-a21f-4bd8-8583-e2115658a55f" providerId="ADAL" clId="{3821B51F-EF30-4C63-BE82-1707C230E536}" dt="2021-05-17T10:28:06.160" v="360" actId="1036"/>
          <ac:picMkLst>
            <pc:docMk/>
            <pc:sldMk cId="2694848396" sldId="270"/>
            <ac:picMk id="1027" creationId="{00000000-0000-0000-0000-000000000000}"/>
          </ac:picMkLst>
        </pc:picChg>
        <pc:picChg chg="mod">
          <ac:chgData name="Chaffey, Jessica" userId="dfaac082-a21f-4bd8-8583-e2115658a55f" providerId="ADAL" clId="{3821B51F-EF30-4C63-BE82-1707C230E536}" dt="2021-05-17T10:28:06.160" v="360" actId="1036"/>
          <ac:picMkLst>
            <pc:docMk/>
            <pc:sldMk cId="2694848396" sldId="270"/>
            <ac:picMk id="1028" creationId="{00000000-0000-0000-0000-000000000000}"/>
          </ac:picMkLst>
        </pc:picChg>
        <pc:picChg chg="mod">
          <ac:chgData name="Chaffey, Jessica" userId="dfaac082-a21f-4bd8-8583-e2115658a55f" providerId="ADAL" clId="{3821B51F-EF30-4C63-BE82-1707C230E536}" dt="2021-05-17T10:28:06.160" v="360" actId="1036"/>
          <ac:picMkLst>
            <pc:docMk/>
            <pc:sldMk cId="2694848396" sldId="270"/>
            <ac:picMk id="1029" creationId="{00000000-0000-0000-0000-000000000000}"/>
          </ac:picMkLst>
        </pc:picChg>
        <pc:picChg chg="mod">
          <ac:chgData name="Chaffey, Jessica" userId="dfaac082-a21f-4bd8-8583-e2115658a55f" providerId="ADAL" clId="{3821B51F-EF30-4C63-BE82-1707C230E536}" dt="2021-05-17T10:28:06.160" v="360" actId="1036"/>
          <ac:picMkLst>
            <pc:docMk/>
            <pc:sldMk cId="2694848396" sldId="270"/>
            <ac:picMk id="2051" creationId="{00000000-0000-0000-0000-000000000000}"/>
          </ac:picMkLst>
        </pc:picChg>
        <pc:picChg chg="mod">
          <ac:chgData name="Chaffey, Jessica" userId="dfaac082-a21f-4bd8-8583-e2115658a55f" providerId="ADAL" clId="{3821B51F-EF30-4C63-BE82-1707C230E536}" dt="2021-05-17T10:28:06.160" v="360" actId="1036"/>
          <ac:picMkLst>
            <pc:docMk/>
            <pc:sldMk cId="2694848396" sldId="270"/>
            <ac:picMk id="2052" creationId="{00000000-0000-0000-0000-000000000000}"/>
          </ac:picMkLst>
        </pc:picChg>
      </pc:sldChg>
      <pc:sldChg chg="add del">
        <pc:chgData name="Chaffey, Jessica" userId="dfaac082-a21f-4bd8-8583-e2115658a55f" providerId="ADAL" clId="{3821B51F-EF30-4C63-BE82-1707C230E536}" dt="2021-05-17T10:21:06.282" v="216" actId="2696"/>
        <pc:sldMkLst>
          <pc:docMk/>
          <pc:sldMk cId="448742877" sldId="271"/>
        </pc:sldMkLst>
      </pc:sldChg>
      <pc:sldChg chg="add del">
        <pc:chgData name="Chaffey, Jessica" userId="dfaac082-a21f-4bd8-8583-e2115658a55f" providerId="ADAL" clId="{3821B51F-EF30-4C63-BE82-1707C230E536}" dt="2021-05-17T10:09:55.838" v="119"/>
        <pc:sldMkLst>
          <pc:docMk/>
          <pc:sldMk cId="2792692216" sldId="271"/>
        </pc:sldMkLst>
      </pc:sldChg>
      <pc:sldChg chg="addSp delSp modSp add">
        <pc:chgData name="Chaffey, Jessica" userId="dfaac082-a21f-4bd8-8583-e2115658a55f" providerId="ADAL" clId="{3821B51F-EF30-4C63-BE82-1707C230E536}" dt="2021-05-17T11:13:14.402" v="826" actId="478"/>
        <pc:sldMkLst>
          <pc:docMk/>
          <pc:sldMk cId="4005150265" sldId="271"/>
        </pc:sldMkLst>
        <pc:spChg chg="del mod">
          <ac:chgData name="Chaffey, Jessica" userId="dfaac082-a21f-4bd8-8583-e2115658a55f" providerId="ADAL" clId="{3821B51F-EF30-4C63-BE82-1707C230E536}" dt="2021-05-17T10:55:39.660" v="396" actId="478"/>
          <ac:spMkLst>
            <pc:docMk/>
            <pc:sldMk cId="4005150265" sldId="271"/>
            <ac:spMk id="2" creationId="{5B2BB23C-C0A4-4D97-81C2-34AC454D3002}"/>
          </ac:spMkLst>
        </pc:spChg>
        <pc:spChg chg="del">
          <ac:chgData name="Chaffey, Jessica" userId="dfaac082-a21f-4bd8-8583-e2115658a55f" providerId="ADAL" clId="{3821B51F-EF30-4C63-BE82-1707C230E536}" dt="2021-05-17T10:57:31.823" v="437" actId="478"/>
          <ac:spMkLst>
            <pc:docMk/>
            <pc:sldMk cId="4005150265" sldId="271"/>
            <ac:spMk id="3" creationId="{4D3ECA46-0E61-4B09-9AC0-B1641F4C1395}"/>
          </ac:spMkLst>
        </pc:spChg>
        <pc:spChg chg="add del mod">
          <ac:chgData name="Chaffey, Jessica" userId="dfaac082-a21f-4bd8-8583-e2115658a55f" providerId="ADAL" clId="{3821B51F-EF30-4C63-BE82-1707C230E536}" dt="2021-05-17T10:57:33.292" v="438" actId="478"/>
          <ac:spMkLst>
            <pc:docMk/>
            <pc:sldMk cId="4005150265" sldId="271"/>
            <ac:spMk id="5" creationId="{3541AC19-06F8-452F-9DF8-D60342B80C08}"/>
          </ac:spMkLst>
        </pc:spChg>
        <pc:spChg chg="add del mod">
          <ac:chgData name="Chaffey, Jessica" userId="dfaac082-a21f-4bd8-8583-e2115658a55f" providerId="ADAL" clId="{3821B51F-EF30-4C63-BE82-1707C230E536}" dt="2021-05-17T11:13:14.402" v="826" actId="478"/>
          <ac:spMkLst>
            <pc:docMk/>
            <pc:sldMk cId="4005150265" sldId="271"/>
            <ac:spMk id="8" creationId="{FAA24811-657F-4400-AE19-23062202E51C}"/>
          </ac:spMkLst>
        </pc:spChg>
        <pc:spChg chg="add mod">
          <ac:chgData name="Chaffey, Jessica" userId="dfaac082-a21f-4bd8-8583-e2115658a55f" providerId="ADAL" clId="{3821B51F-EF30-4C63-BE82-1707C230E536}" dt="2021-05-17T11:13:11.472" v="825" actId="20577"/>
          <ac:spMkLst>
            <pc:docMk/>
            <pc:sldMk cId="4005150265" sldId="271"/>
            <ac:spMk id="9" creationId="{457D6A30-836D-4C00-B69F-C747F6D68E4E}"/>
          </ac:spMkLst>
        </pc:spChg>
        <pc:graphicFrameChg chg="add mod modGraphic">
          <ac:chgData name="Chaffey, Jessica" userId="dfaac082-a21f-4bd8-8583-e2115658a55f" providerId="ADAL" clId="{3821B51F-EF30-4C63-BE82-1707C230E536}" dt="2021-05-17T11:12:41.732" v="814" actId="122"/>
          <ac:graphicFrameMkLst>
            <pc:docMk/>
            <pc:sldMk cId="4005150265" sldId="271"/>
            <ac:graphicFrameMk id="6" creationId="{DF3F3FB9-E17C-456D-9116-49442443C3AD}"/>
          </ac:graphicFrameMkLst>
        </pc:graphicFrameChg>
      </pc:sldChg>
      <pc:sldChg chg="add del ord">
        <pc:chgData name="Chaffey, Jessica" userId="dfaac082-a21f-4bd8-8583-e2115658a55f" providerId="ADAL" clId="{3821B51F-EF30-4C63-BE82-1707C230E536}" dt="2021-05-17T10:26:59.577" v="287" actId="2696"/>
        <pc:sldMkLst>
          <pc:docMk/>
          <pc:sldMk cId="3625471129" sldId="272"/>
        </pc:sldMkLst>
      </pc:sldChg>
    </pc:docChg>
  </pc:docChgLst>
  <pc:docChgLst>
    <pc:chgData name="Chaffey, Jessica" userId="dfaac082-a21f-4bd8-8583-e2115658a55f" providerId="ADAL" clId="{286912FD-5411-469C-8AD3-0E9D5A939821}"/>
    <pc:docChg chg="undo redo modSld">
      <pc:chgData name="Chaffey, Jessica" userId="dfaac082-a21f-4bd8-8583-e2115658a55f" providerId="ADAL" clId="{286912FD-5411-469C-8AD3-0E9D5A939821}" dt="2021-03-29T15:24:43.738" v="53"/>
      <pc:docMkLst>
        <pc:docMk/>
      </pc:docMkLst>
      <pc:sldChg chg="addSp">
        <pc:chgData name="Chaffey, Jessica" userId="dfaac082-a21f-4bd8-8583-e2115658a55f" providerId="ADAL" clId="{286912FD-5411-469C-8AD3-0E9D5A939821}" dt="2021-03-29T15:23:16.317" v="15"/>
        <pc:sldMkLst>
          <pc:docMk/>
          <pc:sldMk cId="3649101259" sldId="257"/>
        </pc:sldMkLst>
        <pc:spChg chg="add">
          <ac:chgData name="Chaffey, Jessica" userId="dfaac082-a21f-4bd8-8583-e2115658a55f" providerId="ADAL" clId="{286912FD-5411-469C-8AD3-0E9D5A939821}" dt="2021-03-29T15:23:16.317" v="15"/>
          <ac:spMkLst>
            <pc:docMk/>
            <pc:sldMk cId="3649101259" sldId="257"/>
            <ac:spMk id="67" creationId="{8A8871F9-1B0F-43A2-91D9-1244198C91FF}"/>
          </ac:spMkLst>
        </pc:spChg>
      </pc:sldChg>
      <pc:sldChg chg="addSp modSp">
        <pc:chgData name="Chaffey, Jessica" userId="dfaac082-a21f-4bd8-8583-e2115658a55f" providerId="ADAL" clId="{286912FD-5411-469C-8AD3-0E9D5A939821}" dt="2021-03-29T15:23:53.661" v="37" actId="20577"/>
        <pc:sldMkLst>
          <pc:docMk/>
          <pc:sldMk cId="522916658" sldId="258"/>
        </pc:sldMkLst>
        <pc:spChg chg="add mod">
          <ac:chgData name="Chaffey, Jessica" userId="dfaac082-a21f-4bd8-8583-e2115658a55f" providerId="ADAL" clId="{286912FD-5411-469C-8AD3-0E9D5A939821}" dt="2021-03-29T15:23:53.661" v="37" actId="20577"/>
          <ac:spMkLst>
            <pc:docMk/>
            <pc:sldMk cId="522916658" sldId="258"/>
            <ac:spMk id="49" creationId="{D8759829-68E9-4C25-8CAC-992DC2C290C4}"/>
          </ac:spMkLst>
        </pc:spChg>
      </pc:sldChg>
      <pc:sldChg chg="addSp modSp">
        <pc:chgData name="Chaffey, Jessica" userId="dfaac082-a21f-4bd8-8583-e2115658a55f" providerId="ADAL" clId="{286912FD-5411-469C-8AD3-0E9D5A939821}" dt="2021-03-29T15:24:23.208" v="48" actId="20577"/>
        <pc:sldMkLst>
          <pc:docMk/>
          <pc:sldMk cId="3147858600" sldId="259"/>
        </pc:sldMkLst>
        <pc:spChg chg="add mod">
          <ac:chgData name="Chaffey, Jessica" userId="dfaac082-a21f-4bd8-8583-e2115658a55f" providerId="ADAL" clId="{286912FD-5411-469C-8AD3-0E9D5A939821}" dt="2021-03-29T15:24:23.208" v="48" actId="20577"/>
          <ac:spMkLst>
            <pc:docMk/>
            <pc:sldMk cId="3147858600" sldId="259"/>
            <ac:spMk id="2" creationId="{80359C45-03E2-4476-A724-3DD986F5F5BB}"/>
          </ac:spMkLst>
        </pc:spChg>
        <pc:spChg chg="mod">
          <ac:chgData name="Chaffey, Jessica" userId="dfaac082-a21f-4bd8-8583-e2115658a55f" providerId="ADAL" clId="{286912FD-5411-469C-8AD3-0E9D5A939821}" dt="2021-03-29T15:24:02.218" v="38" actId="1076"/>
          <ac:spMkLst>
            <pc:docMk/>
            <pc:sldMk cId="3147858600" sldId="259"/>
            <ac:spMk id="5" creationId="{E7D38749-DDDE-412A-A1A4-853DEA34C195}"/>
          </ac:spMkLst>
        </pc:spChg>
        <pc:spChg chg="mod">
          <ac:chgData name="Chaffey, Jessica" userId="dfaac082-a21f-4bd8-8583-e2115658a55f" providerId="ADAL" clId="{286912FD-5411-469C-8AD3-0E9D5A939821}" dt="2021-03-29T15:24:02.218" v="38" actId="1076"/>
          <ac:spMkLst>
            <pc:docMk/>
            <pc:sldMk cId="3147858600" sldId="259"/>
            <ac:spMk id="6" creationId="{27D672B7-54C0-429B-BE3D-D3ACF967DF88}"/>
          </ac:spMkLst>
        </pc:spChg>
        <pc:spChg chg="mod">
          <ac:chgData name="Chaffey, Jessica" userId="dfaac082-a21f-4bd8-8583-e2115658a55f" providerId="ADAL" clId="{286912FD-5411-469C-8AD3-0E9D5A939821}" dt="2021-03-29T15:24:02.218" v="38" actId="1076"/>
          <ac:spMkLst>
            <pc:docMk/>
            <pc:sldMk cId="3147858600" sldId="259"/>
            <ac:spMk id="7" creationId="{E15026F8-65E0-4BB3-9AB9-F3030556D3A4}"/>
          </ac:spMkLst>
        </pc:spChg>
        <pc:spChg chg="mod">
          <ac:chgData name="Chaffey, Jessica" userId="dfaac082-a21f-4bd8-8583-e2115658a55f" providerId="ADAL" clId="{286912FD-5411-469C-8AD3-0E9D5A939821}" dt="2021-03-29T15:24:02.218" v="38" actId="1076"/>
          <ac:spMkLst>
            <pc:docMk/>
            <pc:sldMk cId="3147858600" sldId="259"/>
            <ac:spMk id="8" creationId="{416CAE7E-A026-418C-818D-602AF1CBA5A5}"/>
          </ac:spMkLst>
        </pc:spChg>
        <pc:spChg chg="mod">
          <ac:chgData name="Chaffey, Jessica" userId="dfaac082-a21f-4bd8-8583-e2115658a55f" providerId="ADAL" clId="{286912FD-5411-469C-8AD3-0E9D5A939821}" dt="2021-03-29T15:24:02.218" v="38" actId="1076"/>
          <ac:spMkLst>
            <pc:docMk/>
            <pc:sldMk cId="3147858600" sldId="259"/>
            <ac:spMk id="9" creationId="{78E7E9B5-663F-433B-987B-6C70534D2E64}"/>
          </ac:spMkLst>
        </pc:spChg>
        <pc:spChg chg="mod">
          <ac:chgData name="Chaffey, Jessica" userId="dfaac082-a21f-4bd8-8583-e2115658a55f" providerId="ADAL" clId="{286912FD-5411-469C-8AD3-0E9D5A939821}" dt="2021-03-29T15:24:02.218" v="38" actId="1076"/>
          <ac:spMkLst>
            <pc:docMk/>
            <pc:sldMk cId="3147858600" sldId="259"/>
            <ac:spMk id="10" creationId="{F86A5B2E-13D4-44BB-BD84-07ED5F38123A}"/>
          </ac:spMkLst>
        </pc:spChg>
        <pc:spChg chg="mod">
          <ac:chgData name="Chaffey, Jessica" userId="dfaac082-a21f-4bd8-8583-e2115658a55f" providerId="ADAL" clId="{286912FD-5411-469C-8AD3-0E9D5A939821}" dt="2021-03-29T15:24:02.218" v="38" actId="1076"/>
          <ac:spMkLst>
            <pc:docMk/>
            <pc:sldMk cId="3147858600" sldId="259"/>
            <ac:spMk id="11" creationId="{80668DB7-7751-4C6C-8E4F-9A97B599B1EA}"/>
          </ac:spMkLst>
        </pc:spChg>
        <pc:spChg chg="mod">
          <ac:chgData name="Chaffey, Jessica" userId="dfaac082-a21f-4bd8-8583-e2115658a55f" providerId="ADAL" clId="{286912FD-5411-469C-8AD3-0E9D5A939821}" dt="2021-03-29T15:24:02.218" v="38" actId="1076"/>
          <ac:spMkLst>
            <pc:docMk/>
            <pc:sldMk cId="3147858600" sldId="259"/>
            <ac:spMk id="12" creationId="{CA3A3B38-F183-4411-BFE6-7397C5E3C592}"/>
          </ac:spMkLst>
        </pc:spChg>
        <pc:spChg chg="mod">
          <ac:chgData name="Chaffey, Jessica" userId="dfaac082-a21f-4bd8-8583-e2115658a55f" providerId="ADAL" clId="{286912FD-5411-469C-8AD3-0E9D5A939821}" dt="2021-03-29T15:24:02.218" v="38" actId="1076"/>
          <ac:spMkLst>
            <pc:docMk/>
            <pc:sldMk cId="3147858600" sldId="259"/>
            <ac:spMk id="13" creationId="{7B8A156A-2CB0-4481-8F40-098567A70D03}"/>
          </ac:spMkLst>
        </pc:spChg>
        <pc:spChg chg="mod">
          <ac:chgData name="Chaffey, Jessica" userId="dfaac082-a21f-4bd8-8583-e2115658a55f" providerId="ADAL" clId="{286912FD-5411-469C-8AD3-0E9D5A939821}" dt="2021-03-29T15:24:02.218" v="38" actId="1076"/>
          <ac:spMkLst>
            <pc:docMk/>
            <pc:sldMk cId="3147858600" sldId="259"/>
            <ac:spMk id="14" creationId="{E681F7BB-A956-499A-AFEA-6D29AEBC84DF}"/>
          </ac:spMkLst>
        </pc:spChg>
        <pc:spChg chg="mod">
          <ac:chgData name="Chaffey, Jessica" userId="dfaac082-a21f-4bd8-8583-e2115658a55f" providerId="ADAL" clId="{286912FD-5411-469C-8AD3-0E9D5A939821}" dt="2021-03-29T15:24:02.218" v="38" actId="1076"/>
          <ac:spMkLst>
            <pc:docMk/>
            <pc:sldMk cId="3147858600" sldId="259"/>
            <ac:spMk id="15" creationId="{FD490BD3-AD0B-41A9-903A-495B07EFE4DD}"/>
          </ac:spMkLst>
        </pc:spChg>
        <pc:spChg chg="mod">
          <ac:chgData name="Chaffey, Jessica" userId="dfaac082-a21f-4bd8-8583-e2115658a55f" providerId="ADAL" clId="{286912FD-5411-469C-8AD3-0E9D5A939821}" dt="2021-03-29T15:24:02.218" v="38" actId="1076"/>
          <ac:spMkLst>
            <pc:docMk/>
            <pc:sldMk cId="3147858600" sldId="259"/>
            <ac:spMk id="16" creationId="{A61F246A-AF49-4C9A-85BA-7A6F3C9606DC}"/>
          </ac:spMkLst>
        </pc:spChg>
        <pc:spChg chg="mod">
          <ac:chgData name="Chaffey, Jessica" userId="dfaac082-a21f-4bd8-8583-e2115658a55f" providerId="ADAL" clId="{286912FD-5411-469C-8AD3-0E9D5A939821}" dt="2021-03-29T15:24:02.218" v="38" actId="1076"/>
          <ac:spMkLst>
            <pc:docMk/>
            <pc:sldMk cId="3147858600" sldId="259"/>
            <ac:spMk id="17" creationId="{0C5C9C7D-5C7F-48A7-8C7E-9B11C60C3BCD}"/>
          </ac:spMkLst>
        </pc:spChg>
        <pc:spChg chg="mod">
          <ac:chgData name="Chaffey, Jessica" userId="dfaac082-a21f-4bd8-8583-e2115658a55f" providerId="ADAL" clId="{286912FD-5411-469C-8AD3-0E9D5A939821}" dt="2021-03-29T15:24:02.218" v="38" actId="1076"/>
          <ac:spMkLst>
            <pc:docMk/>
            <pc:sldMk cId="3147858600" sldId="259"/>
            <ac:spMk id="18" creationId="{420F2F4F-E665-4703-BB01-D174CB58EFAC}"/>
          </ac:spMkLst>
        </pc:spChg>
        <pc:spChg chg="mod">
          <ac:chgData name="Chaffey, Jessica" userId="dfaac082-a21f-4bd8-8583-e2115658a55f" providerId="ADAL" clId="{286912FD-5411-469C-8AD3-0E9D5A939821}" dt="2021-03-29T15:24:02.218" v="38" actId="1076"/>
          <ac:spMkLst>
            <pc:docMk/>
            <pc:sldMk cId="3147858600" sldId="259"/>
            <ac:spMk id="19" creationId="{80F49CC2-83C8-4D9C-BC15-AADC1B0EE95D}"/>
          </ac:spMkLst>
        </pc:spChg>
        <pc:spChg chg="mod">
          <ac:chgData name="Chaffey, Jessica" userId="dfaac082-a21f-4bd8-8583-e2115658a55f" providerId="ADAL" clId="{286912FD-5411-469C-8AD3-0E9D5A939821}" dt="2021-03-29T15:24:02.218" v="38" actId="1076"/>
          <ac:spMkLst>
            <pc:docMk/>
            <pc:sldMk cId="3147858600" sldId="259"/>
            <ac:spMk id="20" creationId="{B14A4D33-DFD5-4C85-88DD-C0674C8337E8}"/>
          </ac:spMkLst>
        </pc:spChg>
        <pc:spChg chg="mod">
          <ac:chgData name="Chaffey, Jessica" userId="dfaac082-a21f-4bd8-8583-e2115658a55f" providerId="ADAL" clId="{286912FD-5411-469C-8AD3-0E9D5A939821}" dt="2021-03-29T15:24:02.218" v="38" actId="1076"/>
          <ac:spMkLst>
            <pc:docMk/>
            <pc:sldMk cId="3147858600" sldId="259"/>
            <ac:spMk id="21" creationId="{1D2B0153-28B3-4676-BF4E-29E8CB2B84CB}"/>
          </ac:spMkLst>
        </pc:spChg>
        <pc:spChg chg="mod">
          <ac:chgData name="Chaffey, Jessica" userId="dfaac082-a21f-4bd8-8583-e2115658a55f" providerId="ADAL" clId="{286912FD-5411-469C-8AD3-0E9D5A939821}" dt="2021-03-29T15:24:02.218" v="38" actId="1076"/>
          <ac:spMkLst>
            <pc:docMk/>
            <pc:sldMk cId="3147858600" sldId="259"/>
            <ac:spMk id="23" creationId="{2DEFC6FC-92EF-4248-ACB9-3EF114416E43}"/>
          </ac:spMkLst>
        </pc:spChg>
        <pc:spChg chg="mod">
          <ac:chgData name="Chaffey, Jessica" userId="dfaac082-a21f-4bd8-8583-e2115658a55f" providerId="ADAL" clId="{286912FD-5411-469C-8AD3-0E9D5A939821}" dt="2021-03-29T15:24:02.218" v="38" actId="1076"/>
          <ac:spMkLst>
            <pc:docMk/>
            <pc:sldMk cId="3147858600" sldId="259"/>
            <ac:spMk id="24" creationId="{770243BE-7855-44C8-B60F-477FA52295C5}"/>
          </ac:spMkLst>
        </pc:spChg>
        <pc:spChg chg="mod">
          <ac:chgData name="Chaffey, Jessica" userId="dfaac082-a21f-4bd8-8583-e2115658a55f" providerId="ADAL" clId="{286912FD-5411-469C-8AD3-0E9D5A939821}" dt="2021-03-29T15:24:02.218" v="38" actId="1076"/>
          <ac:spMkLst>
            <pc:docMk/>
            <pc:sldMk cId="3147858600" sldId="259"/>
            <ac:spMk id="25" creationId="{417F7592-5710-4B4E-B50F-4E345560E5C9}"/>
          </ac:spMkLst>
        </pc:spChg>
        <pc:spChg chg="mod">
          <ac:chgData name="Chaffey, Jessica" userId="dfaac082-a21f-4bd8-8583-e2115658a55f" providerId="ADAL" clId="{286912FD-5411-469C-8AD3-0E9D5A939821}" dt="2021-03-29T15:24:02.218" v="38" actId="1076"/>
          <ac:spMkLst>
            <pc:docMk/>
            <pc:sldMk cId="3147858600" sldId="259"/>
            <ac:spMk id="26" creationId="{B616F545-2270-43F9-8CB9-BD04959CC989}"/>
          </ac:spMkLst>
        </pc:spChg>
        <pc:spChg chg="mod">
          <ac:chgData name="Chaffey, Jessica" userId="dfaac082-a21f-4bd8-8583-e2115658a55f" providerId="ADAL" clId="{286912FD-5411-469C-8AD3-0E9D5A939821}" dt="2021-03-29T15:24:02.218" v="38" actId="1076"/>
          <ac:spMkLst>
            <pc:docMk/>
            <pc:sldMk cId="3147858600" sldId="259"/>
            <ac:spMk id="27" creationId="{6E1B6745-50AB-4A29-B531-F683C7227138}"/>
          </ac:spMkLst>
        </pc:spChg>
        <pc:spChg chg="mod">
          <ac:chgData name="Chaffey, Jessica" userId="dfaac082-a21f-4bd8-8583-e2115658a55f" providerId="ADAL" clId="{286912FD-5411-469C-8AD3-0E9D5A939821}" dt="2021-03-29T15:24:02.218" v="38" actId="1076"/>
          <ac:spMkLst>
            <pc:docMk/>
            <pc:sldMk cId="3147858600" sldId="259"/>
            <ac:spMk id="28" creationId="{24860F2F-88EE-44FB-88BC-B03FF392D777}"/>
          </ac:spMkLst>
        </pc:spChg>
        <pc:spChg chg="mod">
          <ac:chgData name="Chaffey, Jessica" userId="dfaac082-a21f-4bd8-8583-e2115658a55f" providerId="ADAL" clId="{286912FD-5411-469C-8AD3-0E9D5A939821}" dt="2021-03-29T15:24:02.218" v="38" actId="1076"/>
          <ac:spMkLst>
            <pc:docMk/>
            <pc:sldMk cId="3147858600" sldId="259"/>
            <ac:spMk id="29" creationId="{33D8D392-A5AC-464F-991A-6D89CDCEABD5}"/>
          </ac:spMkLst>
        </pc:spChg>
        <pc:spChg chg="mod">
          <ac:chgData name="Chaffey, Jessica" userId="dfaac082-a21f-4bd8-8583-e2115658a55f" providerId="ADAL" clId="{286912FD-5411-469C-8AD3-0E9D5A939821}" dt="2021-03-29T15:24:02.218" v="38" actId="1076"/>
          <ac:spMkLst>
            <pc:docMk/>
            <pc:sldMk cId="3147858600" sldId="259"/>
            <ac:spMk id="30" creationId="{77241103-9F1D-45E3-9418-675A69F0D128}"/>
          </ac:spMkLst>
        </pc:spChg>
        <pc:spChg chg="mod">
          <ac:chgData name="Chaffey, Jessica" userId="dfaac082-a21f-4bd8-8583-e2115658a55f" providerId="ADAL" clId="{286912FD-5411-469C-8AD3-0E9D5A939821}" dt="2021-03-29T15:24:02.218" v="38" actId="1076"/>
          <ac:spMkLst>
            <pc:docMk/>
            <pc:sldMk cId="3147858600" sldId="259"/>
            <ac:spMk id="31" creationId="{5997EB76-608B-44A0-9C03-70592E313519}"/>
          </ac:spMkLst>
        </pc:spChg>
        <pc:spChg chg="mod">
          <ac:chgData name="Chaffey, Jessica" userId="dfaac082-a21f-4bd8-8583-e2115658a55f" providerId="ADAL" clId="{286912FD-5411-469C-8AD3-0E9D5A939821}" dt="2021-03-29T15:24:02.218" v="38" actId="1076"/>
          <ac:spMkLst>
            <pc:docMk/>
            <pc:sldMk cId="3147858600" sldId="259"/>
            <ac:spMk id="32" creationId="{CEC34A9D-7FD4-46A2-9782-8880F4269EBA}"/>
          </ac:spMkLst>
        </pc:spChg>
        <pc:spChg chg="mod">
          <ac:chgData name="Chaffey, Jessica" userId="dfaac082-a21f-4bd8-8583-e2115658a55f" providerId="ADAL" clId="{286912FD-5411-469C-8AD3-0E9D5A939821}" dt="2021-03-29T15:24:02.218" v="38" actId="1076"/>
          <ac:spMkLst>
            <pc:docMk/>
            <pc:sldMk cId="3147858600" sldId="259"/>
            <ac:spMk id="33" creationId="{3C2EECC3-5E64-4F20-87A3-DB9B662E142D}"/>
          </ac:spMkLst>
        </pc:spChg>
        <pc:picChg chg="mod">
          <ac:chgData name="Chaffey, Jessica" userId="dfaac082-a21f-4bd8-8583-e2115658a55f" providerId="ADAL" clId="{286912FD-5411-469C-8AD3-0E9D5A939821}" dt="2021-03-29T15:24:02.218" v="38" actId="1076"/>
          <ac:picMkLst>
            <pc:docMk/>
            <pc:sldMk cId="3147858600" sldId="259"/>
            <ac:picMk id="4" creationId="{249B0446-D01C-43BF-892D-08E077709F4E}"/>
          </ac:picMkLst>
        </pc:picChg>
        <pc:picChg chg="mod">
          <ac:chgData name="Chaffey, Jessica" userId="dfaac082-a21f-4bd8-8583-e2115658a55f" providerId="ADAL" clId="{286912FD-5411-469C-8AD3-0E9D5A939821}" dt="2021-03-29T15:24:02.218" v="38" actId="1076"/>
          <ac:picMkLst>
            <pc:docMk/>
            <pc:sldMk cId="3147858600" sldId="259"/>
            <ac:picMk id="22" creationId="{85391806-21F1-4FBF-A2CD-2ED482940F6C}"/>
          </ac:picMkLst>
        </pc:picChg>
      </pc:sldChg>
      <pc:sldChg chg="addSp modSp">
        <pc:chgData name="Chaffey, Jessica" userId="dfaac082-a21f-4bd8-8583-e2115658a55f" providerId="ADAL" clId="{286912FD-5411-469C-8AD3-0E9D5A939821}" dt="2021-03-29T15:24:28.117" v="49"/>
        <pc:sldMkLst>
          <pc:docMk/>
          <pc:sldMk cId="557411176" sldId="260"/>
        </pc:sldMkLst>
        <pc:spChg chg="mod">
          <ac:chgData name="Chaffey, Jessica" userId="dfaac082-a21f-4bd8-8583-e2115658a55f" providerId="ADAL" clId="{286912FD-5411-469C-8AD3-0E9D5A939821}" dt="2021-03-29T15:24:08.648" v="39" actId="1076"/>
          <ac:spMkLst>
            <pc:docMk/>
            <pc:sldMk cId="557411176" sldId="260"/>
            <ac:spMk id="5" creationId="{03640C94-D800-43C3-B047-D720165EE807}"/>
          </ac:spMkLst>
        </pc:spChg>
        <pc:spChg chg="mod">
          <ac:chgData name="Chaffey, Jessica" userId="dfaac082-a21f-4bd8-8583-e2115658a55f" providerId="ADAL" clId="{286912FD-5411-469C-8AD3-0E9D5A939821}" dt="2021-03-29T15:24:08.648" v="39" actId="1076"/>
          <ac:spMkLst>
            <pc:docMk/>
            <pc:sldMk cId="557411176" sldId="260"/>
            <ac:spMk id="6" creationId="{9DD89CB1-DD19-45B1-BEA2-DA6ABF58E20C}"/>
          </ac:spMkLst>
        </pc:spChg>
        <pc:spChg chg="mod">
          <ac:chgData name="Chaffey, Jessica" userId="dfaac082-a21f-4bd8-8583-e2115658a55f" providerId="ADAL" clId="{286912FD-5411-469C-8AD3-0E9D5A939821}" dt="2021-03-29T15:24:08.648" v="39" actId="1076"/>
          <ac:spMkLst>
            <pc:docMk/>
            <pc:sldMk cId="557411176" sldId="260"/>
            <ac:spMk id="7" creationId="{4BADA522-E1A9-4975-9CDF-384119A4E0A6}"/>
          </ac:spMkLst>
        </pc:spChg>
        <pc:spChg chg="mod">
          <ac:chgData name="Chaffey, Jessica" userId="dfaac082-a21f-4bd8-8583-e2115658a55f" providerId="ADAL" clId="{286912FD-5411-469C-8AD3-0E9D5A939821}" dt="2021-03-29T15:24:08.648" v="39" actId="1076"/>
          <ac:spMkLst>
            <pc:docMk/>
            <pc:sldMk cId="557411176" sldId="260"/>
            <ac:spMk id="8" creationId="{70D69FDD-61E8-4E78-B61C-35C30F95182D}"/>
          </ac:spMkLst>
        </pc:spChg>
        <pc:spChg chg="mod">
          <ac:chgData name="Chaffey, Jessica" userId="dfaac082-a21f-4bd8-8583-e2115658a55f" providerId="ADAL" clId="{286912FD-5411-469C-8AD3-0E9D5A939821}" dt="2021-03-29T15:24:08.648" v="39" actId="1076"/>
          <ac:spMkLst>
            <pc:docMk/>
            <pc:sldMk cId="557411176" sldId="260"/>
            <ac:spMk id="9" creationId="{FBB43EF8-DC48-4413-8302-DB9B7A200CE2}"/>
          </ac:spMkLst>
        </pc:spChg>
        <pc:spChg chg="mod">
          <ac:chgData name="Chaffey, Jessica" userId="dfaac082-a21f-4bd8-8583-e2115658a55f" providerId="ADAL" clId="{286912FD-5411-469C-8AD3-0E9D5A939821}" dt="2021-03-29T15:24:08.648" v="39" actId="1076"/>
          <ac:spMkLst>
            <pc:docMk/>
            <pc:sldMk cId="557411176" sldId="260"/>
            <ac:spMk id="10" creationId="{A88101B2-8CD1-4DC6-80F8-5D3267067D92}"/>
          </ac:spMkLst>
        </pc:spChg>
        <pc:spChg chg="mod">
          <ac:chgData name="Chaffey, Jessica" userId="dfaac082-a21f-4bd8-8583-e2115658a55f" providerId="ADAL" clId="{286912FD-5411-469C-8AD3-0E9D5A939821}" dt="2021-03-29T15:24:08.648" v="39" actId="1076"/>
          <ac:spMkLst>
            <pc:docMk/>
            <pc:sldMk cId="557411176" sldId="260"/>
            <ac:spMk id="11" creationId="{A33A2B22-EB72-45DE-A150-1052C4AD442E}"/>
          </ac:spMkLst>
        </pc:spChg>
        <pc:spChg chg="mod">
          <ac:chgData name="Chaffey, Jessica" userId="dfaac082-a21f-4bd8-8583-e2115658a55f" providerId="ADAL" clId="{286912FD-5411-469C-8AD3-0E9D5A939821}" dt="2021-03-29T15:24:08.648" v="39" actId="1076"/>
          <ac:spMkLst>
            <pc:docMk/>
            <pc:sldMk cId="557411176" sldId="260"/>
            <ac:spMk id="12" creationId="{C2EFBBA3-1B7D-45F7-B2AA-6883A6BDD0DB}"/>
          </ac:spMkLst>
        </pc:spChg>
        <pc:spChg chg="mod">
          <ac:chgData name="Chaffey, Jessica" userId="dfaac082-a21f-4bd8-8583-e2115658a55f" providerId="ADAL" clId="{286912FD-5411-469C-8AD3-0E9D5A939821}" dt="2021-03-29T15:24:08.648" v="39" actId="1076"/>
          <ac:spMkLst>
            <pc:docMk/>
            <pc:sldMk cId="557411176" sldId="260"/>
            <ac:spMk id="13" creationId="{9E529596-B220-4710-9EBE-9B18AE0DA582}"/>
          </ac:spMkLst>
        </pc:spChg>
        <pc:spChg chg="mod">
          <ac:chgData name="Chaffey, Jessica" userId="dfaac082-a21f-4bd8-8583-e2115658a55f" providerId="ADAL" clId="{286912FD-5411-469C-8AD3-0E9D5A939821}" dt="2021-03-29T15:24:08.648" v="39" actId="1076"/>
          <ac:spMkLst>
            <pc:docMk/>
            <pc:sldMk cId="557411176" sldId="260"/>
            <ac:spMk id="14" creationId="{F76A7346-9A7A-4045-9693-70F20FB14C94}"/>
          </ac:spMkLst>
        </pc:spChg>
        <pc:spChg chg="mod">
          <ac:chgData name="Chaffey, Jessica" userId="dfaac082-a21f-4bd8-8583-e2115658a55f" providerId="ADAL" clId="{286912FD-5411-469C-8AD3-0E9D5A939821}" dt="2021-03-29T15:24:08.648" v="39" actId="1076"/>
          <ac:spMkLst>
            <pc:docMk/>
            <pc:sldMk cId="557411176" sldId="260"/>
            <ac:spMk id="16" creationId="{51E545CA-7D09-4068-9A1E-5EE7D9B3B6C1}"/>
          </ac:spMkLst>
        </pc:spChg>
        <pc:spChg chg="mod">
          <ac:chgData name="Chaffey, Jessica" userId="dfaac082-a21f-4bd8-8583-e2115658a55f" providerId="ADAL" clId="{286912FD-5411-469C-8AD3-0E9D5A939821}" dt="2021-03-29T15:24:08.648" v="39" actId="1076"/>
          <ac:spMkLst>
            <pc:docMk/>
            <pc:sldMk cId="557411176" sldId="260"/>
            <ac:spMk id="17" creationId="{29EE9642-352F-4AA3-B187-E1195BD29F53}"/>
          </ac:spMkLst>
        </pc:spChg>
        <pc:spChg chg="mod">
          <ac:chgData name="Chaffey, Jessica" userId="dfaac082-a21f-4bd8-8583-e2115658a55f" providerId="ADAL" clId="{286912FD-5411-469C-8AD3-0E9D5A939821}" dt="2021-03-29T15:24:08.648" v="39" actId="1076"/>
          <ac:spMkLst>
            <pc:docMk/>
            <pc:sldMk cId="557411176" sldId="260"/>
            <ac:spMk id="18" creationId="{03772EB4-9461-49ED-9154-D079DC060545}"/>
          </ac:spMkLst>
        </pc:spChg>
        <pc:spChg chg="mod">
          <ac:chgData name="Chaffey, Jessica" userId="dfaac082-a21f-4bd8-8583-e2115658a55f" providerId="ADAL" clId="{286912FD-5411-469C-8AD3-0E9D5A939821}" dt="2021-03-29T15:24:08.648" v="39" actId="1076"/>
          <ac:spMkLst>
            <pc:docMk/>
            <pc:sldMk cId="557411176" sldId="260"/>
            <ac:spMk id="19" creationId="{89AC6585-D682-484C-815B-127FBA79AF3A}"/>
          </ac:spMkLst>
        </pc:spChg>
        <pc:spChg chg="mod">
          <ac:chgData name="Chaffey, Jessica" userId="dfaac082-a21f-4bd8-8583-e2115658a55f" providerId="ADAL" clId="{286912FD-5411-469C-8AD3-0E9D5A939821}" dt="2021-03-29T15:24:08.648" v="39" actId="1076"/>
          <ac:spMkLst>
            <pc:docMk/>
            <pc:sldMk cId="557411176" sldId="260"/>
            <ac:spMk id="20" creationId="{80498C52-600E-4DCA-8311-1AE196A43901}"/>
          </ac:spMkLst>
        </pc:spChg>
        <pc:spChg chg="mod">
          <ac:chgData name="Chaffey, Jessica" userId="dfaac082-a21f-4bd8-8583-e2115658a55f" providerId="ADAL" clId="{286912FD-5411-469C-8AD3-0E9D5A939821}" dt="2021-03-29T15:24:08.648" v="39" actId="1076"/>
          <ac:spMkLst>
            <pc:docMk/>
            <pc:sldMk cId="557411176" sldId="260"/>
            <ac:spMk id="21" creationId="{3D26DD39-D541-438C-9E98-3E8BDA39673C}"/>
          </ac:spMkLst>
        </pc:spChg>
        <pc:spChg chg="mod">
          <ac:chgData name="Chaffey, Jessica" userId="dfaac082-a21f-4bd8-8583-e2115658a55f" providerId="ADAL" clId="{286912FD-5411-469C-8AD3-0E9D5A939821}" dt="2021-03-29T15:24:08.648" v="39" actId="1076"/>
          <ac:spMkLst>
            <pc:docMk/>
            <pc:sldMk cId="557411176" sldId="260"/>
            <ac:spMk id="22" creationId="{3A64E00D-4D89-42A1-BA08-F8FEAC7C6DAF}"/>
          </ac:spMkLst>
        </pc:spChg>
        <pc:spChg chg="mod">
          <ac:chgData name="Chaffey, Jessica" userId="dfaac082-a21f-4bd8-8583-e2115658a55f" providerId="ADAL" clId="{286912FD-5411-469C-8AD3-0E9D5A939821}" dt="2021-03-29T15:24:08.648" v="39" actId="1076"/>
          <ac:spMkLst>
            <pc:docMk/>
            <pc:sldMk cId="557411176" sldId="260"/>
            <ac:spMk id="23" creationId="{EC4ECC5B-B6B4-4B15-B1C4-7A748AD39FD5}"/>
          </ac:spMkLst>
        </pc:spChg>
        <pc:spChg chg="mod">
          <ac:chgData name="Chaffey, Jessica" userId="dfaac082-a21f-4bd8-8583-e2115658a55f" providerId="ADAL" clId="{286912FD-5411-469C-8AD3-0E9D5A939821}" dt="2021-03-29T15:24:08.648" v="39" actId="1076"/>
          <ac:spMkLst>
            <pc:docMk/>
            <pc:sldMk cId="557411176" sldId="260"/>
            <ac:spMk id="24" creationId="{8F340AF2-2C57-4DD1-B9A6-0E9440CA7DD5}"/>
          </ac:spMkLst>
        </pc:spChg>
        <pc:spChg chg="mod">
          <ac:chgData name="Chaffey, Jessica" userId="dfaac082-a21f-4bd8-8583-e2115658a55f" providerId="ADAL" clId="{286912FD-5411-469C-8AD3-0E9D5A939821}" dt="2021-03-29T15:24:08.648" v="39" actId="1076"/>
          <ac:spMkLst>
            <pc:docMk/>
            <pc:sldMk cId="557411176" sldId="260"/>
            <ac:spMk id="25" creationId="{79EAD1BF-2638-436C-806B-F14691971A8B}"/>
          </ac:spMkLst>
        </pc:spChg>
        <pc:spChg chg="mod">
          <ac:chgData name="Chaffey, Jessica" userId="dfaac082-a21f-4bd8-8583-e2115658a55f" providerId="ADAL" clId="{286912FD-5411-469C-8AD3-0E9D5A939821}" dt="2021-03-29T15:24:08.648" v="39" actId="1076"/>
          <ac:spMkLst>
            <pc:docMk/>
            <pc:sldMk cId="557411176" sldId="260"/>
            <ac:spMk id="26" creationId="{C98D49E6-843E-4B23-8B25-29F39F1CF8EA}"/>
          </ac:spMkLst>
        </pc:spChg>
        <pc:spChg chg="mod">
          <ac:chgData name="Chaffey, Jessica" userId="dfaac082-a21f-4bd8-8583-e2115658a55f" providerId="ADAL" clId="{286912FD-5411-469C-8AD3-0E9D5A939821}" dt="2021-03-29T15:24:08.648" v="39" actId="1076"/>
          <ac:spMkLst>
            <pc:docMk/>
            <pc:sldMk cId="557411176" sldId="260"/>
            <ac:spMk id="27" creationId="{23EF5FAA-7B79-42CC-9AA0-54D939258992}"/>
          </ac:spMkLst>
        </pc:spChg>
        <pc:spChg chg="add">
          <ac:chgData name="Chaffey, Jessica" userId="dfaac082-a21f-4bd8-8583-e2115658a55f" providerId="ADAL" clId="{286912FD-5411-469C-8AD3-0E9D5A939821}" dt="2021-03-29T15:24:28.117" v="49"/>
          <ac:spMkLst>
            <pc:docMk/>
            <pc:sldMk cId="557411176" sldId="260"/>
            <ac:spMk id="28" creationId="{C5E76836-1554-4437-9C22-FBF283D1909A}"/>
          </ac:spMkLst>
        </pc:spChg>
        <pc:picChg chg="mod">
          <ac:chgData name="Chaffey, Jessica" userId="dfaac082-a21f-4bd8-8583-e2115658a55f" providerId="ADAL" clId="{286912FD-5411-469C-8AD3-0E9D5A939821}" dt="2021-03-29T15:24:08.648" v="39" actId="1076"/>
          <ac:picMkLst>
            <pc:docMk/>
            <pc:sldMk cId="557411176" sldId="260"/>
            <ac:picMk id="4" creationId="{1F90A589-9177-442D-90FD-E4DB4F5BCE5C}"/>
          </ac:picMkLst>
        </pc:picChg>
        <pc:picChg chg="mod">
          <ac:chgData name="Chaffey, Jessica" userId="dfaac082-a21f-4bd8-8583-e2115658a55f" providerId="ADAL" clId="{286912FD-5411-469C-8AD3-0E9D5A939821}" dt="2021-03-29T15:24:08.648" v="39" actId="1076"/>
          <ac:picMkLst>
            <pc:docMk/>
            <pc:sldMk cId="557411176" sldId="260"/>
            <ac:picMk id="15" creationId="{EE56AE7D-CD99-4F7B-A146-69E0F72E7CBF}"/>
          </ac:picMkLst>
        </pc:picChg>
      </pc:sldChg>
      <pc:sldChg chg="addSp">
        <pc:chgData name="Chaffey, Jessica" userId="dfaac082-a21f-4bd8-8583-e2115658a55f" providerId="ADAL" clId="{286912FD-5411-469C-8AD3-0E9D5A939821}" dt="2021-03-29T15:24:32.252" v="50"/>
        <pc:sldMkLst>
          <pc:docMk/>
          <pc:sldMk cId="380026549" sldId="261"/>
        </pc:sldMkLst>
        <pc:spChg chg="add">
          <ac:chgData name="Chaffey, Jessica" userId="dfaac082-a21f-4bd8-8583-e2115658a55f" providerId="ADAL" clId="{286912FD-5411-469C-8AD3-0E9D5A939821}" dt="2021-03-29T15:24:32.252" v="50"/>
          <ac:spMkLst>
            <pc:docMk/>
            <pc:sldMk cId="380026549" sldId="261"/>
            <ac:spMk id="3" creationId="{26B347BB-F65A-40E1-8D44-25B2A0FE4554}"/>
          </ac:spMkLst>
        </pc:spChg>
      </pc:sldChg>
      <pc:sldChg chg="addSp">
        <pc:chgData name="Chaffey, Jessica" userId="dfaac082-a21f-4bd8-8583-e2115658a55f" providerId="ADAL" clId="{286912FD-5411-469C-8AD3-0E9D5A939821}" dt="2021-03-29T15:24:35.050" v="51"/>
        <pc:sldMkLst>
          <pc:docMk/>
          <pc:sldMk cId="3009793800" sldId="262"/>
        </pc:sldMkLst>
        <pc:spChg chg="add">
          <ac:chgData name="Chaffey, Jessica" userId="dfaac082-a21f-4bd8-8583-e2115658a55f" providerId="ADAL" clId="{286912FD-5411-469C-8AD3-0E9D5A939821}" dt="2021-03-29T15:24:35.050" v="51"/>
          <ac:spMkLst>
            <pc:docMk/>
            <pc:sldMk cId="3009793800" sldId="262"/>
            <ac:spMk id="3" creationId="{BE1CFE00-CAE3-46FD-8B8A-BFBFBB80273C}"/>
          </ac:spMkLst>
        </pc:spChg>
      </pc:sldChg>
      <pc:sldChg chg="addSp">
        <pc:chgData name="Chaffey, Jessica" userId="dfaac082-a21f-4bd8-8583-e2115658a55f" providerId="ADAL" clId="{286912FD-5411-469C-8AD3-0E9D5A939821}" dt="2021-03-29T15:24:39.291" v="52"/>
        <pc:sldMkLst>
          <pc:docMk/>
          <pc:sldMk cId="76243372" sldId="263"/>
        </pc:sldMkLst>
        <pc:spChg chg="add">
          <ac:chgData name="Chaffey, Jessica" userId="dfaac082-a21f-4bd8-8583-e2115658a55f" providerId="ADAL" clId="{286912FD-5411-469C-8AD3-0E9D5A939821}" dt="2021-03-29T15:24:39.291" v="52"/>
          <ac:spMkLst>
            <pc:docMk/>
            <pc:sldMk cId="76243372" sldId="263"/>
            <ac:spMk id="3" creationId="{4922D3A7-6C01-4E29-A660-CD5C4322C673}"/>
          </ac:spMkLst>
        </pc:spChg>
      </pc:sldChg>
      <pc:sldChg chg="addSp">
        <pc:chgData name="Chaffey, Jessica" userId="dfaac082-a21f-4bd8-8583-e2115658a55f" providerId="ADAL" clId="{286912FD-5411-469C-8AD3-0E9D5A939821}" dt="2021-03-29T15:24:43.738" v="53"/>
        <pc:sldMkLst>
          <pc:docMk/>
          <pc:sldMk cId="1781453486" sldId="264"/>
        </pc:sldMkLst>
        <pc:spChg chg="add">
          <ac:chgData name="Chaffey, Jessica" userId="dfaac082-a21f-4bd8-8583-e2115658a55f" providerId="ADAL" clId="{286912FD-5411-469C-8AD3-0E9D5A939821}" dt="2021-03-29T15:24:43.738" v="53"/>
          <ac:spMkLst>
            <pc:docMk/>
            <pc:sldMk cId="1781453486" sldId="264"/>
            <ac:spMk id="3" creationId="{FF20AF87-EC57-4E9F-88F2-8D82C2F1EC0C}"/>
          </ac:spMkLst>
        </pc:spChg>
      </pc:sldChg>
      <pc:sldChg chg="addSp">
        <pc:chgData name="Chaffey, Jessica" userId="dfaac082-a21f-4bd8-8583-e2115658a55f" providerId="ADAL" clId="{286912FD-5411-469C-8AD3-0E9D5A939821}" dt="2021-03-29T15:23:11.500" v="14"/>
        <pc:sldMkLst>
          <pc:docMk/>
          <pc:sldMk cId="3052797791" sldId="265"/>
        </pc:sldMkLst>
        <pc:spChg chg="add">
          <ac:chgData name="Chaffey, Jessica" userId="dfaac082-a21f-4bd8-8583-e2115658a55f" providerId="ADAL" clId="{286912FD-5411-469C-8AD3-0E9D5A939821}" dt="2021-03-29T15:23:11.500" v="14"/>
          <ac:spMkLst>
            <pc:docMk/>
            <pc:sldMk cId="3052797791" sldId="265"/>
            <ac:spMk id="15" creationId="{EFEDDA83-CC30-4A83-A92C-EB8A7C5A1C4E}"/>
          </ac:spMkLst>
        </pc:spChg>
      </pc:sldChg>
      <pc:sldChg chg="addSp modSp">
        <pc:chgData name="Chaffey, Jessica" userId="dfaac082-a21f-4bd8-8583-e2115658a55f" providerId="ADAL" clId="{286912FD-5411-469C-8AD3-0E9D5A939821}" dt="2021-03-29T15:22:44.430" v="9" actId="14100"/>
        <pc:sldMkLst>
          <pc:docMk/>
          <pc:sldMk cId="2282323561" sldId="267"/>
        </pc:sldMkLst>
        <pc:spChg chg="add mod">
          <ac:chgData name="Chaffey, Jessica" userId="dfaac082-a21f-4bd8-8583-e2115658a55f" providerId="ADAL" clId="{286912FD-5411-469C-8AD3-0E9D5A939821}" dt="2021-03-29T15:22:44.430" v="9" actId="14100"/>
          <ac:spMkLst>
            <pc:docMk/>
            <pc:sldMk cId="2282323561" sldId="267"/>
            <ac:spMk id="5" creationId="{975F7F80-18FD-4E74-A827-6ED5DB4615B2}"/>
          </ac:spMkLst>
        </pc:spChg>
      </pc:sldChg>
      <pc:sldChg chg="addSp modSp">
        <pc:chgData name="Chaffey, Jessica" userId="dfaac082-a21f-4bd8-8583-e2115658a55f" providerId="ADAL" clId="{286912FD-5411-469C-8AD3-0E9D5A939821}" dt="2021-03-29T15:22:56.966" v="11" actId="1076"/>
        <pc:sldMkLst>
          <pc:docMk/>
          <pc:sldMk cId="171246689" sldId="268"/>
        </pc:sldMkLst>
        <pc:spChg chg="add mod">
          <ac:chgData name="Chaffey, Jessica" userId="dfaac082-a21f-4bd8-8583-e2115658a55f" providerId="ADAL" clId="{286912FD-5411-469C-8AD3-0E9D5A939821}" dt="2021-03-29T15:22:56.966" v="11" actId="1076"/>
          <ac:spMkLst>
            <pc:docMk/>
            <pc:sldMk cId="171246689" sldId="268"/>
            <ac:spMk id="9" creationId="{7CC24D83-2869-4A0F-B805-7800429C219C}"/>
          </ac:spMkLst>
        </pc:spChg>
      </pc:sldChg>
      <pc:sldChg chg="addSp">
        <pc:chgData name="Chaffey, Jessica" userId="dfaac082-a21f-4bd8-8583-e2115658a55f" providerId="ADAL" clId="{286912FD-5411-469C-8AD3-0E9D5A939821}" dt="2021-03-29T15:22:59.718" v="12"/>
        <pc:sldMkLst>
          <pc:docMk/>
          <pc:sldMk cId="490872864" sldId="269"/>
        </pc:sldMkLst>
        <pc:spChg chg="add">
          <ac:chgData name="Chaffey, Jessica" userId="dfaac082-a21f-4bd8-8583-e2115658a55f" providerId="ADAL" clId="{286912FD-5411-469C-8AD3-0E9D5A939821}" dt="2021-03-29T15:22:59.718" v="12"/>
          <ac:spMkLst>
            <pc:docMk/>
            <pc:sldMk cId="490872864" sldId="269"/>
            <ac:spMk id="8" creationId="{5BF8C513-761B-4EE0-AF7D-1ACC7C293818}"/>
          </ac:spMkLst>
        </pc:spChg>
      </pc:sldChg>
      <pc:sldChg chg="addSp">
        <pc:chgData name="Chaffey, Jessica" userId="dfaac082-a21f-4bd8-8583-e2115658a55f" providerId="ADAL" clId="{286912FD-5411-469C-8AD3-0E9D5A939821}" dt="2021-03-29T15:23:02.026" v="13"/>
        <pc:sldMkLst>
          <pc:docMk/>
          <pc:sldMk cId="2694848396" sldId="270"/>
        </pc:sldMkLst>
        <pc:spChg chg="add">
          <ac:chgData name="Chaffey, Jessica" userId="dfaac082-a21f-4bd8-8583-e2115658a55f" providerId="ADAL" clId="{286912FD-5411-469C-8AD3-0E9D5A939821}" dt="2021-03-29T15:23:02.026" v="13"/>
          <ac:spMkLst>
            <pc:docMk/>
            <pc:sldMk cId="2694848396" sldId="270"/>
            <ac:spMk id="8" creationId="{08444670-3348-49EE-A102-7094F6737757}"/>
          </ac:spMkLst>
        </pc:spChg>
      </pc:sldChg>
    </pc:docChg>
  </pc:docChgLst>
  <pc:docChgLst>
    <pc:chgData name="Jessica" userId="dfaac082-a21f-4bd8-8583-e2115658a55f" providerId="ADAL" clId="{0826C407-A27E-49D6-A5F0-3C0403B96868}"/>
    <pc:docChg chg="undo custSel addSld modSld">
      <pc:chgData name="Jessica" userId="dfaac082-a21f-4bd8-8583-e2115658a55f" providerId="ADAL" clId="{0826C407-A27E-49D6-A5F0-3C0403B96868}" dt="2021-05-20T14:05:20.147" v="1039" actId="478"/>
      <pc:docMkLst>
        <pc:docMk/>
      </pc:docMkLst>
      <pc:sldChg chg="addSp modSp">
        <pc:chgData name="Jessica" userId="dfaac082-a21f-4bd8-8583-e2115658a55f" providerId="ADAL" clId="{0826C407-A27E-49D6-A5F0-3C0403B96868}" dt="2021-05-20T13:29:44.521" v="199" actId="14100"/>
        <pc:sldMkLst>
          <pc:docMk/>
          <pc:sldMk cId="3649101259" sldId="257"/>
        </pc:sldMkLst>
        <pc:spChg chg="add mod">
          <ac:chgData name="Jessica" userId="dfaac082-a21f-4bd8-8583-e2115658a55f" providerId="ADAL" clId="{0826C407-A27E-49D6-A5F0-3C0403B96868}" dt="2021-05-20T13:29:05.931" v="187" actId="14100"/>
          <ac:spMkLst>
            <pc:docMk/>
            <pc:sldMk cId="3649101259" sldId="257"/>
            <ac:spMk id="68" creationId="{E0CC4925-67C1-4703-BAF3-D8469FE1D7C4}"/>
          </ac:spMkLst>
        </pc:spChg>
        <pc:spChg chg="add mod">
          <ac:chgData name="Jessica" userId="dfaac082-a21f-4bd8-8583-e2115658a55f" providerId="ADAL" clId="{0826C407-A27E-49D6-A5F0-3C0403B96868}" dt="2021-05-20T13:29:20.647" v="194" actId="14100"/>
          <ac:spMkLst>
            <pc:docMk/>
            <pc:sldMk cId="3649101259" sldId="257"/>
            <ac:spMk id="69" creationId="{F278D4C9-0FDB-4FC9-8E26-1CA434A31994}"/>
          </ac:spMkLst>
        </pc:spChg>
        <pc:spChg chg="add mod">
          <ac:chgData name="Jessica" userId="dfaac082-a21f-4bd8-8583-e2115658a55f" providerId="ADAL" clId="{0826C407-A27E-49D6-A5F0-3C0403B96868}" dt="2021-05-20T13:29:44.521" v="199" actId="14100"/>
          <ac:spMkLst>
            <pc:docMk/>
            <pc:sldMk cId="3649101259" sldId="257"/>
            <ac:spMk id="70" creationId="{91E34816-7EEA-461E-84A8-56E5AD1F9E5A}"/>
          </ac:spMkLst>
        </pc:spChg>
        <pc:picChg chg="mod">
          <ac:chgData name="Jessica" userId="dfaac082-a21f-4bd8-8583-e2115658a55f" providerId="ADAL" clId="{0826C407-A27E-49D6-A5F0-3C0403B96868}" dt="2021-05-20T13:29:09.497" v="190" actId="1076"/>
          <ac:picMkLst>
            <pc:docMk/>
            <pc:sldMk cId="3649101259" sldId="257"/>
            <ac:picMk id="4" creationId="{18EF230E-DBC8-43C3-9745-5737EB35B7B1}"/>
          </ac:picMkLst>
        </pc:picChg>
      </pc:sldChg>
      <pc:sldChg chg="addSp modSp">
        <pc:chgData name="Jessica" userId="dfaac082-a21f-4bd8-8583-e2115658a55f" providerId="ADAL" clId="{0826C407-A27E-49D6-A5F0-3C0403B96868}" dt="2021-05-20T13:42:37.626" v="536" actId="555"/>
        <pc:sldMkLst>
          <pc:docMk/>
          <pc:sldMk cId="522916658" sldId="258"/>
        </pc:sldMkLst>
        <pc:spChg chg="mod">
          <ac:chgData name="Jessica" userId="dfaac082-a21f-4bd8-8583-e2115658a55f" providerId="ADAL" clId="{0826C407-A27E-49D6-A5F0-3C0403B96868}" dt="2021-05-20T13:42:30.996" v="535" actId="554"/>
          <ac:spMkLst>
            <pc:docMk/>
            <pc:sldMk cId="522916658" sldId="258"/>
            <ac:spMk id="6" creationId="{5706B450-F7F8-4ACB-9BC4-0645E5339BEA}"/>
          </ac:spMkLst>
        </pc:spChg>
        <pc:spChg chg="mod">
          <ac:chgData name="Jessica" userId="dfaac082-a21f-4bd8-8583-e2115658a55f" providerId="ADAL" clId="{0826C407-A27E-49D6-A5F0-3C0403B96868}" dt="2021-05-20T13:42:30.996" v="535" actId="554"/>
          <ac:spMkLst>
            <pc:docMk/>
            <pc:sldMk cId="522916658" sldId="258"/>
            <ac:spMk id="7" creationId="{67C5BC4B-67ED-415F-AE68-518C4B3CC63C}"/>
          </ac:spMkLst>
        </pc:spChg>
        <pc:spChg chg="mod">
          <ac:chgData name="Jessica" userId="dfaac082-a21f-4bd8-8583-e2115658a55f" providerId="ADAL" clId="{0826C407-A27E-49D6-A5F0-3C0403B96868}" dt="2021-05-20T13:42:30.996" v="535" actId="554"/>
          <ac:spMkLst>
            <pc:docMk/>
            <pc:sldMk cId="522916658" sldId="258"/>
            <ac:spMk id="8" creationId="{67BA5397-BC9D-4A7F-AB2A-AB0B3255E1ED}"/>
          </ac:spMkLst>
        </pc:spChg>
        <pc:spChg chg="mod">
          <ac:chgData name="Jessica" userId="dfaac082-a21f-4bd8-8583-e2115658a55f" providerId="ADAL" clId="{0826C407-A27E-49D6-A5F0-3C0403B96868}" dt="2021-05-20T13:42:30.996" v="535" actId="554"/>
          <ac:spMkLst>
            <pc:docMk/>
            <pc:sldMk cId="522916658" sldId="258"/>
            <ac:spMk id="9" creationId="{6DFD72DB-F095-4A11-803D-25B7FC327208}"/>
          </ac:spMkLst>
        </pc:spChg>
        <pc:spChg chg="mod">
          <ac:chgData name="Jessica" userId="dfaac082-a21f-4bd8-8583-e2115658a55f" providerId="ADAL" clId="{0826C407-A27E-49D6-A5F0-3C0403B96868}" dt="2021-05-20T13:42:37.626" v="536" actId="555"/>
          <ac:spMkLst>
            <pc:docMk/>
            <pc:sldMk cId="522916658" sldId="258"/>
            <ac:spMk id="10" creationId="{3D46EE09-3BF4-4C6E-9590-32BFBAFAA943}"/>
          </ac:spMkLst>
        </pc:spChg>
        <pc:spChg chg="mod">
          <ac:chgData name="Jessica" userId="dfaac082-a21f-4bd8-8583-e2115658a55f" providerId="ADAL" clId="{0826C407-A27E-49D6-A5F0-3C0403B96868}" dt="2021-05-20T13:42:37.626" v="536" actId="555"/>
          <ac:spMkLst>
            <pc:docMk/>
            <pc:sldMk cId="522916658" sldId="258"/>
            <ac:spMk id="11" creationId="{D204E8DF-0A6D-45CA-9346-F29771229BFA}"/>
          </ac:spMkLst>
        </pc:spChg>
        <pc:spChg chg="mod">
          <ac:chgData name="Jessica" userId="dfaac082-a21f-4bd8-8583-e2115658a55f" providerId="ADAL" clId="{0826C407-A27E-49D6-A5F0-3C0403B96868}" dt="2021-05-20T13:42:37.626" v="536" actId="555"/>
          <ac:spMkLst>
            <pc:docMk/>
            <pc:sldMk cId="522916658" sldId="258"/>
            <ac:spMk id="12" creationId="{C8B08D6E-8E4A-48F8-BACA-49E97DC1BED6}"/>
          </ac:spMkLst>
        </pc:spChg>
        <pc:spChg chg="mod">
          <ac:chgData name="Jessica" userId="dfaac082-a21f-4bd8-8583-e2115658a55f" providerId="ADAL" clId="{0826C407-A27E-49D6-A5F0-3C0403B96868}" dt="2021-05-20T13:42:37.626" v="536" actId="555"/>
          <ac:spMkLst>
            <pc:docMk/>
            <pc:sldMk cId="522916658" sldId="258"/>
            <ac:spMk id="13" creationId="{25113076-6C5F-4488-B273-957250922A40}"/>
          </ac:spMkLst>
        </pc:spChg>
        <pc:spChg chg="mod">
          <ac:chgData name="Jessica" userId="dfaac082-a21f-4bd8-8583-e2115658a55f" providerId="ADAL" clId="{0826C407-A27E-49D6-A5F0-3C0403B96868}" dt="2021-05-20T13:42:37.626" v="536" actId="555"/>
          <ac:spMkLst>
            <pc:docMk/>
            <pc:sldMk cId="522916658" sldId="258"/>
            <ac:spMk id="14" creationId="{A64E0CC3-0968-41F5-B7C8-3088A48DBE6C}"/>
          </ac:spMkLst>
        </pc:spChg>
        <pc:spChg chg="mod">
          <ac:chgData name="Jessica" userId="dfaac082-a21f-4bd8-8583-e2115658a55f" providerId="ADAL" clId="{0826C407-A27E-49D6-A5F0-3C0403B96868}" dt="2021-05-20T13:42:37.626" v="536" actId="555"/>
          <ac:spMkLst>
            <pc:docMk/>
            <pc:sldMk cId="522916658" sldId="258"/>
            <ac:spMk id="15" creationId="{89633343-22A7-40D5-9F27-4F6B1DC914A3}"/>
          </ac:spMkLst>
        </pc:spChg>
        <pc:spChg chg="mod">
          <ac:chgData name="Jessica" userId="dfaac082-a21f-4bd8-8583-e2115658a55f" providerId="ADAL" clId="{0826C407-A27E-49D6-A5F0-3C0403B96868}" dt="2021-05-20T13:42:37.626" v="536" actId="555"/>
          <ac:spMkLst>
            <pc:docMk/>
            <pc:sldMk cId="522916658" sldId="258"/>
            <ac:spMk id="16" creationId="{87C73515-432D-4629-B93E-E64D20F5A6CB}"/>
          </ac:spMkLst>
        </pc:spChg>
        <pc:spChg chg="mod">
          <ac:chgData name="Jessica" userId="dfaac082-a21f-4bd8-8583-e2115658a55f" providerId="ADAL" clId="{0826C407-A27E-49D6-A5F0-3C0403B96868}" dt="2021-05-20T13:42:37.626" v="536" actId="555"/>
          <ac:spMkLst>
            <pc:docMk/>
            <pc:sldMk cId="522916658" sldId="258"/>
            <ac:spMk id="17" creationId="{BF7E7D3A-C5D7-4685-9FB4-9B39124F7BE0}"/>
          </ac:spMkLst>
        </pc:spChg>
        <pc:spChg chg="mod">
          <ac:chgData name="Jessica" userId="dfaac082-a21f-4bd8-8583-e2115658a55f" providerId="ADAL" clId="{0826C407-A27E-49D6-A5F0-3C0403B96868}" dt="2021-05-20T13:42:30.996" v="535" actId="554"/>
          <ac:spMkLst>
            <pc:docMk/>
            <pc:sldMk cId="522916658" sldId="258"/>
            <ac:spMk id="18" creationId="{03AC32C5-D4FA-4746-9420-11052E7C9135}"/>
          </ac:spMkLst>
        </pc:spChg>
        <pc:spChg chg="mod">
          <ac:chgData name="Jessica" userId="dfaac082-a21f-4bd8-8583-e2115658a55f" providerId="ADAL" clId="{0826C407-A27E-49D6-A5F0-3C0403B96868}" dt="2021-05-20T13:42:37.626" v="536" actId="555"/>
          <ac:spMkLst>
            <pc:docMk/>
            <pc:sldMk cId="522916658" sldId="258"/>
            <ac:spMk id="19" creationId="{5352CDC3-673E-4DCB-8F83-95474C643E6D}"/>
          </ac:spMkLst>
        </pc:spChg>
        <pc:spChg chg="mod">
          <ac:chgData name="Jessica" userId="dfaac082-a21f-4bd8-8583-e2115658a55f" providerId="ADAL" clId="{0826C407-A27E-49D6-A5F0-3C0403B96868}" dt="2021-05-20T13:42:37.626" v="536" actId="555"/>
          <ac:spMkLst>
            <pc:docMk/>
            <pc:sldMk cId="522916658" sldId="258"/>
            <ac:spMk id="20" creationId="{130F74F1-3CD6-4CBE-B06B-08B2DC661721}"/>
          </ac:spMkLst>
        </pc:spChg>
        <pc:spChg chg="mod">
          <ac:chgData name="Jessica" userId="dfaac082-a21f-4bd8-8583-e2115658a55f" providerId="ADAL" clId="{0826C407-A27E-49D6-A5F0-3C0403B96868}" dt="2021-05-20T13:42:30.996" v="535" actId="554"/>
          <ac:spMkLst>
            <pc:docMk/>
            <pc:sldMk cId="522916658" sldId="258"/>
            <ac:spMk id="21" creationId="{49705378-47BF-4CE3-BA83-554E3DF59E72}"/>
          </ac:spMkLst>
        </pc:spChg>
        <pc:spChg chg="mod">
          <ac:chgData name="Jessica" userId="dfaac082-a21f-4bd8-8583-e2115658a55f" providerId="ADAL" clId="{0826C407-A27E-49D6-A5F0-3C0403B96868}" dt="2021-05-20T13:42:37.626" v="536" actId="555"/>
          <ac:spMkLst>
            <pc:docMk/>
            <pc:sldMk cId="522916658" sldId="258"/>
            <ac:spMk id="22" creationId="{FF1EE082-AA38-44BA-961E-18C8C0729E03}"/>
          </ac:spMkLst>
        </pc:spChg>
        <pc:spChg chg="mod">
          <ac:chgData name="Jessica" userId="dfaac082-a21f-4bd8-8583-e2115658a55f" providerId="ADAL" clId="{0826C407-A27E-49D6-A5F0-3C0403B96868}" dt="2021-05-20T13:42:37.626" v="536" actId="555"/>
          <ac:spMkLst>
            <pc:docMk/>
            <pc:sldMk cId="522916658" sldId="258"/>
            <ac:spMk id="23" creationId="{A785D915-1B6E-4E4F-A84A-F3A0435C8723}"/>
          </ac:spMkLst>
        </pc:spChg>
        <pc:spChg chg="mod">
          <ac:chgData name="Jessica" userId="dfaac082-a21f-4bd8-8583-e2115658a55f" providerId="ADAL" clId="{0826C407-A27E-49D6-A5F0-3C0403B96868}" dt="2021-05-20T13:42:30.996" v="535" actId="554"/>
          <ac:spMkLst>
            <pc:docMk/>
            <pc:sldMk cId="522916658" sldId="258"/>
            <ac:spMk id="25" creationId="{EC858264-1409-4404-957E-763A4B3F0E0A}"/>
          </ac:spMkLst>
        </pc:spChg>
        <pc:spChg chg="mod">
          <ac:chgData name="Jessica" userId="dfaac082-a21f-4bd8-8583-e2115658a55f" providerId="ADAL" clId="{0826C407-A27E-49D6-A5F0-3C0403B96868}" dt="2021-05-20T13:42:30.996" v="535" actId="554"/>
          <ac:spMkLst>
            <pc:docMk/>
            <pc:sldMk cId="522916658" sldId="258"/>
            <ac:spMk id="26" creationId="{47B6BAF9-E731-4FA6-BC67-891D0BD5776E}"/>
          </ac:spMkLst>
        </pc:spChg>
        <pc:spChg chg="mod">
          <ac:chgData name="Jessica" userId="dfaac082-a21f-4bd8-8583-e2115658a55f" providerId="ADAL" clId="{0826C407-A27E-49D6-A5F0-3C0403B96868}" dt="2021-05-20T13:42:30.996" v="535" actId="554"/>
          <ac:spMkLst>
            <pc:docMk/>
            <pc:sldMk cId="522916658" sldId="258"/>
            <ac:spMk id="27" creationId="{5E82A31F-361A-4EE8-8C4D-69E09FFDD096}"/>
          </ac:spMkLst>
        </pc:spChg>
        <pc:spChg chg="mod">
          <ac:chgData name="Jessica" userId="dfaac082-a21f-4bd8-8583-e2115658a55f" providerId="ADAL" clId="{0826C407-A27E-49D6-A5F0-3C0403B96868}" dt="2021-05-20T13:42:37.626" v="536" actId="555"/>
          <ac:spMkLst>
            <pc:docMk/>
            <pc:sldMk cId="522916658" sldId="258"/>
            <ac:spMk id="28" creationId="{832276C8-7D8E-4E99-BB5B-0172EA1BB2FB}"/>
          </ac:spMkLst>
        </pc:spChg>
        <pc:spChg chg="mod">
          <ac:chgData name="Jessica" userId="dfaac082-a21f-4bd8-8583-e2115658a55f" providerId="ADAL" clId="{0826C407-A27E-49D6-A5F0-3C0403B96868}" dt="2021-05-20T13:42:37.626" v="536" actId="555"/>
          <ac:spMkLst>
            <pc:docMk/>
            <pc:sldMk cId="522916658" sldId="258"/>
            <ac:spMk id="29" creationId="{E541D877-AB6E-4F12-9068-680D42AAC77B}"/>
          </ac:spMkLst>
        </pc:spChg>
        <pc:spChg chg="mod">
          <ac:chgData name="Jessica" userId="dfaac082-a21f-4bd8-8583-e2115658a55f" providerId="ADAL" clId="{0826C407-A27E-49D6-A5F0-3C0403B96868}" dt="2021-05-20T13:42:37.626" v="536" actId="555"/>
          <ac:spMkLst>
            <pc:docMk/>
            <pc:sldMk cId="522916658" sldId="258"/>
            <ac:spMk id="30" creationId="{251BEF14-38D4-4857-8A56-D9A7327DF2A5}"/>
          </ac:spMkLst>
        </pc:spChg>
        <pc:spChg chg="mod">
          <ac:chgData name="Jessica" userId="dfaac082-a21f-4bd8-8583-e2115658a55f" providerId="ADAL" clId="{0826C407-A27E-49D6-A5F0-3C0403B96868}" dt="2021-05-20T13:42:37.626" v="536" actId="555"/>
          <ac:spMkLst>
            <pc:docMk/>
            <pc:sldMk cId="522916658" sldId="258"/>
            <ac:spMk id="31" creationId="{1244EEB3-886F-4300-9532-111D508F881A}"/>
          </ac:spMkLst>
        </pc:spChg>
        <pc:spChg chg="mod">
          <ac:chgData name="Jessica" userId="dfaac082-a21f-4bd8-8583-e2115658a55f" providerId="ADAL" clId="{0826C407-A27E-49D6-A5F0-3C0403B96868}" dt="2021-05-20T13:42:37.626" v="536" actId="555"/>
          <ac:spMkLst>
            <pc:docMk/>
            <pc:sldMk cId="522916658" sldId="258"/>
            <ac:spMk id="32" creationId="{3118FC25-F021-41D1-BD18-FB07CCFAC0E3}"/>
          </ac:spMkLst>
        </pc:spChg>
        <pc:spChg chg="mod">
          <ac:chgData name="Jessica" userId="dfaac082-a21f-4bd8-8583-e2115658a55f" providerId="ADAL" clId="{0826C407-A27E-49D6-A5F0-3C0403B96868}" dt="2021-05-20T13:42:37.626" v="536" actId="555"/>
          <ac:spMkLst>
            <pc:docMk/>
            <pc:sldMk cId="522916658" sldId="258"/>
            <ac:spMk id="33" creationId="{99008338-1F17-4D9D-8FCC-FE00C16118BD}"/>
          </ac:spMkLst>
        </pc:spChg>
        <pc:spChg chg="mod">
          <ac:chgData name="Jessica" userId="dfaac082-a21f-4bd8-8583-e2115658a55f" providerId="ADAL" clId="{0826C407-A27E-49D6-A5F0-3C0403B96868}" dt="2021-05-20T13:42:30.996" v="535" actId="554"/>
          <ac:spMkLst>
            <pc:docMk/>
            <pc:sldMk cId="522916658" sldId="258"/>
            <ac:spMk id="34" creationId="{32444ACB-7468-4EAE-99D5-2904564C28F4}"/>
          </ac:spMkLst>
        </pc:spChg>
        <pc:spChg chg="mod">
          <ac:chgData name="Jessica" userId="dfaac082-a21f-4bd8-8583-e2115658a55f" providerId="ADAL" clId="{0826C407-A27E-49D6-A5F0-3C0403B96868}" dt="2021-05-20T13:42:37.626" v="536" actId="555"/>
          <ac:spMkLst>
            <pc:docMk/>
            <pc:sldMk cId="522916658" sldId="258"/>
            <ac:spMk id="35" creationId="{CBFAC5C9-3972-4C43-BB5B-7F96D305E65F}"/>
          </ac:spMkLst>
        </pc:spChg>
        <pc:spChg chg="mod">
          <ac:chgData name="Jessica" userId="dfaac082-a21f-4bd8-8583-e2115658a55f" providerId="ADAL" clId="{0826C407-A27E-49D6-A5F0-3C0403B96868}" dt="2021-05-20T13:42:37.626" v="536" actId="555"/>
          <ac:spMkLst>
            <pc:docMk/>
            <pc:sldMk cId="522916658" sldId="258"/>
            <ac:spMk id="36" creationId="{17538B01-CFB8-4C7C-ACEF-7CC01FD0EC6D}"/>
          </ac:spMkLst>
        </pc:spChg>
        <pc:spChg chg="mod">
          <ac:chgData name="Jessica" userId="dfaac082-a21f-4bd8-8583-e2115658a55f" providerId="ADAL" clId="{0826C407-A27E-49D6-A5F0-3C0403B96868}" dt="2021-05-20T13:42:30.996" v="535" actId="554"/>
          <ac:spMkLst>
            <pc:docMk/>
            <pc:sldMk cId="522916658" sldId="258"/>
            <ac:spMk id="37" creationId="{1E89C4D6-CEDA-471D-9EB9-D60C484D238D}"/>
          </ac:spMkLst>
        </pc:spChg>
        <pc:spChg chg="mod">
          <ac:chgData name="Jessica" userId="dfaac082-a21f-4bd8-8583-e2115658a55f" providerId="ADAL" clId="{0826C407-A27E-49D6-A5F0-3C0403B96868}" dt="2021-05-20T13:42:30.996" v="535" actId="554"/>
          <ac:spMkLst>
            <pc:docMk/>
            <pc:sldMk cId="522916658" sldId="258"/>
            <ac:spMk id="38" creationId="{9B5F1552-A785-48F0-980E-F8ECFAA801FE}"/>
          </ac:spMkLst>
        </pc:spChg>
        <pc:spChg chg="mod">
          <ac:chgData name="Jessica" userId="dfaac082-a21f-4bd8-8583-e2115658a55f" providerId="ADAL" clId="{0826C407-A27E-49D6-A5F0-3C0403B96868}" dt="2021-05-20T13:42:37.626" v="536" actId="555"/>
          <ac:spMkLst>
            <pc:docMk/>
            <pc:sldMk cId="522916658" sldId="258"/>
            <ac:spMk id="39" creationId="{C835F853-9D83-4C49-82BF-080E171E0A31}"/>
          </ac:spMkLst>
        </pc:spChg>
        <pc:spChg chg="mod">
          <ac:chgData name="Jessica" userId="dfaac082-a21f-4bd8-8583-e2115658a55f" providerId="ADAL" clId="{0826C407-A27E-49D6-A5F0-3C0403B96868}" dt="2021-05-20T13:42:37.626" v="536" actId="555"/>
          <ac:spMkLst>
            <pc:docMk/>
            <pc:sldMk cId="522916658" sldId="258"/>
            <ac:spMk id="40" creationId="{E23ED911-0D74-42FD-B28D-A5134A419076}"/>
          </ac:spMkLst>
        </pc:spChg>
        <pc:spChg chg="mod">
          <ac:chgData name="Jessica" userId="dfaac082-a21f-4bd8-8583-e2115658a55f" providerId="ADAL" clId="{0826C407-A27E-49D6-A5F0-3C0403B96868}" dt="2021-05-20T13:42:37.626" v="536" actId="555"/>
          <ac:spMkLst>
            <pc:docMk/>
            <pc:sldMk cId="522916658" sldId="258"/>
            <ac:spMk id="41" creationId="{1E034FBF-094A-4FB9-9BDE-8514D2B033CE}"/>
          </ac:spMkLst>
        </pc:spChg>
        <pc:spChg chg="mod">
          <ac:chgData name="Jessica" userId="dfaac082-a21f-4bd8-8583-e2115658a55f" providerId="ADAL" clId="{0826C407-A27E-49D6-A5F0-3C0403B96868}" dt="2021-05-20T13:42:37.626" v="536" actId="555"/>
          <ac:spMkLst>
            <pc:docMk/>
            <pc:sldMk cId="522916658" sldId="258"/>
            <ac:spMk id="42" creationId="{203BC7A1-93FE-4562-B2B4-B04D1E417743}"/>
          </ac:spMkLst>
        </pc:spChg>
        <pc:spChg chg="add mod">
          <ac:chgData name="Jessica" userId="dfaac082-a21f-4bd8-8583-e2115658a55f" providerId="ADAL" clId="{0826C407-A27E-49D6-A5F0-3C0403B96868}" dt="2021-05-20T13:41:23.533" v="524" actId="14100"/>
          <ac:spMkLst>
            <pc:docMk/>
            <pc:sldMk cId="522916658" sldId="258"/>
            <ac:spMk id="50" creationId="{045FEDB7-19B6-4172-BC39-BB2E3813C150}"/>
          </ac:spMkLst>
        </pc:spChg>
        <pc:spChg chg="add mod">
          <ac:chgData name="Jessica" userId="dfaac082-a21f-4bd8-8583-e2115658a55f" providerId="ADAL" clId="{0826C407-A27E-49D6-A5F0-3C0403B96868}" dt="2021-05-20T13:41:55.795" v="529" actId="14100"/>
          <ac:spMkLst>
            <pc:docMk/>
            <pc:sldMk cId="522916658" sldId="258"/>
            <ac:spMk id="51" creationId="{CAE1A27C-EB38-4C84-881F-86B9D87C7978}"/>
          </ac:spMkLst>
        </pc:spChg>
        <pc:spChg chg="add mod">
          <ac:chgData name="Jessica" userId="dfaac082-a21f-4bd8-8583-e2115658a55f" providerId="ADAL" clId="{0826C407-A27E-49D6-A5F0-3C0403B96868}" dt="2021-05-20T13:42:02.539" v="532" actId="14100"/>
          <ac:spMkLst>
            <pc:docMk/>
            <pc:sldMk cId="522916658" sldId="258"/>
            <ac:spMk id="52" creationId="{388EFC82-DA86-4486-B09A-BFAF5279C679}"/>
          </ac:spMkLst>
        </pc:spChg>
      </pc:sldChg>
      <pc:sldChg chg="addSp modSp">
        <pc:chgData name="Jessica" userId="dfaac082-a21f-4bd8-8583-e2115658a55f" providerId="ADAL" clId="{0826C407-A27E-49D6-A5F0-3C0403B96868}" dt="2021-05-20T13:44:28.889" v="541" actId="1076"/>
        <pc:sldMkLst>
          <pc:docMk/>
          <pc:sldMk cId="3147858600" sldId="259"/>
        </pc:sldMkLst>
        <pc:spChg chg="add mod">
          <ac:chgData name="Jessica" userId="dfaac082-a21f-4bd8-8583-e2115658a55f" providerId="ADAL" clId="{0826C407-A27E-49D6-A5F0-3C0403B96868}" dt="2021-05-20T13:44:24.592" v="539" actId="14100"/>
          <ac:spMkLst>
            <pc:docMk/>
            <pc:sldMk cId="3147858600" sldId="259"/>
            <ac:spMk id="34" creationId="{53E466D2-7E6E-417D-857C-06EEDB64BAE8}"/>
          </ac:spMkLst>
        </pc:spChg>
        <pc:spChg chg="add mod">
          <ac:chgData name="Jessica" userId="dfaac082-a21f-4bd8-8583-e2115658a55f" providerId="ADAL" clId="{0826C407-A27E-49D6-A5F0-3C0403B96868}" dt="2021-05-20T13:44:28.889" v="541" actId="1076"/>
          <ac:spMkLst>
            <pc:docMk/>
            <pc:sldMk cId="3147858600" sldId="259"/>
            <ac:spMk id="35" creationId="{C6BE788D-8C8A-433B-A229-CCCEF5AAB255}"/>
          </ac:spMkLst>
        </pc:spChg>
      </pc:sldChg>
      <pc:sldChg chg="addSp modSp">
        <pc:chgData name="Jessica" userId="dfaac082-a21f-4bd8-8583-e2115658a55f" providerId="ADAL" clId="{0826C407-A27E-49D6-A5F0-3C0403B96868}" dt="2021-05-20T13:44:57.158" v="552" actId="14100"/>
        <pc:sldMkLst>
          <pc:docMk/>
          <pc:sldMk cId="557411176" sldId="260"/>
        </pc:sldMkLst>
        <pc:spChg chg="add mod">
          <ac:chgData name="Jessica" userId="dfaac082-a21f-4bd8-8583-e2115658a55f" providerId="ADAL" clId="{0826C407-A27E-49D6-A5F0-3C0403B96868}" dt="2021-05-20T13:44:38.259" v="544" actId="14100"/>
          <ac:spMkLst>
            <pc:docMk/>
            <pc:sldMk cId="557411176" sldId="260"/>
            <ac:spMk id="29" creationId="{0842B428-4877-4535-B452-FE9C1A07DD2C}"/>
          </ac:spMkLst>
        </pc:spChg>
        <pc:spChg chg="add mod">
          <ac:chgData name="Jessica" userId="dfaac082-a21f-4bd8-8583-e2115658a55f" providerId="ADAL" clId="{0826C407-A27E-49D6-A5F0-3C0403B96868}" dt="2021-05-20T13:44:57.158" v="552" actId="14100"/>
          <ac:spMkLst>
            <pc:docMk/>
            <pc:sldMk cId="557411176" sldId="260"/>
            <ac:spMk id="30" creationId="{3D05118E-9DE6-43C0-B07E-7E27163D3CAA}"/>
          </ac:spMkLst>
        </pc:spChg>
        <pc:picChg chg="mod">
          <ac:chgData name="Jessica" userId="dfaac082-a21f-4bd8-8583-e2115658a55f" providerId="ADAL" clId="{0826C407-A27E-49D6-A5F0-3C0403B96868}" dt="2021-05-20T13:44:48.822" v="549" actId="1076"/>
          <ac:picMkLst>
            <pc:docMk/>
            <pc:sldMk cId="557411176" sldId="260"/>
            <ac:picMk id="4" creationId="{1F90A589-9177-442D-90FD-E4DB4F5BCE5C}"/>
          </ac:picMkLst>
        </pc:picChg>
      </pc:sldChg>
      <pc:sldChg chg="addSp modSp">
        <pc:chgData name="Jessica" userId="dfaac082-a21f-4bd8-8583-e2115658a55f" providerId="ADAL" clId="{0826C407-A27E-49D6-A5F0-3C0403B96868}" dt="2021-05-20T13:46:42.376" v="567" actId="688"/>
        <pc:sldMkLst>
          <pc:docMk/>
          <pc:sldMk cId="380026549" sldId="261"/>
        </pc:sldMkLst>
        <pc:spChg chg="add mod">
          <ac:chgData name="Jessica" userId="dfaac082-a21f-4bd8-8583-e2115658a55f" providerId="ADAL" clId="{0826C407-A27E-49D6-A5F0-3C0403B96868}" dt="2021-05-20T13:45:46.710" v="557" actId="14100"/>
          <ac:spMkLst>
            <pc:docMk/>
            <pc:sldMk cId="380026549" sldId="261"/>
            <ac:spMk id="8" creationId="{495B253B-9299-4A44-9BC8-EFA9B3FA0EFD}"/>
          </ac:spMkLst>
        </pc:spChg>
        <pc:spChg chg="add mod">
          <ac:chgData name="Jessica" userId="dfaac082-a21f-4bd8-8583-e2115658a55f" providerId="ADAL" clId="{0826C407-A27E-49D6-A5F0-3C0403B96868}" dt="2021-05-20T13:46:16.596" v="562" actId="14100"/>
          <ac:spMkLst>
            <pc:docMk/>
            <pc:sldMk cId="380026549" sldId="261"/>
            <ac:spMk id="9" creationId="{1C4356D3-ED53-4454-8D8C-B4919EF6472B}"/>
          </ac:spMkLst>
        </pc:spChg>
        <pc:picChg chg="mod">
          <ac:chgData name="Jessica" userId="dfaac082-a21f-4bd8-8583-e2115658a55f" providerId="ADAL" clId="{0826C407-A27E-49D6-A5F0-3C0403B96868}" dt="2021-05-20T13:46:42.376" v="567" actId="688"/>
          <ac:picMkLst>
            <pc:docMk/>
            <pc:sldMk cId="380026549" sldId="261"/>
            <ac:picMk id="6" creationId="{F0CD575D-E64B-440A-B624-B16F0BF59340}"/>
          </ac:picMkLst>
        </pc:picChg>
      </pc:sldChg>
      <pc:sldChg chg="addSp modSp">
        <pc:chgData name="Jessica" userId="dfaac082-a21f-4bd8-8583-e2115658a55f" providerId="ADAL" clId="{0826C407-A27E-49D6-A5F0-3C0403B96868}" dt="2021-05-20T13:47:03.767" v="575" actId="14100"/>
        <pc:sldMkLst>
          <pc:docMk/>
          <pc:sldMk cId="76243372" sldId="263"/>
        </pc:sldMkLst>
        <pc:spChg chg="add mod">
          <ac:chgData name="Jessica" userId="dfaac082-a21f-4bd8-8583-e2115658a55f" providerId="ADAL" clId="{0826C407-A27E-49D6-A5F0-3C0403B96868}" dt="2021-05-20T13:46:52.602" v="570" actId="14100"/>
          <ac:spMkLst>
            <pc:docMk/>
            <pc:sldMk cId="76243372" sldId="263"/>
            <ac:spMk id="9" creationId="{88D9E5FE-B478-41A8-AEFC-C1601C50A723}"/>
          </ac:spMkLst>
        </pc:spChg>
        <pc:spChg chg="add mod">
          <ac:chgData name="Jessica" userId="dfaac082-a21f-4bd8-8583-e2115658a55f" providerId="ADAL" clId="{0826C407-A27E-49D6-A5F0-3C0403B96868}" dt="2021-05-20T13:46:57.090" v="572" actId="1076"/>
          <ac:spMkLst>
            <pc:docMk/>
            <pc:sldMk cId="76243372" sldId="263"/>
            <ac:spMk id="10" creationId="{CCACB45D-68DA-425A-989A-383765B8A89B}"/>
          </ac:spMkLst>
        </pc:spChg>
        <pc:spChg chg="add mod">
          <ac:chgData name="Jessica" userId="dfaac082-a21f-4bd8-8583-e2115658a55f" providerId="ADAL" clId="{0826C407-A27E-49D6-A5F0-3C0403B96868}" dt="2021-05-20T13:47:03.767" v="575" actId="14100"/>
          <ac:spMkLst>
            <pc:docMk/>
            <pc:sldMk cId="76243372" sldId="263"/>
            <ac:spMk id="11" creationId="{2E920453-A011-4DBC-BB97-2257247DD673}"/>
          </ac:spMkLst>
        </pc:spChg>
      </pc:sldChg>
      <pc:sldChg chg="addSp modSp">
        <pc:chgData name="Jessica" userId="dfaac082-a21f-4bd8-8583-e2115658a55f" providerId="ADAL" clId="{0826C407-A27E-49D6-A5F0-3C0403B96868}" dt="2021-05-20T13:22:53.865" v="182" actId="14100"/>
        <pc:sldMkLst>
          <pc:docMk/>
          <pc:sldMk cId="3052797791" sldId="265"/>
        </pc:sldMkLst>
        <pc:spChg chg="add mod">
          <ac:chgData name="Jessica" userId="dfaac082-a21f-4bd8-8583-e2115658a55f" providerId="ADAL" clId="{0826C407-A27E-49D6-A5F0-3C0403B96868}" dt="2021-05-20T13:22:53.865" v="182" actId="14100"/>
          <ac:spMkLst>
            <pc:docMk/>
            <pc:sldMk cId="3052797791" sldId="265"/>
            <ac:spMk id="17" creationId="{03C99715-0073-45F0-9563-5EC202DCFE22}"/>
          </ac:spMkLst>
        </pc:spChg>
      </pc:sldChg>
      <pc:sldChg chg="addSp delSp modSp">
        <pc:chgData name="Jessica" userId="dfaac082-a21f-4bd8-8583-e2115658a55f" providerId="ADAL" clId="{0826C407-A27E-49D6-A5F0-3C0403B96868}" dt="2021-05-20T13:54:41.064" v="780" actId="478"/>
        <pc:sldMkLst>
          <pc:docMk/>
          <pc:sldMk cId="2282323561" sldId="267"/>
        </pc:sldMkLst>
        <pc:spChg chg="del">
          <ac:chgData name="Jessica" userId="dfaac082-a21f-4bd8-8583-e2115658a55f" providerId="ADAL" clId="{0826C407-A27E-49D6-A5F0-3C0403B96868}" dt="2021-05-20T13:54:41.064" v="780" actId="478"/>
          <ac:spMkLst>
            <pc:docMk/>
            <pc:sldMk cId="2282323561" sldId="267"/>
            <ac:spMk id="4" creationId="{00000000-0000-0000-0000-000000000000}"/>
          </ac:spMkLst>
        </pc:spChg>
        <pc:spChg chg="mod">
          <ac:chgData name="Jessica" userId="dfaac082-a21f-4bd8-8583-e2115658a55f" providerId="ADAL" clId="{0826C407-A27E-49D6-A5F0-3C0403B96868}" dt="2021-05-20T13:54:39.290" v="779" actId="14100"/>
          <ac:spMkLst>
            <pc:docMk/>
            <pc:sldMk cId="2282323561" sldId="267"/>
            <ac:spMk id="5" creationId="{975F7F80-18FD-4E74-A827-6ED5DB4615B2}"/>
          </ac:spMkLst>
        </pc:spChg>
        <pc:spChg chg="add del mod">
          <ac:chgData name="Jessica" userId="dfaac082-a21f-4bd8-8583-e2115658a55f" providerId="ADAL" clId="{0826C407-A27E-49D6-A5F0-3C0403B96868}" dt="2021-05-20T11:31:32.741" v="30"/>
          <ac:spMkLst>
            <pc:docMk/>
            <pc:sldMk cId="2282323561" sldId="267"/>
            <ac:spMk id="7" creationId="{3BB6C087-A7EB-4B70-84AD-1D0DD5B3F2D8}"/>
          </ac:spMkLst>
        </pc:spChg>
        <pc:spChg chg="add mod">
          <ac:chgData name="Jessica" userId="dfaac082-a21f-4bd8-8583-e2115658a55f" providerId="ADAL" clId="{0826C407-A27E-49D6-A5F0-3C0403B96868}" dt="2021-05-20T11:30:37.866" v="11" actId="1582"/>
          <ac:spMkLst>
            <pc:docMk/>
            <pc:sldMk cId="2282323561" sldId="267"/>
            <ac:spMk id="8" creationId="{9A6FB35D-043B-42C3-97FF-9E93CF88BAB0}"/>
          </ac:spMkLst>
        </pc:spChg>
        <pc:spChg chg="add mod">
          <ac:chgData name="Jessica" userId="dfaac082-a21f-4bd8-8583-e2115658a55f" providerId="ADAL" clId="{0826C407-A27E-49D6-A5F0-3C0403B96868}" dt="2021-05-20T11:30:57.286" v="14" actId="14100"/>
          <ac:spMkLst>
            <pc:docMk/>
            <pc:sldMk cId="2282323561" sldId="267"/>
            <ac:spMk id="20" creationId="{C430E9BB-BA7A-4EDA-901D-0969F1006041}"/>
          </ac:spMkLst>
        </pc:spChg>
        <pc:spChg chg="add mod">
          <ac:chgData name="Jessica" userId="dfaac082-a21f-4bd8-8583-e2115658a55f" providerId="ADAL" clId="{0826C407-A27E-49D6-A5F0-3C0403B96868}" dt="2021-05-20T11:31:04.199" v="16" actId="1076"/>
          <ac:spMkLst>
            <pc:docMk/>
            <pc:sldMk cId="2282323561" sldId="267"/>
            <ac:spMk id="21" creationId="{09FE1220-ABB0-4441-B85E-4D25FF116164}"/>
          </ac:spMkLst>
        </pc:spChg>
        <pc:spChg chg="add mod">
          <ac:chgData name="Jessica" userId="dfaac082-a21f-4bd8-8583-e2115658a55f" providerId="ADAL" clId="{0826C407-A27E-49D6-A5F0-3C0403B96868}" dt="2021-05-20T11:31:21.953" v="25" actId="14100"/>
          <ac:spMkLst>
            <pc:docMk/>
            <pc:sldMk cId="2282323561" sldId="267"/>
            <ac:spMk id="22" creationId="{44BCEA06-73E3-43FD-A574-EFFF134D0D72}"/>
          </ac:spMkLst>
        </pc:spChg>
        <pc:spChg chg="add mod">
          <ac:chgData name="Jessica" userId="dfaac082-a21f-4bd8-8583-e2115658a55f" providerId="ADAL" clId="{0826C407-A27E-49D6-A5F0-3C0403B96868}" dt="2021-05-20T11:31:31.996" v="28" actId="14100"/>
          <ac:spMkLst>
            <pc:docMk/>
            <pc:sldMk cId="2282323561" sldId="267"/>
            <ac:spMk id="23" creationId="{F3202B8B-0AA2-4992-8736-FCC11FDA660D}"/>
          </ac:spMkLst>
        </pc:spChg>
        <pc:spChg chg="add del mod">
          <ac:chgData name="Jessica" userId="dfaac082-a21f-4bd8-8583-e2115658a55f" providerId="ADAL" clId="{0826C407-A27E-49D6-A5F0-3C0403B96868}" dt="2021-05-20T11:31:42.603" v="33" actId="478"/>
          <ac:spMkLst>
            <pc:docMk/>
            <pc:sldMk cId="2282323561" sldId="267"/>
            <ac:spMk id="24" creationId="{E832462C-7A79-44C1-B6AF-5DD56BE2734A}"/>
          </ac:spMkLst>
        </pc:spChg>
      </pc:sldChg>
      <pc:sldChg chg="addSp delSp modSp">
        <pc:chgData name="Jessica" userId="dfaac082-a21f-4bd8-8583-e2115658a55f" providerId="ADAL" clId="{0826C407-A27E-49D6-A5F0-3C0403B96868}" dt="2021-05-20T14:05:13.839" v="1038" actId="478"/>
        <pc:sldMkLst>
          <pc:docMk/>
          <pc:sldMk cId="171246689" sldId="268"/>
        </pc:sldMkLst>
        <pc:spChg chg="del">
          <ac:chgData name="Jessica" userId="dfaac082-a21f-4bd8-8583-e2115658a55f" providerId="ADAL" clId="{0826C407-A27E-49D6-A5F0-3C0403B96868}" dt="2021-05-20T13:54:19.624" v="759" actId="478"/>
          <ac:spMkLst>
            <pc:docMk/>
            <pc:sldMk cId="171246689" sldId="268"/>
            <ac:spMk id="4" creationId="{00000000-0000-0000-0000-000000000000}"/>
          </ac:spMkLst>
        </pc:spChg>
        <pc:spChg chg="del">
          <ac:chgData name="Jessica" userId="dfaac082-a21f-4bd8-8583-e2115658a55f" providerId="ADAL" clId="{0826C407-A27E-49D6-A5F0-3C0403B96868}" dt="2021-05-20T13:54:26.274" v="760" actId="478"/>
          <ac:spMkLst>
            <pc:docMk/>
            <pc:sldMk cId="171246689" sldId="268"/>
            <ac:spMk id="9" creationId="{7CC24D83-2869-4A0F-B805-7800429C219C}"/>
          </ac:spMkLst>
        </pc:spChg>
        <pc:spChg chg="mod">
          <ac:chgData name="Jessica" userId="dfaac082-a21f-4bd8-8583-e2115658a55f" providerId="ADAL" clId="{0826C407-A27E-49D6-A5F0-3C0403B96868}" dt="2021-05-20T13:59:39.615" v="978" actId="164"/>
          <ac:spMkLst>
            <pc:docMk/>
            <pc:sldMk cId="171246689" sldId="268"/>
            <ac:spMk id="10" creationId="{7DB753AB-F135-433D-8923-726E24822BD0}"/>
          </ac:spMkLst>
        </pc:spChg>
        <pc:spChg chg="mod">
          <ac:chgData name="Jessica" userId="dfaac082-a21f-4bd8-8583-e2115658a55f" providerId="ADAL" clId="{0826C407-A27E-49D6-A5F0-3C0403B96868}" dt="2021-05-20T13:59:46.126" v="979" actId="164"/>
          <ac:spMkLst>
            <pc:docMk/>
            <pc:sldMk cId="171246689" sldId="268"/>
            <ac:spMk id="11" creationId="{0453B38A-F356-4FF8-892D-B9339D5E27BD}"/>
          </ac:spMkLst>
        </pc:spChg>
        <pc:spChg chg="mod">
          <ac:chgData name="Jessica" userId="dfaac082-a21f-4bd8-8583-e2115658a55f" providerId="ADAL" clId="{0826C407-A27E-49D6-A5F0-3C0403B96868}" dt="2021-05-20T13:59:50.954" v="980" actId="164"/>
          <ac:spMkLst>
            <pc:docMk/>
            <pc:sldMk cId="171246689" sldId="268"/>
            <ac:spMk id="12" creationId="{C4C65B61-382F-465F-B735-47110CE5BD73}"/>
          </ac:spMkLst>
        </pc:spChg>
        <pc:spChg chg="mod">
          <ac:chgData name="Jessica" userId="dfaac082-a21f-4bd8-8583-e2115658a55f" providerId="ADAL" clId="{0826C407-A27E-49D6-A5F0-3C0403B96868}" dt="2021-05-20T13:59:54.673" v="981" actId="164"/>
          <ac:spMkLst>
            <pc:docMk/>
            <pc:sldMk cId="171246689" sldId="268"/>
            <ac:spMk id="13" creationId="{6443383D-C4E3-4D26-BB09-6EB78C16A549}"/>
          </ac:spMkLst>
        </pc:spChg>
        <pc:spChg chg="mod">
          <ac:chgData name="Jessica" userId="dfaac082-a21f-4bd8-8583-e2115658a55f" providerId="ADAL" clId="{0826C407-A27E-49D6-A5F0-3C0403B96868}" dt="2021-05-20T13:59:58.389" v="982" actId="164"/>
          <ac:spMkLst>
            <pc:docMk/>
            <pc:sldMk cId="171246689" sldId="268"/>
            <ac:spMk id="14" creationId="{12AAC83A-783E-4BF9-A8EE-E42D24262739}"/>
          </ac:spMkLst>
        </pc:spChg>
        <pc:spChg chg="mod">
          <ac:chgData name="Jessica" userId="dfaac082-a21f-4bd8-8583-e2115658a55f" providerId="ADAL" clId="{0826C407-A27E-49D6-A5F0-3C0403B96868}" dt="2021-05-20T14:00:02.147" v="983" actId="164"/>
          <ac:spMkLst>
            <pc:docMk/>
            <pc:sldMk cId="171246689" sldId="268"/>
            <ac:spMk id="15" creationId="{12FB68A2-0F05-49DE-A3C6-80B23F3CDEC7}"/>
          </ac:spMkLst>
        </pc:spChg>
        <pc:spChg chg="add mod">
          <ac:chgData name="Jessica" userId="dfaac082-a21f-4bd8-8583-e2115658a55f" providerId="ADAL" clId="{0826C407-A27E-49D6-A5F0-3C0403B96868}" dt="2021-05-20T13:59:39.615" v="978" actId="164"/>
          <ac:spMkLst>
            <pc:docMk/>
            <pc:sldMk cId="171246689" sldId="268"/>
            <ac:spMk id="16" creationId="{ACD1332D-1354-4212-8A54-710E989607A5}"/>
          </ac:spMkLst>
        </pc:spChg>
        <pc:spChg chg="add mod">
          <ac:chgData name="Jessica" userId="dfaac082-a21f-4bd8-8583-e2115658a55f" providerId="ADAL" clId="{0826C407-A27E-49D6-A5F0-3C0403B96868}" dt="2021-05-20T13:59:46.126" v="979" actId="164"/>
          <ac:spMkLst>
            <pc:docMk/>
            <pc:sldMk cId="171246689" sldId="268"/>
            <ac:spMk id="17" creationId="{4D1857A2-208B-459F-B98D-ACC8589663C4}"/>
          </ac:spMkLst>
        </pc:spChg>
        <pc:spChg chg="add mod">
          <ac:chgData name="Jessica" userId="dfaac082-a21f-4bd8-8583-e2115658a55f" providerId="ADAL" clId="{0826C407-A27E-49D6-A5F0-3C0403B96868}" dt="2021-05-20T13:59:50.954" v="980" actId="164"/>
          <ac:spMkLst>
            <pc:docMk/>
            <pc:sldMk cId="171246689" sldId="268"/>
            <ac:spMk id="18" creationId="{523FF06F-D239-4DFA-A905-87F44B25027D}"/>
          </ac:spMkLst>
        </pc:spChg>
        <pc:spChg chg="add mod">
          <ac:chgData name="Jessica" userId="dfaac082-a21f-4bd8-8583-e2115658a55f" providerId="ADAL" clId="{0826C407-A27E-49D6-A5F0-3C0403B96868}" dt="2021-05-20T13:59:54.673" v="981" actId="164"/>
          <ac:spMkLst>
            <pc:docMk/>
            <pc:sldMk cId="171246689" sldId="268"/>
            <ac:spMk id="19" creationId="{B875B261-77CC-42A1-9358-512902AD8D8C}"/>
          </ac:spMkLst>
        </pc:spChg>
        <pc:spChg chg="add mod">
          <ac:chgData name="Jessica" userId="dfaac082-a21f-4bd8-8583-e2115658a55f" providerId="ADAL" clId="{0826C407-A27E-49D6-A5F0-3C0403B96868}" dt="2021-05-20T13:59:58.389" v="982" actId="164"/>
          <ac:spMkLst>
            <pc:docMk/>
            <pc:sldMk cId="171246689" sldId="268"/>
            <ac:spMk id="20" creationId="{DB442598-52C1-46D0-A48F-05AD64C7AEB4}"/>
          </ac:spMkLst>
        </pc:spChg>
        <pc:spChg chg="add del mod">
          <ac:chgData name="Jessica" userId="dfaac082-a21f-4bd8-8583-e2115658a55f" providerId="ADAL" clId="{0826C407-A27E-49D6-A5F0-3C0403B96868}" dt="2021-05-20T14:05:13.839" v="1038" actId="478"/>
          <ac:spMkLst>
            <pc:docMk/>
            <pc:sldMk cId="171246689" sldId="268"/>
            <ac:spMk id="21" creationId="{577D895A-D3A4-4058-A8DE-F496D3749454}"/>
          </ac:spMkLst>
        </pc:spChg>
        <pc:spChg chg="add del mod">
          <ac:chgData name="Jessica" userId="dfaac082-a21f-4bd8-8583-e2115658a55f" providerId="ADAL" clId="{0826C407-A27E-49D6-A5F0-3C0403B96868}" dt="2021-05-20T13:59:11.552" v="977" actId="478"/>
          <ac:spMkLst>
            <pc:docMk/>
            <pc:sldMk cId="171246689" sldId="268"/>
            <ac:spMk id="22" creationId="{C3BEFF82-49AD-45E3-9F70-A5AA0E7F32EE}"/>
          </ac:spMkLst>
        </pc:spChg>
        <pc:spChg chg="add del mod">
          <ac:chgData name="Jessica" userId="dfaac082-a21f-4bd8-8583-e2115658a55f" providerId="ADAL" clId="{0826C407-A27E-49D6-A5F0-3C0403B96868}" dt="2021-05-20T13:53:36.732" v="732" actId="478"/>
          <ac:spMkLst>
            <pc:docMk/>
            <pc:sldMk cId="171246689" sldId="268"/>
            <ac:spMk id="23" creationId="{A947859B-6A21-453F-BBA5-4A105999AB04}"/>
          </ac:spMkLst>
        </pc:spChg>
        <pc:spChg chg="add">
          <ac:chgData name="Jessica" userId="dfaac082-a21f-4bd8-8583-e2115658a55f" providerId="ADAL" clId="{0826C407-A27E-49D6-A5F0-3C0403B96868}" dt="2021-05-20T13:54:26.967" v="761"/>
          <ac:spMkLst>
            <pc:docMk/>
            <pc:sldMk cId="171246689" sldId="268"/>
            <ac:spMk id="24" creationId="{71589091-A049-4904-9E5B-E17F0C1C1DC8}"/>
          </ac:spMkLst>
        </pc:spChg>
        <pc:grpChg chg="add mod">
          <ac:chgData name="Jessica" userId="dfaac082-a21f-4bd8-8583-e2115658a55f" providerId="ADAL" clId="{0826C407-A27E-49D6-A5F0-3C0403B96868}" dt="2021-05-20T14:00:10.581" v="984" actId="555"/>
          <ac:grpSpMkLst>
            <pc:docMk/>
            <pc:sldMk cId="171246689" sldId="268"/>
            <ac:grpSpMk id="2" creationId="{C3656266-8C7A-469F-B243-1606776B5D8D}"/>
          </ac:grpSpMkLst>
        </pc:grpChg>
        <pc:grpChg chg="add mod">
          <ac:chgData name="Jessica" userId="dfaac082-a21f-4bd8-8583-e2115658a55f" providerId="ADAL" clId="{0826C407-A27E-49D6-A5F0-3C0403B96868}" dt="2021-05-20T14:00:10.581" v="984" actId="555"/>
          <ac:grpSpMkLst>
            <pc:docMk/>
            <pc:sldMk cId="171246689" sldId="268"/>
            <ac:grpSpMk id="3" creationId="{9B2F5844-93A2-4262-9539-AA080CEB51CA}"/>
          </ac:grpSpMkLst>
        </pc:grpChg>
        <pc:grpChg chg="add mod">
          <ac:chgData name="Jessica" userId="dfaac082-a21f-4bd8-8583-e2115658a55f" providerId="ADAL" clId="{0826C407-A27E-49D6-A5F0-3C0403B96868}" dt="2021-05-20T14:00:10.581" v="984" actId="555"/>
          <ac:grpSpMkLst>
            <pc:docMk/>
            <pc:sldMk cId="171246689" sldId="268"/>
            <ac:grpSpMk id="5" creationId="{B2E482CF-6451-4789-8FFF-B2DCFEF977D0}"/>
          </ac:grpSpMkLst>
        </pc:grpChg>
        <pc:grpChg chg="add mod">
          <ac:chgData name="Jessica" userId="dfaac082-a21f-4bd8-8583-e2115658a55f" providerId="ADAL" clId="{0826C407-A27E-49D6-A5F0-3C0403B96868}" dt="2021-05-20T14:00:10.581" v="984" actId="555"/>
          <ac:grpSpMkLst>
            <pc:docMk/>
            <pc:sldMk cId="171246689" sldId="268"/>
            <ac:grpSpMk id="6" creationId="{B00AA98E-577D-4B6E-8AD4-90F6679AE058}"/>
          </ac:grpSpMkLst>
        </pc:grpChg>
        <pc:grpChg chg="add mod">
          <ac:chgData name="Jessica" userId="dfaac082-a21f-4bd8-8583-e2115658a55f" providerId="ADAL" clId="{0826C407-A27E-49D6-A5F0-3C0403B96868}" dt="2021-05-20T14:00:10.581" v="984" actId="555"/>
          <ac:grpSpMkLst>
            <pc:docMk/>
            <pc:sldMk cId="171246689" sldId="268"/>
            <ac:grpSpMk id="7" creationId="{FEDE0A80-8DFB-4C35-84E2-197152BB6B6F}"/>
          </ac:grpSpMkLst>
        </pc:grpChg>
        <pc:grpChg chg="add mod">
          <ac:chgData name="Jessica" userId="dfaac082-a21f-4bd8-8583-e2115658a55f" providerId="ADAL" clId="{0826C407-A27E-49D6-A5F0-3C0403B96868}" dt="2021-05-20T14:00:10.581" v="984" actId="555"/>
          <ac:grpSpMkLst>
            <pc:docMk/>
            <pc:sldMk cId="171246689" sldId="268"/>
            <ac:grpSpMk id="8" creationId="{2503D3A3-8CBC-4DC1-84CB-520F7A61B1DB}"/>
          </ac:grpSpMkLst>
        </pc:grpChg>
        <pc:picChg chg="mod">
          <ac:chgData name="Jessica" userId="dfaac082-a21f-4bd8-8583-e2115658a55f" providerId="ADAL" clId="{0826C407-A27E-49D6-A5F0-3C0403B96868}" dt="2021-05-20T13:59:39.615" v="978" actId="164"/>
          <ac:picMkLst>
            <pc:docMk/>
            <pc:sldMk cId="171246689" sldId="268"/>
            <ac:picMk id="2050" creationId="{00000000-0000-0000-0000-000000000000}"/>
          </ac:picMkLst>
        </pc:picChg>
        <pc:picChg chg="mod">
          <ac:chgData name="Jessica" userId="dfaac082-a21f-4bd8-8583-e2115658a55f" providerId="ADAL" clId="{0826C407-A27E-49D6-A5F0-3C0403B96868}" dt="2021-05-20T13:59:46.126" v="979" actId="164"/>
          <ac:picMkLst>
            <pc:docMk/>
            <pc:sldMk cId="171246689" sldId="268"/>
            <ac:picMk id="2051" creationId="{00000000-0000-0000-0000-000000000000}"/>
          </ac:picMkLst>
        </pc:picChg>
        <pc:picChg chg="mod">
          <ac:chgData name="Jessica" userId="dfaac082-a21f-4bd8-8583-e2115658a55f" providerId="ADAL" clId="{0826C407-A27E-49D6-A5F0-3C0403B96868}" dt="2021-05-20T13:59:50.954" v="980" actId="164"/>
          <ac:picMkLst>
            <pc:docMk/>
            <pc:sldMk cId="171246689" sldId="268"/>
            <ac:picMk id="2052" creationId="{00000000-0000-0000-0000-000000000000}"/>
          </ac:picMkLst>
        </pc:picChg>
        <pc:picChg chg="mod">
          <ac:chgData name="Jessica" userId="dfaac082-a21f-4bd8-8583-e2115658a55f" providerId="ADAL" clId="{0826C407-A27E-49D6-A5F0-3C0403B96868}" dt="2021-05-20T13:59:54.673" v="981" actId="164"/>
          <ac:picMkLst>
            <pc:docMk/>
            <pc:sldMk cId="171246689" sldId="268"/>
            <ac:picMk id="2053" creationId="{00000000-0000-0000-0000-000000000000}"/>
          </ac:picMkLst>
        </pc:picChg>
        <pc:picChg chg="mod">
          <ac:chgData name="Jessica" userId="dfaac082-a21f-4bd8-8583-e2115658a55f" providerId="ADAL" clId="{0826C407-A27E-49D6-A5F0-3C0403B96868}" dt="2021-05-20T13:59:58.389" v="982" actId="164"/>
          <ac:picMkLst>
            <pc:docMk/>
            <pc:sldMk cId="171246689" sldId="268"/>
            <ac:picMk id="2054" creationId="{00000000-0000-0000-0000-000000000000}"/>
          </ac:picMkLst>
        </pc:picChg>
        <pc:picChg chg="mod">
          <ac:chgData name="Jessica" userId="dfaac082-a21f-4bd8-8583-e2115658a55f" providerId="ADAL" clId="{0826C407-A27E-49D6-A5F0-3C0403B96868}" dt="2021-05-20T14:00:02.147" v="983" actId="164"/>
          <ac:picMkLst>
            <pc:docMk/>
            <pc:sldMk cId="171246689" sldId="268"/>
            <ac:picMk id="2055" creationId="{00000000-0000-0000-0000-000000000000}"/>
          </ac:picMkLst>
        </pc:picChg>
      </pc:sldChg>
      <pc:sldChg chg="addSp delSp modSp">
        <pc:chgData name="Jessica" userId="dfaac082-a21f-4bd8-8583-e2115658a55f" providerId="ADAL" clId="{0826C407-A27E-49D6-A5F0-3C0403B96868}" dt="2021-05-20T14:01:24.246" v="997" actId="555"/>
        <pc:sldMkLst>
          <pc:docMk/>
          <pc:sldMk cId="490872864" sldId="269"/>
        </pc:sldMkLst>
        <pc:spChg chg="del">
          <ac:chgData name="Jessica" userId="dfaac082-a21f-4bd8-8583-e2115658a55f" providerId="ADAL" clId="{0826C407-A27E-49D6-A5F0-3C0403B96868}" dt="2021-05-20T13:55:03.528" v="809" actId="478"/>
          <ac:spMkLst>
            <pc:docMk/>
            <pc:sldMk cId="490872864" sldId="269"/>
            <ac:spMk id="4" creationId="{00000000-0000-0000-0000-000000000000}"/>
          </ac:spMkLst>
        </pc:spChg>
        <pc:spChg chg="mod">
          <ac:chgData name="Jessica" userId="dfaac082-a21f-4bd8-8583-e2115658a55f" providerId="ADAL" clId="{0826C407-A27E-49D6-A5F0-3C0403B96868}" dt="2021-05-20T13:55:07.073" v="810" actId="14100"/>
          <ac:spMkLst>
            <pc:docMk/>
            <pc:sldMk cId="490872864" sldId="269"/>
            <ac:spMk id="8" creationId="{5BF8C513-761B-4EE0-AF7D-1ACC7C293818}"/>
          </ac:spMkLst>
        </pc:spChg>
        <pc:spChg chg="mod">
          <ac:chgData name="Jessica" userId="dfaac082-a21f-4bd8-8583-e2115658a55f" providerId="ADAL" clId="{0826C407-A27E-49D6-A5F0-3C0403B96868}" dt="2021-05-20T14:01:10.514" v="994" actId="164"/>
          <ac:spMkLst>
            <pc:docMk/>
            <pc:sldMk cId="490872864" sldId="269"/>
            <ac:spMk id="9" creationId="{4CE2E6D0-9CD4-4B6F-8BC7-AAEA95DC297E}"/>
          </ac:spMkLst>
        </pc:spChg>
        <pc:spChg chg="mod">
          <ac:chgData name="Jessica" userId="dfaac082-a21f-4bd8-8583-e2115658a55f" providerId="ADAL" clId="{0826C407-A27E-49D6-A5F0-3C0403B96868}" dt="2021-05-20T14:01:17.764" v="996" actId="164"/>
          <ac:spMkLst>
            <pc:docMk/>
            <pc:sldMk cId="490872864" sldId="269"/>
            <ac:spMk id="10" creationId="{CF8FFB76-62F0-4244-9480-75D838BA5885}"/>
          </ac:spMkLst>
        </pc:spChg>
        <pc:spChg chg="mod">
          <ac:chgData name="Jessica" userId="dfaac082-a21f-4bd8-8583-e2115658a55f" providerId="ADAL" clId="{0826C407-A27E-49D6-A5F0-3C0403B96868}" dt="2021-05-20T14:01:13.971" v="995" actId="164"/>
          <ac:spMkLst>
            <pc:docMk/>
            <pc:sldMk cId="490872864" sldId="269"/>
            <ac:spMk id="11" creationId="{F01569BC-E2A0-4E54-8FAB-C4FB54E570C0}"/>
          </ac:spMkLst>
        </pc:spChg>
        <pc:spChg chg="mod">
          <ac:chgData name="Jessica" userId="dfaac082-a21f-4bd8-8583-e2115658a55f" providerId="ADAL" clId="{0826C407-A27E-49D6-A5F0-3C0403B96868}" dt="2021-05-20T14:01:07.050" v="993" actId="164"/>
          <ac:spMkLst>
            <pc:docMk/>
            <pc:sldMk cId="490872864" sldId="269"/>
            <ac:spMk id="12" creationId="{B383F875-D981-4155-83B9-0E38A852BEA1}"/>
          </ac:spMkLst>
        </pc:spChg>
        <pc:spChg chg="mod">
          <ac:chgData name="Jessica" userId="dfaac082-a21f-4bd8-8583-e2115658a55f" providerId="ADAL" clId="{0826C407-A27E-49D6-A5F0-3C0403B96868}" dt="2021-05-20T14:01:03.592" v="992" actId="164"/>
          <ac:spMkLst>
            <pc:docMk/>
            <pc:sldMk cId="490872864" sldId="269"/>
            <ac:spMk id="13" creationId="{160A8E74-9677-457F-8C41-873C5AD6CA4E}"/>
          </ac:spMkLst>
        </pc:spChg>
        <pc:spChg chg="add mod">
          <ac:chgData name="Jessica" userId="dfaac082-a21f-4bd8-8583-e2115658a55f" providerId="ADAL" clId="{0826C407-A27E-49D6-A5F0-3C0403B96868}" dt="2021-05-20T14:01:17.764" v="996" actId="164"/>
          <ac:spMkLst>
            <pc:docMk/>
            <pc:sldMk cId="490872864" sldId="269"/>
            <ac:spMk id="14" creationId="{191BD3B8-733E-44FC-AC00-7F45156E9610}"/>
          </ac:spMkLst>
        </pc:spChg>
        <pc:spChg chg="add mod">
          <ac:chgData name="Jessica" userId="dfaac082-a21f-4bd8-8583-e2115658a55f" providerId="ADAL" clId="{0826C407-A27E-49D6-A5F0-3C0403B96868}" dt="2021-05-20T14:01:17.764" v="996" actId="164"/>
          <ac:spMkLst>
            <pc:docMk/>
            <pc:sldMk cId="490872864" sldId="269"/>
            <ac:spMk id="15" creationId="{9DAB811E-3109-4B6F-8621-086A42BEBA8D}"/>
          </ac:spMkLst>
        </pc:spChg>
        <pc:spChg chg="add mod">
          <ac:chgData name="Jessica" userId="dfaac082-a21f-4bd8-8583-e2115658a55f" providerId="ADAL" clId="{0826C407-A27E-49D6-A5F0-3C0403B96868}" dt="2021-05-20T14:01:13.971" v="995" actId="164"/>
          <ac:spMkLst>
            <pc:docMk/>
            <pc:sldMk cId="490872864" sldId="269"/>
            <ac:spMk id="16" creationId="{384C1F55-7FDC-41CF-84FA-00410F170F14}"/>
          </ac:spMkLst>
        </pc:spChg>
        <pc:spChg chg="add mod">
          <ac:chgData name="Jessica" userId="dfaac082-a21f-4bd8-8583-e2115658a55f" providerId="ADAL" clId="{0826C407-A27E-49D6-A5F0-3C0403B96868}" dt="2021-05-20T14:01:13.971" v="995" actId="164"/>
          <ac:spMkLst>
            <pc:docMk/>
            <pc:sldMk cId="490872864" sldId="269"/>
            <ac:spMk id="17" creationId="{DFE2A9F8-63A5-469D-BE8C-F4AEE37D40AF}"/>
          </ac:spMkLst>
        </pc:spChg>
        <pc:spChg chg="add mod">
          <ac:chgData name="Jessica" userId="dfaac082-a21f-4bd8-8583-e2115658a55f" providerId="ADAL" clId="{0826C407-A27E-49D6-A5F0-3C0403B96868}" dt="2021-05-20T14:01:10.514" v="994" actId="164"/>
          <ac:spMkLst>
            <pc:docMk/>
            <pc:sldMk cId="490872864" sldId="269"/>
            <ac:spMk id="18" creationId="{A8461329-5D4D-4A59-988E-56AA5B9A8B6C}"/>
          </ac:spMkLst>
        </pc:spChg>
        <pc:spChg chg="add mod">
          <ac:chgData name="Jessica" userId="dfaac082-a21f-4bd8-8583-e2115658a55f" providerId="ADAL" clId="{0826C407-A27E-49D6-A5F0-3C0403B96868}" dt="2021-05-20T14:01:10.514" v="994" actId="164"/>
          <ac:spMkLst>
            <pc:docMk/>
            <pc:sldMk cId="490872864" sldId="269"/>
            <ac:spMk id="19" creationId="{15457349-ADBC-4C86-B45F-C821436F084E}"/>
          </ac:spMkLst>
        </pc:spChg>
        <pc:spChg chg="add mod">
          <ac:chgData name="Jessica" userId="dfaac082-a21f-4bd8-8583-e2115658a55f" providerId="ADAL" clId="{0826C407-A27E-49D6-A5F0-3C0403B96868}" dt="2021-05-20T14:01:07.050" v="993" actId="164"/>
          <ac:spMkLst>
            <pc:docMk/>
            <pc:sldMk cId="490872864" sldId="269"/>
            <ac:spMk id="20" creationId="{B9B9AA99-267E-41C4-BD82-C6E6568974FA}"/>
          </ac:spMkLst>
        </pc:spChg>
        <pc:spChg chg="add mod">
          <ac:chgData name="Jessica" userId="dfaac082-a21f-4bd8-8583-e2115658a55f" providerId="ADAL" clId="{0826C407-A27E-49D6-A5F0-3C0403B96868}" dt="2021-05-20T14:01:07.050" v="993" actId="164"/>
          <ac:spMkLst>
            <pc:docMk/>
            <pc:sldMk cId="490872864" sldId="269"/>
            <ac:spMk id="21" creationId="{F11D7B5B-20F4-4735-BFC7-5266A6CCC31C}"/>
          </ac:spMkLst>
        </pc:spChg>
        <pc:spChg chg="add mod">
          <ac:chgData name="Jessica" userId="dfaac082-a21f-4bd8-8583-e2115658a55f" providerId="ADAL" clId="{0826C407-A27E-49D6-A5F0-3C0403B96868}" dt="2021-05-20T14:01:03.592" v="992" actId="164"/>
          <ac:spMkLst>
            <pc:docMk/>
            <pc:sldMk cId="490872864" sldId="269"/>
            <ac:spMk id="22" creationId="{AF212391-F558-4372-AB93-0F2639C624BF}"/>
          </ac:spMkLst>
        </pc:spChg>
        <pc:spChg chg="add mod">
          <ac:chgData name="Jessica" userId="dfaac082-a21f-4bd8-8583-e2115658a55f" providerId="ADAL" clId="{0826C407-A27E-49D6-A5F0-3C0403B96868}" dt="2021-05-20T14:01:03.592" v="992" actId="164"/>
          <ac:spMkLst>
            <pc:docMk/>
            <pc:sldMk cId="490872864" sldId="269"/>
            <ac:spMk id="23" creationId="{1D3D4079-759D-4B72-962D-4517BC81B6FF}"/>
          </ac:spMkLst>
        </pc:spChg>
        <pc:grpChg chg="add mod">
          <ac:chgData name="Jessica" userId="dfaac082-a21f-4bd8-8583-e2115658a55f" providerId="ADAL" clId="{0826C407-A27E-49D6-A5F0-3C0403B96868}" dt="2021-05-20T14:01:24.246" v="997" actId="555"/>
          <ac:grpSpMkLst>
            <pc:docMk/>
            <pc:sldMk cId="490872864" sldId="269"/>
            <ac:grpSpMk id="6" creationId="{DCE42D86-D721-46F7-8EDF-AB63E63C58F5}"/>
          </ac:grpSpMkLst>
        </pc:grpChg>
        <pc:grpChg chg="add mod">
          <ac:chgData name="Jessica" userId="dfaac082-a21f-4bd8-8583-e2115658a55f" providerId="ADAL" clId="{0826C407-A27E-49D6-A5F0-3C0403B96868}" dt="2021-05-20T14:01:24.246" v="997" actId="555"/>
          <ac:grpSpMkLst>
            <pc:docMk/>
            <pc:sldMk cId="490872864" sldId="269"/>
            <ac:grpSpMk id="7" creationId="{00833BDA-F902-434F-B91B-7108133B7475}"/>
          </ac:grpSpMkLst>
        </pc:grpChg>
        <pc:grpChg chg="add mod">
          <ac:chgData name="Jessica" userId="dfaac082-a21f-4bd8-8583-e2115658a55f" providerId="ADAL" clId="{0826C407-A27E-49D6-A5F0-3C0403B96868}" dt="2021-05-20T14:01:24.246" v="997" actId="555"/>
          <ac:grpSpMkLst>
            <pc:docMk/>
            <pc:sldMk cId="490872864" sldId="269"/>
            <ac:grpSpMk id="24" creationId="{94DA9BFA-A1CB-4B4D-AF9D-ACD3E485F07A}"/>
          </ac:grpSpMkLst>
        </pc:grpChg>
        <pc:grpChg chg="add mod">
          <ac:chgData name="Jessica" userId="dfaac082-a21f-4bd8-8583-e2115658a55f" providerId="ADAL" clId="{0826C407-A27E-49D6-A5F0-3C0403B96868}" dt="2021-05-20T14:01:24.246" v="997" actId="555"/>
          <ac:grpSpMkLst>
            <pc:docMk/>
            <pc:sldMk cId="490872864" sldId="269"/>
            <ac:grpSpMk id="25" creationId="{E1604AB1-9001-4485-8905-5B69A39546D4}"/>
          </ac:grpSpMkLst>
        </pc:grpChg>
        <pc:grpChg chg="add mod">
          <ac:chgData name="Jessica" userId="dfaac082-a21f-4bd8-8583-e2115658a55f" providerId="ADAL" clId="{0826C407-A27E-49D6-A5F0-3C0403B96868}" dt="2021-05-20T14:01:24.246" v="997" actId="555"/>
          <ac:grpSpMkLst>
            <pc:docMk/>
            <pc:sldMk cId="490872864" sldId="269"/>
            <ac:grpSpMk id="26" creationId="{AD9D2167-B20D-46DE-B57C-B423C846B4C5}"/>
          </ac:grpSpMkLst>
        </pc:grpChg>
        <pc:picChg chg="mod">
          <ac:chgData name="Jessica" userId="dfaac082-a21f-4bd8-8583-e2115658a55f" providerId="ADAL" clId="{0826C407-A27E-49D6-A5F0-3C0403B96868}" dt="2021-05-20T14:01:10.514" v="994" actId="164"/>
          <ac:picMkLst>
            <pc:docMk/>
            <pc:sldMk cId="490872864" sldId="269"/>
            <ac:picMk id="2" creationId="{00000000-0000-0000-0000-000000000000}"/>
          </ac:picMkLst>
        </pc:picChg>
        <pc:picChg chg="mod">
          <ac:chgData name="Jessica" userId="dfaac082-a21f-4bd8-8583-e2115658a55f" providerId="ADAL" clId="{0826C407-A27E-49D6-A5F0-3C0403B96868}" dt="2021-05-20T14:01:07.050" v="993" actId="164"/>
          <ac:picMkLst>
            <pc:docMk/>
            <pc:sldMk cId="490872864" sldId="269"/>
            <ac:picMk id="3" creationId="{00000000-0000-0000-0000-000000000000}"/>
          </ac:picMkLst>
        </pc:picChg>
        <pc:picChg chg="mod">
          <ac:chgData name="Jessica" userId="dfaac082-a21f-4bd8-8583-e2115658a55f" providerId="ADAL" clId="{0826C407-A27E-49D6-A5F0-3C0403B96868}" dt="2021-05-20T14:01:03.592" v="992" actId="164"/>
          <ac:picMkLst>
            <pc:docMk/>
            <pc:sldMk cId="490872864" sldId="269"/>
            <ac:picMk id="5" creationId="{00000000-0000-0000-0000-000000000000}"/>
          </ac:picMkLst>
        </pc:picChg>
        <pc:picChg chg="mod">
          <ac:chgData name="Jessica" userId="dfaac082-a21f-4bd8-8583-e2115658a55f" providerId="ADAL" clId="{0826C407-A27E-49D6-A5F0-3C0403B96868}" dt="2021-05-20T14:01:17.764" v="996" actId="164"/>
          <ac:picMkLst>
            <pc:docMk/>
            <pc:sldMk cId="490872864" sldId="269"/>
            <ac:picMk id="1026" creationId="{00000000-0000-0000-0000-000000000000}"/>
          </ac:picMkLst>
        </pc:picChg>
        <pc:picChg chg="mod">
          <ac:chgData name="Jessica" userId="dfaac082-a21f-4bd8-8583-e2115658a55f" providerId="ADAL" clId="{0826C407-A27E-49D6-A5F0-3C0403B96868}" dt="2021-05-20T14:01:13.971" v="995" actId="164"/>
          <ac:picMkLst>
            <pc:docMk/>
            <pc:sldMk cId="490872864" sldId="269"/>
            <ac:picMk id="1027" creationId="{00000000-0000-0000-0000-000000000000}"/>
          </ac:picMkLst>
        </pc:picChg>
      </pc:sldChg>
      <pc:sldChg chg="addSp modSp">
        <pc:chgData name="Jessica" userId="dfaac082-a21f-4bd8-8583-e2115658a55f" providerId="ADAL" clId="{0826C407-A27E-49D6-A5F0-3C0403B96868}" dt="2021-05-20T14:01:53.740" v="1003" actId="555"/>
        <pc:sldMkLst>
          <pc:docMk/>
          <pc:sldMk cId="2694848396" sldId="270"/>
        </pc:sldMkLst>
        <pc:spChg chg="mod">
          <ac:chgData name="Jessica" userId="dfaac082-a21f-4bd8-8583-e2115658a55f" providerId="ADAL" clId="{0826C407-A27E-49D6-A5F0-3C0403B96868}" dt="2021-05-20T14:01:31.832" v="998" actId="164"/>
          <ac:spMkLst>
            <pc:docMk/>
            <pc:sldMk cId="2694848396" sldId="270"/>
            <ac:spMk id="9" creationId="{BCAEA6CE-47E4-4497-964D-2E28745DFB59}"/>
          </ac:spMkLst>
        </pc:spChg>
        <pc:spChg chg="mod">
          <ac:chgData name="Jessica" userId="dfaac082-a21f-4bd8-8583-e2115658a55f" providerId="ADAL" clId="{0826C407-A27E-49D6-A5F0-3C0403B96868}" dt="2021-05-20T14:01:36.271" v="999" actId="164"/>
          <ac:spMkLst>
            <pc:docMk/>
            <pc:sldMk cId="2694848396" sldId="270"/>
            <ac:spMk id="10" creationId="{50D48E97-DB1F-4116-A870-93F50AB4123C}"/>
          </ac:spMkLst>
        </pc:spChg>
        <pc:spChg chg="mod">
          <ac:chgData name="Jessica" userId="dfaac082-a21f-4bd8-8583-e2115658a55f" providerId="ADAL" clId="{0826C407-A27E-49D6-A5F0-3C0403B96868}" dt="2021-05-20T14:01:39.985" v="1000" actId="164"/>
          <ac:spMkLst>
            <pc:docMk/>
            <pc:sldMk cId="2694848396" sldId="270"/>
            <ac:spMk id="11" creationId="{3A42C3A2-A89C-4820-B116-108C701FFA02}"/>
          </ac:spMkLst>
        </pc:spChg>
        <pc:spChg chg="mod">
          <ac:chgData name="Jessica" userId="dfaac082-a21f-4bd8-8583-e2115658a55f" providerId="ADAL" clId="{0826C407-A27E-49D6-A5F0-3C0403B96868}" dt="2021-05-20T14:01:43.805" v="1001" actId="164"/>
          <ac:spMkLst>
            <pc:docMk/>
            <pc:sldMk cId="2694848396" sldId="270"/>
            <ac:spMk id="12" creationId="{0C2D99A1-619A-485D-852A-E21D96D19B3A}"/>
          </ac:spMkLst>
        </pc:spChg>
        <pc:spChg chg="mod">
          <ac:chgData name="Jessica" userId="dfaac082-a21f-4bd8-8583-e2115658a55f" providerId="ADAL" clId="{0826C407-A27E-49D6-A5F0-3C0403B96868}" dt="2021-05-20T14:01:47.483" v="1002" actId="164"/>
          <ac:spMkLst>
            <pc:docMk/>
            <pc:sldMk cId="2694848396" sldId="270"/>
            <ac:spMk id="14" creationId="{33CC0F24-7D94-4320-9F49-027D9DE6DF96}"/>
          </ac:spMkLst>
        </pc:spChg>
        <pc:spChg chg="add mod">
          <ac:chgData name="Jessica" userId="dfaac082-a21f-4bd8-8583-e2115658a55f" providerId="ADAL" clId="{0826C407-A27E-49D6-A5F0-3C0403B96868}" dt="2021-05-20T14:01:47.483" v="1002" actId="164"/>
          <ac:spMkLst>
            <pc:docMk/>
            <pc:sldMk cId="2694848396" sldId="270"/>
            <ac:spMk id="15" creationId="{8EFA7FC4-B019-4FDA-A95C-71E9A0C40F55}"/>
          </ac:spMkLst>
        </pc:spChg>
        <pc:spChg chg="add mod">
          <ac:chgData name="Jessica" userId="dfaac082-a21f-4bd8-8583-e2115658a55f" providerId="ADAL" clId="{0826C407-A27E-49D6-A5F0-3C0403B96868}" dt="2021-05-20T14:01:43.805" v="1001" actId="164"/>
          <ac:spMkLst>
            <pc:docMk/>
            <pc:sldMk cId="2694848396" sldId="270"/>
            <ac:spMk id="16" creationId="{4D43E050-5C0F-4E2D-9C07-2212679AB855}"/>
          </ac:spMkLst>
        </pc:spChg>
        <pc:spChg chg="add mod">
          <ac:chgData name="Jessica" userId="dfaac082-a21f-4bd8-8583-e2115658a55f" providerId="ADAL" clId="{0826C407-A27E-49D6-A5F0-3C0403B96868}" dt="2021-05-20T14:01:39.985" v="1000" actId="164"/>
          <ac:spMkLst>
            <pc:docMk/>
            <pc:sldMk cId="2694848396" sldId="270"/>
            <ac:spMk id="17" creationId="{5F725848-FD7D-4858-A592-CC73B57D2748}"/>
          </ac:spMkLst>
        </pc:spChg>
        <pc:spChg chg="add mod">
          <ac:chgData name="Jessica" userId="dfaac082-a21f-4bd8-8583-e2115658a55f" providerId="ADAL" clId="{0826C407-A27E-49D6-A5F0-3C0403B96868}" dt="2021-05-20T14:01:36.271" v="999" actId="164"/>
          <ac:spMkLst>
            <pc:docMk/>
            <pc:sldMk cId="2694848396" sldId="270"/>
            <ac:spMk id="18" creationId="{4F38EF4A-8209-444F-8F18-7D3096391E8E}"/>
          </ac:spMkLst>
        </pc:spChg>
        <pc:spChg chg="add mod">
          <ac:chgData name="Jessica" userId="dfaac082-a21f-4bd8-8583-e2115658a55f" providerId="ADAL" clId="{0826C407-A27E-49D6-A5F0-3C0403B96868}" dt="2021-05-20T14:01:31.832" v="998" actId="164"/>
          <ac:spMkLst>
            <pc:docMk/>
            <pc:sldMk cId="2694848396" sldId="270"/>
            <ac:spMk id="19" creationId="{82964AA5-798C-42A5-B748-95F47CE7CF1E}"/>
          </ac:spMkLst>
        </pc:spChg>
        <pc:grpChg chg="add mod">
          <ac:chgData name="Jessica" userId="dfaac082-a21f-4bd8-8583-e2115658a55f" providerId="ADAL" clId="{0826C407-A27E-49D6-A5F0-3C0403B96868}" dt="2021-05-20T14:01:53.740" v="1003" actId="555"/>
          <ac:grpSpMkLst>
            <pc:docMk/>
            <pc:sldMk cId="2694848396" sldId="270"/>
            <ac:grpSpMk id="2" creationId="{A2F6AEF4-970D-414C-8F1D-39909D4AF552}"/>
          </ac:grpSpMkLst>
        </pc:grpChg>
        <pc:grpChg chg="add mod">
          <ac:chgData name="Jessica" userId="dfaac082-a21f-4bd8-8583-e2115658a55f" providerId="ADAL" clId="{0826C407-A27E-49D6-A5F0-3C0403B96868}" dt="2021-05-20T14:01:53.740" v="1003" actId="555"/>
          <ac:grpSpMkLst>
            <pc:docMk/>
            <pc:sldMk cId="2694848396" sldId="270"/>
            <ac:grpSpMk id="3" creationId="{AF213A6E-08F3-4DF4-AAC7-0C743CB60782}"/>
          </ac:grpSpMkLst>
        </pc:grpChg>
        <pc:grpChg chg="add mod">
          <ac:chgData name="Jessica" userId="dfaac082-a21f-4bd8-8583-e2115658a55f" providerId="ADAL" clId="{0826C407-A27E-49D6-A5F0-3C0403B96868}" dt="2021-05-20T14:01:53.740" v="1003" actId="555"/>
          <ac:grpSpMkLst>
            <pc:docMk/>
            <pc:sldMk cId="2694848396" sldId="270"/>
            <ac:grpSpMk id="5" creationId="{0A8D5E20-FFBC-4FF8-9B65-16F96AD56BC7}"/>
          </ac:grpSpMkLst>
        </pc:grpChg>
        <pc:grpChg chg="add mod">
          <ac:chgData name="Jessica" userId="dfaac082-a21f-4bd8-8583-e2115658a55f" providerId="ADAL" clId="{0826C407-A27E-49D6-A5F0-3C0403B96868}" dt="2021-05-20T14:01:53.740" v="1003" actId="555"/>
          <ac:grpSpMkLst>
            <pc:docMk/>
            <pc:sldMk cId="2694848396" sldId="270"/>
            <ac:grpSpMk id="6" creationId="{44C66D51-397F-4C92-91B6-A5ED96E11B0E}"/>
          </ac:grpSpMkLst>
        </pc:grpChg>
        <pc:grpChg chg="add mod">
          <ac:chgData name="Jessica" userId="dfaac082-a21f-4bd8-8583-e2115658a55f" providerId="ADAL" clId="{0826C407-A27E-49D6-A5F0-3C0403B96868}" dt="2021-05-20T14:01:53.740" v="1003" actId="555"/>
          <ac:grpSpMkLst>
            <pc:docMk/>
            <pc:sldMk cId="2694848396" sldId="270"/>
            <ac:grpSpMk id="7" creationId="{D5CF5AD4-8214-4016-BAF7-8E778BC3CB3F}"/>
          </ac:grpSpMkLst>
        </pc:grpChg>
        <pc:picChg chg="mod">
          <ac:chgData name="Jessica" userId="dfaac082-a21f-4bd8-8583-e2115658a55f" providerId="ADAL" clId="{0826C407-A27E-49D6-A5F0-3C0403B96868}" dt="2021-05-20T14:01:47.483" v="1002" actId="164"/>
          <ac:picMkLst>
            <pc:docMk/>
            <pc:sldMk cId="2694848396" sldId="270"/>
            <ac:picMk id="1027" creationId="{00000000-0000-0000-0000-000000000000}"/>
          </ac:picMkLst>
        </pc:picChg>
        <pc:picChg chg="mod">
          <ac:chgData name="Jessica" userId="dfaac082-a21f-4bd8-8583-e2115658a55f" providerId="ADAL" clId="{0826C407-A27E-49D6-A5F0-3C0403B96868}" dt="2021-05-20T14:01:43.805" v="1001" actId="164"/>
          <ac:picMkLst>
            <pc:docMk/>
            <pc:sldMk cId="2694848396" sldId="270"/>
            <ac:picMk id="1028" creationId="{00000000-0000-0000-0000-000000000000}"/>
          </ac:picMkLst>
        </pc:picChg>
        <pc:picChg chg="mod">
          <ac:chgData name="Jessica" userId="dfaac082-a21f-4bd8-8583-e2115658a55f" providerId="ADAL" clId="{0826C407-A27E-49D6-A5F0-3C0403B96868}" dt="2021-05-20T14:01:39.985" v="1000" actId="164"/>
          <ac:picMkLst>
            <pc:docMk/>
            <pc:sldMk cId="2694848396" sldId="270"/>
            <ac:picMk id="1029" creationId="{00000000-0000-0000-0000-000000000000}"/>
          </ac:picMkLst>
        </pc:picChg>
        <pc:picChg chg="mod">
          <ac:chgData name="Jessica" userId="dfaac082-a21f-4bd8-8583-e2115658a55f" providerId="ADAL" clId="{0826C407-A27E-49D6-A5F0-3C0403B96868}" dt="2021-05-20T14:01:36.271" v="999" actId="164"/>
          <ac:picMkLst>
            <pc:docMk/>
            <pc:sldMk cId="2694848396" sldId="270"/>
            <ac:picMk id="2051" creationId="{00000000-0000-0000-0000-000000000000}"/>
          </ac:picMkLst>
        </pc:picChg>
        <pc:picChg chg="mod">
          <ac:chgData name="Jessica" userId="dfaac082-a21f-4bd8-8583-e2115658a55f" providerId="ADAL" clId="{0826C407-A27E-49D6-A5F0-3C0403B96868}" dt="2021-05-20T14:01:31.832" v="998" actId="164"/>
          <ac:picMkLst>
            <pc:docMk/>
            <pc:sldMk cId="2694848396" sldId="270"/>
            <ac:picMk id="2052" creationId="{00000000-0000-0000-0000-000000000000}"/>
          </ac:picMkLst>
        </pc:picChg>
      </pc:sldChg>
      <pc:sldChg chg="modSp">
        <pc:chgData name="Jessica" userId="dfaac082-a21f-4bd8-8583-e2115658a55f" providerId="ADAL" clId="{0826C407-A27E-49D6-A5F0-3C0403B96868}" dt="2021-05-20T14:04:12.383" v="1036"/>
        <pc:sldMkLst>
          <pc:docMk/>
          <pc:sldMk cId="4005150265" sldId="271"/>
        </pc:sldMkLst>
        <pc:graphicFrameChg chg="mod modGraphic">
          <ac:chgData name="Jessica" userId="dfaac082-a21f-4bd8-8583-e2115658a55f" providerId="ADAL" clId="{0826C407-A27E-49D6-A5F0-3C0403B96868}" dt="2021-05-20T14:04:12.383" v="1036"/>
          <ac:graphicFrameMkLst>
            <pc:docMk/>
            <pc:sldMk cId="4005150265" sldId="271"/>
            <ac:graphicFrameMk id="6" creationId="{DF3F3FB9-E17C-456D-9116-49442443C3AD}"/>
          </ac:graphicFrameMkLst>
        </pc:graphicFrameChg>
      </pc:sldChg>
      <pc:sldChg chg="addSp delSp modSp add">
        <pc:chgData name="Jessica" userId="dfaac082-a21f-4bd8-8583-e2115658a55f" providerId="ADAL" clId="{0826C407-A27E-49D6-A5F0-3C0403B96868}" dt="2021-05-20T14:05:20.147" v="1039" actId="478"/>
        <pc:sldMkLst>
          <pc:docMk/>
          <pc:sldMk cId="557009560" sldId="272"/>
        </pc:sldMkLst>
        <pc:spChg chg="add mod">
          <ac:chgData name="Jessica" userId="dfaac082-a21f-4bd8-8583-e2115658a55f" providerId="ADAL" clId="{0826C407-A27E-49D6-A5F0-3C0403B96868}" dt="2021-05-20T14:00:43.986" v="990" actId="164"/>
          <ac:spMkLst>
            <pc:docMk/>
            <pc:sldMk cId="557009560" sldId="272"/>
            <ac:spMk id="2" creationId="{F64109BF-6661-4DCD-A8F8-98C56AFBC9BC}"/>
          </ac:spMkLst>
        </pc:spChg>
        <pc:spChg chg="add mod">
          <ac:chgData name="Jessica" userId="dfaac082-a21f-4bd8-8583-e2115658a55f" providerId="ADAL" clId="{0826C407-A27E-49D6-A5F0-3C0403B96868}" dt="2021-05-20T14:00:43.986" v="990" actId="164"/>
          <ac:spMkLst>
            <pc:docMk/>
            <pc:sldMk cId="557009560" sldId="272"/>
            <ac:spMk id="3" creationId="{ECA29094-EA1B-4207-87DF-F9B31A467017}"/>
          </ac:spMkLst>
        </pc:spChg>
        <pc:spChg chg="del mod">
          <ac:chgData name="Jessica" userId="dfaac082-a21f-4bd8-8583-e2115658a55f" providerId="ADAL" clId="{0826C407-A27E-49D6-A5F0-3C0403B96868}" dt="2021-05-20T13:54:11.220" v="757" actId="478"/>
          <ac:spMkLst>
            <pc:docMk/>
            <pc:sldMk cId="557009560" sldId="272"/>
            <ac:spMk id="4" creationId="{00000000-0000-0000-0000-000000000000}"/>
          </ac:spMkLst>
        </pc:spChg>
        <pc:spChg chg="add mod">
          <ac:chgData name="Jessica" userId="dfaac082-a21f-4bd8-8583-e2115658a55f" providerId="ADAL" clId="{0826C407-A27E-49D6-A5F0-3C0403B96868}" dt="2021-05-20T14:00:43.986" v="990" actId="164"/>
          <ac:spMkLst>
            <pc:docMk/>
            <pc:sldMk cId="557009560" sldId="272"/>
            <ac:spMk id="5" creationId="{6A29743A-1275-40B8-8248-AFED4A3ED872}"/>
          </ac:spMkLst>
        </pc:spChg>
        <pc:spChg chg="mod">
          <ac:chgData name="Jessica" userId="dfaac082-a21f-4bd8-8583-e2115658a55f" providerId="ADAL" clId="{0826C407-A27E-49D6-A5F0-3C0403B96868}" dt="2021-05-20T13:54:13.097" v="758" actId="1076"/>
          <ac:spMkLst>
            <pc:docMk/>
            <pc:sldMk cId="557009560" sldId="272"/>
            <ac:spMk id="9" creationId="{7CC24D83-2869-4A0F-B805-7800429C219C}"/>
          </ac:spMkLst>
        </pc:spChg>
        <pc:spChg chg="del mod">
          <ac:chgData name="Jessica" userId="dfaac082-a21f-4bd8-8583-e2115658a55f" providerId="ADAL" clId="{0826C407-A27E-49D6-A5F0-3C0403B96868}" dt="2021-05-20T13:53:43.868" v="733" actId="478"/>
          <ac:spMkLst>
            <pc:docMk/>
            <pc:sldMk cId="557009560" sldId="272"/>
            <ac:spMk id="10" creationId="{7DB753AB-F135-433D-8923-726E24822BD0}"/>
          </ac:spMkLst>
        </pc:spChg>
        <pc:spChg chg="del mod">
          <ac:chgData name="Jessica" userId="dfaac082-a21f-4bd8-8583-e2115658a55f" providerId="ADAL" clId="{0826C407-A27E-49D6-A5F0-3C0403B96868}" dt="2021-05-20T13:53:43.868" v="733" actId="478"/>
          <ac:spMkLst>
            <pc:docMk/>
            <pc:sldMk cId="557009560" sldId="272"/>
            <ac:spMk id="11" creationId="{0453B38A-F356-4FF8-892D-B9339D5E27BD}"/>
          </ac:spMkLst>
        </pc:spChg>
        <pc:spChg chg="del mod">
          <ac:chgData name="Jessica" userId="dfaac082-a21f-4bd8-8583-e2115658a55f" providerId="ADAL" clId="{0826C407-A27E-49D6-A5F0-3C0403B96868}" dt="2021-05-20T13:53:43.868" v="733" actId="478"/>
          <ac:spMkLst>
            <pc:docMk/>
            <pc:sldMk cId="557009560" sldId="272"/>
            <ac:spMk id="12" creationId="{C4C65B61-382F-465F-B735-47110CE5BD73}"/>
          </ac:spMkLst>
        </pc:spChg>
        <pc:spChg chg="del mod">
          <ac:chgData name="Jessica" userId="dfaac082-a21f-4bd8-8583-e2115658a55f" providerId="ADAL" clId="{0826C407-A27E-49D6-A5F0-3C0403B96868}" dt="2021-05-20T13:53:43.868" v="733" actId="478"/>
          <ac:spMkLst>
            <pc:docMk/>
            <pc:sldMk cId="557009560" sldId="272"/>
            <ac:spMk id="13" creationId="{6443383D-C4E3-4D26-BB09-6EB78C16A549}"/>
          </ac:spMkLst>
        </pc:spChg>
        <pc:spChg chg="del mod">
          <ac:chgData name="Jessica" userId="dfaac082-a21f-4bd8-8583-e2115658a55f" providerId="ADAL" clId="{0826C407-A27E-49D6-A5F0-3C0403B96868}" dt="2021-05-20T13:53:43.868" v="733" actId="478"/>
          <ac:spMkLst>
            <pc:docMk/>
            <pc:sldMk cId="557009560" sldId="272"/>
            <ac:spMk id="14" creationId="{12AAC83A-783E-4BF9-A8EE-E42D24262739}"/>
          </ac:spMkLst>
        </pc:spChg>
        <pc:spChg chg="del mod">
          <ac:chgData name="Jessica" userId="dfaac082-a21f-4bd8-8583-e2115658a55f" providerId="ADAL" clId="{0826C407-A27E-49D6-A5F0-3C0403B96868}" dt="2021-05-20T13:53:43.868" v="733" actId="478"/>
          <ac:spMkLst>
            <pc:docMk/>
            <pc:sldMk cId="557009560" sldId="272"/>
            <ac:spMk id="15" creationId="{12FB68A2-0F05-49DE-A3C6-80B23F3CDEC7}"/>
          </ac:spMkLst>
        </pc:spChg>
        <pc:spChg chg="mod ord">
          <ac:chgData name="Jessica" userId="dfaac082-a21f-4bd8-8583-e2115658a55f" providerId="ADAL" clId="{0826C407-A27E-49D6-A5F0-3C0403B96868}" dt="2021-05-20T14:00:43.986" v="990" actId="164"/>
          <ac:spMkLst>
            <pc:docMk/>
            <pc:sldMk cId="557009560" sldId="272"/>
            <ac:spMk id="16" creationId="{ACD1332D-1354-4212-8A54-710E989607A5}"/>
          </ac:spMkLst>
        </pc:spChg>
        <pc:spChg chg="del mod">
          <ac:chgData name="Jessica" userId="dfaac082-a21f-4bd8-8583-e2115658a55f" providerId="ADAL" clId="{0826C407-A27E-49D6-A5F0-3C0403B96868}" dt="2021-05-20T13:53:43.868" v="733" actId="478"/>
          <ac:spMkLst>
            <pc:docMk/>
            <pc:sldMk cId="557009560" sldId="272"/>
            <ac:spMk id="17" creationId="{4D1857A2-208B-459F-B98D-ACC8589663C4}"/>
          </ac:spMkLst>
        </pc:spChg>
        <pc:spChg chg="add mod">
          <ac:chgData name="Jessica" userId="dfaac082-a21f-4bd8-8583-e2115658a55f" providerId="ADAL" clId="{0826C407-A27E-49D6-A5F0-3C0403B96868}" dt="2021-05-20T14:00:39.401" v="989" actId="164"/>
          <ac:spMkLst>
            <pc:docMk/>
            <pc:sldMk cId="557009560" sldId="272"/>
            <ac:spMk id="24" creationId="{069C64D2-A62A-4DFE-AC74-8E0423286DE1}"/>
          </ac:spMkLst>
        </pc:spChg>
        <pc:spChg chg="add mod">
          <ac:chgData name="Jessica" userId="dfaac082-a21f-4bd8-8583-e2115658a55f" providerId="ADAL" clId="{0826C407-A27E-49D6-A5F0-3C0403B96868}" dt="2021-05-20T14:00:43.986" v="990" actId="164"/>
          <ac:spMkLst>
            <pc:docMk/>
            <pc:sldMk cId="557009560" sldId="272"/>
            <ac:spMk id="25" creationId="{0F0C5239-87FF-419B-95D3-6423DF0355BE}"/>
          </ac:spMkLst>
        </pc:spChg>
        <pc:spChg chg="add mod">
          <ac:chgData name="Jessica" userId="dfaac082-a21f-4bd8-8583-e2115658a55f" providerId="ADAL" clId="{0826C407-A27E-49D6-A5F0-3C0403B96868}" dt="2021-05-20T14:00:39.401" v="989" actId="164"/>
          <ac:spMkLst>
            <pc:docMk/>
            <pc:sldMk cId="557009560" sldId="272"/>
            <ac:spMk id="26" creationId="{032343CA-AE50-4CF0-A6D9-F6221BB42CC6}"/>
          </ac:spMkLst>
        </pc:spChg>
        <pc:spChg chg="add mod">
          <ac:chgData name="Jessica" userId="dfaac082-a21f-4bd8-8583-e2115658a55f" providerId="ADAL" clId="{0826C407-A27E-49D6-A5F0-3C0403B96868}" dt="2021-05-20T14:00:34.518" v="988" actId="164"/>
          <ac:spMkLst>
            <pc:docMk/>
            <pc:sldMk cId="557009560" sldId="272"/>
            <ac:spMk id="27" creationId="{C863E763-18CA-4DEE-A8A3-4AFD2CD8F53A}"/>
          </ac:spMkLst>
        </pc:spChg>
        <pc:spChg chg="add mod">
          <ac:chgData name="Jessica" userId="dfaac082-a21f-4bd8-8583-e2115658a55f" providerId="ADAL" clId="{0826C407-A27E-49D6-A5F0-3C0403B96868}" dt="2021-05-20T14:00:30.250" v="987" actId="164"/>
          <ac:spMkLst>
            <pc:docMk/>
            <pc:sldMk cId="557009560" sldId="272"/>
            <ac:spMk id="28" creationId="{4EA601DF-5FDF-4D36-90D0-51BB5053A3F4}"/>
          </ac:spMkLst>
        </pc:spChg>
        <pc:spChg chg="add mod">
          <ac:chgData name="Jessica" userId="dfaac082-a21f-4bd8-8583-e2115658a55f" providerId="ADAL" clId="{0826C407-A27E-49D6-A5F0-3C0403B96868}" dt="2021-05-20T14:00:24.511" v="986" actId="164"/>
          <ac:spMkLst>
            <pc:docMk/>
            <pc:sldMk cId="557009560" sldId="272"/>
            <ac:spMk id="29" creationId="{6E24B5B9-A7D9-4E57-8041-DC9D7BCE517F}"/>
          </ac:spMkLst>
        </pc:spChg>
        <pc:spChg chg="add mod">
          <ac:chgData name="Jessica" userId="dfaac082-a21f-4bd8-8583-e2115658a55f" providerId="ADAL" clId="{0826C407-A27E-49D6-A5F0-3C0403B96868}" dt="2021-05-20T14:00:19.606" v="985" actId="164"/>
          <ac:spMkLst>
            <pc:docMk/>
            <pc:sldMk cId="557009560" sldId="272"/>
            <ac:spMk id="30" creationId="{00E20C7D-862A-41A0-BE71-61DA9ED51FBC}"/>
          </ac:spMkLst>
        </pc:spChg>
        <pc:spChg chg="add mod">
          <ac:chgData name="Jessica" userId="dfaac082-a21f-4bd8-8583-e2115658a55f" providerId="ADAL" clId="{0826C407-A27E-49D6-A5F0-3C0403B96868}" dt="2021-05-20T14:00:34.518" v="988" actId="164"/>
          <ac:spMkLst>
            <pc:docMk/>
            <pc:sldMk cId="557009560" sldId="272"/>
            <ac:spMk id="31" creationId="{74203B08-0A72-4650-AE15-C966ECA28217}"/>
          </ac:spMkLst>
        </pc:spChg>
        <pc:spChg chg="add mod">
          <ac:chgData name="Jessica" userId="dfaac082-a21f-4bd8-8583-e2115658a55f" providerId="ADAL" clId="{0826C407-A27E-49D6-A5F0-3C0403B96868}" dt="2021-05-20T14:00:30.250" v="987" actId="164"/>
          <ac:spMkLst>
            <pc:docMk/>
            <pc:sldMk cId="557009560" sldId="272"/>
            <ac:spMk id="32" creationId="{1D7917D9-BDF8-4D52-B9E9-DD827873DB37}"/>
          </ac:spMkLst>
        </pc:spChg>
        <pc:spChg chg="add mod">
          <ac:chgData name="Jessica" userId="dfaac082-a21f-4bd8-8583-e2115658a55f" providerId="ADAL" clId="{0826C407-A27E-49D6-A5F0-3C0403B96868}" dt="2021-05-20T14:00:24.511" v="986" actId="164"/>
          <ac:spMkLst>
            <pc:docMk/>
            <pc:sldMk cId="557009560" sldId="272"/>
            <ac:spMk id="33" creationId="{6D316987-3FFE-4040-BA1F-B3761F962E2C}"/>
          </ac:spMkLst>
        </pc:spChg>
        <pc:spChg chg="add del mod">
          <ac:chgData name="Jessica" userId="dfaac082-a21f-4bd8-8583-e2115658a55f" providerId="ADAL" clId="{0826C407-A27E-49D6-A5F0-3C0403B96868}" dt="2021-05-20T14:05:20.147" v="1039" actId="478"/>
          <ac:spMkLst>
            <pc:docMk/>
            <pc:sldMk cId="557009560" sldId="272"/>
            <ac:spMk id="34" creationId="{59972E63-EDF5-4AC1-9195-673EB5B784F4}"/>
          </ac:spMkLst>
        </pc:spChg>
        <pc:spChg chg="add del mod">
          <ac:chgData name="Jessica" userId="dfaac082-a21f-4bd8-8583-e2115658a55f" providerId="ADAL" clId="{0826C407-A27E-49D6-A5F0-3C0403B96868}" dt="2021-05-20T13:53:43.868" v="733" actId="478"/>
          <ac:spMkLst>
            <pc:docMk/>
            <pc:sldMk cId="557009560" sldId="272"/>
            <ac:spMk id="35" creationId="{54A6D086-38C7-4514-A6D0-31CDF13ED6F2}"/>
          </ac:spMkLst>
        </pc:spChg>
        <pc:spChg chg="add del mod">
          <ac:chgData name="Jessica" userId="dfaac082-a21f-4bd8-8583-e2115658a55f" providerId="ADAL" clId="{0826C407-A27E-49D6-A5F0-3C0403B96868}" dt="2021-05-20T13:53:43.868" v="733" actId="478"/>
          <ac:spMkLst>
            <pc:docMk/>
            <pc:sldMk cId="557009560" sldId="272"/>
            <ac:spMk id="36" creationId="{B241AB92-AEB9-40BE-9613-CFF9988B0F25}"/>
          </ac:spMkLst>
        </pc:spChg>
        <pc:spChg chg="add del mod">
          <ac:chgData name="Jessica" userId="dfaac082-a21f-4bd8-8583-e2115658a55f" providerId="ADAL" clId="{0826C407-A27E-49D6-A5F0-3C0403B96868}" dt="2021-05-20T13:53:43.868" v="733" actId="478"/>
          <ac:spMkLst>
            <pc:docMk/>
            <pc:sldMk cId="557009560" sldId="272"/>
            <ac:spMk id="37" creationId="{2D50E479-1271-408A-AD73-56CD614D30A9}"/>
          </ac:spMkLst>
        </pc:spChg>
        <pc:spChg chg="add del mod">
          <ac:chgData name="Jessica" userId="dfaac082-a21f-4bd8-8583-e2115658a55f" providerId="ADAL" clId="{0826C407-A27E-49D6-A5F0-3C0403B96868}" dt="2021-05-20T13:53:43.868" v="733" actId="478"/>
          <ac:spMkLst>
            <pc:docMk/>
            <pc:sldMk cId="557009560" sldId="272"/>
            <ac:spMk id="38" creationId="{5DF5C781-375A-4D9D-AAA3-E377009E4246}"/>
          </ac:spMkLst>
        </pc:spChg>
        <pc:spChg chg="add del mod">
          <ac:chgData name="Jessica" userId="dfaac082-a21f-4bd8-8583-e2115658a55f" providerId="ADAL" clId="{0826C407-A27E-49D6-A5F0-3C0403B96868}" dt="2021-05-20T13:53:43.868" v="733" actId="478"/>
          <ac:spMkLst>
            <pc:docMk/>
            <pc:sldMk cId="557009560" sldId="272"/>
            <ac:spMk id="39" creationId="{C9C4BB78-013E-4EF2-8D68-2D7228C46CAF}"/>
          </ac:spMkLst>
        </pc:spChg>
        <pc:spChg chg="add mod">
          <ac:chgData name="Jessica" userId="dfaac082-a21f-4bd8-8583-e2115658a55f" providerId="ADAL" clId="{0826C407-A27E-49D6-A5F0-3C0403B96868}" dt="2021-05-20T14:00:43.986" v="990" actId="164"/>
          <ac:spMkLst>
            <pc:docMk/>
            <pc:sldMk cId="557009560" sldId="272"/>
            <ac:spMk id="42" creationId="{2E556F82-9018-4130-95F0-D681A1F06AD0}"/>
          </ac:spMkLst>
        </pc:spChg>
        <pc:spChg chg="add mod">
          <ac:chgData name="Jessica" userId="dfaac082-a21f-4bd8-8583-e2115658a55f" providerId="ADAL" clId="{0826C407-A27E-49D6-A5F0-3C0403B96868}" dt="2021-05-20T14:00:39.401" v="989" actId="164"/>
          <ac:spMkLst>
            <pc:docMk/>
            <pc:sldMk cId="557009560" sldId="272"/>
            <ac:spMk id="43" creationId="{22A0A310-BC1F-4A4A-ADFD-D881C247B150}"/>
          </ac:spMkLst>
        </pc:spChg>
        <pc:spChg chg="add mod">
          <ac:chgData name="Jessica" userId="dfaac082-a21f-4bd8-8583-e2115658a55f" providerId="ADAL" clId="{0826C407-A27E-49D6-A5F0-3C0403B96868}" dt="2021-05-20T14:00:34.518" v="988" actId="164"/>
          <ac:spMkLst>
            <pc:docMk/>
            <pc:sldMk cId="557009560" sldId="272"/>
            <ac:spMk id="44" creationId="{FE9963F8-3FF9-4A62-8542-2AFC69A65CAF}"/>
          </ac:spMkLst>
        </pc:spChg>
        <pc:spChg chg="add mod">
          <ac:chgData name="Jessica" userId="dfaac082-a21f-4bd8-8583-e2115658a55f" providerId="ADAL" clId="{0826C407-A27E-49D6-A5F0-3C0403B96868}" dt="2021-05-20T14:00:30.250" v="987" actId="164"/>
          <ac:spMkLst>
            <pc:docMk/>
            <pc:sldMk cId="557009560" sldId="272"/>
            <ac:spMk id="45" creationId="{DCFB58C1-981A-431B-B68D-01F94D2A20A4}"/>
          </ac:spMkLst>
        </pc:spChg>
        <pc:spChg chg="add mod">
          <ac:chgData name="Jessica" userId="dfaac082-a21f-4bd8-8583-e2115658a55f" providerId="ADAL" clId="{0826C407-A27E-49D6-A5F0-3C0403B96868}" dt="2021-05-20T14:00:24.511" v="986" actId="164"/>
          <ac:spMkLst>
            <pc:docMk/>
            <pc:sldMk cId="557009560" sldId="272"/>
            <ac:spMk id="46" creationId="{EAD31B40-F326-4659-92A6-0F6F6BE49441}"/>
          </ac:spMkLst>
        </pc:spChg>
        <pc:spChg chg="add mod">
          <ac:chgData name="Jessica" userId="dfaac082-a21f-4bd8-8583-e2115658a55f" providerId="ADAL" clId="{0826C407-A27E-49D6-A5F0-3C0403B96868}" dt="2021-05-20T14:00:19.606" v="985" actId="164"/>
          <ac:spMkLst>
            <pc:docMk/>
            <pc:sldMk cId="557009560" sldId="272"/>
            <ac:spMk id="47" creationId="{17C22431-AD05-4980-8A9F-4DA5C18760F8}"/>
          </ac:spMkLst>
        </pc:spChg>
        <pc:spChg chg="add mod">
          <ac:chgData name="Jessica" userId="dfaac082-a21f-4bd8-8583-e2115658a55f" providerId="ADAL" clId="{0826C407-A27E-49D6-A5F0-3C0403B96868}" dt="2021-05-20T14:00:39.401" v="989" actId="164"/>
          <ac:spMkLst>
            <pc:docMk/>
            <pc:sldMk cId="557009560" sldId="272"/>
            <ac:spMk id="48" creationId="{3A3C3D60-FB94-46C4-8BB7-EF3DD9982BAA}"/>
          </ac:spMkLst>
        </pc:spChg>
        <pc:spChg chg="add mod">
          <ac:chgData name="Jessica" userId="dfaac082-a21f-4bd8-8583-e2115658a55f" providerId="ADAL" clId="{0826C407-A27E-49D6-A5F0-3C0403B96868}" dt="2021-05-20T14:00:39.401" v="989" actId="164"/>
          <ac:spMkLst>
            <pc:docMk/>
            <pc:sldMk cId="557009560" sldId="272"/>
            <ac:spMk id="49" creationId="{30F49294-972B-4F06-84C6-147CF6B194BF}"/>
          </ac:spMkLst>
        </pc:spChg>
        <pc:spChg chg="add mod">
          <ac:chgData name="Jessica" userId="dfaac082-a21f-4bd8-8583-e2115658a55f" providerId="ADAL" clId="{0826C407-A27E-49D6-A5F0-3C0403B96868}" dt="2021-05-20T14:00:34.518" v="988" actId="164"/>
          <ac:spMkLst>
            <pc:docMk/>
            <pc:sldMk cId="557009560" sldId="272"/>
            <ac:spMk id="50" creationId="{A005C1F7-BF53-4E64-BC4C-AF95118DCC18}"/>
          </ac:spMkLst>
        </pc:spChg>
        <pc:spChg chg="add mod">
          <ac:chgData name="Jessica" userId="dfaac082-a21f-4bd8-8583-e2115658a55f" providerId="ADAL" clId="{0826C407-A27E-49D6-A5F0-3C0403B96868}" dt="2021-05-20T14:00:34.518" v="988" actId="164"/>
          <ac:spMkLst>
            <pc:docMk/>
            <pc:sldMk cId="557009560" sldId="272"/>
            <ac:spMk id="51" creationId="{1EDA7D20-4591-4F5C-AD90-5FFC9785A733}"/>
          </ac:spMkLst>
        </pc:spChg>
        <pc:spChg chg="add mod">
          <ac:chgData name="Jessica" userId="dfaac082-a21f-4bd8-8583-e2115658a55f" providerId="ADAL" clId="{0826C407-A27E-49D6-A5F0-3C0403B96868}" dt="2021-05-20T14:00:30.250" v="987" actId="164"/>
          <ac:spMkLst>
            <pc:docMk/>
            <pc:sldMk cId="557009560" sldId="272"/>
            <ac:spMk id="52" creationId="{B4D4112D-33AB-4A56-AB7A-AD5C0F85F3D5}"/>
          </ac:spMkLst>
        </pc:spChg>
        <pc:spChg chg="add mod">
          <ac:chgData name="Jessica" userId="dfaac082-a21f-4bd8-8583-e2115658a55f" providerId="ADAL" clId="{0826C407-A27E-49D6-A5F0-3C0403B96868}" dt="2021-05-20T14:00:30.250" v="987" actId="164"/>
          <ac:spMkLst>
            <pc:docMk/>
            <pc:sldMk cId="557009560" sldId="272"/>
            <ac:spMk id="53" creationId="{646C4AE9-184D-4299-AABB-E46B94327D92}"/>
          </ac:spMkLst>
        </pc:spChg>
        <pc:spChg chg="add mod">
          <ac:chgData name="Jessica" userId="dfaac082-a21f-4bd8-8583-e2115658a55f" providerId="ADAL" clId="{0826C407-A27E-49D6-A5F0-3C0403B96868}" dt="2021-05-20T14:00:24.511" v="986" actId="164"/>
          <ac:spMkLst>
            <pc:docMk/>
            <pc:sldMk cId="557009560" sldId="272"/>
            <ac:spMk id="54" creationId="{3516649C-F2A2-47AE-8E22-16A07CA6F9C1}"/>
          </ac:spMkLst>
        </pc:spChg>
        <pc:spChg chg="add mod">
          <ac:chgData name="Jessica" userId="dfaac082-a21f-4bd8-8583-e2115658a55f" providerId="ADAL" clId="{0826C407-A27E-49D6-A5F0-3C0403B96868}" dt="2021-05-20T14:00:24.511" v="986" actId="164"/>
          <ac:spMkLst>
            <pc:docMk/>
            <pc:sldMk cId="557009560" sldId="272"/>
            <ac:spMk id="55" creationId="{A76D345E-315B-41B4-992E-B99F4A0FC2FC}"/>
          </ac:spMkLst>
        </pc:spChg>
        <pc:spChg chg="add mod">
          <ac:chgData name="Jessica" userId="dfaac082-a21f-4bd8-8583-e2115658a55f" providerId="ADAL" clId="{0826C407-A27E-49D6-A5F0-3C0403B96868}" dt="2021-05-20T14:00:19.606" v="985" actId="164"/>
          <ac:spMkLst>
            <pc:docMk/>
            <pc:sldMk cId="557009560" sldId="272"/>
            <ac:spMk id="56" creationId="{5D164D29-5B5D-4FF2-A2C8-D8D2489734CA}"/>
          </ac:spMkLst>
        </pc:spChg>
        <pc:spChg chg="add mod">
          <ac:chgData name="Jessica" userId="dfaac082-a21f-4bd8-8583-e2115658a55f" providerId="ADAL" clId="{0826C407-A27E-49D6-A5F0-3C0403B96868}" dt="2021-05-20T14:00:19.606" v="985" actId="164"/>
          <ac:spMkLst>
            <pc:docMk/>
            <pc:sldMk cId="557009560" sldId="272"/>
            <ac:spMk id="57" creationId="{CA2D8526-5632-4E09-A280-97DFA7FFD960}"/>
          </ac:spMkLst>
        </pc:spChg>
        <pc:spChg chg="add mod">
          <ac:chgData name="Jessica" userId="dfaac082-a21f-4bd8-8583-e2115658a55f" providerId="ADAL" clId="{0826C407-A27E-49D6-A5F0-3C0403B96868}" dt="2021-05-20T14:00:43.986" v="990" actId="164"/>
          <ac:spMkLst>
            <pc:docMk/>
            <pc:sldMk cId="557009560" sldId="272"/>
            <ac:spMk id="59" creationId="{F307BABB-81E1-452B-B0E1-9DF0D5E47345}"/>
          </ac:spMkLst>
        </pc:spChg>
        <pc:spChg chg="add mod">
          <ac:chgData name="Jessica" userId="dfaac082-a21f-4bd8-8583-e2115658a55f" providerId="ADAL" clId="{0826C407-A27E-49D6-A5F0-3C0403B96868}" dt="2021-05-20T14:00:39.401" v="989" actId="164"/>
          <ac:spMkLst>
            <pc:docMk/>
            <pc:sldMk cId="557009560" sldId="272"/>
            <ac:spMk id="60" creationId="{F9172D04-266B-4808-9BD2-0D5CD02D5079}"/>
          </ac:spMkLst>
        </pc:spChg>
        <pc:spChg chg="add mod">
          <ac:chgData name="Jessica" userId="dfaac082-a21f-4bd8-8583-e2115658a55f" providerId="ADAL" clId="{0826C407-A27E-49D6-A5F0-3C0403B96868}" dt="2021-05-20T14:00:39.401" v="989" actId="164"/>
          <ac:spMkLst>
            <pc:docMk/>
            <pc:sldMk cId="557009560" sldId="272"/>
            <ac:spMk id="61" creationId="{6A991951-2A74-4B72-BA4F-9B08C5B0FAFC}"/>
          </ac:spMkLst>
        </pc:spChg>
        <pc:spChg chg="add mod">
          <ac:chgData name="Jessica" userId="dfaac082-a21f-4bd8-8583-e2115658a55f" providerId="ADAL" clId="{0826C407-A27E-49D6-A5F0-3C0403B96868}" dt="2021-05-20T14:00:34.518" v="988" actId="164"/>
          <ac:spMkLst>
            <pc:docMk/>
            <pc:sldMk cId="557009560" sldId="272"/>
            <ac:spMk id="62" creationId="{53ADD3FA-8435-491A-A799-823508397ECD}"/>
          </ac:spMkLst>
        </pc:spChg>
        <pc:spChg chg="add mod">
          <ac:chgData name="Jessica" userId="dfaac082-a21f-4bd8-8583-e2115658a55f" providerId="ADAL" clId="{0826C407-A27E-49D6-A5F0-3C0403B96868}" dt="2021-05-20T14:00:30.250" v="987" actId="164"/>
          <ac:spMkLst>
            <pc:docMk/>
            <pc:sldMk cId="557009560" sldId="272"/>
            <ac:spMk id="63" creationId="{4CC94796-4D59-427F-9BB6-BFF4F2811FA5}"/>
          </ac:spMkLst>
        </pc:spChg>
        <pc:spChg chg="add mod">
          <ac:chgData name="Jessica" userId="dfaac082-a21f-4bd8-8583-e2115658a55f" providerId="ADAL" clId="{0826C407-A27E-49D6-A5F0-3C0403B96868}" dt="2021-05-20T14:00:24.511" v="986" actId="164"/>
          <ac:spMkLst>
            <pc:docMk/>
            <pc:sldMk cId="557009560" sldId="272"/>
            <ac:spMk id="64" creationId="{9F20DE08-D283-4F89-808A-F3311D9C0023}"/>
          </ac:spMkLst>
        </pc:spChg>
        <pc:spChg chg="add mod">
          <ac:chgData name="Jessica" userId="dfaac082-a21f-4bd8-8583-e2115658a55f" providerId="ADAL" clId="{0826C407-A27E-49D6-A5F0-3C0403B96868}" dt="2021-05-20T14:00:19.606" v="985" actId="164"/>
          <ac:spMkLst>
            <pc:docMk/>
            <pc:sldMk cId="557009560" sldId="272"/>
            <ac:spMk id="65" creationId="{86725B70-B7BF-4DC9-BD51-10EDFA8C838D}"/>
          </ac:spMkLst>
        </pc:spChg>
        <pc:grpChg chg="add mod">
          <ac:chgData name="Jessica" userId="dfaac082-a21f-4bd8-8583-e2115658a55f" providerId="ADAL" clId="{0826C407-A27E-49D6-A5F0-3C0403B96868}" dt="2021-05-20T14:00:51.423" v="991" actId="555"/>
          <ac:grpSpMkLst>
            <pc:docMk/>
            <pc:sldMk cId="557009560" sldId="272"/>
            <ac:grpSpMk id="6" creationId="{4EE323DD-C1E9-4852-9DC4-015909C46D2F}"/>
          </ac:grpSpMkLst>
        </pc:grpChg>
        <pc:grpChg chg="add mod">
          <ac:chgData name="Jessica" userId="dfaac082-a21f-4bd8-8583-e2115658a55f" providerId="ADAL" clId="{0826C407-A27E-49D6-A5F0-3C0403B96868}" dt="2021-05-20T14:00:51.423" v="991" actId="555"/>
          <ac:grpSpMkLst>
            <pc:docMk/>
            <pc:sldMk cId="557009560" sldId="272"/>
            <ac:grpSpMk id="7" creationId="{B2CCC395-5925-4EEC-BCFC-DA6EE35B0646}"/>
          </ac:grpSpMkLst>
        </pc:grpChg>
        <pc:grpChg chg="add mod">
          <ac:chgData name="Jessica" userId="dfaac082-a21f-4bd8-8583-e2115658a55f" providerId="ADAL" clId="{0826C407-A27E-49D6-A5F0-3C0403B96868}" dt="2021-05-20T14:00:51.423" v="991" actId="555"/>
          <ac:grpSpMkLst>
            <pc:docMk/>
            <pc:sldMk cId="557009560" sldId="272"/>
            <ac:grpSpMk id="8" creationId="{1DD04BA8-0CA9-425B-9813-3CEA5971C7AD}"/>
          </ac:grpSpMkLst>
        </pc:grpChg>
        <pc:grpChg chg="add mod">
          <ac:chgData name="Jessica" userId="dfaac082-a21f-4bd8-8583-e2115658a55f" providerId="ADAL" clId="{0826C407-A27E-49D6-A5F0-3C0403B96868}" dt="2021-05-20T14:00:51.423" v="991" actId="555"/>
          <ac:grpSpMkLst>
            <pc:docMk/>
            <pc:sldMk cId="557009560" sldId="272"/>
            <ac:grpSpMk id="2048" creationId="{91C3A3E0-A1F6-420A-8CC7-54F94A62CEF6}"/>
          </ac:grpSpMkLst>
        </pc:grpChg>
        <pc:grpChg chg="add mod">
          <ac:chgData name="Jessica" userId="dfaac082-a21f-4bd8-8583-e2115658a55f" providerId="ADAL" clId="{0826C407-A27E-49D6-A5F0-3C0403B96868}" dt="2021-05-20T14:00:51.423" v="991" actId="555"/>
          <ac:grpSpMkLst>
            <pc:docMk/>
            <pc:sldMk cId="557009560" sldId="272"/>
            <ac:grpSpMk id="2049" creationId="{1C7A287C-7C0E-4714-B68B-50DA6F9E57F3}"/>
          </ac:grpSpMkLst>
        </pc:grpChg>
        <pc:grpChg chg="add mod">
          <ac:chgData name="Jessica" userId="dfaac082-a21f-4bd8-8583-e2115658a55f" providerId="ADAL" clId="{0826C407-A27E-49D6-A5F0-3C0403B96868}" dt="2021-05-20T14:00:51.423" v="991" actId="555"/>
          <ac:grpSpMkLst>
            <pc:docMk/>
            <pc:sldMk cId="557009560" sldId="272"/>
            <ac:grpSpMk id="2056" creationId="{238FE531-821F-4D53-9516-1C795AD23659}"/>
          </ac:grpSpMkLst>
        </pc:grpChg>
        <pc:picChg chg="add mod">
          <ac:chgData name="Jessica" userId="dfaac082-a21f-4bd8-8583-e2115658a55f" providerId="ADAL" clId="{0826C407-A27E-49D6-A5F0-3C0403B96868}" dt="2021-05-20T14:00:43.986" v="990" actId="164"/>
          <ac:picMkLst>
            <pc:docMk/>
            <pc:sldMk cId="557009560" sldId="272"/>
            <ac:picMk id="18" creationId="{B56B5050-06CA-4A75-A81A-432FD3F8CA5F}"/>
          </ac:picMkLst>
        </pc:picChg>
        <pc:picChg chg="add mod">
          <ac:chgData name="Jessica" userId="dfaac082-a21f-4bd8-8583-e2115658a55f" providerId="ADAL" clId="{0826C407-A27E-49D6-A5F0-3C0403B96868}" dt="2021-05-20T14:00:39.401" v="989" actId="164"/>
          <ac:picMkLst>
            <pc:docMk/>
            <pc:sldMk cId="557009560" sldId="272"/>
            <ac:picMk id="19" creationId="{E2EF43D9-D406-48A3-AB0D-CFDC146CA65F}"/>
          </ac:picMkLst>
        </pc:picChg>
        <pc:picChg chg="add mod">
          <ac:chgData name="Jessica" userId="dfaac082-a21f-4bd8-8583-e2115658a55f" providerId="ADAL" clId="{0826C407-A27E-49D6-A5F0-3C0403B96868}" dt="2021-05-20T14:00:34.518" v="988" actId="164"/>
          <ac:picMkLst>
            <pc:docMk/>
            <pc:sldMk cId="557009560" sldId="272"/>
            <ac:picMk id="20" creationId="{BF2E8123-BF0F-4BAA-997D-3D9412BE7CB1}"/>
          </ac:picMkLst>
        </pc:picChg>
        <pc:picChg chg="add mod">
          <ac:chgData name="Jessica" userId="dfaac082-a21f-4bd8-8583-e2115658a55f" providerId="ADAL" clId="{0826C407-A27E-49D6-A5F0-3C0403B96868}" dt="2021-05-20T14:00:30.250" v="987" actId="164"/>
          <ac:picMkLst>
            <pc:docMk/>
            <pc:sldMk cId="557009560" sldId="272"/>
            <ac:picMk id="21" creationId="{DFB499B1-5D18-4792-80B9-767A7680AEBF}"/>
          </ac:picMkLst>
        </pc:picChg>
        <pc:picChg chg="add mod">
          <ac:chgData name="Jessica" userId="dfaac082-a21f-4bd8-8583-e2115658a55f" providerId="ADAL" clId="{0826C407-A27E-49D6-A5F0-3C0403B96868}" dt="2021-05-20T14:00:24.511" v="986" actId="164"/>
          <ac:picMkLst>
            <pc:docMk/>
            <pc:sldMk cId="557009560" sldId="272"/>
            <ac:picMk id="22" creationId="{07ADFCD9-3957-477D-92B8-4B7AD5BE83C7}"/>
          </ac:picMkLst>
        </pc:picChg>
        <pc:picChg chg="add mod">
          <ac:chgData name="Jessica" userId="dfaac082-a21f-4bd8-8583-e2115658a55f" providerId="ADAL" clId="{0826C407-A27E-49D6-A5F0-3C0403B96868}" dt="2021-05-20T14:00:19.606" v="985" actId="164"/>
          <ac:picMkLst>
            <pc:docMk/>
            <pc:sldMk cId="557009560" sldId="272"/>
            <ac:picMk id="23" creationId="{306D1059-ACFC-4BC3-A109-9FDE05669EB9}"/>
          </ac:picMkLst>
        </pc:picChg>
        <pc:picChg chg="del mod">
          <ac:chgData name="Jessica" userId="dfaac082-a21f-4bd8-8583-e2115658a55f" providerId="ADAL" clId="{0826C407-A27E-49D6-A5F0-3C0403B96868}" dt="2021-05-20T13:53:43.868" v="733" actId="478"/>
          <ac:picMkLst>
            <pc:docMk/>
            <pc:sldMk cId="557009560" sldId="272"/>
            <ac:picMk id="2050" creationId="{00000000-0000-0000-0000-000000000000}"/>
          </ac:picMkLst>
        </pc:picChg>
        <pc:picChg chg="del mod">
          <ac:chgData name="Jessica" userId="dfaac082-a21f-4bd8-8583-e2115658a55f" providerId="ADAL" clId="{0826C407-A27E-49D6-A5F0-3C0403B96868}" dt="2021-05-20T13:53:43.868" v="733" actId="478"/>
          <ac:picMkLst>
            <pc:docMk/>
            <pc:sldMk cId="557009560" sldId="272"/>
            <ac:picMk id="2051" creationId="{00000000-0000-0000-0000-000000000000}"/>
          </ac:picMkLst>
        </pc:picChg>
        <pc:picChg chg="del mod">
          <ac:chgData name="Jessica" userId="dfaac082-a21f-4bd8-8583-e2115658a55f" providerId="ADAL" clId="{0826C407-A27E-49D6-A5F0-3C0403B96868}" dt="2021-05-20T13:53:43.868" v="733" actId="478"/>
          <ac:picMkLst>
            <pc:docMk/>
            <pc:sldMk cId="557009560" sldId="272"/>
            <ac:picMk id="2052" creationId="{00000000-0000-0000-0000-000000000000}"/>
          </ac:picMkLst>
        </pc:picChg>
        <pc:picChg chg="del mod">
          <ac:chgData name="Jessica" userId="dfaac082-a21f-4bd8-8583-e2115658a55f" providerId="ADAL" clId="{0826C407-A27E-49D6-A5F0-3C0403B96868}" dt="2021-05-20T13:53:43.868" v="733" actId="478"/>
          <ac:picMkLst>
            <pc:docMk/>
            <pc:sldMk cId="557009560" sldId="272"/>
            <ac:picMk id="2053" creationId="{00000000-0000-0000-0000-000000000000}"/>
          </ac:picMkLst>
        </pc:picChg>
        <pc:picChg chg="del mod">
          <ac:chgData name="Jessica" userId="dfaac082-a21f-4bd8-8583-e2115658a55f" providerId="ADAL" clId="{0826C407-A27E-49D6-A5F0-3C0403B96868}" dt="2021-05-20T13:53:43.868" v="733" actId="478"/>
          <ac:picMkLst>
            <pc:docMk/>
            <pc:sldMk cId="557009560" sldId="272"/>
            <ac:picMk id="2054" creationId="{00000000-0000-0000-0000-000000000000}"/>
          </ac:picMkLst>
        </pc:picChg>
        <pc:picChg chg="del mod">
          <ac:chgData name="Jessica" userId="dfaac082-a21f-4bd8-8583-e2115658a55f" providerId="ADAL" clId="{0826C407-A27E-49D6-A5F0-3C0403B96868}" dt="2021-05-20T13:53:43.868" v="733" actId="478"/>
          <ac:picMkLst>
            <pc:docMk/>
            <pc:sldMk cId="557009560" sldId="272"/>
            <ac:picMk id="2055" creationId="{00000000-0000-0000-0000-000000000000}"/>
          </ac:picMkLst>
        </pc:picChg>
      </pc:sldChg>
      <pc:sldChg chg="addSp delSp modSp add">
        <pc:chgData name="Jessica" userId="dfaac082-a21f-4bd8-8583-e2115658a55f" providerId="ADAL" clId="{0826C407-A27E-49D6-A5F0-3C0403B96868}" dt="2021-05-20T13:40:09.819" v="521" actId="732"/>
        <pc:sldMkLst>
          <pc:docMk/>
          <pc:sldMk cId="310262893" sldId="273"/>
        </pc:sldMkLst>
        <pc:spChg chg="del">
          <ac:chgData name="Jessica" userId="dfaac082-a21f-4bd8-8583-e2115658a55f" providerId="ADAL" clId="{0826C407-A27E-49D6-A5F0-3C0403B96868}" dt="2021-05-20T13:30:51.563" v="201" actId="478"/>
          <ac:spMkLst>
            <pc:docMk/>
            <pc:sldMk cId="310262893" sldId="273"/>
            <ac:spMk id="2" creationId="{A1F12355-F430-4E54-922D-59BEA4C78749}"/>
          </ac:spMkLst>
        </pc:spChg>
        <pc:spChg chg="del">
          <ac:chgData name="Jessica" userId="dfaac082-a21f-4bd8-8583-e2115658a55f" providerId="ADAL" clId="{0826C407-A27E-49D6-A5F0-3C0403B96868}" dt="2021-05-20T13:30:52.465" v="202" actId="478"/>
          <ac:spMkLst>
            <pc:docMk/>
            <pc:sldMk cId="310262893" sldId="273"/>
            <ac:spMk id="3" creationId="{4F655946-CCD3-4F0B-A72D-AEF787F9646D}"/>
          </ac:spMkLst>
        </pc:spChg>
        <pc:spChg chg="add mod">
          <ac:chgData name="Jessica" userId="dfaac082-a21f-4bd8-8583-e2115658a55f" providerId="ADAL" clId="{0826C407-A27E-49D6-A5F0-3C0403B96868}" dt="2021-05-20T13:39:45.110" v="517" actId="1076"/>
          <ac:spMkLst>
            <pc:docMk/>
            <pc:sldMk cId="310262893" sldId="273"/>
            <ac:spMk id="8" creationId="{939C6DD0-485E-4A4A-B0BA-7ADA5AA89F65}"/>
          </ac:spMkLst>
        </pc:spChg>
        <pc:spChg chg="add mod">
          <ac:chgData name="Jessica" userId="dfaac082-a21f-4bd8-8583-e2115658a55f" providerId="ADAL" clId="{0826C407-A27E-49D6-A5F0-3C0403B96868}" dt="2021-05-20T13:39:45.110" v="517" actId="1076"/>
          <ac:spMkLst>
            <pc:docMk/>
            <pc:sldMk cId="310262893" sldId="273"/>
            <ac:spMk id="9" creationId="{6AC4388D-6609-4CE0-957C-A30E1606BA5F}"/>
          </ac:spMkLst>
        </pc:spChg>
        <pc:spChg chg="add mod">
          <ac:chgData name="Jessica" userId="dfaac082-a21f-4bd8-8583-e2115658a55f" providerId="ADAL" clId="{0826C407-A27E-49D6-A5F0-3C0403B96868}" dt="2021-05-20T13:39:51.537" v="518" actId="1076"/>
          <ac:spMkLst>
            <pc:docMk/>
            <pc:sldMk cId="310262893" sldId="273"/>
            <ac:spMk id="10" creationId="{752D55AB-5546-4D19-9ADD-29B7C146D645}"/>
          </ac:spMkLst>
        </pc:spChg>
        <pc:spChg chg="add mod">
          <ac:chgData name="Jessica" userId="dfaac082-a21f-4bd8-8583-e2115658a55f" providerId="ADAL" clId="{0826C407-A27E-49D6-A5F0-3C0403B96868}" dt="2021-05-20T13:39:51.537" v="518" actId="1076"/>
          <ac:spMkLst>
            <pc:docMk/>
            <pc:sldMk cId="310262893" sldId="273"/>
            <ac:spMk id="11" creationId="{5342B7BC-7210-4B14-9CA4-83AB4447097C}"/>
          </ac:spMkLst>
        </pc:spChg>
        <pc:spChg chg="add mod">
          <ac:chgData name="Jessica" userId="dfaac082-a21f-4bd8-8583-e2115658a55f" providerId="ADAL" clId="{0826C407-A27E-49D6-A5F0-3C0403B96868}" dt="2021-05-20T13:39:45.110" v="517" actId="1076"/>
          <ac:spMkLst>
            <pc:docMk/>
            <pc:sldMk cId="310262893" sldId="273"/>
            <ac:spMk id="12" creationId="{9DEC926F-52A6-403B-8E31-E1C30CD15A07}"/>
          </ac:spMkLst>
        </pc:spChg>
        <pc:spChg chg="add mod">
          <ac:chgData name="Jessica" userId="dfaac082-a21f-4bd8-8583-e2115658a55f" providerId="ADAL" clId="{0826C407-A27E-49D6-A5F0-3C0403B96868}" dt="2021-05-20T13:39:45.110" v="517" actId="1076"/>
          <ac:spMkLst>
            <pc:docMk/>
            <pc:sldMk cId="310262893" sldId="273"/>
            <ac:spMk id="13" creationId="{EDD2059E-4AFD-499F-9E2F-79CC091FD978}"/>
          </ac:spMkLst>
        </pc:spChg>
        <pc:spChg chg="add mod">
          <ac:chgData name="Jessica" userId="dfaac082-a21f-4bd8-8583-e2115658a55f" providerId="ADAL" clId="{0826C407-A27E-49D6-A5F0-3C0403B96868}" dt="2021-05-20T13:39:45.110" v="517" actId="1076"/>
          <ac:spMkLst>
            <pc:docMk/>
            <pc:sldMk cId="310262893" sldId="273"/>
            <ac:spMk id="14" creationId="{7BC9467C-76F9-4A69-85CF-B824966484D1}"/>
          </ac:spMkLst>
        </pc:spChg>
        <pc:spChg chg="add mod">
          <ac:chgData name="Jessica" userId="dfaac082-a21f-4bd8-8583-e2115658a55f" providerId="ADAL" clId="{0826C407-A27E-49D6-A5F0-3C0403B96868}" dt="2021-05-20T13:39:45.110" v="517" actId="1076"/>
          <ac:spMkLst>
            <pc:docMk/>
            <pc:sldMk cId="310262893" sldId="273"/>
            <ac:spMk id="15" creationId="{42AD4116-3CD6-4DEC-B33F-A24908FE7FBE}"/>
          </ac:spMkLst>
        </pc:spChg>
        <pc:spChg chg="add mod">
          <ac:chgData name="Jessica" userId="dfaac082-a21f-4bd8-8583-e2115658a55f" providerId="ADAL" clId="{0826C407-A27E-49D6-A5F0-3C0403B96868}" dt="2021-05-20T13:39:45.110" v="517" actId="1076"/>
          <ac:spMkLst>
            <pc:docMk/>
            <pc:sldMk cId="310262893" sldId="273"/>
            <ac:spMk id="16" creationId="{4259CA60-EA8F-4D47-B828-AAE5016ED1E9}"/>
          </ac:spMkLst>
        </pc:spChg>
        <pc:spChg chg="add mod">
          <ac:chgData name="Jessica" userId="dfaac082-a21f-4bd8-8583-e2115658a55f" providerId="ADAL" clId="{0826C407-A27E-49D6-A5F0-3C0403B96868}" dt="2021-05-20T13:39:45.110" v="517" actId="1076"/>
          <ac:spMkLst>
            <pc:docMk/>
            <pc:sldMk cId="310262893" sldId="273"/>
            <ac:spMk id="17" creationId="{15A11B7B-5C2B-4888-8C25-4355DCED7C5C}"/>
          </ac:spMkLst>
        </pc:spChg>
        <pc:spChg chg="add mod">
          <ac:chgData name="Jessica" userId="dfaac082-a21f-4bd8-8583-e2115658a55f" providerId="ADAL" clId="{0826C407-A27E-49D6-A5F0-3C0403B96868}" dt="2021-05-20T13:39:45.110" v="517" actId="1076"/>
          <ac:spMkLst>
            <pc:docMk/>
            <pc:sldMk cId="310262893" sldId="273"/>
            <ac:spMk id="18" creationId="{329C4807-FDE0-4B17-8036-99441F499639}"/>
          </ac:spMkLst>
        </pc:spChg>
        <pc:spChg chg="add mod">
          <ac:chgData name="Jessica" userId="dfaac082-a21f-4bd8-8583-e2115658a55f" providerId="ADAL" clId="{0826C407-A27E-49D6-A5F0-3C0403B96868}" dt="2021-05-20T13:39:45.110" v="517" actId="1076"/>
          <ac:spMkLst>
            <pc:docMk/>
            <pc:sldMk cId="310262893" sldId="273"/>
            <ac:spMk id="19" creationId="{2DF792FA-7B4E-41BE-83C3-E838FBC11D52}"/>
          </ac:spMkLst>
        </pc:spChg>
        <pc:spChg chg="add mod">
          <ac:chgData name="Jessica" userId="dfaac082-a21f-4bd8-8583-e2115658a55f" providerId="ADAL" clId="{0826C407-A27E-49D6-A5F0-3C0403B96868}" dt="2021-05-20T13:39:51.537" v="518" actId="1076"/>
          <ac:spMkLst>
            <pc:docMk/>
            <pc:sldMk cId="310262893" sldId="273"/>
            <ac:spMk id="20" creationId="{A8470ACA-6557-4335-81D9-116AA8E90950}"/>
          </ac:spMkLst>
        </pc:spChg>
        <pc:spChg chg="add mod">
          <ac:chgData name="Jessica" userId="dfaac082-a21f-4bd8-8583-e2115658a55f" providerId="ADAL" clId="{0826C407-A27E-49D6-A5F0-3C0403B96868}" dt="2021-05-20T13:39:51.537" v="518" actId="1076"/>
          <ac:spMkLst>
            <pc:docMk/>
            <pc:sldMk cId="310262893" sldId="273"/>
            <ac:spMk id="21" creationId="{273640B6-6490-4555-A75B-943DB4C10CEF}"/>
          </ac:spMkLst>
        </pc:spChg>
        <pc:spChg chg="add mod">
          <ac:chgData name="Jessica" userId="dfaac082-a21f-4bd8-8583-e2115658a55f" providerId="ADAL" clId="{0826C407-A27E-49D6-A5F0-3C0403B96868}" dt="2021-05-20T13:39:51.537" v="518" actId="1076"/>
          <ac:spMkLst>
            <pc:docMk/>
            <pc:sldMk cId="310262893" sldId="273"/>
            <ac:spMk id="22" creationId="{58AF532F-4665-480A-8F2F-B31373A58864}"/>
          </ac:spMkLst>
        </pc:spChg>
        <pc:spChg chg="add mod">
          <ac:chgData name="Jessica" userId="dfaac082-a21f-4bd8-8583-e2115658a55f" providerId="ADAL" clId="{0826C407-A27E-49D6-A5F0-3C0403B96868}" dt="2021-05-20T13:39:51.537" v="518" actId="1076"/>
          <ac:spMkLst>
            <pc:docMk/>
            <pc:sldMk cId="310262893" sldId="273"/>
            <ac:spMk id="23" creationId="{9A390AEA-2ADF-4128-B32F-38D1143A4892}"/>
          </ac:spMkLst>
        </pc:spChg>
        <pc:spChg chg="add mod">
          <ac:chgData name="Jessica" userId="dfaac082-a21f-4bd8-8583-e2115658a55f" providerId="ADAL" clId="{0826C407-A27E-49D6-A5F0-3C0403B96868}" dt="2021-05-20T13:39:51.537" v="518" actId="1076"/>
          <ac:spMkLst>
            <pc:docMk/>
            <pc:sldMk cId="310262893" sldId="273"/>
            <ac:spMk id="24" creationId="{39C92FF1-8F2B-4F6D-BDEC-C59DE14D6839}"/>
          </ac:spMkLst>
        </pc:spChg>
        <pc:spChg chg="add mod">
          <ac:chgData name="Jessica" userId="dfaac082-a21f-4bd8-8583-e2115658a55f" providerId="ADAL" clId="{0826C407-A27E-49D6-A5F0-3C0403B96868}" dt="2021-05-20T13:39:51.537" v="518" actId="1076"/>
          <ac:spMkLst>
            <pc:docMk/>
            <pc:sldMk cId="310262893" sldId="273"/>
            <ac:spMk id="25" creationId="{791652FF-DC2E-46FE-BE53-C3488364BE1A}"/>
          </ac:spMkLst>
        </pc:spChg>
        <pc:spChg chg="add mod">
          <ac:chgData name="Jessica" userId="dfaac082-a21f-4bd8-8583-e2115658a55f" providerId="ADAL" clId="{0826C407-A27E-49D6-A5F0-3C0403B96868}" dt="2021-05-20T13:39:51.537" v="518" actId="1076"/>
          <ac:spMkLst>
            <pc:docMk/>
            <pc:sldMk cId="310262893" sldId="273"/>
            <ac:spMk id="26" creationId="{7B1CA57E-5BB1-43DA-ACA7-41ABD367A22D}"/>
          </ac:spMkLst>
        </pc:spChg>
        <pc:spChg chg="add mod">
          <ac:chgData name="Jessica" userId="dfaac082-a21f-4bd8-8583-e2115658a55f" providerId="ADAL" clId="{0826C407-A27E-49D6-A5F0-3C0403B96868}" dt="2021-05-20T13:39:51.537" v="518" actId="1076"/>
          <ac:spMkLst>
            <pc:docMk/>
            <pc:sldMk cId="310262893" sldId="273"/>
            <ac:spMk id="27" creationId="{3F1C91C3-57E8-42A6-B36E-EF6717D6449F}"/>
          </ac:spMkLst>
        </pc:spChg>
        <pc:spChg chg="add mod">
          <ac:chgData name="Jessica" userId="dfaac082-a21f-4bd8-8583-e2115658a55f" providerId="ADAL" clId="{0826C407-A27E-49D6-A5F0-3C0403B96868}" dt="2021-05-20T13:38:28.448" v="500" actId="14100"/>
          <ac:spMkLst>
            <pc:docMk/>
            <pc:sldMk cId="310262893" sldId="273"/>
            <ac:spMk id="28" creationId="{2AAA313B-6817-4EFE-99FB-0B6490AEA5C6}"/>
          </ac:spMkLst>
        </pc:spChg>
        <pc:spChg chg="add mod">
          <ac:chgData name="Jessica" userId="dfaac082-a21f-4bd8-8583-e2115658a55f" providerId="ADAL" clId="{0826C407-A27E-49D6-A5F0-3C0403B96868}" dt="2021-05-20T13:39:45.110" v="517" actId="1076"/>
          <ac:spMkLst>
            <pc:docMk/>
            <pc:sldMk cId="310262893" sldId="273"/>
            <ac:spMk id="29" creationId="{6A04A0A5-2E8B-4AA1-850F-D2D2F4D5FAB1}"/>
          </ac:spMkLst>
        </pc:spChg>
        <pc:spChg chg="add mod">
          <ac:chgData name="Jessica" userId="dfaac082-a21f-4bd8-8583-e2115658a55f" providerId="ADAL" clId="{0826C407-A27E-49D6-A5F0-3C0403B96868}" dt="2021-05-20T13:39:51.537" v="518" actId="1076"/>
          <ac:spMkLst>
            <pc:docMk/>
            <pc:sldMk cId="310262893" sldId="273"/>
            <ac:spMk id="30" creationId="{3A8D7D16-06B8-4402-8EF1-62A39420E298}"/>
          </ac:spMkLst>
        </pc:spChg>
        <pc:picChg chg="add mod modCrop">
          <ac:chgData name="Jessica" userId="dfaac082-a21f-4bd8-8583-e2115658a55f" providerId="ADAL" clId="{0826C407-A27E-49D6-A5F0-3C0403B96868}" dt="2021-05-20T13:39:45.110" v="517" actId="1076"/>
          <ac:picMkLst>
            <pc:docMk/>
            <pc:sldMk cId="310262893" sldId="273"/>
            <ac:picMk id="4" creationId="{20FF207D-471A-4B81-A575-6B36D0BAE1D3}"/>
          </ac:picMkLst>
        </pc:picChg>
        <pc:picChg chg="add mod modCrop">
          <ac:chgData name="Jessica" userId="dfaac082-a21f-4bd8-8583-e2115658a55f" providerId="ADAL" clId="{0826C407-A27E-49D6-A5F0-3C0403B96868}" dt="2021-05-20T13:40:09.819" v="521" actId="732"/>
          <ac:picMkLst>
            <pc:docMk/>
            <pc:sldMk cId="310262893" sldId="273"/>
            <ac:picMk id="5" creationId="{94947B00-3331-4F81-AFC5-4E48A3BE4CDE}"/>
          </ac:picMkLst>
        </pc:picChg>
        <pc:picChg chg="add del mod modCrop">
          <ac:chgData name="Jessica" userId="dfaac082-a21f-4bd8-8583-e2115658a55f" providerId="ADAL" clId="{0826C407-A27E-49D6-A5F0-3C0403B96868}" dt="2021-05-20T13:38:12.850" v="488" actId="478"/>
          <ac:picMkLst>
            <pc:docMk/>
            <pc:sldMk cId="310262893" sldId="273"/>
            <ac:picMk id="6" creationId="{0B901B3C-FC50-4181-AB39-66A0622EE396}"/>
          </ac:picMkLst>
        </pc:picChg>
        <pc:picChg chg="add del mod modCrop">
          <ac:chgData name="Jessica" userId="dfaac082-a21f-4bd8-8583-e2115658a55f" providerId="ADAL" clId="{0826C407-A27E-49D6-A5F0-3C0403B96868}" dt="2021-05-20T13:38:12.094" v="487" actId="478"/>
          <ac:picMkLst>
            <pc:docMk/>
            <pc:sldMk cId="310262893" sldId="273"/>
            <ac:picMk id="7" creationId="{7951EFAA-3537-4E14-BF16-2033ED8E3810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6AE831-6BDB-46A7-BA49-DD9F01D68CA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E450B04-DB9D-4DED-9C2F-1D549DB25EB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8166CD-D46E-425B-88BF-EC3093034D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4585EA-504F-4B2B-846E-3A8A88438221}" type="datetimeFigureOut">
              <a:rPr lang="en-GB" smtClean="0"/>
              <a:t>20/05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A5015F-CA15-4B57-95D1-7EC35B1FEA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78CFE96-08F3-4F35-BFDE-821AF7D572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86C63-BB9B-4B7A-A140-08A83EE812F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71287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C4918B-384F-4061-B4C4-3B26913BE8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63152FF-3B72-4D1D-A424-BE6A5E087E9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D39773-74F5-4505-94D6-B30A55F39B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4585EA-504F-4B2B-846E-3A8A88438221}" type="datetimeFigureOut">
              <a:rPr lang="en-GB" smtClean="0"/>
              <a:t>20/05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463302-5925-4CE7-9B3C-1C9ED325AC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C07976-1979-457D-AE26-133E3AC23A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86C63-BB9B-4B7A-A140-08A83EE812F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76984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7C32F39-73B6-47EB-9996-A27ADCF0C7E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565DEE1-5ED1-4587-BFFD-0AC0F855C06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EFFA6F9-DDFC-47F9-8171-F91157CAFB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4585EA-504F-4B2B-846E-3A8A88438221}" type="datetimeFigureOut">
              <a:rPr lang="en-GB" smtClean="0"/>
              <a:t>20/05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45A11A-D66A-4FC5-88A0-1F5E8D1BF4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03503B-3828-4DAB-85A1-7F9932BBED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86C63-BB9B-4B7A-A140-08A83EE812F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93259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93C437-B81C-4E9C-8B2F-1E4422F8DA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3678CD0-DF4E-454C-9B63-388C0EF5EAB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0700B0-C1CF-4F2A-8CBA-52ECAA8AB1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4585EA-504F-4B2B-846E-3A8A88438221}" type="datetimeFigureOut">
              <a:rPr lang="en-GB" smtClean="0"/>
              <a:t>20/05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4A2AAA-191F-41FD-98E6-B8A5CA8E43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A6336B-67D0-4895-A46D-CE127C86EA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86C63-BB9B-4B7A-A140-08A83EE812F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48461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2120CB-DF9C-4ABD-8B09-95973D9697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5680B95-A93E-4F5D-83EB-794B6302EE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6270A60-0987-4297-849D-8FE368D887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4585EA-504F-4B2B-846E-3A8A88438221}" type="datetimeFigureOut">
              <a:rPr lang="en-GB" smtClean="0"/>
              <a:t>20/05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67E1DA-21BA-4894-8A73-C56F6CC7CB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1C04D0-D1E8-40DD-9F76-5C68E20084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86C63-BB9B-4B7A-A140-08A83EE812F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574288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BB4EB1-3DC4-49D9-9A3F-385516A8BC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1C78E24-1332-456B-965F-671D409404F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6D4645D-B568-4629-BC0D-0C48D9B7C9D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6F40023-291D-4532-A0DF-2AF778C53A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4585EA-504F-4B2B-846E-3A8A88438221}" type="datetimeFigureOut">
              <a:rPr lang="en-GB" smtClean="0"/>
              <a:t>20/05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E3117DD-3E9A-4FEC-BA6A-F4F1CC2F86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6D52F92-0B2A-4575-B8FE-D60227ADEA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86C63-BB9B-4B7A-A140-08A83EE812F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830371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5CB08B-54D2-4D5D-B828-2AD72CC57A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E97C3E5-2B7E-4FBB-90CC-0297077828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E2C23CB-D80A-4440-8FA1-50D70B92550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154DEE9-27A1-46D7-9AD2-DBBF0A24AAA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B73A80F-B5DE-4973-8E20-DC537AEE625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CEA75F4-B032-4FF4-9F16-BF113E663D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4585EA-504F-4B2B-846E-3A8A88438221}" type="datetimeFigureOut">
              <a:rPr lang="en-GB" smtClean="0"/>
              <a:t>20/05/2021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B8B963F-D529-4AB3-8B39-3DF390B531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181A73A-B8BA-4501-B8E2-8C67406075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86C63-BB9B-4B7A-A140-08A83EE812F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747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DED2C0-D349-4959-A1D5-4C8A08E5D5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DC3789D-BE38-4B75-A8F3-E068D29E99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4585EA-504F-4B2B-846E-3A8A88438221}" type="datetimeFigureOut">
              <a:rPr lang="en-GB" smtClean="0"/>
              <a:t>20/05/2021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00C9DB9-3072-4027-A84B-AAC72A5165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0003F73-BDA0-4FF7-B97C-9C567F1FF5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86C63-BB9B-4B7A-A140-08A83EE812F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07820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8BDD88D-8253-4B6F-A7C5-4C7421E391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4585EA-504F-4B2B-846E-3A8A88438221}" type="datetimeFigureOut">
              <a:rPr lang="en-GB" smtClean="0"/>
              <a:t>20/05/2021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48E02D0-6A10-4233-B8AE-49EC86BB3A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964B66B-545D-4B4E-8A3C-676E02A330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86C63-BB9B-4B7A-A140-08A83EE812F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492758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DBE7D2-21FB-4666-B5B2-FDD9F4063C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17CD563-9C1C-48C5-8D3B-5C264CB9C87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FF44A6C-B925-4A86-A068-45874F425EF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4BB3832-1177-43E0-8213-629B5DEE46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4585EA-504F-4B2B-846E-3A8A88438221}" type="datetimeFigureOut">
              <a:rPr lang="en-GB" smtClean="0"/>
              <a:t>20/05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600DCD5-EC8A-4230-87AA-05219D7562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EEF7B28-8646-4B75-BC22-894B9FC2D4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86C63-BB9B-4B7A-A140-08A83EE812F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64718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93256F-E8A8-432B-88CA-87C316365B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A50360A-E25C-4E0B-B855-FE7D52ED3C5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0EA3835-F2D2-4649-927E-0A8797D4CAF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2E13340-9627-457A-9C53-CFDB3494E5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4585EA-504F-4B2B-846E-3A8A88438221}" type="datetimeFigureOut">
              <a:rPr lang="en-GB" smtClean="0"/>
              <a:t>20/05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A447555-60E0-499E-8993-23575A96AC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CE14DD7-FCF6-4A37-9CEF-4BB88F7D49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86C63-BB9B-4B7A-A140-08A83EE812F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76743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4BE39C4-915C-4304-A602-9101E6A9A2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B279A84-2D6A-4186-A1D0-25E63B254B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187E53-A8D4-46A2-880C-24B8DD79397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4585EA-504F-4B2B-846E-3A8A88438221}" type="datetimeFigureOut">
              <a:rPr lang="en-GB" smtClean="0"/>
              <a:t>20/05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BE5A782-BEFC-46EF-A435-1D38555ED58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2DB06BC-084E-49BD-B227-2B48F872898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986C63-BB9B-4B7A-A140-08A83EE812F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71869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jpeg"/><Relationship Id="rId2" Type="http://schemas.openxmlformats.org/officeDocument/2006/relationships/image" Target="../media/image30.jpe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tiff"/><Relationship Id="rId2" Type="http://schemas.openxmlformats.org/officeDocument/2006/relationships/image" Target="../media/image32.jpe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png"/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png"/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7" Type="http://schemas.openxmlformats.org/officeDocument/2006/relationships/image" Target="../media/image17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png"/><Relationship Id="rId5" Type="http://schemas.openxmlformats.org/officeDocument/2006/relationships/image" Target="../media/image15.png"/><Relationship Id="rId4" Type="http://schemas.microsoft.com/office/2007/relationships/hdphoto" Target="../media/hdphoto1.wdp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2.png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jpeg"/><Relationship Id="rId2" Type="http://schemas.openxmlformats.org/officeDocument/2006/relationships/image" Target="../media/image24.jpe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tiff"/><Relationship Id="rId2" Type="http://schemas.openxmlformats.org/officeDocument/2006/relationships/image" Target="../media/image28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E6CB7C-0BA8-4F61-AC8D-6D45E1A364C6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GB" dirty="0"/>
              <a:t>Supplementary information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0D0DF06-0341-4B03-99FC-C3B0C1A57748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574050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249B0446-D01C-43BF-892D-08E077709F4E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317" t="1693" r="31626" b="24063"/>
          <a:stretch/>
        </p:blipFill>
        <p:spPr>
          <a:xfrm>
            <a:off x="1093999" y="2058432"/>
            <a:ext cx="4014933" cy="3856203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E7D38749-DDDE-412A-A1A4-853DEA34C195}"/>
              </a:ext>
            </a:extLst>
          </p:cNvPr>
          <p:cNvSpPr txBox="1"/>
          <p:nvPr/>
        </p:nvSpPr>
        <p:spPr>
          <a:xfrm rot="16200000">
            <a:off x="1496690" y="1776308"/>
            <a:ext cx="236085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GB" sz="1000" i="1"/>
              <a:t>IN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7D672B7-54C0-429B-BE3D-D3ACF967DF88}"/>
              </a:ext>
            </a:extLst>
          </p:cNvPr>
          <p:cNvSpPr txBox="1"/>
          <p:nvPr/>
        </p:nvSpPr>
        <p:spPr>
          <a:xfrm rot="16200000">
            <a:off x="1651056" y="1709559"/>
            <a:ext cx="369584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GB" sz="1000" i="1"/>
              <a:t>GLUT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15026F8-65E0-4BB3-9AB9-F3030556D3A4}"/>
              </a:ext>
            </a:extLst>
          </p:cNvPr>
          <p:cNvSpPr txBox="1"/>
          <p:nvPr/>
        </p:nvSpPr>
        <p:spPr>
          <a:xfrm rot="16200000">
            <a:off x="1904884" y="1745510"/>
            <a:ext cx="297681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GB" sz="1000" i="1"/>
              <a:t>ZNT8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16CAE7E-A026-418C-818D-602AF1CBA5A5}"/>
              </a:ext>
            </a:extLst>
          </p:cNvPr>
          <p:cNvSpPr txBox="1"/>
          <p:nvPr/>
        </p:nvSpPr>
        <p:spPr>
          <a:xfrm rot="16200000">
            <a:off x="2133564" y="1752340"/>
            <a:ext cx="284019" cy="153890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GB" sz="1000" i="1"/>
              <a:t>PDX1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8E7E9B5-663F-433B-987B-6C70534D2E64}"/>
              </a:ext>
            </a:extLst>
          </p:cNvPr>
          <p:cNvSpPr txBox="1"/>
          <p:nvPr/>
        </p:nvSpPr>
        <p:spPr>
          <a:xfrm rot="16200000">
            <a:off x="2228871" y="1630505"/>
            <a:ext cx="527692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GB" sz="1000" i="1"/>
              <a:t>NKX6.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86A5B2E-13D4-44BB-BD84-07ED5F38123A}"/>
              </a:ext>
            </a:extLst>
          </p:cNvPr>
          <p:cNvSpPr txBox="1"/>
          <p:nvPr/>
        </p:nvSpPr>
        <p:spPr>
          <a:xfrm rot="16200000">
            <a:off x="2520992" y="1714472"/>
            <a:ext cx="359757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GB" sz="1000" i="1"/>
              <a:t>PC1/3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0668DB7-7751-4C6C-8E4F-9A97B599B1EA}"/>
              </a:ext>
            </a:extLst>
          </p:cNvPr>
          <p:cNvSpPr txBox="1"/>
          <p:nvPr/>
        </p:nvSpPr>
        <p:spPr>
          <a:xfrm rot="16200000">
            <a:off x="2729146" y="1714472"/>
            <a:ext cx="359757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GB" sz="1000" i="1"/>
              <a:t>SUR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A3A3B38-F183-4411-BFE6-7397C5E3C592}"/>
              </a:ext>
            </a:extLst>
          </p:cNvPr>
          <p:cNvSpPr txBox="1"/>
          <p:nvPr/>
        </p:nvSpPr>
        <p:spPr>
          <a:xfrm rot="16200000">
            <a:off x="2921588" y="1714472"/>
            <a:ext cx="359757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GB" sz="1000" i="1"/>
              <a:t>GCK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B8A156A-2CB0-4481-8F40-098567A70D03}"/>
              </a:ext>
            </a:extLst>
          </p:cNvPr>
          <p:cNvSpPr txBox="1"/>
          <p:nvPr/>
        </p:nvSpPr>
        <p:spPr>
          <a:xfrm rot="16200000">
            <a:off x="3051469" y="1630505"/>
            <a:ext cx="527691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GB" sz="1000" i="1"/>
              <a:t>CAR-SIV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681F7BB-A956-499A-AFEA-6D29AEBC84DF}"/>
              </a:ext>
            </a:extLst>
          </p:cNvPr>
          <p:cNvSpPr txBox="1"/>
          <p:nvPr/>
        </p:nvSpPr>
        <p:spPr>
          <a:xfrm rot="16200000">
            <a:off x="3341420" y="1714472"/>
            <a:ext cx="359757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GB" sz="1000" i="1"/>
              <a:t>ACTB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D490BD3-AD0B-41A9-903A-495B07EFE4DD}"/>
              </a:ext>
            </a:extLst>
          </p:cNvPr>
          <p:cNvSpPr txBox="1"/>
          <p:nvPr/>
        </p:nvSpPr>
        <p:spPr>
          <a:xfrm>
            <a:off x="680936" y="3069418"/>
            <a:ext cx="5258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/>
              <a:t>600 </a:t>
            </a:r>
            <a:r>
              <a:rPr lang="en-GB" sz="900" err="1"/>
              <a:t>bp</a:t>
            </a:r>
            <a:endParaRPr lang="en-GB" sz="90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61F246A-AF49-4C9A-85BA-7A6F3C9606DC}"/>
              </a:ext>
            </a:extLst>
          </p:cNvPr>
          <p:cNvSpPr txBox="1"/>
          <p:nvPr/>
        </p:nvSpPr>
        <p:spPr>
          <a:xfrm>
            <a:off x="680936" y="3167261"/>
            <a:ext cx="5258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/>
              <a:t>500 </a:t>
            </a:r>
            <a:r>
              <a:rPr lang="en-GB" sz="900" err="1"/>
              <a:t>bp</a:t>
            </a:r>
            <a:endParaRPr lang="en-GB" sz="90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C5C9C7D-5C7F-48A7-8C7E-9B11C60C3BCD}"/>
              </a:ext>
            </a:extLst>
          </p:cNvPr>
          <p:cNvSpPr txBox="1"/>
          <p:nvPr/>
        </p:nvSpPr>
        <p:spPr>
          <a:xfrm>
            <a:off x="680936" y="3755702"/>
            <a:ext cx="5258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/>
              <a:t>100 </a:t>
            </a:r>
            <a:r>
              <a:rPr lang="en-GB" sz="900" err="1"/>
              <a:t>bp</a:t>
            </a:r>
            <a:endParaRPr lang="en-GB" sz="90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20F2F4F-E665-4703-BB01-D174CB58EFAC}"/>
              </a:ext>
            </a:extLst>
          </p:cNvPr>
          <p:cNvSpPr txBox="1"/>
          <p:nvPr/>
        </p:nvSpPr>
        <p:spPr>
          <a:xfrm>
            <a:off x="680936" y="3442829"/>
            <a:ext cx="5258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/>
              <a:t>300 </a:t>
            </a:r>
            <a:r>
              <a:rPr lang="en-GB" sz="900" err="1"/>
              <a:t>bp</a:t>
            </a:r>
            <a:endParaRPr lang="en-GB" sz="90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0F49CC2-83C8-4D9C-BC15-AADC1B0EE95D}"/>
              </a:ext>
            </a:extLst>
          </p:cNvPr>
          <p:cNvSpPr txBox="1"/>
          <p:nvPr/>
        </p:nvSpPr>
        <p:spPr>
          <a:xfrm>
            <a:off x="680936" y="3565951"/>
            <a:ext cx="5258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/>
              <a:t>200 </a:t>
            </a:r>
            <a:r>
              <a:rPr lang="en-GB" sz="900" err="1"/>
              <a:t>bp</a:t>
            </a:r>
            <a:endParaRPr lang="en-GB" sz="90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14A4D33-DFD5-4C85-88DD-C0674C8337E8}"/>
              </a:ext>
            </a:extLst>
          </p:cNvPr>
          <p:cNvSpPr txBox="1"/>
          <p:nvPr/>
        </p:nvSpPr>
        <p:spPr>
          <a:xfrm>
            <a:off x="680936" y="3263161"/>
            <a:ext cx="5258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/>
              <a:t>400 </a:t>
            </a:r>
            <a:r>
              <a:rPr lang="en-GB" sz="900" err="1"/>
              <a:t>bp</a:t>
            </a:r>
            <a:endParaRPr lang="en-GB" sz="90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D2B0153-28B3-4676-BF4E-29E8CB2B84CB}"/>
              </a:ext>
            </a:extLst>
          </p:cNvPr>
          <p:cNvSpPr txBox="1"/>
          <p:nvPr/>
        </p:nvSpPr>
        <p:spPr>
          <a:xfrm>
            <a:off x="1068231" y="5872035"/>
            <a:ext cx="9391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h. Islets</a:t>
            </a:r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id="{85391806-21F1-4FBF-A2CD-2ED482940F6C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153" t="2619" r="30941" b="25908"/>
          <a:stretch/>
        </p:blipFill>
        <p:spPr>
          <a:xfrm>
            <a:off x="5410981" y="2299570"/>
            <a:ext cx="3747912" cy="3375378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2DEFC6FC-92EF-4248-ACB9-3EF114416E43}"/>
              </a:ext>
            </a:extLst>
          </p:cNvPr>
          <p:cNvSpPr txBox="1"/>
          <p:nvPr/>
        </p:nvSpPr>
        <p:spPr>
          <a:xfrm rot="16200000">
            <a:off x="5736543" y="2067016"/>
            <a:ext cx="236085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GB" sz="1000" i="1"/>
              <a:t>INS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770243BE-7855-44C8-B60F-477FA52295C5}"/>
              </a:ext>
            </a:extLst>
          </p:cNvPr>
          <p:cNvSpPr txBox="1"/>
          <p:nvPr/>
        </p:nvSpPr>
        <p:spPr>
          <a:xfrm rot="16200000">
            <a:off x="5890909" y="2000267"/>
            <a:ext cx="369584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GB" sz="1000" i="1"/>
              <a:t>GLUT1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417F7592-5710-4B4E-B50F-4E345560E5C9}"/>
              </a:ext>
            </a:extLst>
          </p:cNvPr>
          <p:cNvSpPr txBox="1"/>
          <p:nvPr/>
        </p:nvSpPr>
        <p:spPr>
          <a:xfrm rot="16200000">
            <a:off x="6144737" y="2036218"/>
            <a:ext cx="297681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GB" sz="1000" i="1"/>
              <a:t>ZNT8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B616F545-2270-43F9-8CB9-BD04959CC989}"/>
              </a:ext>
            </a:extLst>
          </p:cNvPr>
          <p:cNvSpPr txBox="1"/>
          <p:nvPr/>
        </p:nvSpPr>
        <p:spPr>
          <a:xfrm rot="16200000">
            <a:off x="6373417" y="2043048"/>
            <a:ext cx="284019" cy="153890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GB" sz="1000" i="1"/>
              <a:t>PDX1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6E1B6745-50AB-4A29-B531-F683C7227138}"/>
              </a:ext>
            </a:extLst>
          </p:cNvPr>
          <p:cNvSpPr txBox="1"/>
          <p:nvPr/>
        </p:nvSpPr>
        <p:spPr>
          <a:xfrm rot="16200000">
            <a:off x="6760845" y="2005180"/>
            <a:ext cx="359757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GB" sz="1000" i="1"/>
              <a:t>PC1/3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24860F2F-88EE-44FB-88BC-B03FF392D777}"/>
              </a:ext>
            </a:extLst>
          </p:cNvPr>
          <p:cNvSpPr txBox="1"/>
          <p:nvPr/>
        </p:nvSpPr>
        <p:spPr>
          <a:xfrm rot="16200000">
            <a:off x="6968999" y="2005180"/>
            <a:ext cx="359757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GB" sz="1000" i="1"/>
              <a:t>SUR1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33D8D392-A5AC-464F-991A-6D89CDCEABD5}"/>
              </a:ext>
            </a:extLst>
          </p:cNvPr>
          <p:cNvSpPr txBox="1"/>
          <p:nvPr/>
        </p:nvSpPr>
        <p:spPr>
          <a:xfrm rot="16200000">
            <a:off x="7161441" y="2005180"/>
            <a:ext cx="359757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GB" sz="1000" i="1"/>
              <a:t>GCK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77241103-9F1D-45E3-9418-675A69F0D128}"/>
              </a:ext>
            </a:extLst>
          </p:cNvPr>
          <p:cNvSpPr txBox="1"/>
          <p:nvPr/>
        </p:nvSpPr>
        <p:spPr>
          <a:xfrm rot="16200000">
            <a:off x="7581273" y="2005180"/>
            <a:ext cx="359757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GB" sz="1000" i="1"/>
              <a:t>ACTB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5997EB76-608B-44A0-9C03-70592E313519}"/>
              </a:ext>
            </a:extLst>
          </p:cNvPr>
          <p:cNvSpPr txBox="1"/>
          <p:nvPr/>
        </p:nvSpPr>
        <p:spPr>
          <a:xfrm rot="16200000">
            <a:off x="6459735" y="1921213"/>
            <a:ext cx="527692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GB" sz="1000" i="1"/>
              <a:t>NKX6.1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CEC34A9D-7FD4-46A2-9782-8880F4269EBA}"/>
              </a:ext>
            </a:extLst>
          </p:cNvPr>
          <p:cNvSpPr txBox="1"/>
          <p:nvPr/>
        </p:nvSpPr>
        <p:spPr>
          <a:xfrm rot="16200000">
            <a:off x="7302688" y="1921213"/>
            <a:ext cx="527691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GB" sz="1000" i="1"/>
              <a:t>CAR-SIV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3C2EECC3-5E64-4F20-87A3-DB9B662E142D}"/>
              </a:ext>
            </a:extLst>
          </p:cNvPr>
          <p:cNvSpPr txBox="1"/>
          <p:nvPr/>
        </p:nvSpPr>
        <p:spPr>
          <a:xfrm>
            <a:off x="5285582" y="5712515"/>
            <a:ext cx="14015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err="1"/>
              <a:t>EndoC</a:t>
            </a:r>
            <a:r>
              <a:rPr lang="en-GB" sz="1200" dirty="0"/>
              <a:t>-</a:t>
            </a:r>
            <a:r>
              <a:rPr lang="el-GR" sz="1200" dirty="0"/>
              <a:t>β</a:t>
            </a:r>
            <a:r>
              <a:rPr lang="en-GB" sz="1200" dirty="0"/>
              <a:t>H1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0359C45-03E2-4476-A724-3DD986F5F5BB}"/>
              </a:ext>
            </a:extLst>
          </p:cNvPr>
          <p:cNvSpPr txBox="1"/>
          <p:nvPr/>
        </p:nvSpPr>
        <p:spPr>
          <a:xfrm>
            <a:off x="408562" y="311285"/>
            <a:ext cx="17900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Figure 5A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53E466D2-7E6E-417D-857C-06EEDB64BAE8}"/>
              </a:ext>
            </a:extLst>
          </p:cNvPr>
          <p:cNvSpPr/>
          <p:nvPr/>
        </p:nvSpPr>
        <p:spPr>
          <a:xfrm>
            <a:off x="1230249" y="2993831"/>
            <a:ext cx="2598801" cy="1263843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C6BE788D-8C8A-433B-A229-CCCEF5AAB255}"/>
              </a:ext>
            </a:extLst>
          </p:cNvPr>
          <p:cNvSpPr/>
          <p:nvPr/>
        </p:nvSpPr>
        <p:spPr>
          <a:xfrm>
            <a:off x="5521995" y="3157735"/>
            <a:ext cx="2598801" cy="1263843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785860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1F90A589-9177-442D-90FD-E4DB4F5BCE5C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829" t="678" r="30622" b="26029"/>
          <a:stretch/>
        </p:blipFill>
        <p:spPr>
          <a:xfrm>
            <a:off x="967721" y="1415344"/>
            <a:ext cx="4504267" cy="4027311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03640C94-D800-43C3-B047-D720165EE807}"/>
              </a:ext>
            </a:extLst>
          </p:cNvPr>
          <p:cNvSpPr txBox="1"/>
          <p:nvPr/>
        </p:nvSpPr>
        <p:spPr>
          <a:xfrm rot="16200000">
            <a:off x="1609926" y="1202165"/>
            <a:ext cx="236085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GB" sz="1000" i="1"/>
              <a:t>IN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DD89CB1-DD19-45B1-BEA2-DA6ABF58E20C}"/>
              </a:ext>
            </a:extLst>
          </p:cNvPr>
          <p:cNvSpPr txBox="1"/>
          <p:nvPr/>
        </p:nvSpPr>
        <p:spPr>
          <a:xfrm rot="16200000">
            <a:off x="1734047" y="1144747"/>
            <a:ext cx="369584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GB" sz="1000" i="1"/>
              <a:t>GLUT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BADA522-E1A9-4975-9CDF-384119A4E0A6}"/>
              </a:ext>
            </a:extLst>
          </p:cNvPr>
          <p:cNvSpPr txBox="1"/>
          <p:nvPr/>
        </p:nvSpPr>
        <p:spPr>
          <a:xfrm rot="16200000">
            <a:off x="2014629" y="1180698"/>
            <a:ext cx="297681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GB" sz="1000" i="1"/>
              <a:t>ZNT8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0D69FDD-61E8-4E78-B61C-35C30F95182D}"/>
              </a:ext>
            </a:extLst>
          </p:cNvPr>
          <p:cNvSpPr txBox="1"/>
          <p:nvPr/>
        </p:nvSpPr>
        <p:spPr>
          <a:xfrm rot="16200000">
            <a:off x="2266091" y="1196389"/>
            <a:ext cx="284019" cy="153890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GB" sz="1000" i="1"/>
              <a:t>PDX1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BB43EF8-DC48-4413-8302-DB9B7A200CE2}"/>
              </a:ext>
            </a:extLst>
          </p:cNvPr>
          <p:cNvSpPr txBox="1"/>
          <p:nvPr/>
        </p:nvSpPr>
        <p:spPr>
          <a:xfrm rot="16200000">
            <a:off x="2409803" y="1115670"/>
            <a:ext cx="445458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GB" sz="1000" i="1"/>
              <a:t>NKX6.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88101B2-8CD1-4DC6-80F8-5D3267067D92}"/>
              </a:ext>
            </a:extLst>
          </p:cNvPr>
          <p:cNvSpPr txBox="1"/>
          <p:nvPr/>
        </p:nvSpPr>
        <p:spPr>
          <a:xfrm rot="16200000">
            <a:off x="2724408" y="1148444"/>
            <a:ext cx="359757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GB" sz="1000" i="1"/>
              <a:t>PC1/3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33A2B22-EB72-45DE-A150-1052C4AD442E}"/>
              </a:ext>
            </a:extLst>
          </p:cNvPr>
          <p:cNvSpPr txBox="1"/>
          <p:nvPr/>
        </p:nvSpPr>
        <p:spPr>
          <a:xfrm rot="16200000">
            <a:off x="2989270" y="1134567"/>
            <a:ext cx="359757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GB" sz="1000" i="1"/>
              <a:t>SUR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2EFBBA3-1B7D-45F7-B2AA-6883A6BDD0DB}"/>
              </a:ext>
            </a:extLst>
          </p:cNvPr>
          <p:cNvSpPr txBox="1"/>
          <p:nvPr/>
        </p:nvSpPr>
        <p:spPr>
          <a:xfrm rot="16200000">
            <a:off x="3214768" y="1158521"/>
            <a:ext cx="359757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GB" sz="1000" i="1"/>
              <a:t>GCK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E529596-B220-4710-9EBE-9B18AE0DA582}"/>
              </a:ext>
            </a:extLst>
          </p:cNvPr>
          <p:cNvSpPr txBox="1"/>
          <p:nvPr/>
        </p:nvSpPr>
        <p:spPr>
          <a:xfrm rot="16200000">
            <a:off x="3344549" y="1042296"/>
            <a:ext cx="555542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GB" sz="1000" i="1"/>
              <a:t>CAR-SIV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76A7346-9A7A-4045-9693-70F20FB14C94}"/>
              </a:ext>
            </a:extLst>
          </p:cNvPr>
          <p:cNvSpPr txBox="1"/>
          <p:nvPr/>
        </p:nvSpPr>
        <p:spPr>
          <a:xfrm rot="16200000">
            <a:off x="3715584" y="1158521"/>
            <a:ext cx="359757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GB" sz="1000" i="1"/>
              <a:t>ACTB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EE56AE7D-CD99-4F7B-A146-69E0F72E7CBF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870" t="1207" r="22349" b="25589"/>
          <a:stretch/>
        </p:blipFill>
        <p:spPr>
          <a:xfrm>
            <a:off x="6115455" y="1822000"/>
            <a:ext cx="3990108" cy="3620655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51E545CA-7D09-4068-9A1E-5EE7D9B3B6C1}"/>
              </a:ext>
            </a:extLst>
          </p:cNvPr>
          <p:cNvSpPr txBox="1"/>
          <p:nvPr/>
        </p:nvSpPr>
        <p:spPr>
          <a:xfrm>
            <a:off x="1083499" y="5460847"/>
            <a:ext cx="14015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1.1B4 Colony 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9EE9642-352F-4AA3-B187-E1195BD29F53}"/>
              </a:ext>
            </a:extLst>
          </p:cNvPr>
          <p:cNvSpPr txBox="1"/>
          <p:nvPr/>
        </p:nvSpPr>
        <p:spPr>
          <a:xfrm rot="16200000">
            <a:off x="6516229" y="1583631"/>
            <a:ext cx="236085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GB" sz="1000" i="1"/>
              <a:t>INS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3772EB4-9461-49ED-9154-D079DC060545}"/>
              </a:ext>
            </a:extLst>
          </p:cNvPr>
          <p:cNvSpPr txBox="1"/>
          <p:nvPr/>
        </p:nvSpPr>
        <p:spPr>
          <a:xfrm rot="16200000">
            <a:off x="6653177" y="1516882"/>
            <a:ext cx="369584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GB" sz="1000" i="1"/>
              <a:t>GLUT1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9AC6585-D682-484C-815B-127FBA79AF3A}"/>
              </a:ext>
            </a:extLst>
          </p:cNvPr>
          <p:cNvSpPr txBox="1"/>
          <p:nvPr/>
        </p:nvSpPr>
        <p:spPr>
          <a:xfrm rot="16200000">
            <a:off x="7119657" y="1552833"/>
            <a:ext cx="297681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GB" sz="1000" i="1"/>
              <a:t>ZNT8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0498C52-600E-4DCA-8311-1AE196A43901}"/>
              </a:ext>
            </a:extLst>
          </p:cNvPr>
          <p:cNvSpPr txBox="1"/>
          <p:nvPr/>
        </p:nvSpPr>
        <p:spPr>
          <a:xfrm rot="16200000">
            <a:off x="7352185" y="1559663"/>
            <a:ext cx="284019" cy="153890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GB" sz="1000" i="1"/>
              <a:t>PDX1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D26DD39-D541-438C-9E98-3E8BDA39673C}"/>
              </a:ext>
            </a:extLst>
          </p:cNvPr>
          <p:cNvSpPr txBox="1"/>
          <p:nvPr/>
        </p:nvSpPr>
        <p:spPr>
          <a:xfrm rot="16200000">
            <a:off x="7757031" y="1521795"/>
            <a:ext cx="359757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GB" sz="1000" i="1"/>
              <a:t>PC1/3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3A64E00D-4D89-42A1-BA08-F8FEAC7C6DAF}"/>
              </a:ext>
            </a:extLst>
          </p:cNvPr>
          <p:cNvSpPr txBox="1"/>
          <p:nvPr/>
        </p:nvSpPr>
        <p:spPr>
          <a:xfrm rot="16200000">
            <a:off x="7965185" y="1521795"/>
            <a:ext cx="359757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GB" sz="1000" i="1"/>
              <a:t>SUR1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C4ECC5B-B6B4-4B15-B1C4-7A748AD39FD5}"/>
              </a:ext>
            </a:extLst>
          </p:cNvPr>
          <p:cNvSpPr txBox="1"/>
          <p:nvPr/>
        </p:nvSpPr>
        <p:spPr>
          <a:xfrm rot="16200000">
            <a:off x="8166336" y="1521795"/>
            <a:ext cx="359757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GB" sz="1000" i="1"/>
              <a:t>GCK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F340AF2-2C57-4DD1-B9A6-0E9440CA7DD5}"/>
              </a:ext>
            </a:extLst>
          </p:cNvPr>
          <p:cNvSpPr txBox="1"/>
          <p:nvPr/>
        </p:nvSpPr>
        <p:spPr>
          <a:xfrm rot="16200000">
            <a:off x="8360959" y="1521795"/>
            <a:ext cx="359757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GB" sz="1000" i="1"/>
              <a:t>ACTB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9EAD1BF-2638-436C-806B-F14691971A8B}"/>
              </a:ext>
            </a:extLst>
          </p:cNvPr>
          <p:cNvSpPr txBox="1"/>
          <p:nvPr/>
        </p:nvSpPr>
        <p:spPr>
          <a:xfrm rot="16200000">
            <a:off x="6861646" y="1520036"/>
            <a:ext cx="363275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GB" sz="1000" i="1"/>
              <a:t>MAFA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C98D49E6-843E-4B23-8B25-29F39F1CF8EA}"/>
              </a:ext>
            </a:extLst>
          </p:cNvPr>
          <p:cNvSpPr txBox="1"/>
          <p:nvPr/>
        </p:nvSpPr>
        <p:spPr>
          <a:xfrm rot="16200000">
            <a:off x="7464982" y="1460048"/>
            <a:ext cx="483252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GB" sz="1000" i="1"/>
              <a:t>NKX6.1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3EF5FAA-7B79-42CC-9AA0-54D939258992}"/>
              </a:ext>
            </a:extLst>
          </p:cNvPr>
          <p:cNvSpPr txBox="1"/>
          <p:nvPr/>
        </p:nvSpPr>
        <p:spPr>
          <a:xfrm>
            <a:off x="6100984" y="5460846"/>
            <a:ext cx="61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PANC1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C5E76836-1554-4437-9C22-FBF283D1909A}"/>
              </a:ext>
            </a:extLst>
          </p:cNvPr>
          <p:cNvSpPr txBox="1"/>
          <p:nvPr/>
        </p:nvSpPr>
        <p:spPr>
          <a:xfrm>
            <a:off x="408562" y="311285"/>
            <a:ext cx="17900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Figure 5A</a:t>
            </a: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0842B428-4877-4535-B452-FE9C1A07DD2C}"/>
              </a:ext>
            </a:extLst>
          </p:cNvPr>
          <p:cNvSpPr/>
          <p:nvPr/>
        </p:nvSpPr>
        <p:spPr>
          <a:xfrm>
            <a:off x="1256187" y="2536631"/>
            <a:ext cx="2820513" cy="1263843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3D05118E-9DE6-43C0-B07E-7E27163D3CAA}"/>
              </a:ext>
            </a:extLst>
          </p:cNvPr>
          <p:cNvSpPr/>
          <p:nvPr/>
        </p:nvSpPr>
        <p:spPr>
          <a:xfrm>
            <a:off x="6219407" y="3470401"/>
            <a:ext cx="2820513" cy="1339724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5741117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E10DD320-6C6A-4C31-BE2E-32B12C245C0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8562" y="806579"/>
            <a:ext cx="5114925" cy="4371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26B347BB-F65A-40E1-8D44-25B2A0FE4554}"/>
              </a:ext>
            </a:extLst>
          </p:cNvPr>
          <p:cNvSpPr txBox="1"/>
          <p:nvPr/>
        </p:nvSpPr>
        <p:spPr>
          <a:xfrm>
            <a:off x="408562" y="311285"/>
            <a:ext cx="17900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Figure 5D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C7174C41-84CE-4B8E-8FC1-803B73BB670D}"/>
              </a:ext>
            </a:extLst>
          </p:cNvPr>
          <p:cNvSpPr/>
          <p:nvPr/>
        </p:nvSpPr>
        <p:spPr>
          <a:xfrm>
            <a:off x="1159410" y="1048624"/>
            <a:ext cx="3937833" cy="375826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F0CD575D-E64B-440A-B624-B16F0BF5934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60989" y="806579"/>
            <a:ext cx="5095875" cy="4343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449B6169-7498-4C9B-96F8-326A60A75ED9}"/>
              </a:ext>
            </a:extLst>
          </p:cNvPr>
          <p:cNvSpPr/>
          <p:nvPr/>
        </p:nvSpPr>
        <p:spPr>
          <a:xfrm>
            <a:off x="5986342" y="1424703"/>
            <a:ext cx="3988168" cy="331684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495B253B-9299-4A44-9BC8-EFA9B3FA0EFD}"/>
              </a:ext>
            </a:extLst>
          </p:cNvPr>
          <p:cNvSpPr/>
          <p:nvPr/>
        </p:nvSpPr>
        <p:spPr>
          <a:xfrm>
            <a:off x="1505840" y="1504950"/>
            <a:ext cx="2542285" cy="381001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1C4356D3-ED53-4454-8D8C-B4919EF6472B}"/>
              </a:ext>
            </a:extLst>
          </p:cNvPr>
          <p:cNvSpPr/>
          <p:nvPr/>
        </p:nvSpPr>
        <p:spPr>
          <a:xfrm>
            <a:off x="6592735" y="2505075"/>
            <a:ext cx="2542285" cy="422683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02654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BB7FAC9B-8021-403C-8449-50CC4880F6E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1553" y="904963"/>
            <a:ext cx="5067300" cy="4343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4922D3A7-6C01-4E29-A660-CD5C4322C673}"/>
              </a:ext>
            </a:extLst>
          </p:cNvPr>
          <p:cNvSpPr txBox="1"/>
          <p:nvPr/>
        </p:nvSpPr>
        <p:spPr>
          <a:xfrm>
            <a:off x="408562" y="311285"/>
            <a:ext cx="17900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Figure 5D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157514D0-1F0F-47F8-B66D-14C8051BABBF}"/>
              </a:ext>
            </a:extLst>
          </p:cNvPr>
          <p:cNvSpPr/>
          <p:nvPr/>
        </p:nvSpPr>
        <p:spPr>
          <a:xfrm>
            <a:off x="608999" y="1418241"/>
            <a:ext cx="3988168" cy="331684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22B06C6E-9A10-48D7-8320-6AFAA102D57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77586" y="1331752"/>
            <a:ext cx="4543425" cy="3657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8EECFCDF-B4C0-4E95-8DE5-7A9266B618CC}"/>
              </a:ext>
            </a:extLst>
          </p:cNvPr>
          <p:cNvSpPr/>
          <p:nvPr/>
        </p:nvSpPr>
        <p:spPr>
          <a:xfrm>
            <a:off x="5577586" y="1331752"/>
            <a:ext cx="4447258" cy="36576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88D9E5FE-B478-41A8-AEFC-C1601C50A723}"/>
              </a:ext>
            </a:extLst>
          </p:cNvPr>
          <p:cNvSpPr/>
          <p:nvPr/>
        </p:nvSpPr>
        <p:spPr>
          <a:xfrm>
            <a:off x="1184584" y="3238499"/>
            <a:ext cx="2501592" cy="381001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CCACB45D-68DA-425A-989A-383765B8A89B}"/>
              </a:ext>
            </a:extLst>
          </p:cNvPr>
          <p:cNvSpPr/>
          <p:nvPr/>
        </p:nvSpPr>
        <p:spPr>
          <a:xfrm>
            <a:off x="1184584" y="4132778"/>
            <a:ext cx="2501592" cy="381001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2E920453-A011-4DBC-BB97-2257247DD673}"/>
              </a:ext>
            </a:extLst>
          </p:cNvPr>
          <p:cNvSpPr/>
          <p:nvPr/>
        </p:nvSpPr>
        <p:spPr>
          <a:xfrm>
            <a:off x="6147180" y="2181224"/>
            <a:ext cx="2977770" cy="381001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4337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6">
            <a:extLst>
              <a:ext uri="{FF2B5EF4-FFF2-40B4-BE49-F238E27FC236}">
                <a16:creationId xmlns:a16="http://schemas.microsoft.com/office/drawing/2014/main" id="{DF3F3FB9-E17C-456D-9116-49442443C3A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4847125"/>
              </p:ext>
            </p:extLst>
          </p:nvPr>
        </p:nvGraphicFramePr>
        <p:xfrm>
          <a:off x="693818" y="1489687"/>
          <a:ext cx="10650459" cy="20624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401682">
                  <a:extLst>
                    <a:ext uri="{9D8B030D-6E8A-4147-A177-3AD203B41FA5}">
                      <a16:colId xmlns:a16="http://schemas.microsoft.com/office/drawing/2014/main" val="1850166567"/>
                    </a:ext>
                  </a:extLst>
                </a:gridCol>
                <a:gridCol w="3288599">
                  <a:extLst>
                    <a:ext uri="{9D8B030D-6E8A-4147-A177-3AD203B41FA5}">
                      <a16:colId xmlns:a16="http://schemas.microsoft.com/office/drawing/2014/main" val="1291202335"/>
                    </a:ext>
                  </a:extLst>
                </a:gridCol>
                <a:gridCol w="3288599">
                  <a:extLst>
                    <a:ext uri="{9D8B030D-6E8A-4147-A177-3AD203B41FA5}">
                      <a16:colId xmlns:a16="http://schemas.microsoft.com/office/drawing/2014/main" val="106702873"/>
                    </a:ext>
                  </a:extLst>
                </a:gridCol>
                <a:gridCol w="1576203">
                  <a:extLst>
                    <a:ext uri="{9D8B030D-6E8A-4147-A177-3AD203B41FA5}">
                      <a16:colId xmlns:a16="http://schemas.microsoft.com/office/drawing/2014/main" val="2708710299"/>
                    </a:ext>
                  </a:extLst>
                </a:gridCol>
                <a:gridCol w="1095376">
                  <a:extLst>
                    <a:ext uri="{9D8B030D-6E8A-4147-A177-3AD203B41FA5}">
                      <a16:colId xmlns:a16="http://schemas.microsoft.com/office/drawing/2014/main" val="3453509387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GB" sz="1600" b="0" dirty="0"/>
                        <a:t>Primer nam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600" b="0" dirty="0"/>
                        <a:t>Forward sequenc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600" b="0" dirty="0"/>
                        <a:t>Reverse sequenc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600" b="0" dirty="0"/>
                        <a:t>Annealing temperatur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600" b="0" dirty="0"/>
                        <a:t>Product siz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7761528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GB" sz="1600" b="0" dirty="0"/>
                        <a:t>Rat 1 (R.1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600" b="0" dirty="0"/>
                        <a:t>TGGCTTTCAGGCCACCAGG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600" b="0" dirty="0"/>
                        <a:t>GCTCTGTCCTCAGGGGCAGGT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600" b="0" dirty="0"/>
                        <a:t>66.5°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600" b="0" dirty="0"/>
                        <a:t>387bp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7139272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GB" sz="1600" b="0" dirty="0"/>
                        <a:t>Rat 2 (R.2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600" b="0" dirty="0"/>
                        <a:t>AGAAGAGTTACTGGCCCAAGGGAC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600" b="0" dirty="0"/>
                        <a:t>GGGGCTGAACGCTGGGAAG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600" b="0" dirty="0"/>
                        <a:t>66.5°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600" b="0" dirty="0"/>
                        <a:t>408bp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3567001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GB" sz="1600" b="0" dirty="0"/>
                        <a:t>Human 1 (H.1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600" b="0" dirty="0"/>
                        <a:t>TGGTCTGGGCCAGTGGCTC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600" b="0" dirty="0"/>
                        <a:t>GAGTGTTTTCCTTGTCCTGCAGGC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600" b="0" dirty="0"/>
                        <a:t>67.5°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600" b="0" dirty="0"/>
                        <a:t>332bp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914691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GB" sz="1600" b="0" dirty="0"/>
                        <a:t>Human 2 (H.2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600" b="0" dirty="0"/>
                        <a:t>TCGCACAGACACTGCGTGC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600" b="0" dirty="0"/>
                        <a:t>ACACTGGGGTCACAGCTCATGAG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600" b="0" dirty="0"/>
                        <a:t>67.5°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600" b="0" dirty="0"/>
                        <a:t>352bp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3615344"/>
                  </a:ext>
                </a:extLst>
              </a:tr>
            </a:tbl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457D6A30-836D-4C00-B69F-C747F6D68E4E}"/>
              </a:ext>
            </a:extLst>
          </p:cNvPr>
          <p:cNvSpPr txBox="1"/>
          <p:nvPr/>
        </p:nvSpPr>
        <p:spPr>
          <a:xfrm>
            <a:off x="593558" y="3762951"/>
            <a:ext cx="942473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Table 1. Details of the Vomeronasal receptor PCR primers used in this study. Previously verified in Holder and Cooper (2011)</a:t>
            </a:r>
            <a:r>
              <a:rPr lang="en-GB" baseline="30000" dirty="0"/>
              <a:t>28</a:t>
            </a:r>
            <a:r>
              <a:rPr lang="en-GB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40051502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94299" y="1305109"/>
            <a:ext cx="1296144" cy="283887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5668" y="1305109"/>
            <a:ext cx="1285876" cy="284437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86128" y="1291838"/>
            <a:ext cx="1019111" cy="28618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28849" y="1305109"/>
            <a:ext cx="1121355" cy="285835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" name="Picture 2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3073"/>
          <a:stretch/>
        </p:blipFill>
        <p:spPr bwMode="auto">
          <a:xfrm>
            <a:off x="3816338" y="1291838"/>
            <a:ext cx="969790" cy="30669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" name="Picture 3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704"/>
          <a:stretch/>
        </p:blipFill>
        <p:spPr bwMode="auto">
          <a:xfrm>
            <a:off x="7103134" y="1222970"/>
            <a:ext cx="2475755" cy="313579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975F7F80-18FD-4E74-A827-6ED5DB4615B2}"/>
              </a:ext>
            </a:extLst>
          </p:cNvPr>
          <p:cNvSpPr txBox="1"/>
          <p:nvPr/>
        </p:nvSpPr>
        <p:spPr>
          <a:xfrm>
            <a:off x="58721" y="147990"/>
            <a:ext cx="25950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Figure 3A – HeLa cells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2C00DF54-A0EE-49DF-8D5F-043425D2F462}"/>
              </a:ext>
            </a:extLst>
          </p:cNvPr>
          <p:cNvSpPr/>
          <p:nvPr/>
        </p:nvSpPr>
        <p:spPr>
          <a:xfrm>
            <a:off x="2653813" y="1775271"/>
            <a:ext cx="848659" cy="19512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FAA75E1E-8E60-4B58-9C6C-F59CFEB8092F}"/>
              </a:ext>
            </a:extLst>
          </p:cNvPr>
          <p:cNvSpPr/>
          <p:nvPr/>
        </p:nvSpPr>
        <p:spPr>
          <a:xfrm>
            <a:off x="1218216" y="1751652"/>
            <a:ext cx="906356" cy="229420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C652FF0E-5C37-4E61-9DFA-4678A9CBE36B}"/>
              </a:ext>
            </a:extLst>
          </p:cNvPr>
          <p:cNvSpPr/>
          <p:nvPr/>
        </p:nvSpPr>
        <p:spPr>
          <a:xfrm>
            <a:off x="4898883" y="1785016"/>
            <a:ext cx="906356" cy="21933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E9F46D42-4628-42A8-8BD4-B9988262DCA9}"/>
              </a:ext>
            </a:extLst>
          </p:cNvPr>
          <p:cNvSpPr/>
          <p:nvPr/>
        </p:nvSpPr>
        <p:spPr>
          <a:xfrm>
            <a:off x="6181439" y="1785015"/>
            <a:ext cx="722728" cy="229420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1F2C9789-2E57-44C2-BAEB-A49BD6DC2A4A}"/>
              </a:ext>
            </a:extLst>
          </p:cNvPr>
          <p:cNvSpPr/>
          <p:nvPr/>
        </p:nvSpPr>
        <p:spPr>
          <a:xfrm>
            <a:off x="4011230" y="1754877"/>
            <a:ext cx="690549" cy="211881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777D00D8-5E75-4614-BC67-3838BA5DCFE0}"/>
              </a:ext>
            </a:extLst>
          </p:cNvPr>
          <p:cNvSpPr/>
          <p:nvPr/>
        </p:nvSpPr>
        <p:spPr>
          <a:xfrm>
            <a:off x="7520536" y="1746682"/>
            <a:ext cx="642628" cy="231512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7AA119D1-6876-482B-B098-A4F4659E5C03}"/>
              </a:ext>
            </a:extLst>
          </p:cNvPr>
          <p:cNvSpPr/>
          <p:nvPr/>
        </p:nvSpPr>
        <p:spPr>
          <a:xfrm>
            <a:off x="8495440" y="1728566"/>
            <a:ext cx="976569" cy="231512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9A6FB35D-043B-42C3-97FF-9E93CF88BAB0}"/>
              </a:ext>
            </a:extLst>
          </p:cNvPr>
          <p:cNvSpPr/>
          <p:nvPr/>
        </p:nvSpPr>
        <p:spPr>
          <a:xfrm>
            <a:off x="1339516" y="2855494"/>
            <a:ext cx="728888" cy="344906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C430E9BB-BA7A-4EDA-901D-0969F1006041}"/>
              </a:ext>
            </a:extLst>
          </p:cNvPr>
          <p:cNvSpPr/>
          <p:nvPr/>
        </p:nvSpPr>
        <p:spPr>
          <a:xfrm>
            <a:off x="2680265" y="1997241"/>
            <a:ext cx="544000" cy="344906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09FE1220-ABB0-4441-B85E-4D25FF116164}"/>
              </a:ext>
            </a:extLst>
          </p:cNvPr>
          <p:cNvSpPr/>
          <p:nvPr/>
        </p:nvSpPr>
        <p:spPr>
          <a:xfrm>
            <a:off x="4105523" y="2377875"/>
            <a:ext cx="544000" cy="344906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44BCEA06-73E3-43FD-A574-EFFF134D0D72}"/>
              </a:ext>
            </a:extLst>
          </p:cNvPr>
          <p:cNvSpPr/>
          <p:nvPr/>
        </p:nvSpPr>
        <p:spPr>
          <a:xfrm>
            <a:off x="5163424" y="2208095"/>
            <a:ext cx="558545" cy="344906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F3202B8B-0AA2-4992-8736-FCC11FDA660D}"/>
              </a:ext>
            </a:extLst>
          </p:cNvPr>
          <p:cNvSpPr/>
          <p:nvPr/>
        </p:nvSpPr>
        <p:spPr>
          <a:xfrm>
            <a:off x="6304547" y="3622333"/>
            <a:ext cx="596853" cy="344906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8232356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7CC24D83-2869-4A0F-B805-7800429C219C}"/>
              </a:ext>
            </a:extLst>
          </p:cNvPr>
          <p:cNvSpPr txBox="1"/>
          <p:nvPr/>
        </p:nvSpPr>
        <p:spPr>
          <a:xfrm>
            <a:off x="95962" y="110894"/>
            <a:ext cx="26593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Figure 3A – Human islets</a:t>
            </a:r>
          </a:p>
        </p:txBody>
      </p:sp>
      <p:grpSp>
        <p:nvGrpSpPr>
          <p:cNvPr id="2056" name="Group 2055">
            <a:extLst>
              <a:ext uri="{FF2B5EF4-FFF2-40B4-BE49-F238E27FC236}">
                <a16:creationId xmlns:a16="http://schemas.microsoft.com/office/drawing/2014/main" id="{238FE531-821F-4D53-9516-1C795AD23659}"/>
              </a:ext>
            </a:extLst>
          </p:cNvPr>
          <p:cNvGrpSpPr/>
          <p:nvPr/>
        </p:nvGrpSpPr>
        <p:grpSpPr>
          <a:xfrm>
            <a:off x="87103" y="1169583"/>
            <a:ext cx="1701516" cy="3515721"/>
            <a:chOff x="87103" y="1138214"/>
            <a:chExt cx="1701516" cy="3515721"/>
          </a:xfrm>
        </p:grpSpPr>
        <p:pic>
          <p:nvPicPr>
            <p:cNvPr id="18" name="Picture 2">
              <a:extLst>
                <a:ext uri="{FF2B5EF4-FFF2-40B4-BE49-F238E27FC236}">
                  <a16:creationId xmlns:a16="http://schemas.microsoft.com/office/drawing/2014/main" id="{B56B5050-06CA-4A75-A81A-432FD3F8CA5F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9352" r="13017"/>
            <a:stretch/>
          </p:blipFill>
          <p:spPr bwMode="auto">
            <a:xfrm flipH="1">
              <a:off x="571514" y="1847161"/>
              <a:ext cx="1207113" cy="280677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ACD1332D-1354-4212-8A54-710E989607A5}"/>
                </a:ext>
              </a:extLst>
            </p:cNvPr>
            <p:cNvSpPr/>
            <p:nvPr/>
          </p:nvSpPr>
          <p:spPr>
            <a:xfrm>
              <a:off x="873217" y="2467337"/>
              <a:ext cx="744642" cy="344906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0F0C5239-87FF-419B-95D3-6423DF0355BE}"/>
                </a:ext>
              </a:extLst>
            </p:cNvPr>
            <p:cNvSpPr/>
            <p:nvPr/>
          </p:nvSpPr>
          <p:spPr>
            <a:xfrm>
              <a:off x="732052" y="1882852"/>
              <a:ext cx="1056567" cy="270134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F64109BF-6661-4DCD-A8F8-98C56AFBC9BC}"/>
                </a:ext>
              </a:extLst>
            </p:cNvPr>
            <p:cNvSpPr txBox="1"/>
            <p:nvPr/>
          </p:nvSpPr>
          <p:spPr>
            <a:xfrm>
              <a:off x="867904" y="1138214"/>
              <a:ext cx="755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/>
                <a:t>STAT1</a:t>
              </a:r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ECA29094-EA1B-4207-87DF-F9B31A467017}"/>
                </a:ext>
              </a:extLst>
            </p:cNvPr>
            <p:cNvSpPr txBox="1"/>
            <p:nvPr/>
          </p:nvSpPr>
          <p:spPr>
            <a:xfrm rot="16200000">
              <a:off x="1245592" y="1556788"/>
              <a:ext cx="39532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50" dirty="0"/>
                <a:t>IFN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2E556F82-9018-4130-95F0-D681A1F06AD0}"/>
                </a:ext>
              </a:extLst>
            </p:cNvPr>
            <p:cNvSpPr txBox="1"/>
            <p:nvPr/>
          </p:nvSpPr>
          <p:spPr>
            <a:xfrm rot="16200000">
              <a:off x="723340" y="1458079"/>
              <a:ext cx="649545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50" dirty="0"/>
                <a:t>Control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6A29743A-1275-40B8-8248-AFED4A3ED872}"/>
                </a:ext>
              </a:extLst>
            </p:cNvPr>
            <p:cNvSpPr txBox="1"/>
            <p:nvPr/>
          </p:nvSpPr>
          <p:spPr>
            <a:xfrm>
              <a:off x="87103" y="2393569"/>
              <a:ext cx="54562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/>
                <a:t>75 </a:t>
              </a:r>
              <a:r>
                <a:rPr lang="en-GB" sz="1000" dirty="0" err="1"/>
                <a:t>kDa</a:t>
              </a:r>
              <a:endParaRPr lang="en-GB" sz="1000" dirty="0"/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F307BABB-81E1-452B-B0E1-9DF0D5E47345}"/>
                </a:ext>
              </a:extLst>
            </p:cNvPr>
            <p:cNvSpPr txBox="1"/>
            <p:nvPr/>
          </p:nvSpPr>
          <p:spPr>
            <a:xfrm>
              <a:off x="96629" y="2575547"/>
              <a:ext cx="54562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/>
                <a:t>41 </a:t>
              </a:r>
              <a:r>
                <a:rPr lang="en-GB" sz="1000" dirty="0" err="1"/>
                <a:t>kDa</a:t>
              </a:r>
              <a:endParaRPr lang="en-GB" sz="1000" dirty="0"/>
            </a:p>
          </p:txBody>
        </p:sp>
      </p:grpSp>
      <p:grpSp>
        <p:nvGrpSpPr>
          <p:cNvPr id="2049" name="Group 2048">
            <a:extLst>
              <a:ext uri="{FF2B5EF4-FFF2-40B4-BE49-F238E27FC236}">
                <a16:creationId xmlns:a16="http://schemas.microsoft.com/office/drawing/2014/main" id="{1C7A287C-7C0E-4714-B68B-50DA6F9E57F3}"/>
              </a:ext>
            </a:extLst>
          </p:cNvPr>
          <p:cNvGrpSpPr/>
          <p:nvPr/>
        </p:nvGrpSpPr>
        <p:grpSpPr>
          <a:xfrm>
            <a:off x="1873758" y="1161310"/>
            <a:ext cx="1660179" cy="3523994"/>
            <a:chOff x="1873758" y="1110056"/>
            <a:chExt cx="1660179" cy="3523994"/>
          </a:xfrm>
        </p:grpSpPr>
        <p:pic>
          <p:nvPicPr>
            <p:cNvPr id="19" name="Picture 3">
              <a:extLst>
                <a:ext uri="{FF2B5EF4-FFF2-40B4-BE49-F238E27FC236}">
                  <a16:creationId xmlns:a16="http://schemas.microsoft.com/office/drawing/2014/main" id="{E2EF43D9-D406-48A3-AB0D-CFDC146CA65F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2093"/>
            <a:stretch/>
          </p:blipFill>
          <p:spPr bwMode="auto">
            <a:xfrm flipH="1">
              <a:off x="2441624" y="1940977"/>
              <a:ext cx="1080120" cy="26847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069C64D2-A62A-4DFE-AC74-8E0423286DE1}"/>
                </a:ext>
              </a:extLst>
            </p:cNvPr>
            <p:cNvSpPr/>
            <p:nvPr/>
          </p:nvSpPr>
          <p:spPr>
            <a:xfrm>
              <a:off x="2635951" y="2266726"/>
              <a:ext cx="744642" cy="344906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032343CA-AE50-4CF0-A6D9-F6221BB42CC6}"/>
                </a:ext>
              </a:extLst>
            </p:cNvPr>
            <p:cNvSpPr/>
            <p:nvPr/>
          </p:nvSpPr>
          <p:spPr>
            <a:xfrm>
              <a:off x="2529287" y="1932701"/>
              <a:ext cx="1004650" cy="270134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22A0A310-BC1F-4A4A-ADFD-D881C247B150}"/>
                </a:ext>
              </a:extLst>
            </p:cNvPr>
            <p:cNvSpPr txBox="1"/>
            <p:nvPr/>
          </p:nvSpPr>
          <p:spPr>
            <a:xfrm>
              <a:off x="2604050" y="1110056"/>
              <a:ext cx="755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/>
                <a:t>MDA5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3A3C3D60-FB94-46C4-8BB7-EF3DD9982BAA}"/>
                </a:ext>
              </a:extLst>
            </p:cNvPr>
            <p:cNvSpPr txBox="1"/>
            <p:nvPr/>
          </p:nvSpPr>
          <p:spPr>
            <a:xfrm rot="16200000">
              <a:off x="2963622" y="1553185"/>
              <a:ext cx="39532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50" dirty="0"/>
                <a:t>IFN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30F49294-972B-4F06-84C6-147CF6B194BF}"/>
                </a:ext>
              </a:extLst>
            </p:cNvPr>
            <p:cNvSpPr txBox="1"/>
            <p:nvPr/>
          </p:nvSpPr>
          <p:spPr>
            <a:xfrm rot="16200000">
              <a:off x="2517570" y="1454476"/>
              <a:ext cx="649545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50" dirty="0"/>
                <a:t>Control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F9172D04-266B-4808-9BD2-0D5CD02D5079}"/>
                </a:ext>
              </a:extLst>
            </p:cNvPr>
            <p:cNvSpPr txBox="1"/>
            <p:nvPr/>
          </p:nvSpPr>
          <p:spPr>
            <a:xfrm>
              <a:off x="1873758" y="2271952"/>
              <a:ext cx="63500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/>
                <a:t>125 </a:t>
              </a:r>
              <a:r>
                <a:rPr lang="en-GB" sz="1000" dirty="0" err="1"/>
                <a:t>kDa</a:t>
              </a:r>
              <a:endParaRPr lang="en-GB" sz="1000" dirty="0"/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6A991951-2A74-4B72-BA4F-9B08C5B0FAFC}"/>
                </a:ext>
              </a:extLst>
            </p:cNvPr>
            <p:cNvSpPr txBox="1"/>
            <p:nvPr/>
          </p:nvSpPr>
          <p:spPr>
            <a:xfrm>
              <a:off x="1892972" y="2467337"/>
              <a:ext cx="63500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/>
                <a:t>93 </a:t>
              </a:r>
              <a:r>
                <a:rPr lang="en-GB" sz="1000" dirty="0" err="1"/>
                <a:t>kDa</a:t>
              </a:r>
              <a:endParaRPr lang="en-GB" sz="1000" dirty="0"/>
            </a:p>
          </p:txBody>
        </p:sp>
      </p:grpSp>
      <p:grpSp>
        <p:nvGrpSpPr>
          <p:cNvPr id="2048" name="Group 2047">
            <a:extLst>
              <a:ext uri="{FF2B5EF4-FFF2-40B4-BE49-F238E27FC236}">
                <a16:creationId xmlns:a16="http://schemas.microsoft.com/office/drawing/2014/main" id="{91C3A3E0-A1F6-420A-8CC7-54F94A62CEF6}"/>
              </a:ext>
            </a:extLst>
          </p:cNvPr>
          <p:cNvGrpSpPr/>
          <p:nvPr/>
        </p:nvGrpSpPr>
        <p:grpSpPr>
          <a:xfrm>
            <a:off x="3543275" y="1111421"/>
            <a:ext cx="1701571" cy="3573883"/>
            <a:chOff x="3543275" y="1110056"/>
            <a:chExt cx="1701571" cy="3573883"/>
          </a:xfrm>
        </p:grpSpPr>
        <p:pic>
          <p:nvPicPr>
            <p:cNvPr id="20" name="Picture 4">
              <a:extLst>
                <a:ext uri="{FF2B5EF4-FFF2-40B4-BE49-F238E27FC236}">
                  <a16:creationId xmlns:a16="http://schemas.microsoft.com/office/drawing/2014/main" id="{BF2E8123-BF0F-4BAA-997D-3D9412BE7CB1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0188"/>
            <a:stretch/>
          </p:blipFill>
          <p:spPr bwMode="auto">
            <a:xfrm flipH="1">
              <a:off x="3983832" y="1940977"/>
              <a:ext cx="1261014" cy="274296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id="{C863E763-18CA-4DEE-A8A3-4AFD2CD8F53A}"/>
                </a:ext>
              </a:extLst>
            </p:cNvPr>
            <p:cNvSpPr/>
            <p:nvPr/>
          </p:nvSpPr>
          <p:spPr>
            <a:xfrm>
              <a:off x="4169322" y="1933739"/>
              <a:ext cx="1004650" cy="270134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1" name="Rectangle 30">
              <a:extLst>
                <a:ext uri="{FF2B5EF4-FFF2-40B4-BE49-F238E27FC236}">
                  <a16:creationId xmlns:a16="http://schemas.microsoft.com/office/drawing/2014/main" id="{74203B08-0A72-4650-AE15-C966ECA28217}"/>
                </a:ext>
              </a:extLst>
            </p:cNvPr>
            <p:cNvSpPr/>
            <p:nvPr/>
          </p:nvSpPr>
          <p:spPr>
            <a:xfrm>
              <a:off x="4221928" y="3205368"/>
              <a:ext cx="744642" cy="344906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FE9963F8-3FF9-4A62-8542-2AFC69A65CAF}"/>
                </a:ext>
              </a:extLst>
            </p:cNvPr>
            <p:cNvSpPr txBox="1"/>
            <p:nvPr/>
          </p:nvSpPr>
          <p:spPr>
            <a:xfrm>
              <a:off x="4294013" y="1110056"/>
              <a:ext cx="755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/>
                <a:t>IRF1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A005C1F7-BF53-4E64-BC4C-AF95118DCC18}"/>
                </a:ext>
              </a:extLst>
            </p:cNvPr>
            <p:cNvSpPr txBox="1"/>
            <p:nvPr/>
          </p:nvSpPr>
          <p:spPr>
            <a:xfrm rot="16200000">
              <a:off x="4629469" y="1575399"/>
              <a:ext cx="39532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50" dirty="0"/>
                <a:t>IFN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1EDA7D20-4591-4F5C-AD90-5FFC9785A733}"/>
                </a:ext>
              </a:extLst>
            </p:cNvPr>
            <p:cNvSpPr txBox="1"/>
            <p:nvPr/>
          </p:nvSpPr>
          <p:spPr>
            <a:xfrm rot="16200000">
              <a:off x="4135792" y="1476690"/>
              <a:ext cx="649545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50" dirty="0"/>
                <a:t>Control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53ADD3FA-8435-491A-A799-823508397ECD}"/>
                </a:ext>
              </a:extLst>
            </p:cNvPr>
            <p:cNvSpPr txBox="1"/>
            <p:nvPr/>
          </p:nvSpPr>
          <p:spPr>
            <a:xfrm>
              <a:off x="3543275" y="3198176"/>
              <a:ext cx="54562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/>
                <a:t>41 </a:t>
              </a:r>
              <a:r>
                <a:rPr lang="en-GB" sz="1000" dirty="0" err="1"/>
                <a:t>kDa</a:t>
              </a:r>
              <a:endParaRPr lang="en-GB" sz="1000" dirty="0"/>
            </a:p>
          </p:txBody>
        </p:sp>
      </p:grpSp>
      <p:grpSp>
        <p:nvGrpSpPr>
          <p:cNvPr id="8" name="Group 7">
            <a:extLst>
              <a:ext uri="{FF2B5EF4-FFF2-40B4-BE49-F238E27FC236}">
                <a16:creationId xmlns:a16="http://schemas.microsoft.com/office/drawing/2014/main" id="{1DD04BA8-0CA9-425B-9813-3CEA5971C7AD}"/>
              </a:ext>
            </a:extLst>
          </p:cNvPr>
          <p:cNvGrpSpPr/>
          <p:nvPr/>
        </p:nvGrpSpPr>
        <p:grpSpPr>
          <a:xfrm>
            <a:off x="5319893" y="1127371"/>
            <a:ext cx="1717145" cy="3557933"/>
            <a:chOff x="5319893" y="1126006"/>
            <a:chExt cx="1717145" cy="3557933"/>
          </a:xfrm>
        </p:grpSpPr>
        <p:pic>
          <p:nvPicPr>
            <p:cNvPr id="21" name="Picture 5">
              <a:extLst>
                <a:ext uri="{FF2B5EF4-FFF2-40B4-BE49-F238E27FC236}">
                  <a16:creationId xmlns:a16="http://schemas.microsoft.com/office/drawing/2014/main" id="{DFB499B1-5D18-4792-80B9-767A7680AEBF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1413" r="29179"/>
            <a:stretch/>
          </p:blipFill>
          <p:spPr bwMode="auto">
            <a:xfrm flipH="1">
              <a:off x="5776023" y="1940977"/>
              <a:ext cx="1261015" cy="274296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id="{4EA601DF-5FDF-4D36-90D0-51BB5053A3F4}"/>
                </a:ext>
              </a:extLst>
            </p:cNvPr>
            <p:cNvSpPr/>
            <p:nvPr/>
          </p:nvSpPr>
          <p:spPr>
            <a:xfrm>
              <a:off x="5941927" y="1927546"/>
              <a:ext cx="1004650" cy="270134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2" name="Rectangle 31">
              <a:extLst>
                <a:ext uri="{FF2B5EF4-FFF2-40B4-BE49-F238E27FC236}">
                  <a16:creationId xmlns:a16="http://schemas.microsoft.com/office/drawing/2014/main" id="{1D7917D9-BDF8-4D52-B9E9-DD827873DB37}"/>
                </a:ext>
              </a:extLst>
            </p:cNvPr>
            <p:cNvSpPr/>
            <p:nvPr/>
          </p:nvSpPr>
          <p:spPr>
            <a:xfrm>
              <a:off x="6146172" y="2748649"/>
              <a:ext cx="641586" cy="344906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DCFB58C1-981A-431B-B68D-01F94D2A20A4}"/>
                </a:ext>
              </a:extLst>
            </p:cNvPr>
            <p:cNvSpPr txBox="1"/>
            <p:nvPr/>
          </p:nvSpPr>
          <p:spPr>
            <a:xfrm>
              <a:off x="6066618" y="1126006"/>
              <a:ext cx="755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/>
                <a:t>PKR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B4D4112D-33AB-4A56-AB7A-AD5C0F85F3D5}"/>
                </a:ext>
              </a:extLst>
            </p:cNvPr>
            <p:cNvSpPr txBox="1"/>
            <p:nvPr/>
          </p:nvSpPr>
          <p:spPr>
            <a:xfrm rot="16200000">
              <a:off x="6420832" y="1620185"/>
              <a:ext cx="39532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50" dirty="0"/>
                <a:t>IFN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646C4AE9-184D-4299-AABB-E46B94327D92}"/>
                </a:ext>
              </a:extLst>
            </p:cNvPr>
            <p:cNvSpPr txBox="1"/>
            <p:nvPr/>
          </p:nvSpPr>
          <p:spPr>
            <a:xfrm rot="16200000">
              <a:off x="5993830" y="1521476"/>
              <a:ext cx="649545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50" dirty="0"/>
                <a:t>Control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4CC94796-4D59-427F-9BB6-BFF4F2811FA5}"/>
                </a:ext>
              </a:extLst>
            </p:cNvPr>
            <p:cNvSpPr txBox="1"/>
            <p:nvPr/>
          </p:nvSpPr>
          <p:spPr>
            <a:xfrm>
              <a:off x="5319893" y="2779592"/>
              <a:ext cx="54562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/>
                <a:t>70 </a:t>
              </a:r>
              <a:r>
                <a:rPr lang="en-GB" sz="1000" dirty="0" err="1"/>
                <a:t>kDa</a:t>
              </a:r>
              <a:endParaRPr lang="en-GB" sz="1000" dirty="0"/>
            </a:p>
          </p:txBody>
        </p: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B2CCC395-5925-4EEC-BCFC-DA6EE35B0646}"/>
              </a:ext>
            </a:extLst>
          </p:cNvPr>
          <p:cNvGrpSpPr/>
          <p:nvPr/>
        </p:nvGrpSpPr>
        <p:grpSpPr>
          <a:xfrm>
            <a:off x="7051828" y="1111548"/>
            <a:ext cx="1845641" cy="3573756"/>
            <a:chOff x="7051828" y="1111548"/>
            <a:chExt cx="1845641" cy="3573756"/>
          </a:xfrm>
        </p:grpSpPr>
        <p:pic>
          <p:nvPicPr>
            <p:cNvPr id="22" name="Picture 6">
              <a:extLst>
                <a:ext uri="{FF2B5EF4-FFF2-40B4-BE49-F238E27FC236}">
                  <a16:creationId xmlns:a16="http://schemas.microsoft.com/office/drawing/2014/main" id="{07ADFCD9-3957-477D-92B8-4B7AD5BE83C7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1413"/>
            <a:stretch/>
          </p:blipFill>
          <p:spPr bwMode="auto">
            <a:xfrm flipH="1">
              <a:off x="7447397" y="1942342"/>
              <a:ext cx="1450072" cy="274296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6E24B5B9-A7D9-4E57-8041-DC9D7BCE517F}"/>
                </a:ext>
              </a:extLst>
            </p:cNvPr>
            <p:cNvSpPr/>
            <p:nvPr/>
          </p:nvSpPr>
          <p:spPr>
            <a:xfrm>
              <a:off x="7593703" y="1942342"/>
              <a:ext cx="1227361" cy="270134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3" name="Rectangle 32">
              <a:extLst>
                <a:ext uri="{FF2B5EF4-FFF2-40B4-BE49-F238E27FC236}">
                  <a16:creationId xmlns:a16="http://schemas.microsoft.com/office/drawing/2014/main" id="{6D316987-3FFE-4040-BA1F-B3761F962E2C}"/>
                </a:ext>
              </a:extLst>
            </p:cNvPr>
            <p:cNvSpPr/>
            <p:nvPr/>
          </p:nvSpPr>
          <p:spPr>
            <a:xfrm>
              <a:off x="7792059" y="3872036"/>
              <a:ext cx="641586" cy="344906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EAD31B40-F326-4659-92A6-0F6F6BE49441}"/>
                </a:ext>
              </a:extLst>
            </p:cNvPr>
            <p:cNvSpPr txBox="1"/>
            <p:nvPr/>
          </p:nvSpPr>
          <p:spPr>
            <a:xfrm>
              <a:off x="7800193" y="1111548"/>
              <a:ext cx="755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/>
                <a:t>ISG15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3516649C-F2A2-47AE-8E22-16A07CA6F9C1}"/>
                </a:ext>
              </a:extLst>
            </p:cNvPr>
            <p:cNvSpPr txBox="1"/>
            <p:nvPr/>
          </p:nvSpPr>
          <p:spPr>
            <a:xfrm rot="16200000">
              <a:off x="8048029" y="1538834"/>
              <a:ext cx="39532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50" dirty="0"/>
                <a:t>IFN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A76D345E-315B-41B4-992E-B99F4A0FC2FC}"/>
                </a:ext>
              </a:extLst>
            </p:cNvPr>
            <p:cNvSpPr txBox="1"/>
            <p:nvPr/>
          </p:nvSpPr>
          <p:spPr>
            <a:xfrm rot="16200000">
              <a:off x="7573402" y="1440125"/>
              <a:ext cx="649545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50" dirty="0"/>
                <a:t>Control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9F20DE08-D283-4F89-808A-F3311D9C0023}"/>
                </a:ext>
              </a:extLst>
            </p:cNvPr>
            <p:cNvSpPr txBox="1"/>
            <p:nvPr/>
          </p:nvSpPr>
          <p:spPr>
            <a:xfrm>
              <a:off x="7051828" y="3921378"/>
              <a:ext cx="54562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/>
                <a:t>14 </a:t>
              </a:r>
              <a:r>
                <a:rPr lang="en-GB" sz="1000" dirty="0" err="1"/>
                <a:t>kDa</a:t>
              </a:r>
              <a:endParaRPr lang="en-GB" sz="1000" dirty="0"/>
            </a:p>
          </p:txBody>
        </p:sp>
      </p:grpSp>
      <p:grpSp>
        <p:nvGrpSpPr>
          <p:cNvPr id="6" name="Group 5">
            <a:extLst>
              <a:ext uri="{FF2B5EF4-FFF2-40B4-BE49-F238E27FC236}">
                <a16:creationId xmlns:a16="http://schemas.microsoft.com/office/drawing/2014/main" id="{4EE323DD-C1E9-4852-9DC4-015909C46D2F}"/>
              </a:ext>
            </a:extLst>
          </p:cNvPr>
          <p:cNvGrpSpPr/>
          <p:nvPr/>
        </p:nvGrpSpPr>
        <p:grpSpPr>
          <a:xfrm>
            <a:off x="8810391" y="1189587"/>
            <a:ext cx="1811395" cy="3495717"/>
            <a:chOff x="8810391" y="1188222"/>
            <a:chExt cx="1811395" cy="3495717"/>
          </a:xfrm>
        </p:grpSpPr>
        <p:pic>
          <p:nvPicPr>
            <p:cNvPr id="23" name="Picture 7">
              <a:extLst>
                <a:ext uri="{FF2B5EF4-FFF2-40B4-BE49-F238E27FC236}">
                  <a16:creationId xmlns:a16="http://schemas.microsoft.com/office/drawing/2014/main" id="{306D1059-ACFC-4BC3-A109-9FDE05669EB9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410" r="12413"/>
            <a:stretch/>
          </p:blipFill>
          <p:spPr bwMode="auto">
            <a:xfrm flipH="1">
              <a:off x="9293037" y="2031101"/>
              <a:ext cx="1328749" cy="265283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00E20C7D-862A-41A0-BE71-61DA9ED51FBC}"/>
                </a:ext>
              </a:extLst>
            </p:cNvPr>
            <p:cNvSpPr/>
            <p:nvPr/>
          </p:nvSpPr>
          <p:spPr>
            <a:xfrm>
              <a:off x="9345346" y="1936132"/>
              <a:ext cx="1035956" cy="270134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17C22431-AD05-4980-8A9F-4DA5C18760F8}"/>
                </a:ext>
              </a:extLst>
            </p:cNvPr>
            <p:cNvSpPr txBox="1"/>
            <p:nvPr/>
          </p:nvSpPr>
          <p:spPr>
            <a:xfrm>
              <a:off x="9485619" y="1188222"/>
              <a:ext cx="9941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/>
                <a:t>Beta-actin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5D164D29-5B5D-4FF2-A2C8-D8D2489734CA}"/>
                </a:ext>
              </a:extLst>
            </p:cNvPr>
            <p:cNvSpPr txBox="1"/>
            <p:nvPr/>
          </p:nvSpPr>
          <p:spPr>
            <a:xfrm rot="16200000">
              <a:off x="9799406" y="1680567"/>
              <a:ext cx="39532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50" dirty="0"/>
                <a:t>IFN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CA2D8526-5632-4E09-A280-97DFA7FFD960}"/>
                </a:ext>
              </a:extLst>
            </p:cNvPr>
            <p:cNvSpPr txBox="1"/>
            <p:nvPr/>
          </p:nvSpPr>
          <p:spPr>
            <a:xfrm rot="16200000">
              <a:off x="9381929" y="1581858"/>
              <a:ext cx="649545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50" dirty="0"/>
                <a:t>Control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86725B70-B7BF-4DC9-BD51-10EDFA8C838D}"/>
                </a:ext>
              </a:extLst>
            </p:cNvPr>
            <p:cNvSpPr txBox="1"/>
            <p:nvPr/>
          </p:nvSpPr>
          <p:spPr>
            <a:xfrm>
              <a:off x="8810391" y="3198176"/>
              <a:ext cx="54562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/>
                <a:t>42 </a:t>
              </a:r>
              <a:r>
                <a:rPr lang="en-GB" sz="1000" dirty="0" err="1"/>
                <a:t>kDa</a:t>
              </a:r>
              <a:endParaRPr lang="en-GB" sz="1000" dirty="0"/>
            </a:p>
          </p:txBody>
        </p:sp>
      </p:grpSp>
    </p:spTree>
    <p:extLst>
      <p:ext uri="{BB962C8B-B14F-4D97-AF65-F5344CB8AC3E}">
        <p14:creationId xmlns:p14="http://schemas.microsoft.com/office/powerpoint/2010/main" val="55700956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5BF8C513-761B-4EE0-AF7D-1ACC7C293818}"/>
              </a:ext>
            </a:extLst>
          </p:cNvPr>
          <p:cNvSpPr txBox="1"/>
          <p:nvPr/>
        </p:nvSpPr>
        <p:spPr>
          <a:xfrm>
            <a:off x="214010" y="147990"/>
            <a:ext cx="44722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Figure 3A – PANC1 and </a:t>
            </a:r>
            <a:r>
              <a:rPr lang="en-GB" dirty="0" err="1"/>
              <a:t>EndoC</a:t>
            </a:r>
            <a:r>
              <a:rPr lang="en-GB" dirty="0"/>
              <a:t>-</a:t>
            </a:r>
            <a:r>
              <a:rPr lang="el-GR" dirty="0"/>
              <a:t>β</a:t>
            </a:r>
            <a:r>
              <a:rPr lang="en-GB" dirty="0"/>
              <a:t>H1 cells</a:t>
            </a:r>
          </a:p>
        </p:txBody>
      </p:sp>
      <p:grpSp>
        <p:nvGrpSpPr>
          <p:cNvPr id="26" name="Group 25">
            <a:extLst>
              <a:ext uri="{FF2B5EF4-FFF2-40B4-BE49-F238E27FC236}">
                <a16:creationId xmlns:a16="http://schemas.microsoft.com/office/drawing/2014/main" id="{AD9D2167-B20D-46DE-B57C-B423C846B4C5}"/>
              </a:ext>
            </a:extLst>
          </p:cNvPr>
          <p:cNvGrpSpPr/>
          <p:nvPr/>
        </p:nvGrpSpPr>
        <p:grpSpPr>
          <a:xfrm>
            <a:off x="91489" y="1258254"/>
            <a:ext cx="1760108" cy="3240359"/>
            <a:chOff x="91489" y="1258254"/>
            <a:chExt cx="1760108" cy="3240359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1489" y="1258254"/>
              <a:ext cx="1729194" cy="324035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CF8FFB76-62F0-4244-9480-75D838BA5885}"/>
                </a:ext>
              </a:extLst>
            </p:cNvPr>
            <p:cNvSpPr/>
            <p:nvPr/>
          </p:nvSpPr>
          <p:spPr>
            <a:xfrm>
              <a:off x="171003" y="1729436"/>
              <a:ext cx="1680594" cy="259711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191BD3B8-733E-44FC-AC00-7F45156E9610}"/>
                </a:ext>
              </a:extLst>
            </p:cNvPr>
            <p:cNvSpPr/>
            <p:nvPr/>
          </p:nvSpPr>
          <p:spPr>
            <a:xfrm>
              <a:off x="428936" y="2024526"/>
              <a:ext cx="619688" cy="344906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9DAB811E-3109-4B6F-8621-086A42BEBA8D}"/>
                </a:ext>
              </a:extLst>
            </p:cNvPr>
            <p:cNvSpPr/>
            <p:nvPr/>
          </p:nvSpPr>
          <p:spPr>
            <a:xfrm>
              <a:off x="1168230" y="2024526"/>
              <a:ext cx="619688" cy="344906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25" name="Group 24">
            <a:extLst>
              <a:ext uri="{FF2B5EF4-FFF2-40B4-BE49-F238E27FC236}">
                <a16:creationId xmlns:a16="http://schemas.microsoft.com/office/drawing/2014/main" id="{E1604AB1-9001-4485-8905-5B69A39546D4}"/>
              </a:ext>
            </a:extLst>
          </p:cNvPr>
          <p:cNvGrpSpPr/>
          <p:nvPr/>
        </p:nvGrpSpPr>
        <p:grpSpPr>
          <a:xfrm>
            <a:off x="1882511" y="1258254"/>
            <a:ext cx="2000030" cy="3240359"/>
            <a:chOff x="1882511" y="1258254"/>
            <a:chExt cx="2000030" cy="3240359"/>
          </a:xfrm>
        </p:grpSpPr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882511" y="1258254"/>
              <a:ext cx="2000030" cy="324035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F01569BC-E2A0-4E54-8FAB-C4FB54E570C0}"/>
                </a:ext>
              </a:extLst>
            </p:cNvPr>
            <p:cNvSpPr/>
            <p:nvPr/>
          </p:nvSpPr>
          <p:spPr>
            <a:xfrm>
              <a:off x="2119049" y="1729436"/>
              <a:ext cx="1680594" cy="259711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384C1F55-7FDC-41CF-84FA-00410F170F14}"/>
                </a:ext>
              </a:extLst>
            </p:cNvPr>
            <p:cNvSpPr/>
            <p:nvPr/>
          </p:nvSpPr>
          <p:spPr>
            <a:xfrm>
              <a:off x="2374084" y="1766212"/>
              <a:ext cx="585262" cy="344906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DFE2A9F8-63A5-469D-BE8C-F4AEE37D40AF}"/>
                </a:ext>
              </a:extLst>
            </p:cNvPr>
            <p:cNvSpPr/>
            <p:nvPr/>
          </p:nvSpPr>
          <p:spPr>
            <a:xfrm>
              <a:off x="3137352" y="1773091"/>
              <a:ext cx="585262" cy="344906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24" name="Group 23">
            <a:extLst>
              <a:ext uri="{FF2B5EF4-FFF2-40B4-BE49-F238E27FC236}">
                <a16:creationId xmlns:a16="http://schemas.microsoft.com/office/drawing/2014/main" id="{94DA9BFA-A1CB-4B4D-AF9D-ACD3E485F07A}"/>
              </a:ext>
            </a:extLst>
          </p:cNvPr>
          <p:cNvGrpSpPr/>
          <p:nvPr/>
        </p:nvGrpSpPr>
        <p:grpSpPr>
          <a:xfrm>
            <a:off x="3924871" y="1258254"/>
            <a:ext cx="2055794" cy="3240359"/>
            <a:chOff x="3924871" y="1258254"/>
            <a:chExt cx="2055794" cy="3240359"/>
          </a:xfrm>
        </p:grpSpPr>
        <p:pic>
          <p:nvPicPr>
            <p:cNvPr id="2" name="Picture 2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924871" y="1258254"/>
              <a:ext cx="2055794" cy="324035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4CE2E6D0-9CD4-4B6F-8BC7-AAEA95DC297E}"/>
                </a:ext>
              </a:extLst>
            </p:cNvPr>
            <p:cNvSpPr/>
            <p:nvPr/>
          </p:nvSpPr>
          <p:spPr>
            <a:xfrm>
              <a:off x="4212903" y="1844967"/>
              <a:ext cx="1680594" cy="259711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A8461329-5D4D-4A59-988E-56AA5B9A8B6C}"/>
                </a:ext>
              </a:extLst>
            </p:cNvPr>
            <p:cNvSpPr/>
            <p:nvPr/>
          </p:nvSpPr>
          <p:spPr>
            <a:xfrm>
              <a:off x="4314301" y="2541821"/>
              <a:ext cx="585262" cy="344906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15457349-ADBC-4C86-B45F-C821436F084E}"/>
                </a:ext>
              </a:extLst>
            </p:cNvPr>
            <p:cNvSpPr/>
            <p:nvPr/>
          </p:nvSpPr>
          <p:spPr>
            <a:xfrm>
              <a:off x="5019169" y="2615540"/>
              <a:ext cx="649860" cy="344906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00833BDA-F902-434F-B91B-7108133B7475}"/>
              </a:ext>
            </a:extLst>
          </p:cNvPr>
          <p:cNvGrpSpPr/>
          <p:nvPr/>
        </p:nvGrpSpPr>
        <p:grpSpPr>
          <a:xfrm>
            <a:off x="6154707" y="1314788"/>
            <a:ext cx="1800200" cy="3183825"/>
            <a:chOff x="6154707" y="1258254"/>
            <a:chExt cx="1800200" cy="3183825"/>
          </a:xfrm>
        </p:grpSpPr>
        <p:pic>
          <p:nvPicPr>
            <p:cNvPr id="3" name="Picture 3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54707" y="1258254"/>
              <a:ext cx="1800200" cy="31838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B383F875-D981-4155-83B9-0E38A852BEA1}"/>
                </a:ext>
              </a:extLst>
            </p:cNvPr>
            <p:cNvSpPr/>
            <p:nvPr/>
          </p:nvSpPr>
          <p:spPr>
            <a:xfrm>
              <a:off x="6214510" y="1844967"/>
              <a:ext cx="1680594" cy="259711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B9B9AA99-267E-41C4-BD82-C6E6568974FA}"/>
                </a:ext>
              </a:extLst>
            </p:cNvPr>
            <p:cNvSpPr/>
            <p:nvPr/>
          </p:nvSpPr>
          <p:spPr>
            <a:xfrm>
              <a:off x="6538974" y="2886727"/>
              <a:ext cx="574890" cy="344906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F11D7B5B-20F4-4735-BFC7-5266A6CCC31C}"/>
                </a:ext>
              </a:extLst>
            </p:cNvPr>
            <p:cNvSpPr/>
            <p:nvPr/>
          </p:nvSpPr>
          <p:spPr>
            <a:xfrm>
              <a:off x="7233778" y="2886727"/>
              <a:ext cx="574890" cy="344906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6" name="Group 5">
            <a:extLst>
              <a:ext uri="{FF2B5EF4-FFF2-40B4-BE49-F238E27FC236}">
                <a16:creationId xmlns:a16="http://schemas.microsoft.com/office/drawing/2014/main" id="{DCE42D86-D721-46F7-8EDF-AB63E63C58F5}"/>
              </a:ext>
            </a:extLst>
          </p:cNvPr>
          <p:cNvGrpSpPr/>
          <p:nvPr/>
        </p:nvGrpSpPr>
        <p:grpSpPr>
          <a:xfrm>
            <a:off x="8014710" y="1302046"/>
            <a:ext cx="2092678" cy="3196567"/>
            <a:chOff x="8014710" y="1258254"/>
            <a:chExt cx="2092678" cy="3196567"/>
          </a:xfrm>
        </p:grpSpPr>
        <p:pic>
          <p:nvPicPr>
            <p:cNvPr id="5" name="Picture 2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014710" y="1258254"/>
              <a:ext cx="2083409" cy="319656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160A8E74-9677-457F-8C41-873C5AD6CA4E}"/>
                </a:ext>
              </a:extLst>
            </p:cNvPr>
            <p:cNvSpPr/>
            <p:nvPr/>
          </p:nvSpPr>
          <p:spPr>
            <a:xfrm>
              <a:off x="8426794" y="1518236"/>
              <a:ext cx="1680594" cy="273698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id="{AF212391-F558-4372-AB93-0F2639C624BF}"/>
                </a:ext>
              </a:extLst>
            </p:cNvPr>
            <p:cNvSpPr/>
            <p:nvPr/>
          </p:nvSpPr>
          <p:spPr>
            <a:xfrm>
              <a:off x="8581938" y="3592801"/>
              <a:ext cx="620701" cy="344906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1D3D4079-759D-4B72-962D-4517BC81B6FF}"/>
                </a:ext>
              </a:extLst>
            </p:cNvPr>
            <p:cNvSpPr/>
            <p:nvPr/>
          </p:nvSpPr>
          <p:spPr>
            <a:xfrm>
              <a:off x="9357783" y="3592801"/>
              <a:ext cx="647863" cy="344906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</p:spTree>
    <p:extLst>
      <p:ext uri="{BB962C8B-B14F-4D97-AF65-F5344CB8AC3E}">
        <p14:creationId xmlns:p14="http://schemas.microsoft.com/office/powerpoint/2010/main" val="49087286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847528" y="634552"/>
            <a:ext cx="23407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In HeLa and 1.1B4 cells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8444670-3348-49EE-A102-7094F6737757}"/>
              </a:ext>
            </a:extLst>
          </p:cNvPr>
          <p:cNvSpPr txBox="1"/>
          <p:nvPr/>
        </p:nvSpPr>
        <p:spPr>
          <a:xfrm>
            <a:off x="214010" y="147990"/>
            <a:ext cx="12261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Figure 3A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D5CF5AD4-8214-4016-BAF7-8E778BC3CB3F}"/>
              </a:ext>
            </a:extLst>
          </p:cNvPr>
          <p:cNvGrpSpPr/>
          <p:nvPr/>
        </p:nvGrpSpPr>
        <p:grpSpPr>
          <a:xfrm>
            <a:off x="418954" y="1759010"/>
            <a:ext cx="1306555" cy="2857500"/>
            <a:chOff x="418954" y="1225842"/>
            <a:chExt cx="1306555" cy="2857500"/>
          </a:xfrm>
        </p:grpSpPr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18954" y="1225842"/>
              <a:ext cx="1304925" cy="28575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33CC0F24-7D94-4320-9F49-027D9DE6DF96}"/>
                </a:ext>
              </a:extLst>
            </p:cNvPr>
            <p:cNvSpPr/>
            <p:nvPr/>
          </p:nvSpPr>
          <p:spPr>
            <a:xfrm>
              <a:off x="499363" y="1525701"/>
              <a:ext cx="1226146" cy="250621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8EFA7FC4-B019-4FDA-A95C-71E9A0C40F55}"/>
                </a:ext>
              </a:extLst>
            </p:cNvPr>
            <p:cNvSpPr/>
            <p:nvPr/>
          </p:nvSpPr>
          <p:spPr>
            <a:xfrm>
              <a:off x="1049055" y="2482139"/>
              <a:ext cx="620701" cy="344906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6" name="Group 5">
            <a:extLst>
              <a:ext uri="{FF2B5EF4-FFF2-40B4-BE49-F238E27FC236}">
                <a16:creationId xmlns:a16="http://schemas.microsoft.com/office/drawing/2014/main" id="{44C66D51-397F-4C92-91B6-A5ED96E11B0E}"/>
              </a:ext>
            </a:extLst>
          </p:cNvPr>
          <p:cNvGrpSpPr/>
          <p:nvPr/>
        </p:nvGrpSpPr>
        <p:grpSpPr>
          <a:xfrm>
            <a:off x="1847528" y="1759010"/>
            <a:ext cx="1512169" cy="2857500"/>
            <a:chOff x="1847528" y="1225842"/>
            <a:chExt cx="1512169" cy="2857500"/>
          </a:xfrm>
        </p:grpSpPr>
        <p:pic>
          <p:nvPicPr>
            <p:cNvPr id="1028" name="Picture 4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26412"/>
            <a:stretch/>
          </p:blipFill>
          <p:spPr bwMode="auto">
            <a:xfrm>
              <a:off x="1847528" y="1225842"/>
              <a:ext cx="1512168" cy="28575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0C2D99A1-619A-485D-852A-E21D96D19B3A}"/>
                </a:ext>
              </a:extLst>
            </p:cNvPr>
            <p:cNvSpPr/>
            <p:nvPr/>
          </p:nvSpPr>
          <p:spPr>
            <a:xfrm>
              <a:off x="2133551" y="1577130"/>
              <a:ext cx="1226146" cy="250621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4D43E050-5C0F-4E2D-9C07-2212679AB855}"/>
                </a:ext>
              </a:extLst>
            </p:cNvPr>
            <p:cNvSpPr/>
            <p:nvPr/>
          </p:nvSpPr>
          <p:spPr>
            <a:xfrm>
              <a:off x="2626081" y="2200229"/>
              <a:ext cx="620701" cy="344906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5" name="Group 4">
            <a:extLst>
              <a:ext uri="{FF2B5EF4-FFF2-40B4-BE49-F238E27FC236}">
                <a16:creationId xmlns:a16="http://schemas.microsoft.com/office/drawing/2014/main" id="{0A8D5E20-FFBC-4FF8-9B65-16F96AD56BC7}"/>
              </a:ext>
            </a:extLst>
          </p:cNvPr>
          <p:cNvGrpSpPr/>
          <p:nvPr/>
        </p:nvGrpSpPr>
        <p:grpSpPr>
          <a:xfrm>
            <a:off x="3549140" y="1759010"/>
            <a:ext cx="1394732" cy="2857500"/>
            <a:chOff x="3549140" y="1225842"/>
            <a:chExt cx="1394732" cy="2857500"/>
          </a:xfrm>
        </p:grpSpPr>
        <p:pic>
          <p:nvPicPr>
            <p:cNvPr id="1029" name="Picture 5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49140" y="1225842"/>
              <a:ext cx="1394732" cy="28575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3A42C3A2-A89C-4820-B116-108C701FFA02}"/>
                </a:ext>
              </a:extLst>
            </p:cNvPr>
            <p:cNvSpPr/>
            <p:nvPr/>
          </p:nvSpPr>
          <p:spPr>
            <a:xfrm>
              <a:off x="3823241" y="1474272"/>
              <a:ext cx="1087075" cy="260907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5F725848-FD7D-4858-A592-CC73B57D2748}"/>
                </a:ext>
              </a:extLst>
            </p:cNvPr>
            <p:cNvSpPr/>
            <p:nvPr/>
          </p:nvSpPr>
          <p:spPr>
            <a:xfrm>
              <a:off x="4239937" y="2921176"/>
              <a:ext cx="620701" cy="344906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id="{AF213A6E-08F3-4DF4-AAC7-0C743CB60782}"/>
              </a:ext>
            </a:extLst>
          </p:cNvPr>
          <p:cNvGrpSpPr/>
          <p:nvPr/>
        </p:nvGrpSpPr>
        <p:grpSpPr>
          <a:xfrm>
            <a:off x="5133316" y="1292285"/>
            <a:ext cx="1308681" cy="3324225"/>
            <a:chOff x="5133316" y="1225842"/>
            <a:chExt cx="1308681" cy="3324225"/>
          </a:xfrm>
        </p:grpSpPr>
        <p:pic>
          <p:nvPicPr>
            <p:cNvPr id="2051" name="Picture 3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33316" y="1225842"/>
              <a:ext cx="1269553" cy="33242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50D48E97-DB1F-4116-A870-93F50AB4123C}"/>
                </a:ext>
              </a:extLst>
            </p:cNvPr>
            <p:cNvSpPr/>
            <p:nvPr/>
          </p:nvSpPr>
          <p:spPr>
            <a:xfrm>
              <a:off x="5354922" y="1711261"/>
              <a:ext cx="1087075" cy="260907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4F38EF4A-8209-444F-8F18-7D3096391E8E}"/>
                </a:ext>
              </a:extLst>
            </p:cNvPr>
            <p:cNvSpPr/>
            <p:nvPr/>
          </p:nvSpPr>
          <p:spPr>
            <a:xfrm>
              <a:off x="5801732" y="3876237"/>
              <a:ext cx="620701" cy="344906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A2F6AEF4-970D-414C-8F1D-39909D4AF552}"/>
              </a:ext>
            </a:extLst>
          </p:cNvPr>
          <p:cNvGrpSpPr/>
          <p:nvPr/>
        </p:nvGrpSpPr>
        <p:grpSpPr>
          <a:xfrm>
            <a:off x="6717492" y="1225842"/>
            <a:ext cx="1803339" cy="3390668"/>
            <a:chOff x="6717492" y="1225842"/>
            <a:chExt cx="1803339" cy="3390668"/>
          </a:xfrm>
        </p:grpSpPr>
        <p:pic>
          <p:nvPicPr>
            <p:cNvPr id="2052" name="Picture 4"/>
            <p:cNvPicPr>
              <a:picLocks noChangeAspect="1" noChangeArrowheads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174"/>
            <a:stretch/>
          </p:blipFill>
          <p:spPr bwMode="auto">
            <a:xfrm>
              <a:off x="6717492" y="1225842"/>
              <a:ext cx="1803339" cy="339066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BCAEA6CE-47E4-4497-964D-2E28745DFB59}"/>
                </a:ext>
              </a:extLst>
            </p:cNvPr>
            <p:cNvSpPr/>
            <p:nvPr/>
          </p:nvSpPr>
          <p:spPr>
            <a:xfrm>
              <a:off x="6840237" y="1711261"/>
              <a:ext cx="1593445" cy="276007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82964AA5-798C-42A5-B748-95F47CE7CF1E}"/>
                </a:ext>
              </a:extLst>
            </p:cNvPr>
            <p:cNvSpPr/>
            <p:nvPr/>
          </p:nvSpPr>
          <p:spPr>
            <a:xfrm>
              <a:off x="7343386" y="2654592"/>
              <a:ext cx="620701" cy="344906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</p:spTree>
    <p:extLst>
      <p:ext uri="{BB962C8B-B14F-4D97-AF65-F5344CB8AC3E}">
        <p14:creationId xmlns:p14="http://schemas.microsoft.com/office/powerpoint/2010/main" val="269484839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B6BA2107-0AC7-4581-93F9-DB78224EBA5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7671"/>
          <a:stretch/>
        </p:blipFill>
        <p:spPr>
          <a:xfrm>
            <a:off x="2369878" y="1966048"/>
            <a:ext cx="4801222" cy="4132452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B7ACB047-A4BC-4D54-984A-2718C7DA9C13}"/>
              </a:ext>
            </a:extLst>
          </p:cNvPr>
          <p:cNvSpPr txBox="1"/>
          <p:nvPr/>
        </p:nvSpPr>
        <p:spPr>
          <a:xfrm rot="16200000">
            <a:off x="2360679" y="1267056"/>
            <a:ext cx="12455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dirty="0"/>
              <a:t>1.1B4 0.5% triton-x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05C71D6-1E0C-475A-9259-507526B1BD0D}"/>
              </a:ext>
            </a:extLst>
          </p:cNvPr>
          <p:cNvSpPr txBox="1"/>
          <p:nvPr/>
        </p:nvSpPr>
        <p:spPr>
          <a:xfrm rot="16200000">
            <a:off x="2681416" y="1267056"/>
            <a:ext cx="12455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dirty="0"/>
              <a:t>1.1B4 1% triton-x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3BE7DA6-1839-4A9B-8A22-047A7FDB2616}"/>
              </a:ext>
            </a:extLst>
          </p:cNvPr>
          <p:cNvSpPr txBox="1"/>
          <p:nvPr/>
        </p:nvSpPr>
        <p:spPr>
          <a:xfrm rot="16200000">
            <a:off x="3044500" y="1267056"/>
            <a:ext cx="12455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dirty="0"/>
              <a:t>1.1B4  5x RIP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D7755B9-BEE5-4EA7-A95F-28C95E70814B}"/>
              </a:ext>
            </a:extLst>
          </p:cNvPr>
          <p:cNvSpPr txBox="1"/>
          <p:nvPr/>
        </p:nvSpPr>
        <p:spPr>
          <a:xfrm rot="16200000">
            <a:off x="3476206" y="1267056"/>
            <a:ext cx="12455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dirty="0"/>
              <a:t>Panc1 1% triton-x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F808192-A594-4225-B3F7-2278220FA4CF}"/>
              </a:ext>
            </a:extLst>
          </p:cNvPr>
          <p:cNvSpPr txBox="1"/>
          <p:nvPr/>
        </p:nvSpPr>
        <p:spPr>
          <a:xfrm rot="16200000">
            <a:off x="3886337" y="1267056"/>
            <a:ext cx="12455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dirty="0"/>
              <a:t>Panc1 5xRIP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6A6F22A-E5F4-492E-844D-837953560A1D}"/>
              </a:ext>
            </a:extLst>
          </p:cNvPr>
          <p:cNvSpPr txBox="1"/>
          <p:nvPr/>
        </p:nvSpPr>
        <p:spPr>
          <a:xfrm rot="16200000">
            <a:off x="4219999" y="1267056"/>
            <a:ext cx="12455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dirty="0"/>
              <a:t>HeLa 1% triton-x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6E830B1-8E49-418F-864E-AD3807C58010}"/>
              </a:ext>
            </a:extLst>
          </p:cNvPr>
          <p:cNvSpPr txBox="1"/>
          <p:nvPr/>
        </p:nvSpPr>
        <p:spPr>
          <a:xfrm rot="16200000">
            <a:off x="4526709" y="1267056"/>
            <a:ext cx="12455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dirty="0"/>
              <a:t>HeLa 5x RIP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3C0A5E4-8C15-40C3-AF77-5918DDADCF1F}"/>
              </a:ext>
            </a:extLst>
          </p:cNvPr>
          <p:cNvSpPr txBox="1"/>
          <p:nvPr/>
        </p:nvSpPr>
        <p:spPr>
          <a:xfrm>
            <a:off x="1167320" y="5222818"/>
            <a:ext cx="11243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14 </a:t>
            </a:r>
            <a:r>
              <a:rPr lang="en-GB" dirty="0" err="1"/>
              <a:t>kDa</a:t>
            </a:r>
            <a:r>
              <a:rPr lang="en-GB" dirty="0"/>
              <a:t>-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1C3C590-99F2-4297-AD7C-D3C9875E3391}"/>
              </a:ext>
            </a:extLst>
          </p:cNvPr>
          <p:cNvSpPr txBox="1"/>
          <p:nvPr/>
        </p:nvSpPr>
        <p:spPr>
          <a:xfrm>
            <a:off x="1167320" y="4761850"/>
            <a:ext cx="11243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18 </a:t>
            </a:r>
            <a:r>
              <a:rPr lang="en-GB" dirty="0" err="1"/>
              <a:t>kDa</a:t>
            </a:r>
            <a:r>
              <a:rPr lang="en-GB" dirty="0"/>
              <a:t>-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A7EF933-BF5F-4B05-9C55-D310F79FD0EE}"/>
              </a:ext>
            </a:extLst>
          </p:cNvPr>
          <p:cNvSpPr txBox="1"/>
          <p:nvPr/>
        </p:nvSpPr>
        <p:spPr>
          <a:xfrm>
            <a:off x="1167320" y="4268270"/>
            <a:ext cx="11243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22 </a:t>
            </a:r>
            <a:r>
              <a:rPr lang="en-GB" dirty="0" err="1"/>
              <a:t>kDa</a:t>
            </a:r>
            <a:r>
              <a:rPr lang="en-GB" dirty="0"/>
              <a:t>-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FEDDA83-CC30-4A83-A92C-EB8A7C5A1C4E}"/>
              </a:ext>
            </a:extLst>
          </p:cNvPr>
          <p:cNvSpPr txBox="1"/>
          <p:nvPr/>
        </p:nvSpPr>
        <p:spPr>
          <a:xfrm>
            <a:off x="214009" y="147990"/>
            <a:ext cx="11869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Figure 3C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9D0572F1-282D-4D18-8957-6F7B4C5D84AF}"/>
              </a:ext>
            </a:extLst>
          </p:cNvPr>
          <p:cNvSpPr/>
          <p:nvPr/>
        </p:nvSpPr>
        <p:spPr>
          <a:xfrm>
            <a:off x="2369878" y="2001778"/>
            <a:ext cx="3988168" cy="395440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03C99715-0073-45F0-9563-5EC202DCFE22}"/>
              </a:ext>
            </a:extLst>
          </p:cNvPr>
          <p:cNvSpPr/>
          <p:nvPr/>
        </p:nvSpPr>
        <p:spPr>
          <a:xfrm>
            <a:off x="2803908" y="4492459"/>
            <a:ext cx="1650646" cy="507380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5279779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18EF230E-DBC8-43C3-9745-5737EB35B7B1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219" t="11825" r="22439" b="26602"/>
          <a:stretch/>
        </p:blipFill>
        <p:spPr>
          <a:xfrm>
            <a:off x="802639" y="1110344"/>
            <a:ext cx="5178284" cy="4231432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70236089-641A-4682-997E-D5E17FFBEA50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" t="-1292" r="-4498" b="-158"/>
          <a:stretch/>
        </p:blipFill>
        <p:spPr>
          <a:xfrm>
            <a:off x="6279503" y="886409"/>
            <a:ext cx="5514391" cy="4786603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199741FF-6D85-4944-9222-8566DBDA9356}"/>
              </a:ext>
            </a:extLst>
          </p:cNvPr>
          <p:cNvSpPr txBox="1"/>
          <p:nvPr/>
        </p:nvSpPr>
        <p:spPr>
          <a:xfrm>
            <a:off x="6809873" y="503413"/>
            <a:ext cx="6176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/>
              <a:t>Mock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B02BD9A-5AB6-4208-A8BE-E0A4F8DE0B82}"/>
              </a:ext>
            </a:extLst>
          </p:cNvPr>
          <p:cNvSpPr txBox="1"/>
          <p:nvPr/>
        </p:nvSpPr>
        <p:spPr>
          <a:xfrm>
            <a:off x="7543799" y="349524"/>
            <a:ext cx="98659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/>
              <a:t>Persistently infected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1083774-2E77-4EA9-A529-97647748356E}"/>
              </a:ext>
            </a:extLst>
          </p:cNvPr>
          <p:cNvSpPr txBox="1"/>
          <p:nvPr/>
        </p:nvSpPr>
        <p:spPr>
          <a:xfrm>
            <a:off x="6857999" y="704348"/>
            <a:ext cx="1925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/>
              <a:t>R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3CD1BC5-0096-466D-9561-3DB459FDAB90}"/>
              </a:ext>
            </a:extLst>
          </p:cNvPr>
          <p:cNvSpPr txBox="1"/>
          <p:nvPr/>
        </p:nvSpPr>
        <p:spPr>
          <a:xfrm>
            <a:off x="7142749" y="704348"/>
            <a:ext cx="1925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/>
              <a:t>H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829C5D5-4710-41B9-BAA0-30DF21DD96FC}"/>
              </a:ext>
            </a:extLst>
          </p:cNvPr>
          <p:cNvSpPr txBox="1"/>
          <p:nvPr/>
        </p:nvSpPr>
        <p:spPr>
          <a:xfrm>
            <a:off x="7844589" y="704348"/>
            <a:ext cx="1925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/>
              <a:t>R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AAA0EB7-14EF-4D91-B252-B058DA80AF42}"/>
              </a:ext>
            </a:extLst>
          </p:cNvPr>
          <p:cNvSpPr txBox="1"/>
          <p:nvPr/>
        </p:nvSpPr>
        <p:spPr>
          <a:xfrm>
            <a:off x="8129339" y="704348"/>
            <a:ext cx="1925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/>
              <a:t>H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67CB746-D7CB-437B-86F0-41E700330E34}"/>
              </a:ext>
            </a:extLst>
          </p:cNvPr>
          <p:cNvSpPr txBox="1"/>
          <p:nvPr/>
        </p:nvSpPr>
        <p:spPr>
          <a:xfrm>
            <a:off x="8447966" y="704348"/>
            <a:ext cx="1925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/>
              <a:t>R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5178D03-6DCE-4FAA-AF2B-AE5EC4FDCF84}"/>
              </a:ext>
            </a:extLst>
          </p:cNvPr>
          <p:cNvSpPr txBox="1"/>
          <p:nvPr/>
        </p:nvSpPr>
        <p:spPr>
          <a:xfrm>
            <a:off x="9023684" y="704348"/>
            <a:ext cx="1925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/>
              <a:t>H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74476F1-5520-497E-84C8-C7A6709767A7}"/>
              </a:ext>
            </a:extLst>
          </p:cNvPr>
          <p:cNvSpPr txBox="1"/>
          <p:nvPr/>
        </p:nvSpPr>
        <p:spPr>
          <a:xfrm>
            <a:off x="9341986" y="704348"/>
            <a:ext cx="1925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/>
              <a:t>R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900A416-9930-4916-B9A1-5287A0165D2E}"/>
              </a:ext>
            </a:extLst>
          </p:cNvPr>
          <p:cNvSpPr txBox="1"/>
          <p:nvPr/>
        </p:nvSpPr>
        <p:spPr>
          <a:xfrm>
            <a:off x="9626736" y="704348"/>
            <a:ext cx="1925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/>
              <a:t>H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B1F3BA3-C75D-449E-9578-7145A720B8C9}"/>
              </a:ext>
            </a:extLst>
          </p:cNvPr>
          <p:cNvSpPr txBox="1"/>
          <p:nvPr/>
        </p:nvSpPr>
        <p:spPr>
          <a:xfrm>
            <a:off x="10884567" y="704348"/>
            <a:ext cx="1925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/>
              <a:t>R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170131C-4C62-446C-ADCB-B79B54F0D53B}"/>
              </a:ext>
            </a:extLst>
          </p:cNvPr>
          <p:cNvSpPr txBox="1"/>
          <p:nvPr/>
        </p:nvSpPr>
        <p:spPr>
          <a:xfrm>
            <a:off x="11169317" y="704348"/>
            <a:ext cx="1925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/>
              <a:t>H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882B88F-EA8F-4929-978A-02BDAD337478}"/>
              </a:ext>
            </a:extLst>
          </p:cNvPr>
          <p:cNvSpPr txBox="1"/>
          <p:nvPr/>
        </p:nvSpPr>
        <p:spPr>
          <a:xfrm>
            <a:off x="10860506" y="503413"/>
            <a:ext cx="6176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/>
              <a:t>Water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73CFE30B-962E-40D6-A822-DEF6359809C6}"/>
              </a:ext>
            </a:extLst>
          </p:cNvPr>
          <p:cNvSpPr txBox="1"/>
          <p:nvPr/>
        </p:nvSpPr>
        <p:spPr>
          <a:xfrm>
            <a:off x="9194866" y="503413"/>
            <a:ext cx="8555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 err="1"/>
              <a:t>EndoC</a:t>
            </a:r>
            <a:r>
              <a:rPr lang="en-GB" sz="1000" dirty="0"/>
              <a:t>-</a:t>
            </a:r>
            <a:r>
              <a:rPr lang="el-GR" sz="1000" dirty="0"/>
              <a:t>β</a:t>
            </a:r>
            <a:r>
              <a:rPr lang="en-GB" sz="1000" dirty="0"/>
              <a:t>H1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E41C580-05D7-43BD-A843-91971202CC2A}"/>
              </a:ext>
            </a:extLst>
          </p:cNvPr>
          <p:cNvSpPr txBox="1"/>
          <p:nvPr/>
        </p:nvSpPr>
        <p:spPr>
          <a:xfrm>
            <a:off x="8536934" y="503413"/>
            <a:ext cx="6176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/>
              <a:t>INS-1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257489A-FC61-4818-A2E0-D7D7531EB380}"/>
              </a:ext>
            </a:extLst>
          </p:cNvPr>
          <p:cNvSpPr txBox="1"/>
          <p:nvPr/>
        </p:nvSpPr>
        <p:spPr>
          <a:xfrm>
            <a:off x="930452" y="684815"/>
            <a:ext cx="8089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 err="1"/>
              <a:t>EndoC</a:t>
            </a:r>
            <a:r>
              <a:rPr lang="en-GB" sz="1000" dirty="0"/>
              <a:t>-</a:t>
            </a:r>
            <a:r>
              <a:rPr lang="el-GR" sz="1000" dirty="0"/>
              <a:t>β</a:t>
            </a:r>
            <a:r>
              <a:rPr lang="en-GB" sz="1000" dirty="0"/>
              <a:t>H1</a:t>
            </a:r>
          </a:p>
        </p:txBody>
      </p:sp>
      <p:sp>
        <p:nvSpPr>
          <p:cNvPr id="26" name="TextBox 77">
            <a:extLst>
              <a:ext uri="{FF2B5EF4-FFF2-40B4-BE49-F238E27FC236}">
                <a16:creationId xmlns:a16="http://schemas.microsoft.com/office/drawing/2014/main" id="{C62B7408-EC0D-41E5-B89D-C3343031FC58}"/>
              </a:ext>
            </a:extLst>
          </p:cNvPr>
          <p:cNvSpPr txBox="1"/>
          <p:nvPr/>
        </p:nvSpPr>
        <p:spPr>
          <a:xfrm>
            <a:off x="1740579" y="886409"/>
            <a:ext cx="1877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dirty="0"/>
              <a:t>R</a:t>
            </a:r>
          </a:p>
        </p:txBody>
      </p:sp>
      <p:sp>
        <p:nvSpPr>
          <p:cNvPr id="27" name="TextBox 78">
            <a:extLst>
              <a:ext uri="{FF2B5EF4-FFF2-40B4-BE49-F238E27FC236}">
                <a16:creationId xmlns:a16="http://schemas.microsoft.com/office/drawing/2014/main" id="{61198679-975C-4FA4-91E6-AB2343CF5E58}"/>
              </a:ext>
            </a:extLst>
          </p:cNvPr>
          <p:cNvSpPr txBox="1"/>
          <p:nvPr/>
        </p:nvSpPr>
        <p:spPr>
          <a:xfrm>
            <a:off x="2020124" y="886409"/>
            <a:ext cx="2464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dirty="0"/>
              <a:t>H</a:t>
            </a:r>
          </a:p>
        </p:txBody>
      </p:sp>
      <p:sp>
        <p:nvSpPr>
          <p:cNvPr id="28" name="TextBox 79">
            <a:extLst>
              <a:ext uri="{FF2B5EF4-FFF2-40B4-BE49-F238E27FC236}">
                <a16:creationId xmlns:a16="http://schemas.microsoft.com/office/drawing/2014/main" id="{29FE24BB-164C-4CD2-B808-A4850F011C7F}"/>
              </a:ext>
            </a:extLst>
          </p:cNvPr>
          <p:cNvSpPr txBox="1"/>
          <p:nvPr/>
        </p:nvSpPr>
        <p:spPr>
          <a:xfrm>
            <a:off x="2984467" y="886409"/>
            <a:ext cx="1877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dirty="0"/>
              <a:t>R</a:t>
            </a:r>
          </a:p>
        </p:txBody>
      </p:sp>
      <p:sp>
        <p:nvSpPr>
          <p:cNvPr id="29" name="TextBox 82">
            <a:extLst>
              <a:ext uri="{FF2B5EF4-FFF2-40B4-BE49-F238E27FC236}">
                <a16:creationId xmlns:a16="http://schemas.microsoft.com/office/drawing/2014/main" id="{F8276749-E40F-4237-B314-41463EDAC862}"/>
              </a:ext>
            </a:extLst>
          </p:cNvPr>
          <p:cNvSpPr txBox="1"/>
          <p:nvPr/>
        </p:nvSpPr>
        <p:spPr>
          <a:xfrm>
            <a:off x="3254712" y="886409"/>
            <a:ext cx="2464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dirty="0"/>
              <a:t>H</a:t>
            </a:r>
          </a:p>
        </p:txBody>
      </p:sp>
      <p:sp>
        <p:nvSpPr>
          <p:cNvPr id="30" name="TextBox 83">
            <a:extLst>
              <a:ext uri="{FF2B5EF4-FFF2-40B4-BE49-F238E27FC236}">
                <a16:creationId xmlns:a16="http://schemas.microsoft.com/office/drawing/2014/main" id="{70892A5A-10BF-4DD6-B50E-226ECFE8163E}"/>
              </a:ext>
            </a:extLst>
          </p:cNvPr>
          <p:cNvSpPr txBox="1"/>
          <p:nvPr/>
        </p:nvSpPr>
        <p:spPr>
          <a:xfrm>
            <a:off x="2392867" y="886409"/>
            <a:ext cx="1877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dirty="0"/>
              <a:t>R</a:t>
            </a:r>
          </a:p>
        </p:txBody>
      </p:sp>
      <p:sp>
        <p:nvSpPr>
          <p:cNvPr id="31" name="TextBox 94">
            <a:extLst>
              <a:ext uri="{FF2B5EF4-FFF2-40B4-BE49-F238E27FC236}">
                <a16:creationId xmlns:a16="http://schemas.microsoft.com/office/drawing/2014/main" id="{CF0028E1-0933-4182-AB33-0DC70B4E246B}"/>
              </a:ext>
            </a:extLst>
          </p:cNvPr>
          <p:cNvSpPr txBox="1"/>
          <p:nvPr/>
        </p:nvSpPr>
        <p:spPr>
          <a:xfrm>
            <a:off x="2683690" y="886409"/>
            <a:ext cx="2464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dirty="0"/>
              <a:t>H</a:t>
            </a:r>
          </a:p>
        </p:txBody>
      </p:sp>
      <p:sp>
        <p:nvSpPr>
          <p:cNvPr id="32" name="TextBox 95">
            <a:extLst>
              <a:ext uri="{FF2B5EF4-FFF2-40B4-BE49-F238E27FC236}">
                <a16:creationId xmlns:a16="http://schemas.microsoft.com/office/drawing/2014/main" id="{8AE06A38-9CB7-4BD4-A4FE-94B9D2B72F8E}"/>
              </a:ext>
            </a:extLst>
          </p:cNvPr>
          <p:cNvSpPr txBox="1"/>
          <p:nvPr/>
        </p:nvSpPr>
        <p:spPr>
          <a:xfrm>
            <a:off x="3599936" y="886409"/>
            <a:ext cx="1877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dirty="0"/>
              <a:t>R</a:t>
            </a:r>
          </a:p>
        </p:txBody>
      </p:sp>
      <p:sp>
        <p:nvSpPr>
          <p:cNvPr id="33" name="TextBox 96">
            <a:extLst>
              <a:ext uri="{FF2B5EF4-FFF2-40B4-BE49-F238E27FC236}">
                <a16:creationId xmlns:a16="http://schemas.microsoft.com/office/drawing/2014/main" id="{D0F06D22-C522-4898-9D9B-7817FB5F4AB3}"/>
              </a:ext>
            </a:extLst>
          </p:cNvPr>
          <p:cNvSpPr txBox="1"/>
          <p:nvPr/>
        </p:nvSpPr>
        <p:spPr>
          <a:xfrm>
            <a:off x="3868148" y="886409"/>
            <a:ext cx="2464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dirty="0"/>
              <a:t>H</a:t>
            </a:r>
          </a:p>
        </p:txBody>
      </p:sp>
      <p:sp>
        <p:nvSpPr>
          <p:cNvPr id="34" name="TextBox 100">
            <a:extLst>
              <a:ext uri="{FF2B5EF4-FFF2-40B4-BE49-F238E27FC236}">
                <a16:creationId xmlns:a16="http://schemas.microsoft.com/office/drawing/2014/main" id="{0576C4CA-9C15-4A9B-BE93-5E11413E9356}"/>
              </a:ext>
            </a:extLst>
          </p:cNvPr>
          <p:cNvSpPr txBox="1"/>
          <p:nvPr/>
        </p:nvSpPr>
        <p:spPr>
          <a:xfrm>
            <a:off x="1670248" y="607870"/>
            <a:ext cx="63597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dirty="0"/>
              <a:t>18/2/12</a:t>
            </a:r>
          </a:p>
          <a:p>
            <a:pPr algn="ctr"/>
            <a:r>
              <a:rPr lang="en-GB" sz="1000" dirty="0"/>
              <a:t>p32</a:t>
            </a:r>
          </a:p>
        </p:txBody>
      </p:sp>
      <p:sp>
        <p:nvSpPr>
          <p:cNvPr id="35" name="TextBox 101">
            <a:extLst>
              <a:ext uri="{FF2B5EF4-FFF2-40B4-BE49-F238E27FC236}">
                <a16:creationId xmlns:a16="http://schemas.microsoft.com/office/drawing/2014/main" id="{54D41134-3876-4D78-A8E5-EEC66DA14717}"/>
              </a:ext>
            </a:extLst>
          </p:cNvPr>
          <p:cNvSpPr txBox="1"/>
          <p:nvPr/>
        </p:nvSpPr>
        <p:spPr>
          <a:xfrm>
            <a:off x="2960061" y="607870"/>
            <a:ext cx="57495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dirty="0"/>
              <a:t>4/8/14</a:t>
            </a:r>
          </a:p>
          <a:p>
            <a:pPr algn="ctr"/>
            <a:r>
              <a:rPr lang="en-GB" sz="1000" dirty="0"/>
              <a:t>p34</a:t>
            </a:r>
          </a:p>
        </p:txBody>
      </p:sp>
      <p:sp>
        <p:nvSpPr>
          <p:cNvPr id="36" name="TextBox 102">
            <a:extLst>
              <a:ext uri="{FF2B5EF4-FFF2-40B4-BE49-F238E27FC236}">
                <a16:creationId xmlns:a16="http://schemas.microsoft.com/office/drawing/2014/main" id="{16202E7B-7477-40FE-85B8-1CE56288053F}"/>
              </a:ext>
            </a:extLst>
          </p:cNvPr>
          <p:cNvSpPr txBox="1"/>
          <p:nvPr/>
        </p:nvSpPr>
        <p:spPr>
          <a:xfrm>
            <a:off x="3467383" y="607870"/>
            <a:ext cx="72986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dirty="0"/>
              <a:t>Feb 2015 </a:t>
            </a:r>
          </a:p>
          <a:p>
            <a:pPr algn="ctr"/>
            <a:r>
              <a:rPr lang="en-GB" sz="1000" dirty="0"/>
              <a:t>p28</a:t>
            </a:r>
          </a:p>
        </p:txBody>
      </p:sp>
      <p:sp>
        <p:nvSpPr>
          <p:cNvPr id="37" name="TextBox 103">
            <a:extLst>
              <a:ext uri="{FF2B5EF4-FFF2-40B4-BE49-F238E27FC236}">
                <a16:creationId xmlns:a16="http://schemas.microsoft.com/office/drawing/2014/main" id="{FFECB793-DA29-459C-BDAC-BBE0D8ACD8AC}"/>
              </a:ext>
            </a:extLst>
          </p:cNvPr>
          <p:cNvSpPr txBox="1"/>
          <p:nvPr/>
        </p:nvSpPr>
        <p:spPr>
          <a:xfrm>
            <a:off x="2337768" y="607870"/>
            <a:ext cx="61307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dirty="0"/>
              <a:t>14/6/12 </a:t>
            </a:r>
          </a:p>
          <a:p>
            <a:pPr algn="ctr"/>
            <a:r>
              <a:rPr lang="en-GB" sz="1000" dirty="0"/>
              <a:t>p33</a:t>
            </a:r>
          </a:p>
        </p:txBody>
      </p:sp>
      <p:sp>
        <p:nvSpPr>
          <p:cNvPr id="41" name="TextBox 136">
            <a:extLst>
              <a:ext uri="{FF2B5EF4-FFF2-40B4-BE49-F238E27FC236}">
                <a16:creationId xmlns:a16="http://schemas.microsoft.com/office/drawing/2014/main" id="{B71A6BEA-BC7D-45A0-A8E5-5D58CA62411E}"/>
              </a:ext>
            </a:extLst>
          </p:cNvPr>
          <p:cNvSpPr txBox="1"/>
          <p:nvPr/>
        </p:nvSpPr>
        <p:spPr>
          <a:xfrm>
            <a:off x="3454097" y="386260"/>
            <a:ext cx="795119" cy="24622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GB" sz="1000" b="1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842288A6-A6B7-47CC-A16A-68410066E1A2}"/>
              </a:ext>
            </a:extLst>
          </p:cNvPr>
          <p:cNvSpPr txBox="1"/>
          <p:nvPr/>
        </p:nvSpPr>
        <p:spPr>
          <a:xfrm>
            <a:off x="4414234" y="684815"/>
            <a:ext cx="8089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 err="1"/>
              <a:t>EndoC</a:t>
            </a:r>
            <a:r>
              <a:rPr lang="en-GB" sz="1000" dirty="0"/>
              <a:t>-</a:t>
            </a:r>
            <a:r>
              <a:rPr lang="el-GR" sz="1000" dirty="0"/>
              <a:t>β</a:t>
            </a:r>
            <a:r>
              <a:rPr lang="en-GB" sz="1000" dirty="0"/>
              <a:t>H1</a:t>
            </a:r>
          </a:p>
        </p:txBody>
      </p:sp>
      <p:sp>
        <p:nvSpPr>
          <p:cNvPr id="48" name="TextBox 97">
            <a:extLst>
              <a:ext uri="{FF2B5EF4-FFF2-40B4-BE49-F238E27FC236}">
                <a16:creationId xmlns:a16="http://schemas.microsoft.com/office/drawing/2014/main" id="{1006E231-7819-4ED5-86D4-C955BFED27DA}"/>
              </a:ext>
            </a:extLst>
          </p:cNvPr>
          <p:cNvSpPr txBox="1"/>
          <p:nvPr/>
        </p:nvSpPr>
        <p:spPr>
          <a:xfrm>
            <a:off x="5217346" y="886409"/>
            <a:ext cx="1877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dirty="0"/>
              <a:t>R</a:t>
            </a:r>
          </a:p>
        </p:txBody>
      </p:sp>
      <p:sp>
        <p:nvSpPr>
          <p:cNvPr id="49" name="TextBox 98">
            <a:extLst>
              <a:ext uri="{FF2B5EF4-FFF2-40B4-BE49-F238E27FC236}">
                <a16:creationId xmlns:a16="http://schemas.microsoft.com/office/drawing/2014/main" id="{09CC8827-E293-4C4C-A9CE-3720DFF7C154}"/>
              </a:ext>
            </a:extLst>
          </p:cNvPr>
          <p:cNvSpPr txBox="1"/>
          <p:nvPr/>
        </p:nvSpPr>
        <p:spPr>
          <a:xfrm>
            <a:off x="5485558" y="886409"/>
            <a:ext cx="2464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dirty="0"/>
              <a:t>H</a:t>
            </a:r>
          </a:p>
        </p:txBody>
      </p:sp>
      <p:sp>
        <p:nvSpPr>
          <p:cNvPr id="50" name="TextBox 109">
            <a:extLst>
              <a:ext uri="{FF2B5EF4-FFF2-40B4-BE49-F238E27FC236}">
                <a16:creationId xmlns:a16="http://schemas.microsoft.com/office/drawing/2014/main" id="{B9606C2A-FC53-4082-A012-2B05423E02F3}"/>
              </a:ext>
            </a:extLst>
          </p:cNvPr>
          <p:cNvSpPr txBox="1"/>
          <p:nvPr/>
        </p:nvSpPr>
        <p:spPr>
          <a:xfrm>
            <a:off x="5189621" y="684815"/>
            <a:ext cx="5764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dirty="0"/>
              <a:t>Water</a:t>
            </a:r>
          </a:p>
        </p:txBody>
      </p:sp>
      <p:sp>
        <p:nvSpPr>
          <p:cNvPr id="51" name="TextBox 97">
            <a:extLst>
              <a:ext uri="{FF2B5EF4-FFF2-40B4-BE49-F238E27FC236}">
                <a16:creationId xmlns:a16="http://schemas.microsoft.com/office/drawing/2014/main" id="{5817E9AA-2A0D-466F-8735-C093807CA20F}"/>
              </a:ext>
            </a:extLst>
          </p:cNvPr>
          <p:cNvSpPr txBox="1"/>
          <p:nvPr/>
        </p:nvSpPr>
        <p:spPr>
          <a:xfrm>
            <a:off x="4575763" y="886409"/>
            <a:ext cx="1877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dirty="0"/>
              <a:t>R</a:t>
            </a:r>
          </a:p>
        </p:txBody>
      </p:sp>
      <p:sp>
        <p:nvSpPr>
          <p:cNvPr id="52" name="TextBox 98">
            <a:extLst>
              <a:ext uri="{FF2B5EF4-FFF2-40B4-BE49-F238E27FC236}">
                <a16:creationId xmlns:a16="http://schemas.microsoft.com/office/drawing/2014/main" id="{BA79AB29-4475-44D7-9508-7046B5330221}"/>
              </a:ext>
            </a:extLst>
          </p:cNvPr>
          <p:cNvSpPr txBox="1"/>
          <p:nvPr/>
        </p:nvSpPr>
        <p:spPr>
          <a:xfrm>
            <a:off x="4843975" y="886409"/>
            <a:ext cx="2464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dirty="0"/>
              <a:t>H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2C4B07B0-C948-4607-A938-7C747403865E}"/>
              </a:ext>
            </a:extLst>
          </p:cNvPr>
          <p:cNvSpPr txBox="1"/>
          <p:nvPr/>
        </p:nvSpPr>
        <p:spPr>
          <a:xfrm>
            <a:off x="4167279" y="5476708"/>
            <a:ext cx="6176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/>
              <a:t>INS-1E</a:t>
            </a:r>
          </a:p>
        </p:txBody>
      </p:sp>
      <p:sp>
        <p:nvSpPr>
          <p:cNvPr id="54" name="TextBox 97">
            <a:extLst>
              <a:ext uri="{FF2B5EF4-FFF2-40B4-BE49-F238E27FC236}">
                <a16:creationId xmlns:a16="http://schemas.microsoft.com/office/drawing/2014/main" id="{CDE96BF8-B504-426B-984D-5C86094970C5}"/>
              </a:ext>
            </a:extLst>
          </p:cNvPr>
          <p:cNvSpPr txBox="1"/>
          <p:nvPr/>
        </p:nvSpPr>
        <p:spPr>
          <a:xfrm>
            <a:off x="4214661" y="5284086"/>
            <a:ext cx="1877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dirty="0"/>
              <a:t>R</a:t>
            </a:r>
          </a:p>
        </p:txBody>
      </p:sp>
      <p:sp>
        <p:nvSpPr>
          <p:cNvPr id="55" name="TextBox 98">
            <a:extLst>
              <a:ext uri="{FF2B5EF4-FFF2-40B4-BE49-F238E27FC236}">
                <a16:creationId xmlns:a16="http://schemas.microsoft.com/office/drawing/2014/main" id="{CF52723A-6808-4CAE-B9E2-4B01FD4EA655}"/>
              </a:ext>
            </a:extLst>
          </p:cNvPr>
          <p:cNvSpPr txBox="1"/>
          <p:nvPr/>
        </p:nvSpPr>
        <p:spPr>
          <a:xfrm>
            <a:off x="4482873" y="5284086"/>
            <a:ext cx="2464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dirty="0"/>
              <a:t>H</a:t>
            </a:r>
          </a:p>
        </p:txBody>
      </p:sp>
      <p:sp>
        <p:nvSpPr>
          <p:cNvPr id="56" name="TextBox 97">
            <a:extLst>
              <a:ext uri="{FF2B5EF4-FFF2-40B4-BE49-F238E27FC236}">
                <a16:creationId xmlns:a16="http://schemas.microsoft.com/office/drawing/2014/main" id="{175D87B0-4BB0-44D4-B2C2-B61FBA2BBA27}"/>
              </a:ext>
            </a:extLst>
          </p:cNvPr>
          <p:cNvSpPr txBox="1"/>
          <p:nvPr/>
        </p:nvSpPr>
        <p:spPr>
          <a:xfrm>
            <a:off x="1165880" y="886409"/>
            <a:ext cx="1877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dirty="0"/>
              <a:t>R</a:t>
            </a:r>
          </a:p>
        </p:txBody>
      </p:sp>
      <p:sp>
        <p:nvSpPr>
          <p:cNvPr id="57" name="TextBox 98">
            <a:extLst>
              <a:ext uri="{FF2B5EF4-FFF2-40B4-BE49-F238E27FC236}">
                <a16:creationId xmlns:a16="http://schemas.microsoft.com/office/drawing/2014/main" id="{1EF914DE-0FE3-41D0-AC13-C68E4BB24BFF}"/>
              </a:ext>
            </a:extLst>
          </p:cNvPr>
          <p:cNvSpPr txBox="1"/>
          <p:nvPr/>
        </p:nvSpPr>
        <p:spPr>
          <a:xfrm>
            <a:off x="1434092" y="886409"/>
            <a:ext cx="2464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dirty="0"/>
              <a:t>H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6E29655D-3799-4238-B71B-030854634BF0}"/>
              </a:ext>
            </a:extLst>
          </p:cNvPr>
          <p:cNvSpPr txBox="1"/>
          <p:nvPr/>
        </p:nvSpPr>
        <p:spPr>
          <a:xfrm rot="16200000">
            <a:off x="666046" y="711116"/>
            <a:ext cx="5522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Ladder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D3E31D74-928C-4C5F-BF21-94FFF6A27C60}"/>
              </a:ext>
            </a:extLst>
          </p:cNvPr>
          <p:cNvSpPr txBox="1"/>
          <p:nvPr/>
        </p:nvSpPr>
        <p:spPr>
          <a:xfrm rot="16200000">
            <a:off x="6290118" y="626523"/>
            <a:ext cx="5522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Ladder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85F49008-B831-4721-BBC9-FCD5E5F5FEA2}"/>
              </a:ext>
            </a:extLst>
          </p:cNvPr>
          <p:cNvSpPr txBox="1"/>
          <p:nvPr/>
        </p:nvSpPr>
        <p:spPr>
          <a:xfrm rot="16200000">
            <a:off x="3705241" y="5437093"/>
            <a:ext cx="5522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Ladder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4346AD31-E8D8-4ECB-823D-6793E44667D8}"/>
              </a:ext>
            </a:extLst>
          </p:cNvPr>
          <p:cNvSpPr txBox="1"/>
          <p:nvPr/>
        </p:nvSpPr>
        <p:spPr>
          <a:xfrm>
            <a:off x="436814" y="2312191"/>
            <a:ext cx="4680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600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5F8E6345-9FA3-45D0-8BC6-2BB32B75F81B}"/>
              </a:ext>
            </a:extLst>
          </p:cNvPr>
          <p:cNvSpPr txBox="1"/>
          <p:nvPr/>
        </p:nvSpPr>
        <p:spPr>
          <a:xfrm>
            <a:off x="433146" y="2432708"/>
            <a:ext cx="4680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500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83227DE3-DEBD-47D0-BD89-C62DACC9F675}"/>
              </a:ext>
            </a:extLst>
          </p:cNvPr>
          <p:cNvSpPr txBox="1"/>
          <p:nvPr/>
        </p:nvSpPr>
        <p:spPr>
          <a:xfrm>
            <a:off x="433145" y="2553225"/>
            <a:ext cx="4680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400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5B2A5812-F821-4227-B29E-1B3F17BCB1C6}"/>
              </a:ext>
            </a:extLst>
          </p:cNvPr>
          <p:cNvSpPr txBox="1"/>
          <p:nvPr/>
        </p:nvSpPr>
        <p:spPr>
          <a:xfrm>
            <a:off x="429477" y="2658182"/>
            <a:ext cx="4680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300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B7F75172-5E24-48AA-B01A-55402CECF402}"/>
              </a:ext>
            </a:extLst>
          </p:cNvPr>
          <p:cNvSpPr txBox="1"/>
          <p:nvPr/>
        </p:nvSpPr>
        <p:spPr>
          <a:xfrm>
            <a:off x="436060" y="2762957"/>
            <a:ext cx="4680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200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987F8829-12A4-4DBD-A84E-765A87ADDADE}"/>
              </a:ext>
            </a:extLst>
          </p:cNvPr>
          <p:cNvSpPr txBox="1"/>
          <p:nvPr/>
        </p:nvSpPr>
        <p:spPr>
          <a:xfrm>
            <a:off x="430730" y="2913164"/>
            <a:ext cx="4680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100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8A8871F9-1B0F-43A2-91D9-1244198C91FF}"/>
              </a:ext>
            </a:extLst>
          </p:cNvPr>
          <p:cNvSpPr txBox="1"/>
          <p:nvPr/>
        </p:nvSpPr>
        <p:spPr>
          <a:xfrm>
            <a:off x="214010" y="147990"/>
            <a:ext cx="12005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Figure 3D</a:t>
            </a:r>
          </a:p>
        </p:txBody>
      </p:sp>
      <p:sp>
        <p:nvSpPr>
          <p:cNvPr id="68" name="Rectangle 67">
            <a:extLst>
              <a:ext uri="{FF2B5EF4-FFF2-40B4-BE49-F238E27FC236}">
                <a16:creationId xmlns:a16="http://schemas.microsoft.com/office/drawing/2014/main" id="{E0CC4925-67C1-4703-BAF3-D8469FE1D7C4}"/>
              </a:ext>
            </a:extLst>
          </p:cNvPr>
          <p:cNvSpPr/>
          <p:nvPr/>
        </p:nvSpPr>
        <p:spPr>
          <a:xfrm>
            <a:off x="1744952" y="2432708"/>
            <a:ext cx="1854984" cy="576470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9" name="Rectangle 68">
            <a:extLst>
              <a:ext uri="{FF2B5EF4-FFF2-40B4-BE49-F238E27FC236}">
                <a16:creationId xmlns:a16="http://schemas.microsoft.com/office/drawing/2014/main" id="{F278D4C9-0FDB-4FC9-8E26-1CA434A31994}"/>
              </a:ext>
            </a:extLst>
          </p:cNvPr>
          <p:cNvSpPr/>
          <p:nvPr/>
        </p:nvSpPr>
        <p:spPr>
          <a:xfrm>
            <a:off x="802639" y="2426921"/>
            <a:ext cx="363241" cy="576470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0" name="Rectangle 69">
            <a:extLst>
              <a:ext uri="{FF2B5EF4-FFF2-40B4-BE49-F238E27FC236}">
                <a16:creationId xmlns:a16="http://schemas.microsoft.com/office/drawing/2014/main" id="{91E34816-7EEA-461E-84A8-56E5AD1F9E5A}"/>
              </a:ext>
            </a:extLst>
          </p:cNvPr>
          <p:cNvSpPr/>
          <p:nvPr/>
        </p:nvSpPr>
        <p:spPr>
          <a:xfrm>
            <a:off x="6494388" y="3355596"/>
            <a:ext cx="1878943" cy="637564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4910125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20FF207D-471A-4B81-A575-6B36D0BAE1D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6950" t="13135" r="-3292" b="15534"/>
          <a:stretch/>
        </p:blipFill>
        <p:spPr>
          <a:xfrm>
            <a:off x="1306782" y="4125395"/>
            <a:ext cx="6017974" cy="2388637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94947B00-3331-4F81-AFC5-4E48A3BE4CD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6960" t="21281" r="-502" b="13519"/>
          <a:stretch/>
        </p:blipFill>
        <p:spPr>
          <a:xfrm>
            <a:off x="1562100" y="872241"/>
            <a:ext cx="5762656" cy="234721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939C6DD0-485E-4A4A-B0BA-7ADA5AA89F65}"/>
              </a:ext>
            </a:extLst>
          </p:cNvPr>
          <p:cNvSpPr txBox="1"/>
          <p:nvPr/>
        </p:nvSpPr>
        <p:spPr>
          <a:xfrm>
            <a:off x="2092779" y="3515528"/>
            <a:ext cx="2010853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 err="1"/>
              <a:t>EndoC</a:t>
            </a:r>
            <a:r>
              <a:rPr lang="en-GB" dirty="0"/>
              <a:t>-</a:t>
            </a:r>
            <a:r>
              <a:rPr lang="el-GR" dirty="0"/>
              <a:t>β</a:t>
            </a:r>
            <a:r>
              <a:rPr lang="en-GB" dirty="0"/>
              <a:t>H1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AC4388D-6609-4CE0-957C-A30E1606BA5F}"/>
              </a:ext>
            </a:extLst>
          </p:cNvPr>
          <p:cNvSpPr txBox="1"/>
          <p:nvPr/>
        </p:nvSpPr>
        <p:spPr>
          <a:xfrm>
            <a:off x="4591052" y="3515528"/>
            <a:ext cx="2015004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Water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52D55AB-5546-4D19-9ADD-29B7C146D645}"/>
              </a:ext>
            </a:extLst>
          </p:cNvPr>
          <p:cNvSpPr txBox="1"/>
          <p:nvPr/>
        </p:nvSpPr>
        <p:spPr>
          <a:xfrm>
            <a:off x="2145397" y="343968"/>
            <a:ext cx="2010853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INS-1E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342B7BC-7210-4B14-9CA4-83AB4447097C}"/>
              </a:ext>
            </a:extLst>
          </p:cNvPr>
          <p:cNvSpPr txBox="1"/>
          <p:nvPr/>
        </p:nvSpPr>
        <p:spPr>
          <a:xfrm>
            <a:off x="4822056" y="343968"/>
            <a:ext cx="1667439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1.1B4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DEC926F-52A6-403B-8E31-E1C30CD15A07}"/>
              </a:ext>
            </a:extLst>
          </p:cNvPr>
          <p:cNvSpPr txBox="1"/>
          <p:nvPr/>
        </p:nvSpPr>
        <p:spPr>
          <a:xfrm>
            <a:off x="1926398" y="3951466"/>
            <a:ext cx="4264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R.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DD2059E-4AFD-499F-9E2F-79CC091FD978}"/>
              </a:ext>
            </a:extLst>
          </p:cNvPr>
          <p:cNvSpPr txBox="1"/>
          <p:nvPr/>
        </p:nvSpPr>
        <p:spPr>
          <a:xfrm>
            <a:off x="2505385" y="3951466"/>
            <a:ext cx="4264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R.2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BC9467C-76F9-4A69-85CF-B824966484D1}"/>
              </a:ext>
            </a:extLst>
          </p:cNvPr>
          <p:cNvSpPr txBox="1"/>
          <p:nvPr/>
        </p:nvSpPr>
        <p:spPr>
          <a:xfrm>
            <a:off x="3258020" y="3951466"/>
            <a:ext cx="4264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H.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2AD4116-3CD6-4DEC-B33F-A24908FE7FBE}"/>
              </a:ext>
            </a:extLst>
          </p:cNvPr>
          <p:cNvSpPr txBox="1"/>
          <p:nvPr/>
        </p:nvSpPr>
        <p:spPr>
          <a:xfrm>
            <a:off x="3909644" y="3951466"/>
            <a:ext cx="4264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H.2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259CA60-EA8F-4D47-B828-AAE5016ED1E9}"/>
              </a:ext>
            </a:extLst>
          </p:cNvPr>
          <p:cNvSpPr txBox="1"/>
          <p:nvPr/>
        </p:nvSpPr>
        <p:spPr>
          <a:xfrm>
            <a:off x="4562139" y="3951466"/>
            <a:ext cx="4264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R.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5A11B7B-5C2B-4888-8C25-4355DCED7C5C}"/>
              </a:ext>
            </a:extLst>
          </p:cNvPr>
          <p:cNvSpPr txBox="1"/>
          <p:nvPr/>
        </p:nvSpPr>
        <p:spPr>
          <a:xfrm>
            <a:off x="4914623" y="3951466"/>
            <a:ext cx="4264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R.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29C4807-FDE0-4B17-8036-99441F499639}"/>
              </a:ext>
            </a:extLst>
          </p:cNvPr>
          <p:cNvSpPr txBox="1"/>
          <p:nvPr/>
        </p:nvSpPr>
        <p:spPr>
          <a:xfrm>
            <a:off x="5558201" y="3951466"/>
            <a:ext cx="4264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H.1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DF792FA-7B4E-41BE-83C3-E838FBC11D52}"/>
              </a:ext>
            </a:extLst>
          </p:cNvPr>
          <p:cNvSpPr txBox="1"/>
          <p:nvPr/>
        </p:nvSpPr>
        <p:spPr>
          <a:xfrm>
            <a:off x="6226603" y="3951466"/>
            <a:ext cx="4264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H.2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A8470ACA-6557-4335-81D9-116AA8E90950}"/>
              </a:ext>
            </a:extLst>
          </p:cNvPr>
          <p:cNvSpPr txBox="1"/>
          <p:nvPr/>
        </p:nvSpPr>
        <p:spPr>
          <a:xfrm>
            <a:off x="2098411" y="654271"/>
            <a:ext cx="4264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R.1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73640B6-6490-4555-A75B-943DB4C10CEF}"/>
              </a:ext>
            </a:extLst>
          </p:cNvPr>
          <p:cNvSpPr txBox="1"/>
          <p:nvPr/>
        </p:nvSpPr>
        <p:spPr>
          <a:xfrm>
            <a:off x="2358616" y="654271"/>
            <a:ext cx="4264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R.2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8AF532F-4665-480A-8F2F-B31373A58864}"/>
              </a:ext>
            </a:extLst>
          </p:cNvPr>
          <p:cNvSpPr txBox="1"/>
          <p:nvPr/>
        </p:nvSpPr>
        <p:spPr>
          <a:xfrm>
            <a:off x="3153196" y="654271"/>
            <a:ext cx="4264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H.1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A390AEA-2ADF-4128-B32F-38D1143A4892}"/>
              </a:ext>
            </a:extLst>
          </p:cNvPr>
          <p:cNvSpPr txBox="1"/>
          <p:nvPr/>
        </p:nvSpPr>
        <p:spPr>
          <a:xfrm>
            <a:off x="3444093" y="654271"/>
            <a:ext cx="4264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H.2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9C92FF1-8F2B-4F6D-BDEC-C59DE14D6839}"/>
              </a:ext>
            </a:extLst>
          </p:cNvPr>
          <p:cNvSpPr txBox="1"/>
          <p:nvPr/>
        </p:nvSpPr>
        <p:spPr>
          <a:xfrm>
            <a:off x="4734152" y="654271"/>
            <a:ext cx="4264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R.1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91652FF-DC2E-46FE-BE53-C3488364BE1A}"/>
              </a:ext>
            </a:extLst>
          </p:cNvPr>
          <p:cNvSpPr txBox="1"/>
          <p:nvPr/>
        </p:nvSpPr>
        <p:spPr>
          <a:xfrm>
            <a:off x="5086636" y="654271"/>
            <a:ext cx="4264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R.2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7B1CA57E-5BB1-43DA-ACA7-41ABD367A22D}"/>
              </a:ext>
            </a:extLst>
          </p:cNvPr>
          <p:cNvSpPr txBox="1"/>
          <p:nvPr/>
        </p:nvSpPr>
        <p:spPr>
          <a:xfrm>
            <a:off x="5730214" y="654271"/>
            <a:ext cx="4264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H.1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3F1C91C3-57E8-42A6-B36E-EF6717D6449F}"/>
              </a:ext>
            </a:extLst>
          </p:cNvPr>
          <p:cNvSpPr txBox="1"/>
          <p:nvPr/>
        </p:nvSpPr>
        <p:spPr>
          <a:xfrm>
            <a:off x="6096612" y="654271"/>
            <a:ext cx="4264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H.2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2AAA313B-6817-4EFE-99FB-0B6490AEA5C6}"/>
              </a:ext>
            </a:extLst>
          </p:cNvPr>
          <p:cNvSpPr txBox="1"/>
          <p:nvPr/>
        </p:nvSpPr>
        <p:spPr>
          <a:xfrm>
            <a:off x="302004" y="218114"/>
            <a:ext cx="11073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Figure 3D</a:t>
            </a: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6A04A0A5-2E8B-4AA1-850F-D2D2F4D5FAB1}"/>
              </a:ext>
            </a:extLst>
          </p:cNvPr>
          <p:cNvSpPr/>
          <p:nvPr/>
        </p:nvSpPr>
        <p:spPr>
          <a:xfrm>
            <a:off x="1637009" y="4882120"/>
            <a:ext cx="2699073" cy="576470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3A8D7D16-06B8-4402-8EF1-62A39420E298}"/>
              </a:ext>
            </a:extLst>
          </p:cNvPr>
          <p:cNvSpPr/>
          <p:nvPr/>
        </p:nvSpPr>
        <p:spPr>
          <a:xfrm>
            <a:off x="1801287" y="1873313"/>
            <a:ext cx="2102172" cy="420322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26289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9565BA81-455E-4866-B1C0-5633ACDE8960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243" t="2446" r="22422" b="24625"/>
          <a:stretch/>
        </p:blipFill>
        <p:spPr>
          <a:xfrm>
            <a:off x="712237" y="1296955"/>
            <a:ext cx="5383763" cy="500120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5706B450-F7F8-4ACB-9BC4-0645E5339BEA}"/>
              </a:ext>
            </a:extLst>
          </p:cNvPr>
          <p:cNvSpPr txBox="1"/>
          <p:nvPr/>
        </p:nvSpPr>
        <p:spPr>
          <a:xfrm>
            <a:off x="1101863" y="836046"/>
            <a:ext cx="7712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/>
              <a:t>INS-1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7C5BC4B-67ED-415F-AE68-518C4B3CC63C}"/>
              </a:ext>
            </a:extLst>
          </p:cNvPr>
          <p:cNvSpPr txBox="1"/>
          <p:nvPr/>
        </p:nvSpPr>
        <p:spPr>
          <a:xfrm>
            <a:off x="1662856" y="836046"/>
            <a:ext cx="107533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/>
              <a:t>EndoC-</a:t>
            </a:r>
            <a:r>
              <a:rPr lang="el-GR" sz="1100"/>
              <a:t>β</a:t>
            </a:r>
            <a:r>
              <a:rPr lang="en-GB" sz="1100"/>
              <a:t>H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7BA5397-BC9D-4A7F-AB2A-AB0B3255E1ED}"/>
              </a:ext>
            </a:extLst>
          </p:cNvPr>
          <p:cNvSpPr txBox="1"/>
          <p:nvPr/>
        </p:nvSpPr>
        <p:spPr>
          <a:xfrm>
            <a:off x="3023688" y="836046"/>
            <a:ext cx="70766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Col. 2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DFD72DB-F095-4A11-803D-25B7FC327208}"/>
              </a:ext>
            </a:extLst>
          </p:cNvPr>
          <p:cNvSpPr txBox="1"/>
          <p:nvPr/>
        </p:nvSpPr>
        <p:spPr>
          <a:xfrm>
            <a:off x="3654242" y="836046"/>
            <a:ext cx="72356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Col. 3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D46EE09-3BF4-4C6E-9590-32BFBAFAA943}"/>
              </a:ext>
            </a:extLst>
          </p:cNvPr>
          <p:cNvSpPr txBox="1"/>
          <p:nvPr/>
        </p:nvSpPr>
        <p:spPr>
          <a:xfrm>
            <a:off x="1219492" y="1086635"/>
            <a:ext cx="2703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/>
              <a:t>R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204E8DF-0A6D-45CA-9346-F29771229BFA}"/>
              </a:ext>
            </a:extLst>
          </p:cNvPr>
          <p:cNvSpPr txBox="1"/>
          <p:nvPr/>
        </p:nvSpPr>
        <p:spPr>
          <a:xfrm>
            <a:off x="1566959" y="1086635"/>
            <a:ext cx="26239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/>
              <a:t>H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8B08D6E-8E4A-48F8-BACA-49E97DC1BED6}"/>
              </a:ext>
            </a:extLst>
          </p:cNvPr>
          <p:cNvSpPr txBox="1"/>
          <p:nvPr/>
        </p:nvSpPr>
        <p:spPr>
          <a:xfrm>
            <a:off x="1906475" y="1086635"/>
            <a:ext cx="2703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/>
              <a:t>R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5113076-6C5F-4488-B273-957250922A40}"/>
              </a:ext>
            </a:extLst>
          </p:cNvPr>
          <p:cNvSpPr txBox="1"/>
          <p:nvPr/>
        </p:nvSpPr>
        <p:spPr>
          <a:xfrm>
            <a:off x="2206317" y="1086635"/>
            <a:ext cx="26239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/>
              <a:t>H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64E0CC3-0968-41F5-B7C8-3088A48DBE6C}"/>
              </a:ext>
            </a:extLst>
          </p:cNvPr>
          <p:cNvSpPr txBox="1"/>
          <p:nvPr/>
        </p:nvSpPr>
        <p:spPr>
          <a:xfrm>
            <a:off x="3103076" y="1086635"/>
            <a:ext cx="2703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/>
              <a:t>R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9633343-22A7-40D5-9F27-4F6B1DC914A3}"/>
              </a:ext>
            </a:extLst>
          </p:cNvPr>
          <p:cNvSpPr txBox="1"/>
          <p:nvPr/>
        </p:nvSpPr>
        <p:spPr>
          <a:xfrm>
            <a:off x="3374343" y="1086635"/>
            <a:ext cx="26239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/>
              <a:t>H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7C73515-432D-4629-B93E-E64D20F5A6CB}"/>
              </a:ext>
            </a:extLst>
          </p:cNvPr>
          <p:cNvSpPr txBox="1"/>
          <p:nvPr/>
        </p:nvSpPr>
        <p:spPr>
          <a:xfrm>
            <a:off x="3724523" y="1086635"/>
            <a:ext cx="2703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/>
              <a:t>R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F7E7D3A-C5D7-4685-9FB4-9B39124F7BE0}"/>
              </a:ext>
            </a:extLst>
          </p:cNvPr>
          <p:cNvSpPr txBox="1"/>
          <p:nvPr/>
        </p:nvSpPr>
        <p:spPr>
          <a:xfrm>
            <a:off x="4061171" y="1086635"/>
            <a:ext cx="26239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H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3AC32C5-D4FA-4746-9420-11052E7C9135}"/>
              </a:ext>
            </a:extLst>
          </p:cNvPr>
          <p:cNvSpPr txBox="1"/>
          <p:nvPr/>
        </p:nvSpPr>
        <p:spPr>
          <a:xfrm>
            <a:off x="2535358" y="836046"/>
            <a:ext cx="51328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100" dirty="0"/>
              <a:t>Col. 1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352CDC3-673E-4DCB-8F83-95474C643E6D}"/>
              </a:ext>
            </a:extLst>
          </p:cNvPr>
          <p:cNvSpPr txBox="1"/>
          <p:nvPr/>
        </p:nvSpPr>
        <p:spPr>
          <a:xfrm>
            <a:off x="2458741" y="1086635"/>
            <a:ext cx="26481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/>
              <a:t>R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30F74F1-3CD6-4CBE-B06B-08B2DC661721}"/>
              </a:ext>
            </a:extLst>
          </p:cNvPr>
          <p:cNvSpPr txBox="1"/>
          <p:nvPr/>
        </p:nvSpPr>
        <p:spPr>
          <a:xfrm>
            <a:off x="2780214" y="1086635"/>
            <a:ext cx="2728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/>
              <a:t>H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9705378-47BF-4CE3-BA83-554E3DF59E72}"/>
              </a:ext>
            </a:extLst>
          </p:cNvPr>
          <p:cNvSpPr txBox="1"/>
          <p:nvPr/>
        </p:nvSpPr>
        <p:spPr>
          <a:xfrm>
            <a:off x="4540459" y="836046"/>
            <a:ext cx="72356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Water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F1EE082-AA38-44BA-961E-18C8C0729E03}"/>
              </a:ext>
            </a:extLst>
          </p:cNvPr>
          <p:cNvSpPr txBox="1"/>
          <p:nvPr/>
        </p:nvSpPr>
        <p:spPr>
          <a:xfrm>
            <a:off x="4610740" y="1086635"/>
            <a:ext cx="2703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/>
              <a:t>R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785D915-1B6E-4E4F-A84A-F3A0435C8723}"/>
              </a:ext>
            </a:extLst>
          </p:cNvPr>
          <p:cNvSpPr txBox="1"/>
          <p:nvPr/>
        </p:nvSpPr>
        <p:spPr>
          <a:xfrm>
            <a:off x="4947388" y="1086635"/>
            <a:ext cx="26239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H</a:t>
            </a:r>
          </a:p>
        </p:txBody>
      </p:sp>
      <p:pic>
        <p:nvPicPr>
          <p:cNvPr id="24" name="Picture 23">
            <a:extLst>
              <a:ext uri="{FF2B5EF4-FFF2-40B4-BE49-F238E27FC236}">
                <a16:creationId xmlns:a16="http://schemas.microsoft.com/office/drawing/2014/main" id="{EF52D2A3-4B20-4994-9A7A-198CFC8E8667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745" t="457" r="25430" b="26661"/>
          <a:stretch/>
        </p:blipFill>
        <p:spPr>
          <a:xfrm>
            <a:off x="6162304" y="1296955"/>
            <a:ext cx="5599255" cy="5161444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EC858264-1409-4404-957E-763A4B3F0E0A}"/>
              </a:ext>
            </a:extLst>
          </p:cNvPr>
          <p:cNvSpPr txBox="1"/>
          <p:nvPr/>
        </p:nvSpPr>
        <p:spPr>
          <a:xfrm>
            <a:off x="8709788" y="836046"/>
            <a:ext cx="51328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100" dirty="0"/>
              <a:t>Col. 5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47B6BAF9-E731-4FA6-BC67-891D0BD5776E}"/>
              </a:ext>
            </a:extLst>
          </p:cNvPr>
          <p:cNvSpPr txBox="1"/>
          <p:nvPr/>
        </p:nvSpPr>
        <p:spPr>
          <a:xfrm>
            <a:off x="9309227" y="836046"/>
            <a:ext cx="51328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100" dirty="0"/>
              <a:t>Col. 6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5E82A31F-361A-4EE8-8C4D-69E09FFDD096}"/>
              </a:ext>
            </a:extLst>
          </p:cNvPr>
          <p:cNvSpPr txBox="1"/>
          <p:nvPr/>
        </p:nvSpPr>
        <p:spPr>
          <a:xfrm>
            <a:off x="10227299" y="836046"/>
            <a:ext cx="55175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100" dirty="0"/>
              <a:t>Water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832276C8-7D8E-4E99-BB5B-0172EA1BB2FB}"/>
              </a:ext>
            </a:extLst>
          </p:cNvPr>
          <p:cNvSpPr txBox="1"/>
          <p:nvPr/>
        </p:nvSpPr>
        <p:spPr>
          <a:xfrm>
            <a:off x="8693141" y="1086635"/>
            <a:ext cx="26481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/>
              <a:t>R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E541D877-AB6E-4F12-9068-680D42AAC77B}"/>
              </a:ext>
            </a:extLst>
          </p:cNvPr>
          <p:cNvSpPr txBox="1"/>
          <p:nvPr/>
        </p:nvSpPr>
        <p:spPr>
          <a:xfrm>
            <a:off x="9014614" y="1086635"/>
            <a:ext cx="27283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/>
              <a:t>H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251BEF14-38D4-4857-8A56-D9A7327DF2A5}"/>
              </a:ext>
            </a:extLst>
          </p:cNvPr>
          <p:cNvSpPr txBox="1"/>
          <p:nvPr/>
        </p:nvSpPr>
        <p:spPr>
          <a:xfrm>
            <a:off x="9330570" y="1086635"/>
            <a:ext cx="26481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/>
              <a:t>R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1244EEB3-886F-4300-9532-111D508F881A}"/>
              </a:ext>
            </a:extLst>
          </p:cNvPr>
          <p:cNvSpPr txBox="1"/>
          <p:nvPr/>
        </p:nvSpPr>
        <p:spPr>
          <a:xfrm>
            <a:off x="9569940" y="1086635"/>
            <a:ext cx="2728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/>
              <a:t>H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3118FC25-F021-41D1-BD18-FB07CCFAC0E3}"/>
              </a:ext>
            </a:extLst>
          </p:cNvPr>
          <p:cNvSpPr txBox="1"/>
          <p:nvPr/>
        </p:nvSpPr>
        <p:spPr>
          <a:xfrm>
            <a:off x="10235445" y="1086635"/>
            <a:ext cx="2926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/>
              <a:t>R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99008338-1F17-4D9D-8FCC-FE00C16118BD}"/>
              </a:ext>
            </a:extLst>
          </p:cNvPr>
          <p:cNvSpPr txBox="1"/>
          <p:nvPr/>
        </p:nvSpPr>
        <p:spPr>
          <a:xfrm>
            <a:off x="10532756" y="1086635"/>
            <a:ext cx="2728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/>
              <a:t>H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32444ACB-7468-4EAE-99D5-2904564C28F4}"/>
              </a:ext>
            </a:extLst>
          </p:cNvPr>
          <p:cNvSpPr txBox="1"/>
          <p:nvPr/>
        </p:nvSpPr>
        <p:spPr>
          <a:xfrm>
            <a:off x="7953465" y="836046"/>
            <a:ext cx="7871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/>
              <a:t>Col. 4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CBFAC5C9-3972-4C43-BB5B-7F96D305E65F}"/>
              </a:ext>
            </a:extLst>
          </p:cNvPr>
          <p:cNvSpPr txBox="1"/>
          <p:nvPr/>
        </p:nvSpPr>
        <p:spPr>
          <a:xfrm>
            <a:off x="8085230" y="1086635"/>
            <a:ext cx="2703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R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17538B01-CFB8-4C7C-ACEF-7CC01FD0EC6D}"/>
              </a:ext>
            </a:extLst>
          </p:cNvPr>
          <p:cNvSpPr txBox="1"/>
          <p:nvPr/>
        </p:nvSpPr>
        <p:spPr>
          <a:xfrm>
            <a:off x="8374599" y="1086635"/>
            <a:ext cx="26239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H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1E89C4D6-CEDA-471D-9EB9-D60C484D238D}"/>
              </a:ext>
            </a:extLst>
          </p:cNvPr>
          <p:cNvSpPr txBox="1"/>
          <p:nvPr/>
        </p:nvSpPr>
        <p:spPr>
          <a:xfrm>
            <a:off x="6678358" y="836046"/>
            <a:ext cx="7712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/>
              <a:t>INS-1E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9B5F1552-A785-48F0-980E-F8ECFAA801FE}"/>
              </a:ext>
            </a:extLst>
          </p:cNvPr>
          <p:cNvSpPr txBox="1"/>
          <p:nvPr/>
        </p:nvSpPr>
        <p:spPr>
          <a:xfrm>
            <a:off x="7239351" y="836046"/>
            <a:ext cx="107533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/>
              <a:t>EndoC-</a:t>
            </a:r>
            <a:r>
              <a:rPr lang="el-GR" sz="1100"/>
              <a:t>β</a:t>
            </a:r>
            <a:r>
              <a:rPr lang="en-GB" sz="1100"/>
              <a:t>H1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C835F853-9D83-4C49-82BF-080E171E0A31}"/>
              </a:ext>
            </a:extLst>
          </p:cNvPr>
          <p:cNvSpPr txBox="1"/>
          <p:nvPr/>
        </p:nvSpPr>
        <p:spPr>
          <a:xfrm>
            <a:off x="6795987" y="1086635"/>
            <a:ext cx="2703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/>
              <a:t>R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E23ED911-0D74-42FD-B28D-A5134A419076}"/>
              </a:ext>
            </a:extLst>
          </p:cNvPr>
          <p:cNvSpPr txBox="1"/>
          <p:nvPr/>
        </p:nvSpPr>
        <p:spPr>
          <a:xfrm>
            <a:off x="7143454" y="1086635"/>
            <a:ext cx="26239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/>
              <a:t>H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1E034FBF-094A-4FB9-9BDE-8514D2B033CE}"/>
              </a:ext>
            </a:extLst>
          </p:cNvPr>
          <p:cNvSpPr txBox="1"/>
          <p:nvPr/>
        </p:nvSpPr>
        <p:spPr>
          <a:xfrm>
            <a:off x="7482970" y="1086635"/>
            <a:ext cx="2703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/>
              <a:t>R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203BC7A1-93FE-4562-B2B4-B04D1E417743}"/>
              </a:ext>
            </a:extLst>
          </p:cNvPr>
          <p:cNvSpPr txBox="1"/>
          <p:nvPr/>
        </p:nvSpPr>
        <p:spPr>
          <a:xfrm>
            <a:off x="7782812" y="1086635"/>
            <a:ext cx="26239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/>
              <a:t>H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FDF6D577-F968-474B-A04F-B03A6ACAFEFD}"/>
              </a:ext>
            </a:extLst>
          </p:cNvPr>
          <p:cNvSpPr txBox="1"/>
          <p:nvPr/>
        </p:nvSpPr>
        <p:spPr>
          <a:xfrm>
            <a:off x="411908" y="3305889"/>
            <a:ext cx="4680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600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D1513B50-EDEA-4C0B-8E07-B9CD63F8D985}"/>
              </a:ext>
            </a:extLst>
          </p:cNvPr>
          <p:cNvSpPr txBox="1"/>
          <p:nvPr/>
        </p:nvSpPr>
        <p:spPr>
          <a:xfrm>
            <a:off x="404569" y="3460293"/>
            <a:ext cx="4680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500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57D83BAB-51E9-4BBC-8F0C-68BEA332CC83}"/>
              </a:ext>
            </a:extLst>
          </p:cNvPr>
          <p:cNvSpPr txBox="1"/>
          <p:nvPr/>
        </p:nvSpPr>
        <p:spPr>
          <a:xfrm>
            <a:off x="411907" y="3645522"/>
            <a:ext cx="4680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400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661B7775-AA24-4E12-B4AD-5DCECE34F83A}"/>
              </a:ext>
            </a:extLst>
          </p:cNvPr>
          <p:cNvSpPr txBox="1"/>
          <p:nvPr/>
        </p:nvSpPr>
        <p:spPr>
          <a:xfrm>
            <a:off x="393252" y="3919259"/>
            <a:ext cx="4680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300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34525AE1-9C26-4C42-97E1-D766FADBCCAC}"/>
              </a:ext>
            </a:extLst>
          </p:cNvPr>
          <p:cNvSpPr txBox="1"/>
          <p:nvPr/>
        </p:nvSpPr>
        <p:spPr>
          <a:xfrm>
            <a:off x="411908" y="4070685"/>
            <a:ext cx="4680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200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DBC5FA2D-9DDB-4B15-8BAD-0D33AF8315ED}"/>
              </a:ext>
            </a:extLst>
          </p:cNvPr>
          <p:cNvSpPr txBox="1"/>
          <p:nvPr/>
        </p:nvSpPr>
        <p:spPr>
          <a:xfrm>
            <a:off x="404570" y="4316106"/>
            <a:ext cx="4680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100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D8759829-68E9-4C25-8CAC-992DC2C290C4}"/>
              </a:ext>
            </a:extLst>
          </p:cNvPr>
          <p:cNvSpPr txBox="1"/>
          <p:nvPr/>
        </p:nvSpPr>
        <p:spPr>
          <a:xfrm>
            <a:off x="214010" y="147990"/>
            <a:ext cx="11617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Figure 4B</a:t>
            </a:r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045FEDB7-19B6-4172-BC39-BB2E3813C150}"/>
              </a:ext>
            </a:extLst>
          </p:cNvPr>
          <p:cNvSpPr/>
          <p:nvPr/>
        </p:nvSpPr>
        <p:spPr>
          <a:xfrm>
            <a:off x="946260" y="3667516"/>
            <a:ext cx="3511440" cy="420322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CAE1A27C-EB38-4C84-881F-86B9D87C7978}"/>
              </a:ext>
            </a:extLst>
          </p:cNvPr>
          <p:cNvSpPr/>
          <p:nvPr/>
        </p:nvSpPr>
        <p:spPr>
          <a:xfrm>
            <a:off x="8085229" y="2885567"/>
            <a:ext cx="1849346" cy="420322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388EFC82-DA86-4486-B09A-BFAF5279C679}"/>
              </a:ext>
            </a:extLst>
          </p:cNvPr>
          <p:cNvSpPr/>
          <p:nvPr/>
        </p:nvSpPr>
        <p:spPr>
          <a:xfrm>
            <a:off x="10095004" y="2885567"/>
            <a:ext cx="684049" cy="420322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229166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B26A3B7F7948EF48AA93BBA6A6ABDE78" ma:contentTypeVersion="13" ma:contentTypeDescription="Create a new document." ma:contentTypeScope="" ma:versionID="b4192a745dc2626d8aa98807cb0f649d">
  <xsd:schema xmlns:xsd="http://www.w3.org/2001/XMLSchema" xmlns:xs="http://www.w3.org/2001/XMLSchema" xmlns:p="http://schemas.microsoft.com/office/2006/metadata/properties" xmlns:ns3="1a703673-5156-40d6-bd17-9d77e817651c" xmlns:ns4="3190fef2-146d-4cb3-88e5-a612589f5e92" targetNamespace="http://schemas.microsoft.com/office/2006/metadata/properties" ma:root="true" ma:fieldsID="3b8679d7f0fdeed66f91a05a1bb46c15" ns3:_="" ns4:_="">
    <xsd:import namespace="1a703673-5156-40d6-bd17-9d77e817651c"/>
    <xsd:import namespace="3190fef2-146d-4cb3-88e5-a612589f5e92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AutoKeyPoints" minOccurs="0"/>
                <xsd:element ref="ns4:MediaServiceKeyPoints" minOccurs="0"/>
                <xsd:element ref="ns4:MediaServiceAutoTags" minOccurs="0"/>
                <xsd:element ref="ns4:MediaServiceGenerationTime" minOccurs="0"/>
                <xsd:element ref="ns4:MediaServiceEventHashCode" minOccurs="0"/>
                <xsd:element ref="ns4:MediaServiceDateTaken" minOccurs="0"/>
                <xsd:element ref="ns4:MediaServiceLocation" minOccurs="0"/>
                <xsd:element ref="ns4:MediaServiceOCR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a703673-5156-40d6-bd17-9d77e817651c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Sharing Hint Hash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190fef2-146d-4cb3-88e5-a612589f5e92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5" nillable="true" ma:displayName="Tags" ma:internalName="MediaServiceAutoTags" ma:readOnly="true">
      <xsd:simpleType>
        <xsd:restriction base="dms:Text"/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8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9" nillable="true" ma:displayName="Location" ma:internalName="MediaServiceLocation" ma:readOnly="true">
      <xsd:simpleType>
        <xsd:restriction base="dms:Text"/>
      </xsd:simpleType>
    </xsd:element>
    <xsd:element name="MediaServiceOCR" ma:index="20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B307A953-E2AE-4616-8E55-ADEBCDC9D873}">
  <ds:schemaRefs>
    <ds:schemaRef ds:uri="http://purl.org/dc/elements/1.1/"/>
    <ds:schemaRef ds:uri="http://schemas.microsoft.com/office/2006/metadata/properties"/>
    <ds:schemaRef ds:uri="1a703673-5156-40d6-bd17-9d77e817651c"/>
    <ds:schemaRef ds:uri="http://purl.org/dc/terms/"/>
    <ds:schemaRef ds:uri="http://schemas.openxmlformats.org/package/2006/metadata/core-properties"/>
    <ds:schemaRef ds:uri="http://schemas.microsoft.com/office/2006/documentManagement/types"/>
    <ds:schemaRef ds:uri="http://schemas.microsoft.com/office/infopath/2007/PartnerControls"/>
    <ds:schemaRef ds:uri="3190fef2-146d-4cb3-88e5-a612589f5e92"/>
    <ds:schemaRef ds:uri="http://www.w3.org/XML/1998/namespace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86562FAC-5FDB-4FD2-BC8C-9A1CBE4F2CB2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0B32B47D-0D68-4E47-930C-9355F2CD31B0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a703673-5156-40d6-bd17-9d77e817651c"/>
    <ds:schemaRef ds:uri="3190fef2-146d-4cb3-88e5-a612589f5e92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451</TotalTime>
  <Words>380</Words>
  <Application>Microsoft Office PowerPoint</Application>
  <PresentationFormat>Widescreen</PresentationFormat>
  <Paragraphs>240</Paragraphs>
  <Slides>1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18" baseType="lpstr">
      <vt:lpstr>Arial</vt:lpstr>
      <vt:lpstr>Calibri</vt:lpstr>
      <vt:lpstr>Calibri Light</vt:lpstr>
      <vt:lpstr>Office Theme</vt:lpstr>
      <vt:lpstr>Supplementary inform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Whole blot ppt for 1.1b4 paper</dc:title>
  <dc:creator>Chaffey, Jessica</dc:creator>
  <cp:lastModifiedBy>Morgan, Noel</cp:lastModifiedBy>
  <cp:revision>14</cp:revision>
  <dcterms:created xsi:type="dcterms:W3CDTF">2020-10-12T10:29:16Z</dcterms:created>
  <dcterms:modified xsi:type="dcterms:W3CDTF">2021-05-20T14:47:4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B26A3B7F7948EF48AA93BBA6A6ABDE78</vt:lpwstr>
  </property>
</Properties>
</file>